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9760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0224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1791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410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5561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1872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7330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5087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899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4855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6811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708D3-3847-4436-B8EB-74E5B1BBD55C}" type="datetimeFigureOut">
              <a:rPr lang="it-IT" smtClean="0"/>
              <a:t>09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17D13-116E-412F-9D50-83A1AF6A9CE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2770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igura a mano libera 4"/>
          <p:cNvSpPr/>
          <p:nvPr/>
        </p:nvSpPr>
        <p:spPr>
          <a:xfrm>
            <a:off x="6202017" y="1995777"/>
            <a:ext cx="2870421" cy="1335820"/>
          </a:xfrm>
          <a:custGeom>
            <a:avLst/>
            <a:gdLst>
              <a:gd name="connsiteX0" fmla="*/ 0 w 2870421"/>
              <a:gd name="connsiteY0" fmla="*/ 0 h 1335820"/>
              <a:gd name="connsiteX1" fmla="*/ 214686 w 2870421"/>
              <a:gd name="connsiteY1" fmla="*/ 79513 h 1335820"/>
              <a:gd name="connsiteX2" fmla="*/ 262393 w 2870421"/>
              <a:gd name="connsiteY2" fmla="*/ 95416 h 1335820"/>
              <a:gd name="connsiteX3" fmla="*/ 278296 w 2870421"/>
              <a:gd name="connsiteY3" fmla="*/ 159026 h 1335820"/>
              <a:gd name="connsiteX4" fmla="*/ 326004 w 2870421"/>
              <a:gd name="connsiteY4" fmla="*/ 214686 h 1335820"/>
              <a:gd name="connsiteX5" fmla="*/ 389614 w 2870421"/>
              <a:gd name="connsiteY5" fmla="*/ 254442 h 1335820"/>
              <a:gd name="connsiteX6" fmla="*/ 413468 w 2870421"/>
              <a:gd name="connsiteY6" fmla="*/ 286247 h 1335820"/>
              <a:gd name="connsiteX7" fmla="*/ 461176 w 2870421"/>
              <a:gd name="connsiteY7" fmla="*/ 365760 h 1335820"/>
              <a:gd name="connsiteX8" fmla="*/ 500933 w 2870421"/>
              <a:gd name="connsiteY8" fmla="*/ 437322 h 1335820"/>
              <a:gd name="connsiteX9" fmla="*/ 548640 w 2870421"/>
              <a:gd name="connsiteY9" fmla="*/ 548640 h 1335820"/>
              <a:gd name="connsiteX10" fmla="*/ 556592 w 2870421"/>
              <a:gd name="connsiteY10" fmla="*/ 659959 h 1335820"/>
              <a:gd name="connsiteX11" fmla="*/ 588397 w 2870421"/>
              <a:gd name="connsiteY11" fmla="*/ 787180 h 1335820"/>
              <a:gd name="connsiteX12" fmla="*/ 620202 w 2870421"/>
              <a:gd name="connsiteY12" fmla="*/ 906449 h 1335820"/>
              <a:gd name="connsiteX13" fmla="*/ 620202 w 2870421"/>
              <a:gd name="connsiteY13" fmla="*/ 970060 h 1335820"/>
              <a:gd name="connsiteX14" fmla="*/ 707666 w 2870421"/>
              <a:gd name="connsiteY14" fmla="*/ 1033670 h 1335820"/>
              <a:gd name="connsiteX15" fmla="*/ 850790 w 2870421"/>
              <a:gd name="connsiteY15" fmla="*/ 1081378 h 1335820"/>
              <a:gd name="connsiteX16" fmla="*/ 1001865 w 2870421"/>
              <a:gd name="connsiteY16" fmla="*/ 1152940 h 1335820"/>
              <a:gd name="connsiteX17" fmla="*/ 1049573 w 2870421"/>
              <a:gd name="connsiteY17" fmla="*/ 1160891 h 1335820"/>
              <a:gd name="connsiteX18" fmla="*/ 1160891 w 2870421"/>
              <a:gd name="connsiteY18" fmla="*/ 1216550 h 1335820"/>
              <a:gd name="connsiteX19" fmla="*/ 1351722 w 2870421"/>
              <a:gd name="connsiteY19" fmla="*/ 1288112 h 1335820"/>
              <a:gd name="connsiteX20" fmla="*/ 1550505 w 2870421"/>
              <a:gd name="connsiteY20" fmla="*/ 1319917 h 1335820"/>
              <a:gd name="connsiteX21" fmla="*/ 1971924 w 2870421"/>
              <a:gd name="connsiteY21" fmla="*/ 1335820 h 1335820"/>
              <a:gd name="connsiteX22" fmla="*/ 2305879 w 2870421"/>
              <a:gd name="connsiteY22" fmla="*/ 1335820 h 1335820"/>
              <a:gd name="connsiteX23" fmla="*/ 2600077 w 2870421"/>
              <a:gd name="connsiteY23" fmla="*/ 1335820 h 1335820"/>
              <a:gd name="connsiteX24" fmla="*/ 2870421 w 2870421"/>
              <a:gd name="connsiteY24" fmla="*/ 1327868 h 13358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2870421" h="1335820">
                <a:moveTo>
                  <a:pt x="0" y="0"/>
                </a:moveTo>
                <a:lnTo>
                  <a:pt x="214686" y="79513"/>
                </a:lnTo>
                <a:lnTo>
                  <a:pt x="262393" y="95416"/>
                </a:lnTo>
                <a:lnTo>
                  <a:pt x="278296" y="159026"/>
                </a:lnTo>
                <a:lnTo>
                  <a:pt x="326004" y="214686"/>
                </a:lnTo>
                <a:lnTo>
                  <a:pt x="389614" y="254442"/>
                </a:lnTo>
                <a:lnTo>
                  <a:pt x="413468" y="286247"/>
                </a:lnTo>
                <a:lnTo>
                  <a:pt x="461176" y="365760"/>
                </a:lnTo>
                <a:lnTo>
                  <a:pt x="500933" y="437322"/>
                </a:lnTo>
                <a:lnTo>
                  <a:pt x="548640" y="548640"/>
                </a:lnTo>
                <a:lnTo>
                  <a:pt x="556592" y="659959"/>
                </a:lnTo>
                <a:lnTo>
                  <a:pt x="588397" y="787180"/>
                </a:lnTo>
                <a:lnTo>
                  <a:pt x="620202" y="906449"/>
                </a:lnTo>
                <a:lnTo>
                  <a:pt x="620202" y="970060"/>
                </a:lnTo>
                <a:lnTo>
                  <a:pt x="707666" y="1033670"/>
                </a:lnTo>
                <a:lnTo>
                  <a:pt x="850790" y="1081378"/>
                </a:lnTo>
                <a:lnTo>
                  <a:pt x="1001865" y="1152940"/>
                </a:lnTo>
                <a:lnTo>
                  <a:pt x="1049573" y="1160891"/>
                </a:lnTo>
                <a:lnTo>
                  <a:pt x="1160891" y="1216550"/>
                </a:lnTo>
                <a:lnTo>
                  <a:pt x="1351722" y="1288112"/>
                </a:lnTo>
                <a:lnTo>
                  <a:pt x="1550505" y="1319917"/>
                </a:lnTo>
                <a:lnTo>
                  <a:pt x="1971924" y="1335820"/>
                </a:lnTo>
                <a:lnTo>
                  <a:pt x="2305879" y="1335820"/>
                </a:lnTo>
                <a:lnTo>
                  <a:pt x="2600077" y="1335820"/>
                </a:lnTo>
                <a:lnTo>
                  <a:pt x="2870421" y="1327868"/>
                </a:lnTo>
              </a:path>
            </a:pathLst>
          </a:cu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Line 8"/>
          <p:cNvSpPr>
            <a:spLocks noChangeShapeType="1"/>
          </p:cNvSpPr>
          <p:nvPr/>
        </p:nvSpPr>
        <p:spPr bwMode="auto">
          <a:xfrm>
            <a:off x="6165310" y="5546561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2" name="Line 9"/>
          <p:cNvSpPr>
            <a:spLocks noChangeShapeType="1"/>
          </p:cNvSpPr>
          <p:nvPr/>
        </p:nvSpPr>
        <p:spPr bwMode="auto">
          <a:xfrm>
            <a:off x="7055674" y="5546561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3" name="Line 10"/>
          <p:cNvSpPr>
            <a:spLocks noChangeShapeType="1"/>
          </p:cNvSpPr>
          <p:nvPr/>
        </p:nvSpPr>
        <p:spPr bwMode="auto">
          <a:xfrm>
            <a:off x="7946038" y="5546561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4" name="Line 11"/>
          <p:cNvSpPr>
            <a:spLocks noChangeShapeType="1"/>
          </p:cNvSpPr>
          <p:nvPr/>
        </p:nvSpPr>
        <p:spPr bwMode="auto">
          <a:xfrm>
            <a:off x="8836402" y="5546561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5" name="Line 12"/>
          <p:cNvSpPr>
            <a:spLocks noChangeShapeType="1"/>
          </p:cNvSpPr>
          <p:nvPr/>
        </p:nvSpPr>
        <p:spPr bwMode="auto">
          <a:xfrm>
            <a:off x="9726766" y="5546561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7" name="Freeform 14"/>
          <p:cNvSpPr>
            <a:spLocks noEditPoints="1"/>
          </p:cNvSpPr>
          <p:nvPr/>
        </p:nvSpPr>
        <p:spPr bwMode="auto">
          <a:xfrm>
            <a:off x="9569811" y="5643588"/>
            <a:ext cx="313910" cy="91319"/>
          </a:xfrm>
          <a:custGeom>
            <a:avLst/>
            <a:gdLst>
              <a:gd name="T0" fmla="*/ 55 w 519"/>
              <a:gd name="T1" fmla="*/ 96 h 152"/>
              <a:gd name="T2" fmla="*/ 0 w 519"/>
              <a:gd name="T3" fmla="*/ 82 h 152"/>
              <a:gd name="T4" fmla="*/ 70 w 519"/>
              <a:gd name="T5" fmla="*/ 1 h 152"/>
              <a:gd name="T6" fmla="*/ 87 w 519"/>
              <a:gd name="T7" fmla="*/ 82 h 152"/>
              <a:gd name="T8" fmla="*/ 70 w 519"/>
              <a:gd name="T9" fmla="*/ 96 h 152"/>
              <a:gd name="T10" fmla="*/ 55 w 519"/>
              <a:gd name="T11" fmla="*/ 127 h 152"/>
              <a:gd name="T12" fmla="*/ 55 w 519"/>
              <a:gd name="T13" fmla="*/ 25 h 152"/>
              <a:gd name="T14" fmla="*/ 55 w 519"/>
              <a:gd name="T15" fmla="*/ 82 h 152"/>
              <a:gd name="T16" fmla="*/ 105 w 519"/>
              <a:gd name="T17" fmla="*/ 28 h 152"/>
              <a:gd name="T18" fmla="*/ 142 w 519"/>
              <a:gd name="T19" fmla="*/ 0 h 152"/>
              <a:gd name="T20" fmla="*/ 172 w 519"/>
              <a:gd name="T21" fmla="*/ 16 h 152"/>
              <a:gd name="T22" fmla="*/ 183 w 519"/>
              <a:gd name="T23" fmla="*/ 64 h 152"/>
              <a:gd name="T24" fmla="*/ 165 w 519"/>
              <a:gd name="T25" fmla="*/ 121 h 152"/>
              <a:gd name="T26" fmla="*/ 113 w 519"/>
              <a:gd name="T27" fmla="*/ 116 h 152"/>
              <a:gd name="T28" fmla="*/ 117 w 519"/>
              <a:gd name="T29" fmla="*/ 64 h 152"/>
              <a:gd name="T30" fmla="*/ 142 w 519"/>
              <a:gd name="T31" fmla="*/ 116 h 152"/>
              <a:gd name="T32" fmla="*/ 167 w 519"/>
              <a:gd name="T33" fmla="*/ 64 h 152"/>
              <a:gd name="T34" fmla="*/ 142 w 519"/>
              <a:gd name="T35" fmla="*/ 13 h 152"/>
              <a:gd name="T36" fmla="*/ 117 w 519"/>
              <a:gd name="T37" fmla="*/ 64 h 152"/>
              <a:gd name="T38" fmla="*/ 201 w 519"/>
              <a:gd name="T39" fmla="*/ 28 h 152"/>
              <a:gd name="T40" fmla="*/ 238 w 519"/>
              <a:gd name="T41" fmla="*/ 0 h 152"/>
              <a:gd name="T42" fmla="*/ 268 w 519"/>
              <a:gd name="T43" fmla="*/ 16 h 152"/>
              <a:gd name="T44" fmla="*/ 279 w 519"/>
              <a:gd name="T45" fmla="*/ 64 h 152"/>
              <a:gd name="T46" fmla="*/ 261 w 519"/>
              <a:gd name="T47" fmla="*/ 121 h 152"/>
              <a:gd name="T48" fmla="*/ 209 w 519"/>
              <a:gd name="T49" fmla="*/ 116 h 152"/>
              <a:gd name="T50" fmla="*/ 213 w 519"/>
              <a:gd name="T51" fmla="*/ 64 h 152"/>
              <a:gd name="T52" fmla="*/ 238 w 519"/>
              <a:gd name="T53" fmla="*/ 116 h 152"/>
              <a:gd name="T54" fmla="*/ 263 w 519"/>
              <a:gd name="T55" fmla="*/ 64 h 152"/>
              <a:gd name="T56" fmla="*/ 238 w 519"/>
              <a:gd name="T57" fmla="*/ 13 h 152"/>
              <a:gd name="T58" fmla="*/ 213 w 519"/>
              <a:gd name="T59" fmla="*/ 64 h 152"/>
              <a:gd name="T60" fmla="*/ 297 w 519"/>
              <a:gd name="T61" fmla="*/ 28 h 152"/>
              <a:gd name="T62" fmla="*/ 334 w 519"/>
              <a:gd name="T63" fmla="*/ 0 h 152"/>
              <a:gd name="T64" fmla="*/ 364 w 519"/>
              <a:gd name="T65" fmla="*/ 16 h 152"/>
              <a:gd name="T66" fmla="*/ 375 w 519"/>
              <a:gd name="T67" fmla="*/ 64 h 152"/>
              <a:gd name="T68" fmla="*/ 357 w 519"/>
              <a:gd name="T69" fmla="*/ 121 h 152"/>
              <a:gd name="T70" fmla="*/ 305 w 519"/>
              <a:gd name="T71" fmla="*/ 116 h 152"/>
              <a:gd name="T72" fmla="*/ 309 w 519"/>
              <a:gd name="T73" fmla="*/ 64 h 152"/>
              <a:gd name="T74" fmla="*/ 334 w 519"/>
              <a:gd name="T75" fmla="*/ 116 h 152"/>
              <a:gd name="T76" fmla="*/ 359 w 519"/>
              <a:gd name="T77" fmla="*/ 64 h 152"/>
              <a:gd name="T78" fmla="*/ 334 w 519"/>
              <a:gd name="T79" fmla="*/ 13 h 152"/>
              <a:gd name="T80" fmla="*/ 309 w 519"/>
              <a:gd name="T81" fmla="*/ 64 h 152"/>
              <a:gd name="T82" fmla="*/ 397 w 519"/>
              <a:gd name="T83" fmla="*/ 109 h 152"/>
              <a:gd name="T84" fmla="*/ 415 w 519"/>
              <a:gd name="T85" fmla="*/ 127 h 152"/>
              <a:gd name="T86" fmla="*/ 401 w 519"/>
              <a:gd name="T87" fmla="*/ 152 h 152"/>
              <a:gd name="T88" fmla="*/ 403 w 519"/>
              <a:gd name="T89" fmla="*/ 139 h 152"/>
              <a:gd name="T90" fmla="*/ 397 w 519"/>
              <a:gd name="T91" fmla="*/ 127 h 152"/>
              <a:gd name="T92" fmla="*/ 441 w 519"/>
              <a:gd name="T93" fmla="*/ 28 h 152"/>
              <a:gd name="T94" fmla="*/ 478 w 519"/>
              <a:gd name="T95" fmla="*/ 0 h 152"/>
              <a:gd name="T96" fmla="*/ 508 w 519"/>
              <a:gd name="T97" fmla="*/ 16 h 152"/>
              <a:gd name="T98" fmla="*/ 519 w 519"/>
              <a:gd name="T99" fmla="*/ 64 h 152"/>
              <a:gd name="T100" fmla="*/ 501 w 519"/>
              <a:gd name="T101" fmla="*/ 121 h 152"/>
              <a:gd name="T102" fmla="*/ 449 w 519"/>
              <a:gd name="T103" fmla="*/ 116 h 152"/>
              <a:gd name="T104" fmla="*/ 453 w 519"/>
              <a:gd name="T105" fmla="*/ 64 h 152"/>
              <a:gd name="T106" fmla="*/ 478 w 519"/>
              <a:gd name="T107" fmla="*/ 116 h 152"/>
              <a:gd name="T108" fmla="*/ 503 w 519"/>
              <a:gd name="T109" fmla="*/ 64 h 152"/>
              <a:gd name="T110" fmla="*/ 478 w 519"/>
              <a:gd name="T111" fmla="*/ 13 h 152"/>
              <a:gd name="T112" fmla="*/ 453 w 519"/>
              <a:gd name="T113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519" h="152">
                <a:moveTo>
                  <a:pt x="55" y="127"/>
                </a:moveTo>
                <a:lnTo>
                  <a:pt x="55" y="96"/>
                </a:lnTo>
                <a:lnTo>
                  <a:pt x="0" y="96"/>
                </a:lnTo>
                <a:lnTo>
                  <a:pt x="0" y="82"/>
                </a:lnTo>
                <a:lnTo>
                  <a:pt x="57" y="1"/>
                </a:lnTo>
                <a:lnTo>
                  <a:pt x="70" y="1"/>
                </a:lnTo>
                <a:lnTo>
                  <a:pt x="70" y="82"/>
                </a:lnTo>
                <a:lnTo>
                  <a:pt x="87" y="82"/>
                </a:lnTo>
                <a:lnTo>
                  <a:pt x="87" y="96"/>
                </a:lnTo>
                <a:lnTo>
                  <a:pt x="70" y="96"/>
                </a:lnTo>
                <a:lnTo>
                  <a:pt x="70" y="127"/>
                </a:lnTo>
                <a:lnTo>
                  <a:pt x="55" y="127"/>
                </a:lnTo>
                <a:close/>
                <a:moveTo>
                  <a:pt x="55" y="82"/>
                </a:moveTo>
                <a:lnTo>
                  <a:pt x="55" y="25"/>
                </a:lnTo>
                <a:lnTo>
                  <a:pt x="15" y="82"/>
                </a:lnTo>
                <a:lnTo>
                  <a:pt x="55" y="82"/>
                </a:lnTo>
                <a:close/>
                <a:moveTo>
                  <a:pt x="101" y="64"/>
                </a:moveTo>
                <a:cubicBezTo>
                  <a:pt x="101" y="49"/>
                  <a:pt x="102" y="38"/>
                  <a:pt x="105" y="28"/>
                </a:cubicBezTo>
                <a:cubicBezTo>
                  <a:pt x="109" y="19"/>
                  <a:pt x="113" y="12"/>
                  <a:pt x="119" y="7"/>
                </a:cubicBezTo>
                <a:cubicBezTo>
                  <a:pt x="125" y="3"/>
                  <a:pt x="133" y="0"/>
                  <a:pt x="142" y="0"/>
                </a:cubicBezTo>
                <a:cubicBezTo>
                  <a:pt x="149" y="0"/>
                  <a:pt x="155" y="1"/>
                  <a:pt x="160" y="4"/>
                </a:cubicBezTo>
                <a:cubicBezTo>
                  <a:pt x="165" y="7"/>
                  <a:pt x="169" y="11"/>
                  <a:pt x="172" y="16"/>
                </a:cubicBezTo>
                <a:cubicBezTo>
                  <a:pt x="176" y="21"/>
                  <a:pt x="178" y="27"/>
                  <a:pt x="180" y="35"/>
                </a:cubicBezTo>
                <a:cubicBezTo>
                  <a:pt x="182" y="42"/>
                  <a:pt x="183" y="52"/>
                  <a:pt x="183" y="64"/>
                </a:cubicBezTo>
                <a:cubicBezTo>
                  <a:pt x="183" y="79"/>
                  <a:pt x="182" y="91"/>
                  <a:pt x="178" y="100"/>
                </a:cubicBezTo>
                <a:cubicBezTo>
                  <a:pt x="175" y="109"/>
                  <a:pt x="171" y="116"/>
                  <a:pt x="165" y="121"/>
                </a:cubicBezTo>
                <a:cubicBezTo>
                  <a:pt x="159" y="126"/>
                  <a:pt x="151" y="129"/>
                  <a:pt x="142" y="129"/>
                </a:cubicBezTo>
                <a:cubicBezTo>
                  <a:pt x="130" y="129"/>
                  <a:pt x="120" y="124"/>
                  <a:pt x="113" y="116"/>
                </a:cubicBezTo>
                <a:cubicBezTo>
                  <a:pt x="105" y="105"/>
                  <a:pt x="101" y="88"/>
                  <a:pt x="101" y="64"/>
                </a:cubicBezTo>
                <a:close/>
                <a:moveTo>
                  <a:pt x="117" y="64"/>
                </a:moveTo>
                <a:cubicBezTo>
                  <a:pt x="117" y="85"/>
                  <a:pt x="119" y="99"/>
                  <a:pt x="124" y="106"/>
                </a:cubicBezTo>
                <a:cubicBezTo>
                  <a:pt x="129" y="113"/>
                  <a:pt x="135" y="116"/>
                  <a:pt x="142" y="116"/>
                </a:cubicBezTo>
                <a:cubicBezTo>
                  <a:pt x="149" y="116"/>
                  <a:pt x="155" y="113"/>
                  <a:pt x="160" y="106"/>
                </a:cubicBezTo>
                <a:cubicBezTo>
                  <a:pt x="165" y="99"/>
                  <a:pt x="167" y="85"/>
                  <a:pt x="167" y="64"/>
                </a:cubicBezTo>
                <a:cubicBezTo>
                  <a:pt x="167" y="44"/>
                  <a:pt x="165" y="30"/>
                  <a:pt x="160" y="23"/>
                </a:cubicBezTo>
                <a:cubicBezTo>
                  <a:pt x="155" y="16"/>
                  <a:pt x="149" y="13"/>
                  <a:pt x="142" y="13"/>
                </a:cubicBezTo>
                <a:cubicBezTo>
                  <a:pt x="135" y="13"/>
                  <a:pt x="129" y="16"/>
                  <a:pt x="125" y="22"/>
                </a:cubicBezTo>
                <a:cubicBezTo>
                  <a:pt x="120" y="29"/>
                  <a:pt x="117" y="44"/>
                  <a:pt x="117" y="64"/>
                </a:cubicBezTo>
                <a:close/>
                <a:moveTo>
                  <a:pt x="197" y="64"/>
                </a:moveTo>
                <a:cubicBezTo>
                  <a:pt x="197" y="49"/>
                  <a:pt x="198" y="38"/>
                  <a:pt x="201" y="28"/>
                </a:cubicBezTo>
                <a:cubicBezTo>
                  <a:pt x="205" y="19"/>
                  <a:pt x="209" y="12"/>
                  <a:pt x="215" y="7"/>
                </a:cubicBezTo>
                <a:cubicBezTo>
                  <a:pt x="221" y="3"/>
                  <a:pt x="229" y="0"/>
                  <a:pt x="238" y="0"/>
                </a:cubicBezTo>
                <a:cubicBezTo>
                  <a:pt x="245" y="0"/>
                  <a:pt x="251" y="1"/>
                  <a:pt x="256" y="4"/>
                </a:cubicBezTo>
                <a:cubicBezTo>
                  <a:pt x="261" y="7"/>
                  <a:pt x="265" y="11"/>
                  <a:pt x="268" y="16"/>
                </a:cubicBezTo>
                <a:cubicBezTo>
                  <a:pt x="272" y="21"/>
                  <a:pt x="274" y="27"/>
                  <a:pt x="276" y="35"/>
                </a:cubicBezTo>
                <a:cubicBezTo>
                  <a:pt x="278" y="42"/>
                  <a:pt x="279" y="52"/>
                  <a:pt x="279" y="64"/>
                </a:cubicBezTo>
                <a:cubicBezTo>
                  <a:pt x="279" y="79"/>
                  <a:pt x="278" y="91"/>
                  <a:pt x="274" y="100"/>
                </a:cubicBezTo>
                <a:cubicBezTo>
                  <a:pt x="271" y="109"/>
                  <a:pt x="267" y="116"/>
                  <a:pt x="261" y="121"/>
                </a:cubicBezTo>
                <a:cubicBezTo>
                  <a:pt x="255" y="126"/>
                  <a:pt x="247" y="129"/>
                  <a:pt x="238" y="129"/>
                </a:cubicBezTo>
                <a:cubicBezTo>
                  <a:pt x="226" y="129"/>
                  <a:pt x="216" y="124"/>
                  <a:pt x="209" y="116"/>
                </a:cubicBezTo>
                <a:cubicBezTo>
                  <a:pt x="201" y="105"/>
                  <a:pt x="197" y="88"/>
                  <a:pt x="197" y="64"/>
                </a:cubicBezTo>
                <a:close/>
                <a:moveTo>
                  <a:pt x="213" y="64"/>
                </a:moveTo>
                <a:cubicBezTo>
                  <a:pt x="213" y="85"/>
                  <a:pt x="215" y="99"/>
                  <a:pt x="220" y="106"/>
                </a:cubicBezTo>
                <a:cubicBezTo>
                  <a:pt x="225" y="113"/>
                  <a:pt x="231" y="116"/>
                  <a:pt x="238" y="116"/>
                </a:cubicBezTo>
                <a:cubicBezTo>
                  <a:pt x="245" y="116"/>
                  <a:pt x="251" y="113"/>
                  <a:pt x="256" y="106"/>
                </a:cubicBezTo>
                <a:cubicBezTo>
                  <a:pt x="261" y="99"/>
                  <a:pt x="263" y="85"/>
                  <a:pt x="263" y="64"/>
                </a:cubicBezTo>
                <a:cubicBezTo>
                  <a:pt x="263" y="44"/>
                  <a:pt x="261" y="30"/>
                  <a:pt x="256" y="23"/>
                </a:cubicBezTo>
                <a:cubicBezTo>
                  <a:pt x="251" y="16"/>
                  <a:pt x="245" y="13"/>
                  <a:pt x="238" y="13"/>
                </a:cubicBezTo>
                <a:cubicBezTo>
                  <a:pt x="231" y="13"/>
                  <a:pt x="225" y="16"/>
                  <a:pt x="221" y="22"/>
                </a:cubicBezTo>
                <a:cubicBezTo>
                  <a:pt x="216" y="29"/>
                  <a:pt x="213" y="44"/>
                  <a:pt x="213" y="64"/>
                </a:cubicBezTo>
                <a:close/>
                <a:moveTo>
                  <a:pt x="293" y="64"/>
                </a:moveTo>
                <a:cubicBezTo>
                  <a:pt x="293" y="49"/>
                  <a:pt x="294" y="38"/>
                  <a:pt x="297" y="28"/>
                </a:cubicBezTo>
                <a:cubicBezTo>
                  <a:pt x="301" y="19"/>
                  <a:pt x="305" y="12"/>
                  <a:pt x="311" y="7"/>
                </a:cubicBezTo>
                <a:cubicBezTo>
                  <a:pt x="317" y="3"/>
                  <a:pt x="325" y="0"/>
                  <a:pt x="334" y="0"/>
                </a:cubicBezTo>
                <a:cubicBezTo>
                  <a:pt x="341" y="0"/>
                  <a:pt x="347" y="1"/>
                  <a:pt x="352" y="4"/>
                </a:cubicBezTo>
                <a:cubicBezTo>
                  <a:pt x="357" y="7"/>
                  <a:pt x="361" y="11"/>
                  <a:pt x="364" y="16"/>
                </a:cubicBezTo>
                <a:cubicBezTo>
                  <a:pt x="368" y="21"/>
                  <a:pt x="370" y="27"/>
                  <a:pt x="372" y="35"/>
                </a:cubicBezTo>
                <a:cubicBezTo>
                  <a:pt x="374" y="42"/>
                  <a:pt x="375" y="52"/>
                  <a:pt x="375" y="64"/>
                </a:cubicBezTo>
                <a:cubicBezTo>
                  <a:pt x="375" y="79"/>
                  <a:pt x="374" y="91"/>
                  <a:pt x="370" y="100"/>
                </a:cubicBezTo>
                <a:cubicBezTo>
                  <a:pt x="367" y="109"/>
                  <a:pt x="363" y="116"/>
                  <a:pt x="357" y="121"/>
                </a:cubicBezTo>
                <a:cubicBezTo>
                  <a:pt x="351" y="126"/>
                  <a:pt x="343" y="129"/>
                  <a:pt x="334" y="129"/>
                </a:cubicBezTo>
                <a:cubicBezTo>
                  <a:pt x="322" y="129"/>
                  <a:pt x="312" y="124"/>
                  <a:pt x="305" y="116"/>
                </a:cubicBezTo>
                <a:cubicBezTo>
                  <a:pt x="297" y="105"/>
                  <a:pt x="293" y="88"/>
                  <a:pt x="293" y="64"/>
                </a:cubicBezTo>
                <a:close/>
                <a:moveTo>
                  <a:pt x="309" y="64"/>
                </a:moveTo>
                <a:cubicBezTo>
                  <a:pt x="309" y="85"/>
                  <a:pt x="311" y="99"/>
                  <a:pt x="316" y="106"/>
                </a:cubicBezTo>
                <a:cubicBezTo>
                  <a:pt x="321" y="113"/>
                  <a:pt x="327" y="116"/>
                  <a:pt x="334" y="116"/>
                </a:cubicBezTo>
                <a:cubicBezTo>
                  <a:pt x="341" y="116"/>
                  <a:pt x="347" y="113"/>
                  <a:pt x="352" y="106"/>
                </a:cubicBezTo>
                <a:cubicBezTo>
                  <a:pt x="357" y="99"/>
                  <a:pt x="359" y="85"/>
                  <a:pt x="359" y="64"/>
                </a:cubicBezTo>
                <a:cubicBezTo>
                  <a:pt x="359" y="44"/>
                  <a:pt x="357" y="30"/>
                  <a:pt x="352" y="23"/>
                </a:cubicBezTo>
                <a:cubicBezTo>
                  <a:pt x="347" y="16"/>
                  <a:pt x="341" y="13"/>
                  <a:pt x="334" y="13"/>
                </a:cubicBezTo>
                <a:cubicBezTo>
                  <a:pt x="327" y="13"/>
                  <a:pt x="321" y="16"/>
                  <a:pt x="317" y="22"/>
                </a:cubicBezTo>
                <a:cubicBezTo>
                  <a:pt x="312" y="29"/>
                  <a:pt x="309" y="44"/>
                  <a:pt x="309" y="64"/>
                </a:cubicBezTo>
                <a:close/>
                <a:moveTo>
                  <a:pt x="397" y="127"/>
                </a:moveTo>
                <a:lnTo>
                  <a:pt x="397" y="109"/>
                </a:lnTo>
                <a:lnTo>
                  <a:pt x="415" y="109"/>
                </a:lnTo>
                <a:lnTo>
                  <a:pt x="415" y="127"/>
                </a:lnTo>
                <a:cubicBezTo>
                  <a:pt x="415" y="133"/>
                  <a:pt x="414" y="138"/>
                  <a:pt x="411" y="142"/>
                </a:cubicBezTo>
                <a:cubicBezTo>
                  <a:pt x="409" y="146"/>
                  <a:pt x="406" y="149"/>
                  <a:pt x="401" y="152"/>
                </a:cubicBezTo>
                <a:lnTo>
                  <a:pt x="396" y="145"/>
                </a:lnTo>
                <a:cubicBezTo>
                  <a:pt x="399" y="143"/>
                  <a:pt x="402" y="141"/>
                  <a:pt x="403" y="139"/>
                </a:cubicBezTo>
                <a:cubicBezTo>
                  <a:pt x="405" y="136"/>
                  <a:pt x="406" y="132"/>
                  <a:pt x="406" y="127"/>
                </a:cubicBezTo>
                <a:lnTo>
                  <a:pt x="397" y="127"/>
                </a:lnTo>
                <a:close/>
                <a:moveTo>
                  <a:pt x="437" y="64"/>
                </a:moveTo>
                <a:cubicBezTo>
                  <a:pt x="437" y="49"/>
                  <a:pt x="438" y="38"/>
                  <a:pt x="441" y="28"/>
                </a:cubicBezTo>
                <a:cubicBezTo>
                  <a:pt x="445" y="19"/>
                  <a:pt x="449" y="12"/>
                  <a:pt x="455" y="7"/>
                </a:cubicBezTo>
                <a:cubicBezTo>
                  <a:pt x="461" y="3"/>
                  <a:pt x="469" y="0"/>
                  <a:pt x="478" y="0"/>
                </a:cubicBezTo>
                <a:cubicBezTo>
                  <a:pt x="485" y="0"/>
                  <a:pt x="491" y="1"/>
                  <a:pt x="496" y="4"/>
                </a:cubicBezTo>
                <a:cubicBezTo>
                  <a:pt x="501" y="7"/>
                  <a:pt x="505" y="11"/>
                  <a:pt x="508" y="16"/>
                </a:cubicBezTo>
                <a:cubicBezTo>
                  <a:pt x="512" y="21"/>
                  <a:pt x="514" y="27"/>
                  <a:pt x="516" y="35"/>
                </a:cubicBezTo>
                <a:cubicBezTo>
                  <a:pt x="518" y="42"/>
                  <a:pt x="519" y="52"/>
                  <a:pt x="519" y="64"/>
                </a:cubicBezTo>
                <a:cubicBezTo>
                  <a:pt x="519" y="79"/>
                  <a:pt x="518" y="91"/>
                  <a:pt x="514" y="100"/>
                </a:cubicBezTo>
                <a:cubicBezTo>
                  <a:pt x="511" y="109"/>
                  <a:pt x="507" y="116"/>
                  <a:pt x="501" y="121"/>
                </a:cubicBezTo>
                <a:cubicBezTo>
                  <a:pt x="495" y="126"/>
                  <a:pt x="487" y="129"/>
                  <a:pt x="478" y="129"/>
                </a:cubicBezTo>
                <a:cubicBezTo>
                  <a:pt x="466" y="129"/>
                  <a:pt x="456" y="124"/>
                  <a:pt x="449" y="116"/>
                </a:cubicBezTo>
                <a:cubicBezTo>
                  <a:pt x="441" y="105"/>
                  <a:pt x="437" y="88"/>
                  <a:pt x="437" y="64"/>
                </a:cubicBezTo>
                <a:close/>
                <a:moveTo>
                  <a:pt x="453" y="64"/>
                </a:moveTo>
                <a:cubicBezTo>
                  <a:pt x="453" y="85"/>
                  <a:pt x="455" y="99"/>
                  <a:pt x="460" y="106"/>
                </a:cubicBezTo>
                <a:cubicBezTo>
                  <a:pt x="465" y="113"/>
                  <a:pt x="471" y="116"/>
                  <a:pt x="478" y="116"/>
                </a:cubicBezTo>
                <a:cubicBezTo>
                  <a:pt x="485" y="116"/>
                  <a:pt x="491" y="113"/>
                  <a:pt x="496" y="106"/>
                </a:cubicBezTo>
                <a:cubicBezTo>
                  <a:pt x="501" y="99"/>
                  <a:pt x="503" y="85"/>
                  <a:pt x="503" y="64"/>
                </a:cubicBezTo>
                <a:cubicBezTo>
                  <a:pt x="503" y="44"/>
                  <a:pt x="501" y="30"/>
                  <a:pt x="496" y="23"/>
                </a:cubicBezTo>
                <a:cubicBezTo>
                  <a:pt x="491" y="16"/>
                  <a:pt x="485" y="13"/>
                  <a:pt x="478" y="13"/>
                </a:cubicBezTo>
                <a:cubicBezTo>
                  <a:pt x="471" y="13"/>
                  <a:pt x="465" y="16"/>
                  <a:pt x="461" y="22"/>
                </a:cubicBezTo>
                <a:cubicBezTo>
                  <a:pt x="456" y="29"/>
                  <a:pt x="453" y="44"/>
                  <a:pt x="453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8" name="Freeform 15"/>
          <p:cNvSpPr>
            <a:spLocks noEditPoints="1"/>
          </p:cNvSpPr>
          <p:nvPr/>
        </p:nvSpPr>
        <p:spPr bwMode="auto">
          <a:xfrm>
            <a:off x="8682300" y="5643588"/>
            <a:ext cx="311057" cy="91319"/>
          </a:xfrm>
          <a:custGeom>
            <a:avLst/>
            <a:gdLst>
              <a:gd name="T0" fmla="*/ 24 w 514"/>
              <a:gd name="T1" fmla="*/ 110 h 152"/>
              <a:gd name="T2" fmla="*/ 66 w 514"/>
              <a:gd name="T3" fmla="*/ 90 h 152"/>
              <a:gd name="T4" fmla="*/ 30 w 514"/>
              <a:gd name="T5" fmla="*/ 67 h 152"/>
              <a:gd name="T6" fmla="*/ 52 w 514"/>
              <a:gd name="T7" fmla="*/ 48 h 152"/>
              <a:gd name="T8" fmla="*/ 39 w 514"/>
              <a:gd name="T9" fmla="*/ 13 h 152"/>
              <a:gd name="T10" fmla="*/ 1 w 514"/>
              <a:gd name="T11" fmla="*/ 33 h 152"/>
              <a:gd name="T12" fmla="*/ 58 w 514"/>
              <a:gd name="T13" fmla="*/ 4 h 152"/>
              <a:gd name="T14" fmla="*/ 72 w 514"/>
              <a:gd name="T15" fmla="*/ 48 h 152"/>
              <a:gd name="T16" fmla="*/ 82 w 514"/>
              <a:gd name="T17" fmla="*/ 89 h 152"/>
              <a:gd name="T18" fmla="*/ 12 w 514"/>
              <a:gd name="T19" fmla="*/ 119 h 152"/>
              <a:gd name="T20" fmla="*/ 100 w 514"/>
              <a:gd name="T21" fmla="*/ 28 h 152"/>
              <a:gd name="T22" fmla="*/ 154 w 514"/>
              <a:gd name="T23" fmla="*/ 4 h 152"/>
              <a:gd name="T24" fmla="*/ 178 w 514"/>
              <a:gd name="T25" fmla="*/ 64 h 152"/>
              <a:gd name="T26" fmla="*/ 137 w 514"/>
              <a:gd name="T27" fmla="*/ 129 h 152"/>
              <a:gd name="T28" fmla="*/ 111 w 514"/>
              <a:gd name="T29" fmla="*/ 64 h 152"/>
              <a:gd name="T30" fmla="*/ 154 w 514"/>
              <a:gd name="T31" fmla="*/ 106 h 152"/>
              <a:gd name="T32" fmla="*/ 136 w 514"/>
              <a:gd name="T33" fmla="*/ 13 h 152"/>
              <a:gd name="T34" fmla="*/ 191 w 514"/>
              <a:gd name="T35" fmla="*/ 64 h 152"/>
              <a:gd name="T36" fmla="*/ 233 w 514"/>
              <a:gd name="T37" fmla="*/ 0 h 152"/>
              <a:gd name="T38" fmla="*/ 271 w 514"/>
              <a:gd name="T39" fmla="*/ 35 h 152"/>
              <a:gd name="T40" fmla="*/ 255 w 514"/>
              <a:gd name="T41" fmla="*/ 121 h 152"/>
              <a:gd name="T42" fmla="*/ 191 w 514"/>
              <a:gd name="T43" fmla="*/ 64 h 152"/>
              <a:gd name="T44" fmla="*/ 233 w 514"/>
              <a:gd name="T45" fmla="*/ 116 h 152"/>
              <a:gd name="T46" fmla="*/ 250 w 514"/>
              <a:gd name="T47" fmla="*/ 23 h 152"/>
              <a:gd name="T48" fmla="*/ 207 w 514"/>
              <a:gd name="T49" fmla="*/ 64 h 152"/>
              <a:gd name="T50" fmla="*/ 306 w 514"/>
              <a:gd name="T51" fmla="*/ 7 h 152"/>
              <a:gd name="T52" fmla="*/ 359 w 514"/>
              <a:gd name="T53" fmla="*/ 16 h 152"/>
              <a:gd name="T54" fmla="*/ 365 w 514"/>
              <a:gd name="T55" fmla="*/ 100 h 152"/>
              <a:gd name="T56" fmla="*/ 300 w 514"/>
              <a:gd name="T57" fmla="*/ 116 h 152"/>
              <a:gd name="T58" fmla="*/ 311 w 514"/>
              <a:gd name="T59" fmla="*/ 106 h 152"/>
              <a:gd name="T60" fmla="*/ 354 w 514"/>
              <a:gd name="T61" fmla="*/ 64 h 152"/>
              <a:gd name="T62" fmla="*/ 311 w 514"/>
              <a:gd name="T63" fmla="*/ 22 h 152"/>
              <a:gd name="T64" fmla="*/ 392 w 514"/>
              <a:gd name="T65" fmla="*/ 109 h 152"/>
              <a:gd name="T66" fmla="*/ 406 w 514"/>
              <a:gd name="T67" fmla="*/ 142 h 152"/>
              <a:gd name="T68" fmla="*/ 398 w 514"/>
              <a:gd name="T69" fmla="*/ 139 h 152"/>
              <a:gd name="T70" fmla="*/ 431 w 514"/>
              <a:gd name="T71" fmla="*/ 64 h 152"/>
              <a:gd name="T72" fmla="*/ 473 w 514"/>
              <a:gd name="T73" fmla="*/ 0 h 152"/>
              <a:gd name="T74" fmla="*/ 511 w 514"/>
              <a:gd name="T75" fmla="*/ 35 h 152"/>
              <a:gd name="T76" fmla="*/ 495 w 514"/>
              <a:gd name="T77" fmla="*/ 121 h 152"/>
              <a:gd name="T78" fmla="*/ 431 w 514"/>
              <a:gd name="T79" fmla="*/ 64 h 152"/>
              <a:gd name="T80" fmla="*/ 473 w 514"/>
              <a:gd name="T81" fmla="*/ 116 h 152"/>
              <a:gd name="T82" fmla="*/ 490 w 514"/>
              <a:gd name="T83" fmla="*/ 23 h 152"/>
              <a:gd name="T84" fmla="*/ 447 w 514"/>
              <a:gd name="T85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514" h="152">
                <a:moveTo>
                  <a:pt x="0" y="93"/>
                </a:moveTo>
                <a:lnTo>
                  <a:pt x="15" y="91"/>
                </a:lnTo>
                <a:cubicBezTo>
                  <a:pt x="17" y="100"/>
                  <a:pt x="20" y="106"/>
                  <a:pt x="24" y="110"/>
                </a:cubicBezTo>
                <a:cubicBezTo>
                  <a:pt x="28" y="114"/>
                  <a:pt x="33" y="116"/>
                  <a:pt x="40" y="116"/>
                </a:cubicBezTo>
                <a:cubicBezTo>
                  <a:pt x="47" y="116"/>
                  <a:pt x="53" y="114"/>
                  <a:pt x="58" y="108"/>
                </a:cubicBezTo>
                <a:cubicBezTo>
                  <a:pt x="63" y="103"/>
                  <a:pt x="66" y="97"/>
                  <a:pt x="66" y="90"/>
                </a:cubicBezTo>
                <a:cubicBezTo>
                  <a:pt x="66" y="83"/>
                  <a:pt x="63" y="77"/>
                  <a:pt x="59" y="72"/>
                </a:cubicBezTo>
                <a:cubicBezTo>
                  <a:pt x="54" y="68"/>
                  <a:pt x="48" y="65"/>
                  <a:pt x="41" y="65"/>
                </a:cubicBezTo>
                <a:cubicBezTo>
                  <a:pt x="38" y="65"/>
                  <a:pt x="34" y="66"/>
                  <a:pt x="30" y="67"/>
                </a:cubicBezTo>
                <a:lnTo>
                  <a:pt x="32" y="53"/>
                </a:lnTo>
                <a:cubicBezTo>
                  <a:pt x="33" y="53"/>
                  <a:pt x="34" y="54"/>
                  <a:pt x="34" y="54"/>
                </a:cubicBezTo>
                <a:cubicBezTo>
                  <a:pt x="41" y="54"/>
                  <a:pt x="47" y="52"/>
                  <a:pt x="52" y="48"/>
                </a:cubicBezTo>
                <a:cubicBezTo>
                  <a:pt x="57" y="45"/>
                  <a:pt x="60" y="40"/>
                  <a:pt x="60" y="33"/>
                </a:cubicBezTo>
                <a:cubicBezTo>
                  <a:pt x="60" y="27"/>
                  <a:pt x="58" y="22"/>
                  <a:pt x="54" y="18"/>
                </a:cubicBezTo>
                <a:cubicBezTo>
                  <a:pt x="50" y="15"/>
                  <a:pt x="45" y="13"/>
                  <a:pt x="39" y="13"/>
                </a:cubicBezTo>
                <a:cubicBezTo>
                  <a:pt x="33" y="13"/>
                  <a:pt x="28" y="15"/>
                  <a:pt x="24" y="18"/>
                </a:cubicBezTo>
                <a:cubicBezTo>
                  <a:pt x="20" y="22"/>
                  <a:pt x="18" y="28"/>
                  <a:pt x="17" y="36"/>
                </a:cubicBezTo>
                <a:lnTo>
                  <a:pt x="1" y="33"/>
                </a:lnTo>
                <a:cubicBezTo>
                  <a:pt x="3" y="22"/>
                  <a:pt x="7" y="14"/>
                  <a:pt x="14" y="9"/>
                </a:cubicBezTo>
                <a:cubicBezTo>
                  <a:pt x="21" y="3"/>
                  <a:pt x="29" y="0"/>
                  <a:pt x="39" y="0"/>
                </a:cubicBezTo>
                <a:cubicBezTo>
                  <a:pt x="46" y="0"/>
                  <a:pt x="52" y="2"/>
                  <a:pt x="58" y="4"/>
                </a:cubicBezTo>
                <a:cubicBezTo>
                  <a:pt x="64" y="7"/>
                  <a:pt x="68" y="11"/>
                  <a:pt x="71" y="17"/>
                </a:cubicBezTo>
                <a:cubicBezTo>
                  <a:pt x="74" y="22"/>
                  <a:pt x="76" y="27"/>
                  <a:pt x="76" y="33"/>
                </a:cubicBezTo>
                <a:cubicBezTo>
                  <a:pt x="76" y="38"/>
                  <a:pt x="74" y="43"/>
                  <a:pt x="72" y="48"/>
                </a:cubicBezTo>
                <a:cubicBezTo>
                  <a:pt x="69" y="52"/>
                  <a:pt x="64" y="56"/>
                  <a:pt x="58" y="58"/>
                </a:cubicBezTo>
                <a:cubicBezTo>
                  <a:pt x="66" y="60"/>
                  <a:pt x="72" y="64"/>
                  <a:pt x="76" y="69"/>
                </a:cubicBezTo>
                <a:cubicBezTo>
                  <a:pt x="80" y="74"/>
                  <a:pt x="82" y="81"/>
                  <a:pt x="82" y="89"/>
                </a:cubicBezTo>
                <a:cubicBezTo>
                  <a:pt x="82" y="100"/>
                  <a:pt x="78" y="110"/>
                  <a:pt x="70" y="117"/>
                </a:cubicBezTo>
                <a:cubicBezTo>
                  <a:pt x="62" y="125"/>
                  <a:pt x="52" y="129"/>
                  <a:pt x="40" y="129"/>
                </a:cubicBezTo>
                <a:cubicBezTo>
                  <a:pt x="28" y="129"/>
                  <a:pt x="19" y="126"/>
                  <a:pt x="12" y="119"/>
                </a:cubicBezTo>
                <a:cubicBezTo>
                  <a:pt x="5" y="112"/>
                  <a:pt x="1" y="104"/>
                  <a:pt x="0" y="93"/>
                </a:cubicBezTo>
                <a:close/>
                <a:moveTo>
                  <a:pt x="95" y="64"/>
                </a:moveTo>
                <a:cubicBezTo>
                  <a:pt x="95" y="49"/>
                  <a:pt x="97" y="38"/>
                  <a:pt x="100" y="28"/>
                </a:cubicBezTo>
                <a:cubicBezTo>
                  <a:pt x="103" y="19"/>
                  <a:pt x="108" y="12"/>
                  <a:pt x="114" y="7"/>
                </a:cubicBezTo>
                <a:cubicBezTo>
                  <a:pt x="120" y="3"/>
                  <a:pt x="127" y="0"/>
                  <a:pt x="137" y="0"/>
                </a:cubicBezTo>
                <a:cubicBezTo>
                  <a:pt x="143" y="0"/>
                  <a:pt x="149" y="1"/>
                  <a:pt x="154" y="4"/>
                </a:cubicBezTo>
                <a:cubicBezTo>
                  <a:pt x="159" y="7"/>
                  <a:pt x="164" y="11"/>
                  <a:pt x="167" y="16"/>
                </a:cubicBezTo>
                <a:cubicBezTo>
                  <a:pt x="170" y="21"/>
                  <a:pt x="173" y="27"/>
                  <a:pt x="175" y="35"/>
                </a:cubicBezTo>
                <a:cubicBezTo>
                  <a:pt x="177" y="42"/>
                  <a:pt x="178" y="52"/>
                  <a:pt x="178" y="64"/>
                </a:cubicBezTo>
                <a:cubicBezTo>
                  <a:pt x="178" y="79"/>
                  <a:pt x="176" y="91"/>
                  <a:pt x="173" y="100"/>
                </a:cubicBezTo>
                <a:cubicBezTo>
                  <a:pt x="170" y="109"/>
                  <a:pt x="165" y="116"/>
                  <a:pt x="159" y="121"/>
                </a:cubicBezTo>
                <a:cubicBezTo>
                  <a:pt x="153" y="126"/>
                  <a:pt x="146" y="129"/>
                  <a:pt x="137" y="129"/>
                </a:cubicBezTo>
                <a:cubicBezTo>
                  <a:pt x="124" y="129"/>
                  <a:pt x="115" y="124"/>
                  <a:pt x="108" y="116"/>
                </a:cubicBezTo>
                <a:cubicBezTo>
                  <a:pt x="100" y="105"/>
                  <a:pt x="95" y="88"/>
                  <a:pt x="95" y="64"/>
                </a:cubicBezTo>
                <a:close/>
                <a:moveTo>
                  <a:pt x="111" y="64"/>
                </a:moveTo>
                <a:cubicBezTo>
                  <a:pt x="111" y="85"/>
                  <a:pt x="114" y="99"/>
                  <a:pt x="119" y="106"/>
                </a:cubicBezTo>
                <a:cubicBezTo>
                  <a:pt x="123" y="113"/>
                  <a:pt x="129" y="116"/>
                  <a:pt x="137" y="116"/>
                </a:cubicBezTo>
                <a:cubicBezTo>
                  <a:pt x="144" y="116"/>
                  <a:pt x="150" y="113"/>
                  <a:pt x="154" y="106"/>
                </a:cubicBezTo>
                <a:cubicBezTo>
                  <a:pt x="159" y="99"/>
                  <a:pt x="162" y="85"/>
                  <a:pt x="162" y="64"/>
                </a:cubicBezTo>
                <a:cubicBezTo>
                  <a:pt x="162" y="44"/>
                  <a:pt x="159" y="30"/>
                  <a:pt x="154" y="23"/>
                </a:cubicBezTo>
                <a:cubicBezTo>
                  <a:pt x="150" y="16"/>
                  <a:pt x="144" y="13"/>
                  <a:pt x="136" y="13"/>
                </a:cubicBezTo>
                <a:cubicBezTo>
                  <a:pt x="129" y="13"/>
                  <a:pt x="124" y="16"/>
                  <a:pt x="119" y="22"/>
                </a:cubicBezTo>
                <a:cubicBezTo>
                  <a:pt x="114" y="29"/>
                  <a:pt x="111" y="44"/>
                  <a:pt x="111" y="64"/>
                </a:cubicBezTo>
                <a:close/>
                <a:moveTo>
                  <a:pt x="191" y="64"/>
                </a:moveTo>
                <a:cubicBezTo>
                  <a:pt x="191" y="49"/>
                  <a:pt x="193" y="38"/>
                  <a:pt x="196" y="28"/>
                </a:cubicBezTo>
                <a:cubicBezTo>
                  <a:pt x="199" y="19"/>
                  <a:pt x="204" y="12"/>
                  <a:pt x="210" y="7"/>
                </a:cubicBezTo>
                <a:cubicBezTo>
                  <a:pt x="216" y="3"/>
                  <a:pt x="223" y="0"/>
                  <a:pt x="233" y="0"/>
                </a:cubicBezTo>
                <a:cubicBezTo>
                  <a:pt x="239" y="0"/>
                  <a:pt x="245" y="1"/>
                  <a:pt x="250" y="4"/>
                </a:cubicBezTo>
                <a:cubicBezTo>
                  <a:pt x="255" y="7"/>
                  <a:pt x="260" y="11"/>
                  <a:pt x="263" y="16"/>
                </a:cubicBezTo>
                <a:cubicBezTo>
                  <a:pt x="266" y="21"/>
                  <a:pt x="269" y="27"/>
                  <a:pt x="271" y="35"/>
                </a:cubicBezTo>
                <a:cubicBezTo>
                  <a:pt x="273" y="42"/>
                  <a:pt x="274" y="52"/>
                  <a:pt x="274" y="64"/>
                </a:cubicBezTo>
                <a:cubicBezTo>
                  <a:pt x="274" y="79"/>
                  <a:pt x="272" y="91"/>
                  <a:pt x="269" y="100"/>
                </a:cubicBezTo>
                <a:cubicBezTo>
                  <a:pt x="266" y="109"/>
                  <a:pt x="261" y="116"/>
                  <a:pt x="255" y="121"/>
                </a:cubicBezTo>
                <a:cubicBezTo>
                  <a:pt x="249" y="126"/>
                  <a:pt x="242" y="129"/>
                  <a:pt x="233" y="129"/>
                </a:cubicBezTo>
                <a:cubicBezTo>
                  <a:pt x="220" y="129"/>
                  <a:pt x="211" y="124"/>
                  <a:pt x="204" y="116"/>
                </a:cubicBezTo>
                <a:cubicBezTo>
                  <a:pt x="196" y="105"/>
                  <a:pt x="191" y="88"/>
                  <a:pt x="191" y="64"/>
                </a:cubicBezTo>
                <a:close/>
                <a:moveTo>
                  <a:pt x="207" y="64"/>
                </a:moveTo>
                <a:cubicBezTo>
                  <a:pt x="207" y="85"/>
                  <a:pt x="210" y="99"/>
                  <a:pt x="215" y="106"/>
                </a:cubicBezTo>
                <a:cubicBezTo>
                  <a:pt x="219" y="113"/>
                  <a:pt x="225" y="116"/>
                  <a:pt x="233" y="116"/>
                </a:cubicBezTo>
                <a:cubicBezTo>
                  <a:pt x="240" y="116"/>
                  <a:pt x="246" y="113"/>
                  <a:pt x="250" y="106"/>
                </a:cubicBezTo>
                <a:cubicBezTo>
                  <a:pt x="255" y="99"/>
                  <a:pt x="258" y="85"/>
                  <a:pt x="258" y="64"/>
                </a:cubicBezTo>
                <a:cubicBezTo>
                  <a:pt x="258" y="44"/>
                  <a:pt x="255" y="30"/>
                  <a:pt x="250" y="23"/>
                </a:cubicBezTo>
                <a:cubicBezTo>
                  <a:pt x="246" y="16"/>
                  <a:pt x="240" y="13"/>
                  <a:pt x="232" y="13"/>
                </a:cubicBezTo>
                <a:cubicBezTo>
                  <a:pt x="225" y="13"/>
                  <a:pt x="220" y="16"/>
                  <a:pt x="215" y="22"/>
                </a:cubicBezTo>
                <a:cubicBezTo>
                  <a:pt x="210" y="29"/>
                  <a:pt x="207" y="44"/>
                  <a:pt x="207" y="64"/>
                </a:cubicBezTo>
                <a:close/>
                <a:moveTo>
                  <a:pt x="287" y="64"/>
                </a:moveTo>
                <a:cubicBezTo>
                  <a:pt x="287" y="49"/>
                  <a:pt x="289" y="38"/>
                  <a:pt x="292" y="28"/>
                </a:cubicBezTo>
                <a:cubicBezTo>
                  <a:pt x="295" y="19"/>
                  <a:pt x="300" y="12"/>
                  <a:pt x="306" y="7"/>
                </a:cubicBezTo>
                <a:cubicBezTo>
                  <a:pt x="312" y="3"/>
                  <a:pt x="319" y="0"/>
                  <a:pt x="329" y="0"/>
                </a:cubicBezTo>
                <a:cubicBezTo>
                  <a:pt x="335" y="0"/>
                  <a:pt x="341" y="1"/>
                  <a:pt x="346" y="4"/>
                </a:cubicBezTo>
                <a:cubicBezTo>
                  <a:pt x="351" y="7"/>
                  <a:pt x="356" y="11"/>
                  <a:pt x="359" y="16"/>
                </a:cubicBezTo>
                <a:cubicBezTo>
                  <a:pt x="362" y="21"/>
                  <a:pt x="365" y="27"/>
                  <a:pt x="367" y="35"/>
                </a:cubicBezTo>
                <a:cubicBezTo>
                  <a:pt x="369" y="42"/>
                  <a:pt x="370" y="52"/>
                  <a:pt x="370" y="64"/>
                </a:cubicBezTo>
                <a:cubicBezTo>
                  <a:pt x="370" y="79"/>
                  <a:pt x="368" y="91"/>
                  <a:pt x="365" y="100"/>
                </a:cubicBezTo>
                <a:cubicBezTo>
                  <a:pt x="362" y="109"/>
                  <a:pt x="357" y="116"/>
                  <a:pt x="351" y="121"/>
                </a:cubicBezTo>
                <a:cubicBezTo>
                  <a:pt x="345" y="126"/>
                  <a:pt x="338" y="129"/>
                  <a:pt x="329" y="129"/>
                </a:cubicBezTo>
                <a:cubicBezTo>
                  <a:pt x="316" y="129"/>
                  <a:pt x="307" y="124"/>
                  <a:pt x="300" y="116"/>
                </a:cubicBezTo>
                <a:cubicBezTo>
                  <a:pt x="292" y="105"/>
                  <a:pt x="287" y="88"/>
                  <a:pt x="287" y="64"/>
                </a:cubicBezTo>
                <a:close/>
                <a:moveTo>
                  <a:pt x="303" y="64"/>
                </a:moveTo>
                <a:cubicBezTo>
                  <a:pt x="303" y="85"/>
                  <a:pt x="306" y="99"/>
                  <a:pt x="311" y="106"/>
                </a:cubicBezTo>
                <a:cubicBezTo>
                  <a:pt x="315" y="113"/>
                  <a:pt x="321" y="116"/>
                  <a:pt x="329" y="116"/>
                </a:cubicBezTo>
                <a:cubicBezTo>
                  <a:pt x="336" y="116"/>
                  <a:pt x="342" y="113"/>
                  <a:pt x="346" y="106"/>
                </a:cubicBezTo>
                <a:cubicBezTo>
                  <a:pt x="351" y="99"/>
                  <a:pt x="354" y="85"/>
                  <a:pt x="354" y="64"/>
                </a:cubicBezTo>
                <a:cubicBezTo>
                  <a:pt x="354" y="44"/>
                  <a:pt x="351" y="30"/>
                  <a:pt x="346" y="23"/>
                </a:cubicBezTo>
                <a:cubicBezTo>
                  <a:pt x="342" y="16"/>
                  <a:pt x="336" y="13"/>
                  <a:pt x="328" y="13"/>
                </a:cubicBezTo>
                <a:cubicBezTo>
                  <a:pt x="321" y="13"/>
                  <a:pt x="316" y="16"/>
                  <a:pt x="311" y="22"/>
                </a:cubicBezTo>
                <a:cubicBezTo>
                  <a:pt x="306" y="29"/>
                  <a:pt x="303" y="44"/>
                  <a:pt x="303" y="64"/>
                </a:cubicBezTo>
                <a:close/>
                <a:moveTo>
                  <a:pt x="392" y="127"/>
                </a:moveTo>
                <a:lnTo>
                  <a:pt x="392" y="109"/>
                </a:lnTo>
                <a:lnTo>
                  <a:pt x="409" y="109"/>
                </a:lnTo>
                <a:lnTo>
                  <a:pt x="409" y="127"/>
                </a:lnTo>
                <a:cubicBezTo>
                  <a:pt x="409" y="133"/>
                  <a:pt x="408" y="138"/>
                  <a:pt x="406" y="142"/>
                </a:cubicBezTo>
                <a:cubicBezTo>
                  <a:pt x="404" y="146"/>
                  <a:pt x="400" y="149"/>
                  <a:pt x="395" y="152"/>
                </a:cubicBezTo>
                <a:lnTo>
                  <a:pt x="391" y="145"/>
                </a:lnTo>
                <a:cubicBezTo>
                  <a:pt x="394" y="143"/>
                  <a:pt x="396" y="141"/>
                  <a:pt x="398" y="139"/>
                </a:cubicBezTo>
                <a:cubicBezTo>
                  <a:pt x="400" y="136"/>
                  <a:pt x="400" y="132"/>
                  <a:pt x="401" y="127"/>
                </a:cubicBezTo>
                <a:lnTo>
                  <a:pt x="392" y="127"/>
                </a:lnTo>
                <a:close/>
                <a:moveTo>
                  <a:pt x="431" y="64"/>
                </a:moveTo>
                <a:cubicBezTo>
                  <a:pt x="431" y="49"/>
                  <a:pt x="433" y="38"/>
                  <a:pt x="436" y="28"/>
                </a:cubicBezTo>
                <a:cubicBezTo>
                  <a:pt x="439" y="19"/>
                  <a:pt x="444" y="12"/>
                  <a:pt x="450" y="7"/>
                </a:cubicBezTo>
                <a:cubicBezTo>
                  <a:pt x="456" y="3"/>
                  <a:pt x="463" y="0"/>
                  <a:pt x="473" y="0"/>
                </a:cubicBezTo>
                <a:cubicBezTo>
                  <a:pt x="479" y="0"/>
                  <a:pt x="485" y="1"/>
                  <a:pt x="490" y="4"/>
                </a:cubicBezTo>
                <a:cubicBezTo>
                  <a:pt x="495" y="7"/>
                  <a:pt x="500" y="11"/>
                  <a:pt x="503" y="16"/>
                </a:cubicBezTo>
                <a:cubicBezTo>
                  <a:pt x="506" y="21"/>
                  <a:pt x="509" y="27"/>
                  <a:pt x="511" y="35"/>
                </a:cubicBezTo>
                <a:cubicBezTo>
                  <a:pt x="513" y="42"/>
                  <a:pt x="514" y="52"/>
                  <a:pt x="514" y="64"/>
                </a:cubicBezTo>
                <a:cubicBezTo>
                  <a:pt x="514" y="79"/>
                  <a:pt x="512" y="91"/>
                  <a:pt x="509" y="100"/>
                </a:cubicBezTo>
                <a:cubicBezTo>
                  <a:pt x="506" y="109"/>
                  <a:pt x="501" y="116"/>
                  <a:pt x="495" y="121"/>
                </a:cubicBezTo>
                <a:cubicBezTo>
                  <a:pt x="489" y="126"/>
                  <a:pt x="482" y="129"/>
                  <a:pt x="473" y="129"/>
                </a:cubicBezTo>
                <a:cubicBezTo>
                  <a:pt x="460" y="129"/>
                  <a:pt x="451" y="124"/>
                  <a:pt x="444" y="116"/>
                </a:cubicBezTo>
                <a:cubicBezTo>
                  <a:pt x="436" y="105"/>
                  <a:pt x="431" y="88"/>
                  <a:pt x="431" y="64"/>
                </a:cubicBezTo>
                <a:close/>
                <a:moveTo>
                  <a:pt x="447" y="64"/>
                </a:moveTo>
                <a:cubicBezTo>
                  <a:pt x="447" y="85"/>
                  <a:pt x="450" y="99"/>
                  <a:pt x="455" y="106"/>
                </a:cubicBezTo>
                <a:cubicBezTo>
                  <a:pt x="459" y="113"/>
                  <a:pt x="465" y="116"/>
                  <a:pt x="473" y="116"/>
                </a:cubicBezTo>
                <a:cubicBezTo>
                  <a:pt x="480" y="116"/>
                  <a:pt x="486" y="113"/>
                  <a:pt x="490" y="106"/>
                </a:cubicBezTo>
                <a:cubicBezTo>
                  <a:pt x="495" y="99"/>
                  <a:pt x="498" y="85"/>
                  <a:pt x="498" y="64"/>
                </a:cubicBezTo>
                <a:cubicBezTo>
                  <a:pt x="498" y="44"/>
                  <a:pt x="495" y="30"/>
                  <a:pt x="490" y="23"/>
                </a:cubicBezTo>
                <a:cubicBezTo>
                  <a:pt x="486" y="16"/>
                  <a:pt x="480" y="13"/>
                  <a:pt x="472" y="13"/>
                </a:cubicBezTo>
                <a:cubicBezTo>
                  <a:pt x="465" y="13"/>
                  <a:pt x="460" y="16"/>
                  <a:pt x="455" y="22"/>
                </a:cubicBezTo>
                <a:cubicBezTo>
                  <a:pt x="450" y="29"/>
                  <a:pt x="447" y="44"/>
                  <a:pt x="447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9" name="Freeform 16"/>
          <p:cNvSpPr>
            <a:spLocks noEditPoints="1"/>
          </p:cNvSpPr>
          <p:nvPr/>
        </p:nvSpPr>
        <p:spPr bwMode="auto">
          <a:xfrm>
            <a:off x="7789082" y="5643588"/>
            <a:ext cx="313910" cy="91319"/>
          </a:xfrm>
          <a:custGeom>
            <a:avLst/>
            <a:gdLst>
              <a:gd name="T0" fmla="*/ 83 w 516"/>
              <a:gd name="T1" fmla="*/ 127 h 152"/>
              <a:gd name="T2" fmla="*/ 2 w 516"/>
              <a:gd name="T3" fmla="*/ 116 h 152"/>
              <a:gd name="T4" fmla="*/ 32 w 516"/>
              <a:gd name="T5" fmla="*/ 80 h 152"/>
              <a:gd name="T6" fmla="*/ 67 w 516"/>
              <a:gd name="T7" fmla="*/ 35 h 152"/>
              <a:gd name="T8" fmla="*/ 43 w 516"/>
              <a:gd name="T9" fmla="*/ 13 h 152"/>
              <a:gd name="T10" fmla="*/ 19 w 516"/>
              <a:gd name="T11" fmla="*/ 38 h 152"/>
              <a:gd name="T12" fmla="*/ 15 w 516"/>
              <a:gd name="T13" fmla="*/ 9 h 152"/>
              <a:gd name="T14" fmla="*/ 73 w 516"/>
              <a:gd name="T15" fmla="*/ 10 h 152"/>
              <a:gd name="T16" fmla="*/ 80 w 516"/>
              <a:gd name="T17" fmla="*/ 50 h 152"/>
              <a:gd name="T18" fmla="*/ 46 w 516"/>
              <a:gd name="T19" fmla="*/ 88 h 152"/>
              <a:gd name="T20" fmla="*/ 21 w 516"/>
              <a:gd name="T21" fmla="*/ 112 h 152"/>
              <a:gd name="T22" fmla="*/ 98 w 516"/>
              <a:gd name="T23" fmla="*/ 64 h 152"/>
              <a:gd name="T24" fmla="*/ 116 w 516"/>
              <a:gd name="T25" fmla="*/ 7 h 152"/>
              <a:gd name="T26" fmla="*/ 157 w 516"/>
              <a:gd name="T27" fmla="*/ 4 h 152"/>
              <a:gd name="T28" fmla="*/ 177 w 516"/>
              <a:gd name="T29" fmla="*/ 35 h 152"/>
              <a:gd name="T30" fmla="*/ 176 w 516"/>
              <a:gd name="T31" fmla="*/ 100 h 152"/>
              <a:gd name="T32" fmla="*/ 139 w 516"/>
              <a:gd name="T33" fmla="*/ 129 h 152"/>
              <a:gd name="T34" fmla="*/ 98 w 516"/>
              <a:gd name="T35" fmla="*/ 64 h 152"/>
              <a:gd name="T36" fmla="*/ 121 w 516"/>
              <a:gd name="T37" fmla="*/ 106 h 152"/>
              <a:gd name="T38" fmla="*/ 157 w 516"/>
              <a:gd name="T39" fmla="*/ 106 h 152"/>
              <a:gd name="T40" fmla="*/ 157 w 516"/>
              <a:gd name="T41" fmla="*/ 23 h 152"/>
              <a:gd name="T42" fmla="*/ 122 w 516"/>
              <a:gd name="T43" fmla="*/ 22 h 152"/>
              <a:gd name="T44" fmla="*/ 194 w 516"/>
              <a:gd name="T45" fmla="*/ 64 h 152"/>
              <a:gd name="T46" fmla="*/ 212 w 516"/>
              <a:gd name="T47" fmla="*/ 7 h 152"/>
              <a:gd name="T48" fmla="*/ 253 w 516"/>
              <a:gd name="T49" fmla="*/ 4 h 152"/>
              <a:gd name="T50" fmla="*/ 273 w 516"/>
              <a:gd name="T51" fmla="*/ 35 h 152"/>
              <a:gd name="T52" fmla="*/ 272 w 516"/>
              <a:gd name="T53" fmla="*/ 100 h 152"/>
              <a:gd name="T54" fmla="*/ 235 w 516"/>
              <a:gd name="T55" fmla="*/ 129 h 152"/>
              <a:gd name="T56" fmla="*/ 194 w 516"/>
              <a:gd name="T57" fmla="*/ 64 h 152"/>
              <a:gd name="T58" fmla="*/ 217 w 516"/>
              <a:gd name="T59" fmla="*/ 106 h 152"/>
              <a:gd name="T60" fmla="*/ 253 w 516"/>
              <a:gd name="T61" fmla="*/ 106 h 152"/>
              <a:gd name="T62" fmla="*/ 253 w 516"/>
              <a:gd name="T63" fmla="*/ 23 h 152"/>
              <a:gd name="T64" fmla="*/ 218 w 516"/>
              <a:gd name="T65" fmla="*/ 22 h 152"/>
              <a:gd name="T66" fmla="*/ 290 w 516"/>
              <a:gd name="T67" fmla="*/ 64 h 152"/>
              <a:gd name="T68" fmla="*/ 308 w 516"/>
              <a:gd name="T69" fmla="*/ 7 h 152"/>
              <a:gd name="T70" fmla="*/ 349 w 516"/>
              <a:gd name="T71" fmla="*/ 4 h 152"/>
              <a:gd name="T72" fmla="*/ 369 w 516"/>
              <a:gd name="T73" fmla="*/ 35 h 152"/>
              <a:gd name="T74" fmla="*/ 368 w 516"/>
              <a:gd name="T75" fmla="*/ 100 h 152"/>
              <a:gd name="T76" fmla="*/ 331 w 516"/>
              <a:gd name="T77" fmla="*/ 129 h 152"/>
              <a:gd name="T78" fmla="*/ 290 w 516"/>
              <a:gd name="T79" fmla="*/ 64 h 152"/>
              <a:gd name="T80" fmla="*/ 313 w 516"/>
              <a:gd name="T81" fmla="*/ 106 h 152"/>
              <a:gd name="T82" fmla="*/ 349 w 516"/>
              <a:gd name="T83" fmla="*/ 106 h 152"/>
              <a:gd name="T84" fmla="*/ 349 w 516"/>
              <a:gd name="T85" fmla="*/ 23 h 152"/>
              <a:gd name="T86" fmla="*/ 314 w 516"/>
              <a:gd name="T87" fmla="*/ 22 h 152"/>
              <a:gd name="T88" fmla="*/ 394 w 516"/>
              <a:gd name="T89" fmla="*/ 127 h 152"/>
              <a:gd name="T90" fmla="*/ 412 w 516"/>
              <a:gd name="T91" fmla="*/ 109 h 152"/>
              <a:gd name="T92" fmla="*/ 409 w 516"/>
              <a:gd name="T93" fmla="*/ 142 h 152"/>
              <a:gd name="T94" fmla="*/ 393 w 516"/>
              <a:gd name="T95" fmla="*/ 145 h 152"/>
              <a:gd name="T96" fmla="*/ 403 w 516"/>
              <a:gd name="T97" fmla="*/ 127 h 152"/>
              <a:gd name="T98" fmla="*/ 434 w 516"/>
              <a:gd name="T99" fmla="*/ 64 h 152"/>
              <a:gd name="T100" fmla="*/ 452 w 516"/>
              <a:gd name="T101" fmla="*/ 7 h 152"/>
              <a:gd name="T102" fmla="*/ 493 w 516"/>
              <a:gd name="T103" fmla="*/ 4 h 152"/>
              <a:gd name="T104" fmla="*/ 513 w 516"/>
              <a:gd name="T105" fmla="*/ 35 h 152"/>
              <a:gd name="T106" fmla="*/ 512 w 516"/>
              <a:gd name="T107" fmla="*/ 100 h 152"/>
              <a:gd name="T108" fmla="*/ 475 w 516"/>
              <a:gd name="T109" fmla="*/ 129 h 152"/>
              <a:gd name="T110" fmla="*/ 434 w 516"/>
              <a:gd name="T111" fmla="*/ 64 h 152"/>
              <a:gd name="T112" fmla="*/ 457 w 516"/>
              <a:gd name="T113" fmla="*/ 106 h 152"/>
              <a:gd name="T114" fmla="*/ 493 w 516"/>
              <a:gd name="T115" fmla="*/ 106 h 152"/>
              <a:gd name="T116" fmla="*/ 493 w 516"/>
              <a:gd name="T117" fmla="*/ 23 h 152"/>
              <a:gd name="T118" fmla="*/ 458 w 516"/>
              <a:gd name="T119" fmla="*/ 22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516" h="152">
                <a:moveTo>
                  <a:pt x="83" y="112"/>
                </a:moveTo>
                <a:lnTo>
                  <a:pt x="83" y="127"/>
                </a:lnTo>
                <a:lnTo>
                  <a:pt x="0" y="127"/>
                </a:lnTo>
                <a:cubicBezTo>
                  <a:pt x="0" y="123"/>
                  <a:pt x="1" y="119"/>
                  <a:pt x="2" y="116"/>
                </a:cubicBezTo>
                <a:cubicBezTo>
                  <a:pt x="4" y="110"/>
                  <a:pt x="7" y="105"/>
                  <a:pt x="12" y="99"/>
                </a:cubicBezTo>
                <a:cubicBezTo>
                  <a:pt x="17" y="94"/>
                  <a:pt x="23" y="87"/>
                  <a:pt x="32" y="80"/>
                </a:cubicBezTo>
                <a:cubicBezTo>
                  <a:pt x="46" y="69"/>
                  <a:pt x="55" y="60"/>
                  <a:pt x="60" y="53"/>
                </a:cubicBezTo>
                <a:cubicBezTo>
                  <a:pt x="65" y="47"/>
                  <a:pt x="67" y="41"/>
                  <a:pt x="67" y="35"/>
                </a:cubicBezTo>
                <a:cubicBezTo>
                  <a:pt x="67" y="29"/>
                  <a:pt x="65" y="23"/>
                  <a:pt x="61" y="19"/>
                </a:cubicBezTo>
                <a:cubicBezTo>
                  <a:pt x="56" y="15"/>
                  <a:pt x="51" y="13"/>
                  <a:pt x="43" y="13"/>
                </a:cubicBezTo>
                <a:cubicBezTo>
                  <a:pt x="36" y="13"/>
                  <a:pt x="30" y="15"/>
                  <a:pt x="26" y="20"/>
                </a:cubicBezTo>
                <a:cubicBezTo>
                  <a:pt x="21" y="24"/>
                  <a:pt x="19" y="30"/>
                  <a:pt x="19" y="38"/>
                </a:cubicBezTo>
                <a:lnTo>
                  <a:pt x="3" y="37"/>
                </a:lnTo>
                <a:cubicBezTo>
                  <a:pt x="4" y="25"/>
                  <a:pt x="8" y="16"/>
                  <a:pt x="15" y="9"/>
                </a:cubicBezTo>
                <a:cubicBezTo>
                  <a:pt x="22" y="3"/>
                  <a:pt x="32" y="0"/>
                  <a:pt x="44" y="0"/>
                </a:cubicBezTo>
                <a:cubicBezTo>
                  <a:pt x="56" y="0"/>
                  <a:pt x="66" y="3"/>
                  <a:pt x="73" y="10"/>
                </a:cubicBezTo>
                <a:cubicBezTo>
                  <a:pt x="80" y="17"/>
                  <a:pt x="83" y="25"/>
                  <a:pt x="83" y="35"/>
                </a:cubicBezTo>
                <a:cubicBezTo>
                  <a:pt x="83" y="40"/>
                  <a:pt x="82" y="45"/>
                  <a:pt x="80" y="50"/>
                </a:cubicBezTo>
                <a:cubicBezTo>
                  <a:pt x="78" y="55"/>
                  <a:pt x="75" y="60"/>
                  <a:pt x="70" y="65"/>
                </a:cubicBezTo>
                <a:cubicBezTo>
                  <a:pt x="65" y="71"/>
                  <a:pt x="57" y="78"/>
                  <a:pt x="46" y="88"/>
                </a:cubicBezTo>
                <a:cubicBezTo>
                  <a:pt x="37" y="95"/>
                  <a:pt x="31" y="100"/>
                  <a:pt x="28" y="103"/>
                </a:cubicBezTo>
                <a:cubicBezTo>
                  <a:pt x="26" y="106"/>
                  <a:pt x="23" y="109"/>
                  <a:pt x="21" y="112"/>
                </a:cubicBezTo>
                <a:lnTo>
                  <a:pt x="83" y="112"/>
                </a:lnTo>
                <a:close/>
                <a:moveTo>
                  <a:pt x="98" y="64"/>
                </a:moveTo>
                <a:cubicBezTo>
                  <a:pt x="98" y="49"/>
                  <a:pt x="100" y="38"/>
                  <a:pt x="103" y="28"/>
                </a:cubicBezTo>
                <a:cubicBezTo>
                  <a:pt x="106" y="19"/>
                  <a:pt x="110" y="12"/>
                  <a:pt x="116" y="7"/>
                </a:cubicBezTo>
                <a:cubicBezTo>
                  <a:pt x="122" y="3"/>
                  <a:pt x="130" y="0"/>
                  <a:pt x="139" y="0"/>
                </a:cubicBezTo>
                <a:cubicBezTo>
                  <a:pt x="146" y="0"/>
                  <a:pt x="152" y="1"/>
                  <a:pt x="157" y="4"/>
                </a:cubicBezTo>
                <a:cubicBezTo>
                  <a:pt x="162" y="7"/>
                  <a:pt x="166" y="11"/>
                  <a:pt x="169" y="16"/>
                </a:cubicBezTo>
                <a:cubicBezTo>
                  <a:pt x="173" y="21"/>
                  <a:pt x="175" y="27"/>
                  <a:pt x="177" y="35"/>
                </a:cubicBezTo>
                <a:cubicBezTo>
                  <a:pt x="179" y="42"/>
                  <a:pt x="180" y="52"/>
                  <a:pt x="180" y="64"/>
                </a:cubicBezTo>
                <a:cubicBezTo>
                  <a:pt x="180" y="79"/>
                  <a:pt x="179" y="91"/>
                  <a:pt x="176" y="100"/>
                </a:cubicBezTo>
                <a:cubicBezTo>
                  <a:pt x="173" y="109"/>
                  <a:pt x="168" y="116"/>
                  <a:pt x="162" y="121"/>
                </a:cubicBezTo>
                <a:cubicBezTo>
                  <a:pt x="156" y="126"/>
                  <a:pt x="148" y="129"/>
                  <a:pt x="139" y="129"/>
                </a:cubicBezTo>
                <a:cubicBezTo>
                  <a:pt x="127" y="129"/>
                  <a:pt x="117" y="124"/>
                  <a:pt x="110" y="116"/>
                </a:cubicBezTo>
                <a:cubicBezTo>
                  <a:pt x="102" y="105"/>
                  <a:pt x="98" y="88"/>
                  <a:pt x="98" y="64"/>
                </a:cubicBezTo>
                <a:close/>
                <a:moveTo>
                  <a:pt x="114" y="64"/>
                </a:moveTo>
                <a:cubicBezTo>
                  <a:pt x="114" y="85"/>
                  <a:pt x="116" y="99"/>
                  <a:pt x="121" y="106"/>
                </a:cubicBezTo>
                <a:cubicBezTo>
                  <a:pt x="126" y="113"/>
                  <a:pt x="132" y="116"/>
                  <a:pt x="139" y="116"/>
                </a:cubicBezTo>
                <a:cubicBezTo>
                  <a:pt x="146" y="116"/>
                  <a:pt x="152" y="113"/>
                  <a:pt x="157" y="106"/>
                </a:cubicBezTo>
                <a:cubicBezTo>
                  <a:pt x="162" y="99"/>
                  <a:pt x="164" y="85"/>
                  <a:pt x="164" y="64"/>
                </a:cubicBezTo>
                <a:cubicBezTo>
                  <a:pt x="164" y="44"/>
                  <a:pt x="162" y="30"/>
                  <a:pt x="157" y="23"/>
                </a:cubicBezTo>
                <a:cubicBezTo>
                  <a:pt x="152" y="16"/>
                  <a:pt x="146" y="13"/>
                  <a:pt x="139" y="13"/>
                </a:cubicBezTo>
                <a:cubicBezTo>
                  <a:pt x="132" y="13"/>
                  <a:pt x="126" y="16"/>
                  <a:pt x="122" y="22"/>
                </a:cubicBezTo>
                <a:cubicBezTo>
                  <a:pt x="117" y="29"/>
                  <a:pt x="114" y="44"/>
                  <a:pt x="114" y="64"/>
                </a:cubicBezTo>
                <a:close/>
                <a:moveTo>
                  <a:pt x="194" y="64"/>
                </a:moveTo>
                <a:cubicBezTo>
                  <a:pt x="194" y="49"/>
                  <a:pt x="196" y="38"/>
                  <a:pt x="199" y="28"/>
                </a:cubicBezTo>
                <a:cubicBezTo>
                  <a:pt x="202" y="19"/>
                  <a:pt x="206" y="12"/>
                  <a:pt x="212" y="7"/>
                </a:cubicBezTo>
                <a:cubicBezTo>
                  <a:pt x="218" y="3"/>
                  <a:pt x="226" y="0"/>
                  <a:pt x="235" y="0"/>
                </a:cubicBezTo>
                <a:cubicBezTo>
                  <a:pt x="242" y="0"/>
                  <a:pt x="248" y="1"/>
                  <a:pt x="253" y="4"/>
                </a:cubicBezTo>
                <a:cubicBezTo>
                  <a:pt x="258" y="7"/>
                  <a:pt x="262" y="11"/>
                  <a:pt x="265" y="16"/>
                </a:cubicBezTo>
                <a:cubicBezTo>
                  <a:pt x="269" y="21"/>
                  <a:pt x="271" y="27"/>
                  <a:pt x="273" y="35"/>
                </a:cubicBezTo>
                <a:cubicBezTo>
                  <a:pt x="275" y="42"/>
                  <a:pt x="276" y="52"/>
                  <a:pt x="276" y="64"/>
                </a:cubicBezTo>
                <a:cubicBezTo>
                  <a:pt x="276" y="79"/>
                  <a:pt x="275" y="91"/>
                  <a:pt x="272" y="100"/>
                </a:cubicBezTo>
                <a:cubicBezTo>
                  <a:pt x="269" y="109"/>
                  <a:pt x="264" y="116"/>
                  <a:pt x="258" y="121"/>
                </a:cubicBezTo>
                <a:cubicBezTo>
                  <a:pt x="252" y="126"/>
                  <a:pt x="244" y="129"/>
                  <a:pt x="235" y="129"/>
                </a:cubicBezTo>
                <a:cubicBezTo>
                  <a:pt x="223" y="129"/>
                  <a:pt x="213" y="124"/>
                  <a:pt x="206" y="116"/>
                </a:cubicBezTo>
                <a:cubicBezTo>
                  <a:pt x="198" y="105"/>
                  <a:pt x="194" y="88"/>
                  <a:pt x="194" y="64"/>
                </a:cubicBezTo>
                <a:close/>
                <a:moveTo>
                  <a:pt x="210" y="64"/>
                </a:moveTo>
                <a:cubicBezTo>
                  <a:pt x="210" y="85"/>
                  <a:pt x="212" y="99"/>
                  <a:pt x="217" y="106"/>
                </a:cubicBezTo>
                <a:cubicBezTo>
                  <a:pt x="222" y="113"/>
                  <a:pt x="228" y="116"/>
                  <a:pt x="235" y="116"/>
                </a:cubicBezTo>
                <a:cubicBezTo>
                  <a:pt x="242" y="116"/>
                  <a:pt x="248" y="113"/>
                  <a:pt x="253" y="106"/>
                </a:cubicBezTo>
                <a:cubicBezTo>
                  <a:pt x="258" y="99"/>
                  <a:pt x="260" y="85"/>
                  <a:pt x="260" y="64"/>
                </a:cubicBezTo>
                <a:cubicBezTo>
                  <a:pt x="260" y="44"/>
                  <a:pt x="258" y="30"/>
                  <a:pt x="253" y="23"/>
                </a:cubicBezTo>
                <a:cubicBezTo>
                  <a:pt x="248" y="16"/>
                  <a:pt x="242" y="13"/>
                  <a:pt x="235" y="13"/>
                </a:cubicBezTo>
                <a:cubicBezTo>
                  <a:pt x="228" y="13"/>
                  <a:pt x="222" y="16"/>
                  <a:pt x="218" y="22"/>
                </a:cubicBezTo>
                <a:cubicBezTo>
                  <a:pt x="213" y="29"/>
                  <a:pt x="210" y="44"/>
                  <a:pt x="210" y="64"/>
                </a:cubicBezTo>
                <a:close/>
                <a:moveTo>
                  <a:pt x="290" y="64"/>
                </a:moveTo>
                <a:cubicBezTo>
                  <a:pt x="290" y="49"/>
                  <a:pt x="292" y="38"/>
                  <a:pt x="295" y="28"/>
                </a:cubicBezTo>
                <a:cubicBezTo>
                  <a:pt x="298" y="19"/>
                  <a:pt x="302" y="12"/>
                  <a:pt x="308" y="7"/>
                </a:cubicBezTo>
                <a:cubicBezTo>
                  <a:pt x="314" y="3"/>
                  <a:pt x="322" y="0"/>
                  <a:pt x="331" y="0"/>
                </a:cubicBezTo>
                <a:cubicBezTo>
                  <a:pt x="338" y="0"/>
                  <a:pt x="344" y="1"/>
                  <a:pt x="349" y="4"/>
                </a:cubicBezTo>
                <a:cubicBezTo>
                  <a:pt x="354" y="7"/>
                  <a:pt x="358" y="11"/>
                  <a:pt x="361" y="16"/>
                </a:cubicBezTo>
                <a:cubicBezTo>
                  <a:pt x="365" y="21"/>
                  <a:pt x="367" y="27"/>
                  <a:pt x="369" y="35"/>
                </a:cubicBezTo>
                <a:cubicBezTo>
                  <a:pt x="371" y="42"/>
                  <a:pt x="372" y="52"/>
                  <a:pt x="372" y="64"/>
                </a:cubicBezTo>
                <a:cubicBezTo>
                  <a:pt x="372" y="79"/>
                  <a:pt x="371" y="91"/>
                  <a:pt x="368" y="100"/>
                </a:cubicBezTo>
                <a:cubicBezTo>
                  <a:pt x="365" y="109"/>
                  <a:pt x="360" y="116"/>
                  <a:pt x="354" y="121"/>
                </a:cubicBezTo>
                <a:cubicBezTo>
                  <a:pt x="348" y="126"/>
                  <a:pt x="340" y="129"/>
                  <a:pt x="331" y="129"/>
                </a:cubicBezTo>
                <a:cubicBezTo>
                  <a:pt x="319" y="129"/>
                  <a:pt x="309" y="124"/>
                  <a:pt x="302" y="116"/>
                </a:cubicBezTo>
                <a:cubicBezTo>
                  <a:pt x="294" y="105"/>
                  <a:pt x="290" y="88"/>
                  <a:pt x="290" y="64"/>
                </a:cubicBezTo>
                <a:close/>
                <a:moveTo>
                  <a:pt x="306" y="64"/>
                </a:moveTo>
                <a:cubicBezTo>
                  <a:pt x="306" y="85"/>
                  <a:pt x="308" y="99"/>
                  <a:pt x="313" y="106"/>
                </a:cubicBezTo>
                <a:cubicBezTo>
                  <a:pt x="318" y="113"/>
                  <a:pt x="324" y="116"/>
                  <a:pt x="331" y="116"/>
                </a:cubicBezTo>
                <a:cubicBezTo>
                  <a:pt x="338" y="116"/>
                  <a:pt x="344" y="113"/>
                  <a:pt x="349" y="106"/>
                </a:cubicBezTo>
                <a:cubicBezTo>
                  <a:pt x="354" y="99"/>
                  <a:pt x="356" y="85"/>
                  <a:pt x="356" y="64"/>
                </a:cubicBezTo>
                <a:cubicBezTo>
                  <a:pt x="356" y="44"/>
                  <a:pt x="354" y="30"/>
                  <a:pt x="349" y="23"/>
                </a:cubicBezTo>
                <a:cubicBezTo>
                  <a:pt x="344" y="16"/>
                  <a:pt x="338" y="13"/>
                  <a:pt x="331" y="13"/>
                </a:cubicBezTo>
                <a:cubicBezTo>
                  <a:pt x="324" y="13"/>
                  <a:pt x="318" y="16"/>
                  <a:pt x="314" y="22"/>
                </a:cubicBezTo>
                <a:cubicBezTo>
                  <a:pt x="309" y="29"/>
                  <a:pt x="306" y="44"/>
                  <a:pt x="306" y="64"/>
                </a:cubicBezTo>
                <a:close/>
                <a:moveTo>
                  <a:pt x="394" y="127"/>
                </a:moveTo>
                <a:lnTo>
                  <a:pt x="394" y="109"/>
                </a:lnTo>
                <a:lnTo>
                  <a:pt x="412" y="109"/>
                </a:lnTo>
                <a:lnTo>
                  <a:pt x="412" y="127"/>
                </a:lnTo>
                <a:cubicBezTo>
                  <a:pt x="412" y="133"/>
                  <a:pt x="411" y="138"/>
                  <a:pt x="409" y="142"/>
                </a:cubicBezTo>
                <a:cubicBezTo>
                  <a:pt x="406" y="146"/>
                  <a:pt x="403" y="149"/>
                  <a:pt x="398" y="152"/>
                </a:cubicBezTo>
                <a:lnTo>
                  <a:pt x="393" y="145"/>
                </a:lnTo>
                <a:cubicBezTo>
                  <a:pt x="397" y="143"/>
                  <a:pt x="399" y="141"/>
                  <a:pt x="401" y="139"/>
                </a:cubicBezTo>
                <a:cubicBezTo>
                  <a:pt x="402" y="136"/>
                  <a:pt x="403" y="132"/>
                  <a:pt x="403" y="127"/>
                </a:cubicBezTo>
                <a:lnTo>
                  <a:pt x="394" y="127"/>
                </a:lnTo>
                <a:close/>
                <a:moveTo>
                  <a:pt x="434" y="64"/>
                </a:moveTo>
                <a:cubicBezTo>
                  <a:pt x="434" y="49"/>
                  <a:pt x="436" y="38"/>
                  <a:pt x="439" y="28"/>
                </a:cubicBezTo>
                <a:cubicBezTo>
                  <a:pt x="442" y="19"/>
                  <a:pt x="446" y="12"/>
                  <a:pt x="452" y="7"/>
                </a:cubicBezTo>
                <a:cubicBezTo>
                  <a:pt x="458" y="3"/>
                  <a:pt x="466" y="0"/>
                  <a:pt x="475" y="0"/>
                </a:cubicBezTo>
                <a:cubicBezTo>
                  <a:pt x="482" y="0"/>
                  <a:pt x="488" y="1"/>
                  <a:pt x="493" y="4"/>
                </a:cubicBezTo>
                <a:cubicBezTo>
                  <a:pt x="498" y="7"/>
                  <a:pt x="502" y="11"/>
                  <a:pt x="505" y="16"/>
                </a:cubicBezTo>
                <a:cubicBezTo>
                  <a:pt x="509" y="21"/>
                  <a:pt x="511" y="27"/>
                  <a:pt x="513" y="35"/>
                </a:cubicBezTo>
                <a:cubicBezTo>
                  <a:pt x="515" y="42"/>
                  <a:pt x="516" y="52"/>
                  <a:pt x="516" y="64"/>
                </a:cubicBezTo>
                <a:cubicBezTo>
                  <a:pt x="516" y="79"/>
                  <a:pt x="515" y="91"/>
                  <a:pt x="512" y="100"/>
                </a:cubicBezTo>
                <a:cubicBezTo>
                  <a:pt x="509" y="109"/>
                  <a:pt x="504" y="116"/>
                  <a:pt x="498" y="121"/>
                </a:cubicBezTo>
                <a:cubicBezTo>
                  <a:pt x="492" y="126"/>
                  <a:pt x="484" y="129"/>
                  <a:pt x="475" y="129"/>
                </a:cubicBezTo>
                <a:cubicBezTo>
                  <a:pt x="463" y="129"/>
                  <a:pt x="453" y="124"/>
                  <a:pt x="446" y="116"/>
                </a:cubicBezTo>
                <a:cubicBezTo>
                  <a:pt x="438" y="105"/>
                  <a:pt x="434" y="88"/>
                  <a:pt x="434" y="64"/>
                </a:cubicBezTo>
                <a:close/>
                <a:moveTo>
                  <a:pt x="450" y="64"/>
                </a:moveTo>
                <a:cubicBezTo>
                  <a:pt x="450" y="85"/>
                  <a:pt x="452" y="99"/>
                  <a:pt x="457" y="106"/>
                </a:cubicBezTo>
                <a:cubicBezTo>
                  <a:pt x="462" y="113"/>
                  <a:pt x="468" y="116"/>
                  <a:pt x="475" y="116"/>
                </a:cubicBezTo>
                <a:cubicBezTo>
                  <a:pt x="482" y="116"/>
                  <a:pt x="488" y="113"/>
                  <a:pt x="493" y="106"/>
                </a:cubicBezTo>
                <a:cubicBezTo>
                  <a:pt x="498" y="99"/>
                  <a:pt x="500" y="85"/>
                  <a:pt x="500" y="64"/>
                </a:cubicBezTo>
                <a:cubicBezTo>
                  <a:pt x="500" y="44"/>
                  <a:pt x="498" y="30"/>
                  <a:pt x="493" y="23"/>
                </a:cubicBezTo>
                <a:cubicBezTo>
                  <a:pt x="488" y="16"/>
                  <a:pt x="482" y="13"/>
                  <a:pt x="475" y="13"/>
                </a:cubicBezTo>
                <a:cubicBezTo>
                  <a:pt x="468" y="13"/>
                  <a:pt x="462" y="16"/>
                  <a:pt x="458" y="22"/>
                </a:cubicBezTo>
                <a:cubicBezTo>
                  <a:pt x="453" y="29"/>
                  <a:pt x="450" y="44"/>
                  <a:pt x="450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0" name="Freeform 17"/>
          <p:cNvSpPr>
            <a:spLocks noEditPoints="1"/>
          </p:cNvSpPr>
          <p:nvPr/>
        </p:nvSpPr>
        <p:spPr bwMode="auto">
          <a:xfrm>
            <a:off x="6907280" y="5643588"/>
            <a:ext cx="305349" cy="91319"/>
          </a:xfrm>
          <a:custGeom>
            <a:avLst/>
            <a:gdLst>
              <a:gd name="T0" fmla="*/ 30 w 502"/>
              <a:gd name="T1" fmla="*/ 127 h 152"/>
              <a:gd name="T2" fmla="*/ 16 w 502"/>
              <a:gd name="T3" fmla="*/ 39 h 152"/>
              <a:gd name="T4" fmla="*/ 0 w 502"/>
              <a:gd name="T5" fmla="*/ 32 h 152"/>
              <a:gd name="T6" fmla="*/ 36 w 502"/>
              <a:gd name="T7" fmla="*/ 0 h 152"/>
              <a:gd name="T8" fmla="*/ 46 w 502"/>
              <a:gd name="T9" fmla="*/ 127 h 152"/>
              <a:gd name="T10" fmla="*/ 88 w 502"/>
              <a:gd name="T11" fmla="*/ 28 h 152"/>
              <a:gd name="T12" fmla="*/ 125 w 502"/>
              <a:gd name="T13" fmla="*/ 0 h 152"/>
              <a:gd name="T14" fmla="*/ 155 w 502"/>
              <a:gd name="T15" fmla="*/ 16 h 152"/>
              <a:gd name="T16" fmla="*/ 166 w 502"/>
              <a:gd name="T17" fmla="*/ 64 h 152"/>
              <a:gd name="T18" fmla="*/ 148 w 502"/>
              <a:gd name="T19" fmla="*/ 121 h 152"/>
              <a:gd name="T20" fmla="*/ 96 w 502"/>
              <a:gd name="T21" fmla="*/ 116 h 152"/>
              <a:gd name="T22" fmla="*/ 100 w 502"/>
              <a:gd name="T23" fmla="*/ 64 h 152"/>
              <a:gd name="T24" fmla="*/ 125 w 502"/>
              <a:gd name="T25" fmla="*/ 116 h 152"/>
              <a:gd name="T26" fmla="*/ 150 w 502"/>
              <a:gd name="T27" fmla="*/ 64 h 152"/>
              <a:gd name="T28" fmla="*/ 125 w 502"/>
              <a:gd name="T29" fmla="*/ 13 h 152"/>
              <a:gd name="T30" fmla="*/ 100 w 502"/>
              <a:gd name="T31" fmla="*/ 64 h 152"/>
              <a:gd name="T32" fmla="*/ 184 w 502"/>
              <a:gd name="T33" fmla="*/ 28 h 152"/>
              <a:gd name="T34" fmla="*/ 221 w 502"/>
              <a:gd name="T35" fmla="*/ 0 h 152"/>
              <a:gd name="T36" fmla="*/ 251 w 502"/>
              <a:gd name="T37" fmla="*/ 16 h 152"/>
              <a:gd name="T38" fmla="*/ 262 w 502"/>
              <a:gd name="T39" fmla="*/ 64 h 152"/>
              <a:gd name="T40" fmla="*/ 244 w 502"/>
              <a:gd name="T41" fmla="*/ 121 h 152"/>
              <a:gd name="T42" fmla="*/ 192 w 502"/>
              <a:gd name="T43" fmla="*/ 116 h 152"/>
              <a:gd name="T44" fmla="*/ 196 w 502"/>
              <a:gd name="T45" fmla="*/ 64 h 152"/>
              <a:gd name="T46" fmla="*/ 221 w 502"/>
              <a:gd name="T47" fmla="*/ 116 h 152"/>
              <a:gd name="T48" fmla="*/ 246 w 502"/>
              <a:gd name="T49" fmla="*/ 64 h 152"/>
              <a:gd name="T50" fmla="*/ 221 w 502"/>
              <a:gd name="T51" fmla="*/ 13 h 152"/>
              <a:gd name="T52" fmla="*/ 196 w 502"/>
              <a:gd name="T53" fmla="*/ 64 h 152"/>
              <a:gd name="T54" fmla="*/ 280 w 502"/>
              <a:gd name="T55" fmla="*/ 28 h 152"/>
              <a:gd name="T56" fmla="*/ 317 w 502"/>
              <a:gd name="T57" fmla="*/ 0 h 152"/>
              <a:gd name="T58" fmla="*/ 347 w 502"/>
              <a:gd name="T59" fmla="*/ 16 h 152"/>
              <a:gd name="T60" fmla="*/ 358 w 502"/>
              <a:gd name="T61" fmla="*/ 64 h 152"/>
              <a:gd name="T62" fmla="*/ 340 w 502"/>
              <a:gd name="T63" fmla="*/ 121 h 152"/>
              <a:gd name="T64" fmla="*/ 288 w 502"/>
              <a:gd name="T65" fmla="*/ 116 h 152"/>
              <a:gd name="T66" fmla="*/ 292 w 502"/>
              <a:gd name="T67" fmla="*/ 64 h 152"/>
              <a:gd name="T68" fmla="*/ 317 w 502"/>
              <a:gd name="T69" fmla="*/ 116 h 152"/>
              <a:gd name="T70" fmla="*/ 342 w 502"/>
              <a:gd name="T71" fmla="*/ 64 h 152"/>
              <a:gd name="T72" fmla="*/ 317 w 502"/>
              <a:gd name="T73" fmla="*/ 13 h 152"/>
              <a:gd name="T74" fmla="*/ 292 w 502"/>
              <a:gd name="T75" fmla="*/ 64 h 152"/>
              <a:gd name="T76" fmla="*/ 380 w 502"/>
              <a:gd name="T77" fmla="*/ 109 h 152"/>
              <a:gd name="T78" fmla="*/ 398 w 502"/>
              <a:gd name="T79" fmla="*/ 127 h 152"/>
              <a:gd name="T80" fmla="*/ 383 w 502"/>
              <a:gd name="T81" fmla="*/ 152 h 152"/>
              <a:gd name="T82" fmla="*/ 386 w 502"/>
              <a:gd name="T83" fmla="*/ 139 h 152"/>
              <a:gd name="T84" fmla="*/ 380 w 502"/>
              <a:gd name="T85" fmla="*/ 127 h 152"/>
              <a:gd name="T86" fmla="*/ 424 w 502"/>
              <a:gd name="T87" fmla="*/ 28 h 152"/>
              <a:gd name="T88" fmla="*/ 461 w 502"/>
              <a:gd name="T89" fmla="*/ 0 h 152"/>
              <a:gd name="T90" fmla="*/ 491 w 502"/>
              <a:gd name="T91" fmla="*/ 16 h 152"/>
              <a:gd name="T92" fmla="*/ 502 w 502"/>
              <a:gd name="T93" fmla="*/ 64 h 152"/>
              <a:gd name="T94" fmla="*/ 484 w 502"/>
              <a:gd name="T95" fmla="*/ 121 h 152"/>
              <a:gd name="T96" fmla="*/ 432 w 502"/>
              <a:gd name="T97" fmla="*/ 116 h 152"/>
              <a:gd name="T98" fmla="*/ 436 w 502"/>
              <a:gd name="T99" fmla="*/ 64 h 152"/>
              <a:gd name="T100" fmla="*/ 461 w 502"/>
              <a:gd name="T101" fmla="*/ 116 h 152"/>
              <a:gd name="T102" fmla="*/ 486 w 502"/>
              <a:gd name="T103" fmla="*/ 64 h 152"/>
              <a:gd name="T104" fmla="*/ 461 w 502"/>
              <a:gd name="T105" fmla="*/ 13 h 152"/>
              <a:gd name="T106" fmla="*/ 436 w 502"/>
              <a:gd name="T107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02" h="152">
                <a:moveTo>
                  <a:pt x="46" y="127"/>
                </a:moveTo>
                <a:lnTo>
                  <a:pt x="30" y="127"/>
                </a:lnTo>
                <a:lnTo>
                  <a:pt x="30" y="28"/>
                </a:lnTo>
                <a:cubicBezTo>
                  <a:pt x="27" y="32"/>
                  <a:pt x="22" y="35"/>
                  <a:pt x="16" y="39"/>
                </a:cubicBezTo>
                <a:cubicBezTo>
                  <a:pt x="10" y="42"/>
                  <a:pt x="4" y="45"/>
                  <a:pt x="0" y="47"/>
                </a:cubicBezTo>
                <a:lnTo>
                  <a:pt x="0" y="32"/>
                </a:lnTo>
                <a:cubicBezTo>
                  <a:pt x="8" y="28"/>
                  <a:pt x="16" y="23"/>
                  <a:pt x="22" y="17"/>
                </a:cubicBezTo>
                <a:cubicBezTo>
                  <a:pt x="29" y="11"/>
                  <a:pt x="33" y="6"/>
                  <a:pt x="36" y="0"/>
                </a:cubicBezTo>
                <a:lnTo>
                  <a:pt x="46" y="0"/>
                </a:lnTo>
                <a:lnTo>
                  <a:pt x="46" y="127"/>
                </a:lnTo>
                <a:close/>
                <a:moveTo>
                  <a:pt x="84" y="64"/>
                </a:moveTo>
                <a:cubicBezTo>
                  <a:pt x="84" y="49"/>
                  <a:pt x="85" y="38"/>
                  <a:pt x="88" y="28"/>
                </a:cubicBezTo>
                <a:cubicBezTo>
                  <a:pt x="91" y="19"/>
                  <a:pt x="96" y="12"/>
                  <a:pt x="102" y="7"/>
                </a:cubicBezTo>
                <a:cubicBezTo>
                  <a:pt x="108" y="3"/>
                  <a:pt x="116" y="0"/>
                  <a:pt x="125" y="0"/>
                </a:cubicBezTo>
                <a:cubicBezTo>
                  <a:pt x="131" y="0"/>
                  <a:pt x="137" y="1"/>
                  <a:pt x="142" y="4"/>
                </a:cubicBezTo>
                <a:cubicBezTo>
                  <a:pt x="148" y="7"/>
                  <a:pt x="152" y="11"/>
                  <a:pt x="155" y="16"/>
                </a:cubicBezTo>
                <a:cubicBezTo>
                  <a:pt x="158" y="21"/>
                  <a:pt x="161" y="27"/>
                  <a:pt x="163" y="35"/>
                </a:cubicBezTo>
                <a:cubicBezTo>
                  <a:pt x="165" y="42"/>
                  <a:pt x="166" y="52"/>
                  <a:pt x="166" y="64"/>
                </a:cubicBezTo>
                <a:cubicBezTo>
                  <a:pt x="166" y="79"/>
                  <a:pt x="164" y="91"/>
                  <a:pt x="161" y="100"/>
                </a:cubicBezTo>
                <a:cubicBezTo>
                  <a:pt x="158" y="109"/>
                  <a:pt x="154" y="116"/>
                  <a:pt x="148" y="121"/>
                </a:cubicBezTo>
                <a:cubicBezTo>
                  <a:pt x="142" y="126"/>
                  <a:pt x="134" y="129"/>
                  <a:pt x="125" y="129"/>
                </a:cubicBezTo>
                <a:cubicBezTo>
                  <a:pt x="113" y="129"/>
                  <a:pt x="103" y="124"/>
                  <a:pt x="96" y="116"/>
                </a:cubicBezTo>
                <a:cubicBezTo>
                  <a:pt x="88" y="105"/>
                  <a:pt x="84" y="88"/>
                  <a:pt x="84" y="64"/>
                </a:cubicBezTo>
                <a:close/>
                <a:moveTo>
                  <a:pt x="100" y="64"/>
                </a:moveTo>
                <a:cubicBezTo>
                  <a:pt x="100" y="85"/>
                  <a:pt x="102" y="99"/>
                  <a:pt x="107" y="106"/>
                </a:cubicBezTo>
                <a:cubicBezTo>
                  <a:pt x="112" y="113"/>
                  <a:pt x="118" y="116"/>
                  <a:pt x="125" y="116"/>
                </a:cubicBezTo>
                <a:cubicBezTo>
                  <a:pt x="132" y="116"/>
                  <a:pt x="138" y="113"/>
                  <a:pt x="143" y="106"/>
                </a:cubicBezTo>
                <a:cubicBezTo>
                  <a:pt x="147" y="99"/>
                  <a:pt x="150" y="85"/>
                  <a:pt x="150" y="64"/>
                </a:cubicBezTo>
                <a:cubicBezTo>
                  <a:pt x="150" y="44"/>
                  <a:pt x="147" y="30"/>
                  <a:pt x="143" y="23"/>
                </a:cubicBezTo>
                <a:cubicBezTo>
                  <a:pt x="138" y="16"/>
                  <a:pt x="132" y="13"/>
                  <a:pt x="125" y="13"/>
                </a:cubicBezTo>
                <a:cubicBezTo>
                  <a:pt x="117" y="13"/>
                  <a:pt x="112" y="16"/>
                  <a:pt x="108" y="22"/>
                </a:cubicBezTo>
                <a:cubicBezTo>
                  <a:pt x="102" y="29"/>
                  <a:pt x="100" y="44"/>
                  <a:pt x="100" y="64"/>
                </a:cubicBezTo>
                <a:close/>
                <a:moveTo>
                  <a:pt x="180" y="64"/>
                </a:moveTo>
                <a:cubicBezTo>
                  <a:pt x="180" y="49"/>
                  <a:pt x="181" y="38"/>
                  <a:pt x="184" y="28"/>
                </a:cubicBezTo>
                <a:cubicBezTo>
                  <a:pt x="187" y="19"/>
                  <a:pt x="192" y="12"/>
                  <a:pt x="198" y="7"/>
                </a:cubicBezTo>
                <a:cubicBezTo>
                  <a:pt x="204" y="3"/>
                  <a:pt x="212" y="0"/>
                  <a:pt x="221" y="0"/>
                </a:cubicBezTo>
                <a:cubicBezTo>
                  <a:pt x="227" y="0"/>
                  <a:pt x="233" y="1"/>
                  <a:pt x="238" y="4"/>
                </a:cubicBezTo>
                <a:cubicBezTo>
                  <a:pt x="244" y="7"/>
                  <a:pt x="248" y="11"/>
                  <a:pt x="251" y="16"/>
                </a:cubicBezTo>
                <a:cubicBezTo>
                  <a:pt x="254" y="21"/>
                  <a:pt x="257" y="27"/>
                  <a:pt x="259" y="35"/>
                </a:cubicBezTo>
                <a:cubicBezTo>
                  <a:pt x="261" y="42"/>
                  <a:pt x="262" y="52"/>
                  <a:pt x="262" y="64"/>
                </a:cubicBezTo>
                <a:cubicBezTo>
                  <a:pt x="262" y="79"/>
                  <a:pt x="260" y="91"/>
                  <a:pt x="257" y="100"/>
                </a:cubicBezTo>
                <a:cubicBezTo>
                  <a:pt x="254" y="109"/>
                  <a:pt x="250" y="116"/>
                  <a:pt x="244" y="121"/>
                </a:cubicBezTo>
                <a:cubicBezTo>
                  <a:pt x="238" y="126"/>
                  <a:pt x="230" y="129"/>
                  <a:pt x="221" y="129"/>
                </a:cubicBezTo>
                <a:cubicBezTo>
                  <a:pt x="209" y="129"/>
                  <a:pt x="199" y="124"/>
                  <a:pt x="192" y="116"/>
                </a:cubicBezTo>
                <a:cubicBezTo>
                  <a:pt x="184" y="105"/>
                  <a:pt x="180" y="88"/>
                  <a:pt x="180" y="64"/>
                </a:cubicBezTo>
                <a:close/>
                <a:moveTo>
                  <a:pt x="196" y="64"/>
                </a:moveTo>
                <a:cubicBezTo>
                  <a:pt x="196" y="85"/>
                  <a:pt x="198" y="99"/>
                  <a:pt x="203" y="106"/>
                </a:cubicBezTo>
                <a:cubicBezTo>
                  <a:pt x="208" y="113"/>
                  <a:pt x="214" y="116"/>
                  <a:pt x="221" y="116"/>
                </a:cubicBezTo>
                <a:cubicBezTo>
                  <a:pt x="228" y="116"/>
                  <a:pt x="234" y="113"/>
                  <a:pt x="239" y="106"/>
                </a:cubicBezTo>
                <a:cubicBezTo>
                  <a:pt x="243" y="99"/>
                  <a:pt x="246" y="85"/>
                  <a:pt x="246" y="64"/>
                </a:cubicBezTo>
                <a:cubicBezTo>
                  <a:pt x="246" y="44"/>
                  <a:pt x="243" y="30"/>
                  <a:pt x="239" y="23"/>
                </a:cubicBezTo>
                <a:cubicBezTo>
                  <a:pt x="234" y="16"/>
                  <a:pt x="228" y="13"/>
                  <a:pt x="221" y="13"/>
                </a:cubicBezTo>
                <a:cubicBezTo>
                  <a:pt x="213" y="13"/>
                  <a:pt x="208" y="16"/>
                  <a:pt x="204" y="22"/>
                </a:cubicBezTo>
                <a:cubicBezTo>
                  <a:pt x="198" y="29"/>
                  <a:pt x="196" y="44"/>
                  <a:pt x="196" y="64"/>
                </a:cubicBezTo>
                <a:close/>
                <a:moveTo>
                  <a:pt x="276" y="64"/>
                </a:moveTo>
                <a:cubicBezTo>
                  <a:pt x="276" y="49"/>
                  <a:pt x="277" y="38"/>
                  <a:pt x="280" y="28"/>
                </a:cubicBezTo>
                <a:cubicBezTo>
                  <a:pt x="283" y="19"/>
                  <a:pt x="288" y="12"/>
                  <a:pt x="294" y="7"/>
                </a:cubicBezTo>
                <a:cubicBezTo>
                  <a:pt x="300" y="3"/>
                  <a:pt x="308" y="0"/>
                  <a:pt x="317" y="0"/>
                </a:cubicBezTo>
                <a:cubicBezTo>
                  <a:pt x="323" y="0"/>
                  <a:pt x="329" y="1"/>
                  <a:pt x="334" y="4"/>
                </a:cubicBezTo>
                <a:cubicBezTo>
                  <a:pt x="340" y="7"/>
                  <a:pt x="344" y="11"/>
                  <a:pt x="347" y="16"/>
                </a:cubicBezTo>
                <a:cubicBezTo>
                  <a:pt x="350" y="21"/>
                  <a:pt x="353" y="27"/>
                  <a:pt x="355" y="35"/>
                </a:cubicBezTo>
                <a:cubicBezTo>
                  <a:pt x="357" y="42"/>
                  <a:pt x="358" y="52"/>
                  <a:pt x="358" y="64"/>
                </a:cubicBezTo>
                <a:cubicBezTo>
                  <a:pt x="358" y="79"/>
                  <a:pt x="356" y="91"/>
                  <a:pt x="353" y="100"/>
                </a:cubicBezTo>
                <a:cubicBezTo>
                  <a:pt x="350" y="109"/>
                  <a:pt x="346" y="116"/>
                  <a:pt x="340" y="121"/>
                </a:cubicBezTo>
                <a:cubicBezTo>
                  <a:pt x="334" y="126"/>
                  <a:pt x="326" y="129"/>
                  <a:pt x="317" y="129"/>
                </a:cubicBezTo>
                <a:cubicBezTo>
                  <a:pt x="305" y="129"/>
                  <a:pt x="295" y="124"/>
                  <a:pt x="288" y="116"/>
                </a:cubicBezTo>
                <a:cubicBezTo>
                  <a:pt x="280" y="105"/>
                  <a:pt x="276" y="88"/>
                  <a:pt x="276" y="64"/>
                </a:cubicBezTo>
                <a:close/>
                <a:moveTo>
                  <a:pt x="292" y="64"/>
                </a:moveTo>
                <a:cubicBezTo>
                  <a:pt x="292" y="85"/>
                  <a:pt x="294" y="99"/>
                  <a:pt x="299" y="106"/>
                </a:cubicBezTo>
                <a:cubicBezTo>
                  <a:pt x="304" y="113"/>
                  <a:pt x="310" y="116"/>
                  <a:pt x="317" y="116"/>
                </a:cubicBezTo>
                <a:cubicBezTo>
                  <a:pt x="324" y="116"/>
                  <a:pt x="330" y="113"/>
                  <a:pt x="335" y="106"/>
                </a:cubicBezTo>
                <a:cubicBezTo>
                  <a:pt x="339" y="99"/>
                  <a:pt x="342" y="85"/>
                  <a:pt x="342" y="64"/>
                </a:cubicBezTo>
                <a:cubicBezTo>
                  <a:pt x="342" y="44"/>
                  <a:pt x="339" y="30"/>
                  <a:pt x="335" y="23"/>
                </a:cubicBezTo>
                <a:cubicBezTo>
                  <a:pt x="330" y="16"/>
                  <a:pt x="324" y="13"/>
                  <a:pt x="317" y="13"/>
                </a:cubicBezTo>
                <a:cubicBezTo>
                  <a:pt x="309" y="13"/>
                  <a:pt x="304" y="16"/>
                  <a:pt x="300" y="22"/>
                </a:cubicBezTo>
                <a:cubicBezTo>
                  <a:pt x="294" y="29"/>
                  <a:pt x="292" y="44"/>
                  <a:pt x="292" y="64"/>
                </a:cubicBezTo>
                <a:close/>
                <a:moveTo>
                  <a:pt x="380" y="127"/>
                </a:moveTo>
                <a:lnTo>
                  <a:pt x="380" y="109"/>
                </a:lnTo>
                <a:lnTo>
                  <a:pt x="398" y="109"/>
                </a:lnTo>
                <a:lnTo>
                  <a:pt x="398" y="127"/>
                </a:lnTo>
                <a:cubicBezTo>
                  <a:pt x="398" y="133"/>
                  <a:pt x="396" y="138"/>
                  <a:pt x="394" y="142"/>
                </a:cubicBezTo>
                <a:cubicBezTo>
                  <a:pt x="392" y="146"/>
                  <a:pt x="388" y="149"/>
                  <a:pt x="383" y="152"/>
                </a:cubicBezTo>
                <a:lnTo>
                  <a:pt x="379" y="145"/>
                </a:lnTo>
                <a:cubicBezTo>
                  <a:pt x="382" y="143"/>
                  <a:pt x="385" y="141"/>
                  <a:pt x="386" y="139"/>
                </a:cubicBezTo>
                <a:cubicBezTo>
                  <a:pt x="388" y="136"/>
                  <a:pt x="389" y="132"/>
                  <a:pt x="389" y="127"/>
                </a:cubicBezTo>
                <a:lnTo>
                  <a:pt x="380" y="127"/>
                </a:lnTo>
                <a:close/>
                <a:moveTo>
                  <a:pt x="420" y="64"/>
                </a:moveTo>
                <a:cubicBezTo>
                  <a:pt x="420" y="49"/>
                  <a:pt x="421" y="38"/>
                  <a:pt x="424" y="28"/>
                </a:cubicBezTo>
                <a:cubicBezTo>
                  <a:pt x="427" y="19"/>
                  <a:pt x="432" y="12"/>
                  <a:pt x="438" y="7"/>
                </a:cubicBezTo>
                <a:cubicBezTo>
                  <a:pt x="444" y="3"/>
                  <a:pt x="452" y="0"/>
                  <a:pt x="461" y="0"/>
                </a:cubicBezTo>
                <a:cubicBezTo>
                  <a:pt x="467" y="0"/>
                  <a:pt x="473" y="1"/>
                  <a:pt x="478" y="4"/>
                </a:cubicBezTo>
                <a:cubicBezTo>
                  <a:pt x="484" y="7"/>
                  <a:pt x="488" y="11"/>
                  <a:pt x="491" y="16"/>
                </a:cubicBezTo>
                <a:cubicBezTo>
                  <a:pt x="494" y="21"/>
                  <a:pt x="497" y="27"/>
                  <a:pt x="499" y="35"/>
                </a:cubicBezTo>
                <a:cubicBezTo>
                  <a:pt x="501" y="42"/>
                  <a:pt x="502" y="52"/>
                  <a:pt x="502" y="64"/>
                </a:cubicBezTo>
                <a:cubicBezTo>
                  <a:pt x="502" y="79"/>
                  <a:pt x="500" y="91"/>
                  <a:pt x="497" y="100"/>
                </a:cubicBezTo>
                <a:cubicBezTo>
                  <a:pt x="494" y="109"/>
                  <a:pt x="490" y="116"/>
                  <a:pt x="484" y="121"/>
                </a:cubicBezTo>
                <a:cubicBezTo>
                  <a:pt x="478" y="126"/>
                  <a:pt x="470" y="129"/>
                  <a:pt x="461" y="129"/>
                </a:cubicBezTo>
                <a:cubicBezTo>
                  <a:pt x="449" y="129"/>
                  <a:pt x="439" y="124"/>
                  <a:pt x="432" y="116"/>
                </a:cubicBezTo>
                <a:cubicBezTo>
                  <a:pt x="424" y="105"/>
                  <a:pt x="420" y="88"/>
                  <a:pt x="420" y="64"/>
                </a:cubicBezTo>
                <a:close/>
                <a:moveTo>
                  <a:pt x="436" y="64"/>
                </a:moveTo>
                <a:cubicBezTo>
                  <a:pt x="436" y="85"/>
                  <a:pt x="438" y="99"/>
                  <a:pt x="443" y="106"/>
                </a:cubicBezTo>
                <a:cubicBezTo>
                  <a:pt x="448" y="113"/>
                  <a:pt x="454" y="116"/>
                  <a:pt x="461" y="116"/>
                </a:cubicBezTo>
                <a:cubicBezTo>
                  <a:pt x="468" y="116"/>
                  <a:pt x="474" y="113"/>
                  <a:pt x="479" y="106"/>
                </a:cubicBezTo>
                <a:cubicBezTo>
                  <a:pt x="483" y="99"/>
                  <a:pt x="486" y="85"/>
                  <a:pt x="486" y="64"/>
                </a:cubicBezTo>
                <a:cubicBezTo>
                  <a:pt x="486" y="44"/>
                  <a:pt x="483" y="30"/>
                  <a:pt x="479" y="23"/>
                </a:cubicBezTo>
                <a:cubicBezTo>
                  <a:pt x="474" y="16"/>
                  <a:pt x="468" y="13"/>
                  <a:pt x="461" y="13"/>
                </a:cubicBezTo>
                <a:cubicBezTo>
                  <a:pt x="453" y="13"/>
                  <a:pt x="448" y="16"/>
                  <a:pt x="444" y="22"/>
                </a:cubicBezTo>
                <a:cubicBezTo>
                  <a:pt x="438" y="29"/>
                  <a:pt x="436" y="44"/>
                  <a:pt x="436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1" name="Freeform 18"/>
          <p:cNvSpPr>
            <a:spLocks noEditPoints="1"/>
          </p:cNvSpPr>
          <p:nvPr/>
        </p:nvSpPr>
        <p:spPr bwMode="auto">
          <a:xfrm>
            <a:off x="6128211" y="5643588"/>
            <a:ext cx="77051" cy="91319"/>
          </a:xfrm>
          <a:custGeom>
            <a:avLst/>
            <a:gdLst>
              <a:gd name="T0" fmla="*/ 2 w 123"/>
              <a:gd name="T1" fmla="*/ 127 h 152"/>
              <a:gd name="T2" fmla="*/ 2 w 123"/>
              <a:gd name="T3" fmla="*/ 109 h 152"/>
              <a:gd name="T4" fmla="*/ 19 w 123"/>
              <a:gd name="T5" fmla="*/ 109 h 152"/>
              <a:gd name="T6" fmla="*/ 19 w 123"/>
              <a:gd name="T7" fmla="*/ 127 h 152"/>
              <a:gd name="T8" fmla="*/ 16 w 123"/>
              <a:gd name="T9" fmla="*/ 142 h 152"/>
              <a:gd name="T10" fmla="*/ 5 w 123"/>
              <a:gd name="T11" fmla="*/ 152 h 152"/>
              <a:gd name="T12" fmla="*/ 0 w 123"/>
              <a:gd name="T13" fmla="*/ 145 h 152"/>
              <a:gd name="T14" fmla="*/ 8 w 123"/>
              <a:gd name="T15" fmla="*/ 139 h 152"/>
              <a:gd name="T16" fmla="*/ 10 w 123"/>
              <a:gd name="T17" fmla="*/ 127 h 152"/>
              <a:gd name="T18" fmla="*/ 2 w 123"/>
              <a:gd name="T19" fmla="*/ 127 h 152"/>
              <a:gd name="T20" fmla="*/ 41 w 123"/>
              <a:gd name="T21" fmla="*/ 64 h 152"/>
              <a:gd name="T22" fmla="*/ 46 w 123"/>
              <a:gd name="T23" fmla="*/ 28 h 152"/>
              <a:gd name="T24" fmla="*/ 59 w 123"/>
              <a:gd name="T25" fmla="*/ 7 h 152"/>
              <a:gd name="T26" fmla="*/ 82 w 123"/>
              <a:gd name="T27" fmla="*/ 0 h 152"/>
              <a:gd name="T28" fmla="*/ 100 w 123"/>
              <a:gd name="T29" fmla="*/ 4 h 152"/>
              <a:gd name="T30" fmla="*/ 113 w 123"/>
              <a:gd name="T31" fmla="*/ 16 h 152"/>
              <a:gd name="T32" fmla="*/ 120 w 123"/>
              <a:gd name="T33" fmla="*/ 35 h 152"/>
              <a:gd name="T34" fmla="*/ 123 w 123"/>
              <a:gd name="T35" fmla="*/ 64 h 152"/>
              <a:gd name="T36" fmla="*/ 119 w 123"/>
              <a:gd name="T37" fmla="*/ 100 h 152"/>
              <a:gd name="T38" fmla="*/ 105 w 123"/>
              <a:gd name="T39" fmla="*/ 121 h 152"/>
              <a:gd name="T40" fmla="*/ 82 w 123"/>
              <a:gd name="T41" fmla="*/ 129 h 152"/>
              <a:gd name="T42" fmla="*/ 54 w 123"/>
              <a:gd name="T43" fmla="*/ 116 h 152"/>
              <a:gd name="T44" fmla="*/ 41 w 123"/>
              <a:gd name="T45" fmla="*/ 64 h 152"/>
              <a:gd name="T46" fmla="*/ 57 w 123"/>
              <a:gd name="T47" fmla="*/ 64 h 152"/>
              <a:gd name="T48" fmla="*/ 64 w 123"/>
              <a:gd name="T49" fmla="*/ 106 h 152"/>
              <a:gd name="T50" fmla="*/ 82 w 123"/>
              <a:gd name="T51" fmla="*/ 116 h 152"/>
              <a:gd name="T52" fmla="*/ 100 w 123"/>
              <a:gd name="T53" fmla="*/ 106 h 152"/>
              <a:gd name="T54" fmla="*/ 107 w 123"/>
              <a:gd name="T55" fmla="*/ 64 h 152"/>
              <a:gd name="T56" fmla="*/ 100 w 123"/>
              <a:gd name="T57" fmla="*/ 23 h 152"/>
              <a:gd name="T58" fmla="*/ 82 w 123"/>
              <a:gd name="T59" fmla="*/ 13 h 152"/>
              <a:gd name="T60" fmla="*/ 65 w 123"/>
              <a:gd name="T61" fmla="*/ 22 h 152"/>
              <a:gd name="T62" fmla="*/ 57 w 123"/>
              <a:gd name="T63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123" h="152">
                <a:moveTo>
                  <a:pt x="2" y="127"/>
                </a:moveTo>
                <a:lnTo>
                  <a:pt x="2" y="109"/>
                </a:lnTo>
                <a:lnTo>
                  <a:pt x="19" y="109"/>
                </a:lnTo>
                <a:lnTo>
                  <a:pt x="19" y="127"/>
                </a:lnTo>
                <a:cubicBezTo>
                  <a:pt x="19" y="133"/>
                  <a:pt x="18" y="138"/>
                  <a:pt x="16" y="142"/>
                </a:cubicBezTo>
                <a:cubicBezTo>
                  <a:pt x="13" y="146"/>
                  <a:pt x="10" y="149"/>
                  <a:pt x="5" y="152"/>
                </a:cubicBezTo>
                <a:lnTo>
                  <a:pt x="0" y="145"/>
                </a:lnTo>
                <a:cubicBezTo>
                  <a:pt x="4" y="143"/>
                  <a:pt x="6" y="141"/>
                  <a:pt x="8" y="139"/>
                </a:cubicBezTo>
                <a:cubicBezTo>
                  <a:pt x="9" y="136"/>
                  <a:pt x="10" y="132"/>
                  <a:pt x="10" y="127"/>
                </a:cubicBezTo>
                <a:lnTo>
                  <a:pt x="2" y="127"/>
                </a:lnTo>
                <a:close/>
                <a:moveTo>
                  <a:pt x="41" y="64"/>
                </a:moveTo>
                <a:cubicBezTo>
                  <a:pt x="41" y="49"/>
                  <a:pt x="43" y="38"/>
                  <a:pt x="46" y="28"/>
                </a:cubicBezTo>
                <a:cubicBezTo>
                  <a:pt x="49" y="19"/>
                  <a:pt x="53" y="12"/>
                  <a:pt x="59" y="7"/>
                </a:cubicBezTo>
                <a:cubicBezTo>
                  <a:pt x="66" y="3"/>
                  <a:pt x="73" y="0"/>
                  <a:pt x="82" y="0"/>
                </a:cubicBezTo>
                <a:cubicBezTo>
                  <a:pt x="89" y="0"/>
                  <a:pt x="95" y="1"/>
                  <a:pt x="100" y="4"/>
                </a:cubicBezTo>
                <a:cubicBezTo>
                  <a:pt x="105" y="7"/>
                  <a:pt x="109" y="11"/>
                  <a:pt x="113" y="16"/>
                </a:cubicBezTo>
                <a:cubicBezTo>
                  <a:pt x="116" y="21"/>
                  <a:pt x="119" y="27"/>
                  <a:pt x="120" y="35"/>
                </a:cubicBezTo>
                <a:cubicBezTo>
                  <a:pt x="122" y="42"/>
                  <a:pt x="123" y="52"/>
                  <a:pt x="123" y="64"/>
                </a:cubicBezTo>
                <a:cubicBezTo>
                  <a:pt x="123" y="79"/>
                  <a:pt x="122" y="91"/>
                  <a:pt x="119" y="100"/>
                </a:cubicBezTo>
                <a:cubicBezTo>
                  <a:pt x="116" y="109"/>
                  <a:pt x="111" y="116"/>
                  <a:pt x="105" y="121"/>
                </a:cubicBezTo>
                <a:cubicBezTo>
                  <a:pt x="99" y="126"/>
                  <a:pt x="92" y="129"/>
                  <a:pt x="82" y="129"/>
                </a:cubicBezTo>
                <a:cubicBezTo>
                  <a:pt x="70" y="129"/>
                  <a:pt x="61" y="124"/>
                  <a:pt x="54" y="116"/>
                </a:cubicBezTo>
                <a:cubicBezTo>
                  <a:pt x="45" y="105"/>
                  <a:pt x="41" y="88"/>
                  <a:pt x="41" y="64"/>
                </a:cubicBezTo>
                <a:close/>
                <a:moveTo>
                  <a:pt x="57" y="64"/>
                </a:moveTo>
                <a:cubicBezTo>
                  <a:pt x="57" y="85"/>
                  <a:pt x="60" y="99"/>
                  <a:pt x="64" y="106"/>
                </a:cubicBezTo>
                <a:cubicBezTo>
                  <a:pt x="69" y="113"/>
                  <a:pt x="75" y="116"/>
                  <a:pt x="82" y="116"/>
                </a:cubicBezTo>
                <a:cubicBezTo>
                  <a:pt x="89" y="116"/>
                  <a:pt x="95" y="113"/>
                  <a:pt x="100" y="106"/>
                </a:cubicBezTo>
                <a:cubicBezTo>
                  <a:pt x="105" y="99"/>
                  <a:pt x="107" y="85"/>
                  <a:pt x="107" y="64"/>
                </a:cubicBezTo>
                <a:cubicBezTo>
                  <a:pt x="107" y="44"/>
                  <a:pt x="105" y="30"/>
                  <a:pt x="100" y="23"/>
                </a:cubicBezTo>
                <a:cubicBezTo>
                  <a:pt x="95" y="16"/>
                  <a:pt x="89" y="13"/>
                  <a:pt x="82" y="13"/>
                </a:cubicBezTo>
                <a:cubicBezTo>
                  <a:pt x="75" y="13"/>
                  <a:pt x="69" y="16"/>
                  <a:pt x="65" y="22"/>
                </a:cubicBezTo>
                <a:cubicBezTo>
                  <a:pt x="60" y="29"/>
                  <a:pt x="57" y="44"/>
                  <a:pt x="57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3" name="Line 20"/>
          <p:cNvSpPr>
            <a:spLocks noChangeShapeType="1"/>
          </p:cNvSpPr>
          <p:nvPr/>
        </p:nvSpPr>
        <p:spPr bwMode="auto">
          <a:xfrm flipH="1">
            <a:off x="6060090" y="5541036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4" name="Line 21"/>
          <p:cNvSpPr>
            <a:spLocks noChangeShapeType="1"/>
          </p:cNvSpPr>
          <p:nvPr/>
        </p:nvSpPr>
        <p:spPr bwMode="auto">
          <a:xfrm flipH="1">
            <a:off x="6060090" y="4827603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5" name="Line 22"/>
          <p:cNvSpPr>
            <a:spLocks noChangeShapeType="1"/>
          </p:cNvSpPr>
          <p:nvPr/>
        </p:nvSpPr>
        <p:spPr bwMode="auto">
          <a:xfrm flipH="1">
            <a:off x="6060090" y="4117024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6" name="Line 23"/>
          <p:cNvSpPr>
            <a:spLocks noChangeShapeType="1"/>
          </p:cNvSpPr>
          <p:nvPr/>
        </p:nvSpPr>
        <p:spPr bwMode="auto">
          <a:xfrm flipH="1">
            <a:off x="6060090" y="3406445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7" name="Line 24"/>
          <p:cNvSpPr>
            <a:spLocks noChangeShapeType="1"/>
          </p:cNvSpPr>
          <p:nvPr/>
        </p:nvSpPr>
        <p:spPr bwMode="auto">
          <a:xfrm flipH="1">
            <a:off x="6060090" y="2695866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8" name="Line 25"/>
          <p:cNvSpPr>
            <a:spLocks noChangeShapeType="1"/>
          </p:cNvSpPr>
          <p:nvPr/>
        </p:nvSpPr>
        <p:spPr bwMode="auto">
          <a:xfrm flipH="1">
            <a:off x="6060090" y="1982433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0" name="Freeform 27"/>
          <p:cNvSpPr>
            <a:spLocks noEditPoints="1"/>
          </p:cNvSpPr>
          <p:nvPr/>
        </p:nvSpPr>
        <p:spPr bwMode="auto">
          <a:xfrm>
            <a:off x="5925964" y="1959604"/>
            <a:ext cx="131272" cy="91319"/>
          </a:xfrm>
          <a:custGeom>
            <a:avLst/>
            <a:gdLst>
              <a:gd name="T0" fmla="*/ 46 w 214"/>
              <a:gd name="T1" fmla="*/ 127 h 152"/>
              <a:gd name="T2" fmla="*/ 30 w 214"/>
              <a:gd name="T3" fmla="*/ 127 h 152"/>
              <a:gd name="T4" fmla="*/ 30 w 214"/>
              <a:gd name="T5" fmla="*/ 28 h 152"/>
              <a:gd name="T6" fmla="*/ 16 w 214"/>
              <a:gd name="T7" fmla="*/ 39 h 152"/>
              <a:gd name="T8" fmla="*/ 0 w 214"/>
              <a:gd name="T9" fmla="*/ 47 h 152"/>
              <a:gd name="T10" fmla="*/ 0 w 214"/>
              <a:gd name="T11" fmla="*/ 32 h 152"/>
              <a:gd name="T12" fmla="*/ 22 w 214"/>
              <a:gd name="T13" fmla="*/ 17 h 152"/>
              <a:gd name="T14" fmla="*/ 36 w 214"/>
              <a:gd name="T15" fmla="*/ 0 h 152"/>
              <a:gd name="T16" fmla="*/ 46 w 214"/>
              <a:gd name="T17" fmla="*/ 0 h 152"/>
              <a:gd name="T18" fmla="*/ 46 w 214"/>
              <a:gd name="T19" fmla="*/ 127 h 152"/>
              <a:gd name="T20" fmla="*/ 92 w 214"/>
              <a:gd name="T21" fmla="*/ 127 h 152"/>
              <a:gd name="T22" fmla="*/ 92 w 214"/>
              <a:gd name="T23" fmla="*/ 109 h 152"/>
              <a:gd name="T24" fmla="*/ 110 w 214"/>
              <a:gd name="T25" fmla="*/ 109 h 152"/>
              <a:gd name="T26" fmla="*/ 110 w 214"/>
              <a:gd name="T27" fmla="*/ 127 h 152"/>
              <a:gd name="T28" fmla="*/ 106 w 214"/>
              <a:gd name="T29" fmla="*/ 142 h 152"/>
              <a:gd name="T30" fmla="*/ 95 w 214"/>
              <a:gd name="T31" fmla="*/ 152 h 152"/>
              <a:gd name="T32" fmla="*/ 91 w 214"/>
              <a:gd name="T33" fmla="*/ 145 h 152"/>
              <a:gd name="T34" fmla="*/ 98 w 214"/>
              <a:gd name="T35" fmla="*/ 139 h 152"/>
              <a:gd name="T36" fmla="*/ 101 w 214"/>
              <a:gd name="T37" fmla="*/ 127 h 152"/>
              <a:gd name="T38" fmla="*/ 92 w 214"/>
              <a:gd name="T39" fmla="*/ 127 h 152"/>
              <a:gd name="T40" fmla="*/ 132 w 214"/>
              <a:gd name="T41" fmla="*/ 64 h 152"/>
              <a:gd name="T42" fmla="*/ 136 w 214"/>
              <a:gd name="T43" fmla="*/ 28 h 152"/>
              <a:gd name="T44" fmla="*/ 150 w 214"/>
              <a:gd name="T45" fmla="*/ 7 h 152"/>
              <a:gd name="T46" fmla="*/ 173 w 214"/>
              <a:gd name="T47" fmla="*/ 0 h 152"/>
              <a:gd name="T48" fmla="*/ 190 w 214"/>
              <a:gd name="T49" fmla="*/ 4 h 152"/>
              <a:gd name="T50" fmla="*/ 203 w 214"/>
              <a:gd name="T51" fmla="*/ 16 h 152"/>
              <a:gd name="T52" fmla="*/ 211 w 214"/>
              <a:gd name="T53" fmla="*/ 35 h 152"/>
              <a:gd name="T54" fmla="*/ 214 w 214"/>
              <a:gd name="T55" fmla="*/ 64 h 152"/>
              <a:gd name="T56" fmla="*/ 209 w 214"/>
              <a:gd name="T57" fmla="*/ 100 h 152"/>
              <a:gd name="T58" fmla="*/ 196 w 214"/>
              <a:gd name="T59" fmla="*/ 121 h 152"/>
              <a:gd name="T60" fmla="*/ 173 w 214"/>
              <a:gd name="T61" fmla="*/ 129 h 152"/>
              <a:gd name="T62" fmla="*/ 144 w 214"/>
              <a:gd name="T63" fmla="*/ 116 h 152"/>
              <a:gd name="T64" fmla="*/ 132 w 214"/>
              <a:gd name="T65" fmla="*/ 64 h 152"/>
              <a:gd name="T66" fmla="*/ 148 w 214"/>
              <a:gd name="T67" fmla="*/ 64 h 152"/>
              <a:gd name="T68" fmla="*/ 155 w 214"/>
              <a:gd name="T69" fmla="*/ 106 h 152"/>
              <a:gd name="T70" fmla="*/ 173 w 214"/>
              <a:gd name="T71" fmla="*/ 116 h 152"/>
              <a:gd name="T72" fmla="*/ 191 w 214"/>
              <a:gd name="T73" fmla="*/ 106 h 152"/>
              <a:gd name="T74" fmla="*/ 198 w 214"/>
              <a:gd name="T75" fmla="*/ 64 h 152"/>
              <a:gd name="T76" fmla="*/ 191 w 214"/>
              <a:gd name="T77" fmla="*/ 23 h 152"/>
              <a:gd name="T78" fmla="*/ 173 w 214"/>
              <a:gd name="T79" fmla="*/ 13 h 152"/>
              <a:gd name="T80" fmla="*/ 156 w 214"/>
              <a:gd name="T81" fmla="*/ 22 h 152"/>
              <a:gd name="T82" fmla="*/ 148 w 214"/>
              <a:gd name="T83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</a:cxnLst>
            <a:rect l="0" t="0" r="r" b="b"/>
            <a:pathLst>
              <a:path w="214" h="152">
                <a:moveTo>
                  <a:pt x="46" y="127"/>
                </a:moveTo>
                <a:lnTo>
                  <a:pt x="30" y="127"/>
                </a:lnTo>
                <a:lnTo>
                  <a:pt x="30" y="28"/>
                </a:lnTo>
                <a:cubicBezTo>
                  <a:pt x="27" y="32"/>
                  <a:pt x="22" y="35"/>
                  <a:pt x="16" y="39"/>
                </a:cubicBezTo>
                <a:cubicBezTo>
                  <a:pt x="10" y="42"/>
                  <a:pt x="4" y="45"/>
                  <a:pt x="0" y="47"/>
                </a:cubicBezTo>
                <a:lnTo>
                  <a:pt x="0" y="32"/>
                </a:lnTo>
                <a:cubicBezTo>
                  <a:pt x="8" y="28"/>
                  <a:pt x="16" y="23"/>
                  <a:pt x="22" y="17"/>
                </a:cubicBezTo>
                <a:cubicBezTo>
                  <a:pt x="29" y="11"/>
                  <a:pt x="33" y="6"/>
                  <a:pt x="36" y="0"/>
                </a:cubicBezTo>
                <a:lnTo>
                  <a:pt x="46" y="0"/>
                </a:lnTo>
                <a:lnTo>
                  <a:pt x="46" y="127"/>
                </a:lnTo>
                <a:close/>
                <a:moveTo>
                  <a:pt x="92" y="127"/>
                </a:moveTo>
                <a:lnTo>
                  <a:pt x="92" y="109"/>
                </a:lnTo>
                <a:lnTo>
                  <a:pt x="110" y="109"/>
                </a:lnTo>
                <a:lnTo>
                  <a:pt x="110" y="127"/>
                </a:lnTo>
                <a:cubicBezTo>
                  <a:pt x="110" y="133"/>
                  <a:pt x="108" y="138"/>
                  <a:pt x="106" y="142"/>
                </a:cubicBezTo>
                <a:cubicBezTo>
                  <a:pt x="104" y="146"/>
                  <a:pt x="100" y="149"/>
                  <a:pt x="95" y="152"/>
                </a:cubicBezTo>
                <a:lnTo>
                  <a:pt x="91" y="145"/>
                </a:lnTo>
                <a:cubicBezTo>
                  <a:pt x="94" y="144"/>
                  <a:pt x="97" y="141"/>
                  <a:pt x="98" y="139"/>
                </a:cubicBezTo>
                <a:cubicBezTo>
                  <a:pt x="100" y="136"/>
                  <a:pt x="101" y="132"/>
                  <a:pt x="101" y="127"/>
                </a:cubicBezTo>
                <a:lnTo>
                  <a:pt x="92" y="127"/>
                </a:lnTo>
                <a:close/>
                <a:moveTo>
                  <a:pt x="132" y="64"/>
                </a:moveTo>
                <a:cubicBezTo>
                  <a:pt x="132" y="50"/>
                  <a:pt x="133" y="38"/>
                  <a:pt x="136" y="28"/>
                </a:cubicBezTo>
                <a:cubicBezTo>
                  <a:pt x="139" y="19"/>
                  <a:pt x="144" y="12"/>
                  <a:pt x="150" y="7"/>
                </a:cubicBezTo>
                <a:cubicBezTo>
                  <a:pt x="156" y="3"/>
                  <a:pt x="164" y="0"/>
                  <a:pt x="173" y="0"/>
                </a:cubicBezTo>
                <a:cubicBezTo>
                  <a:pt x="180" y="0"/>
                  <a:pt x="185" y="1"/>
                  <a:pt x="190" y="4"/>
                </a:cubicBezTo>
                <a:cubicBezTo>
                  <a:pt x="196" y="7"/>
                  <a:pt x="200" y="11"/>
                  <a:pt x="203" y="16"/>
                </a:cubicBezTo>
                <a:cubicBezTo>
                  <a:pt x="206" y="21"/>
                  <a:pt x="209" y="27"/>
                  <a:pt x="211" y="35"/>
                </a:cubicBezTo>
                <a:cubicBezTo>
                  <a:pt x="213" y="42"/>
                  <a:pt x="214" y="52"/>
                  <a:pt x="214" y="64"/>
                </a:cubicBezTo>
                <a:cubicBezTo>
                  <a:pt x="214" y="79"/>
                  <a:pt x="212" y="91"/>
                  <a:pt x="209" y="100"/>
                </a:cubicBezTo>
                <a:cubicBezTo>
                  <a:pt x="206" y="109"/>
                  <a:pt x="202" y="116"/>
                  <a:pt x="196" y="121"/>
                </a:cubicBezTo>
                <a:cubicBezTo>
                  <a:pt x="190" y="126"/>
                  <a:pt x="182" y="129"/>
                  <a:pt x="173" y="129"/>
                </a:cubicBezTo>
                <a:cubicBezTo>
                  <a:pt x="161" y="129"/>
                  <a:pt x="151" y="124"/>
                  <a:pt x="144" y="116"/>
                </a:cubicBezTo>
                <a:cubicBezTo>
                  <a:pt x="136" y="105"/>
                  <a:pt x="132" y="88"/>
                  <a:pt x="132" y="64"/>
                </a:cubicBezTo>
                <a:close/>
                <a:moveTo>
                  <a:pt x="148" y="64"/>
                </a:moveTo>
                <a:cubicBezTo>
                  <a:pt x="148" y="85"/>
                  <a:pt x="150" y="99"/>
                  <a:pt x="155" y="106"/>
                </a:cubicBezTo>
                <a:cubicBezTo>
                  <a:pt x="160" y="113"/>
                  <a:pt x="166" y="116"/>
                  <a:pt x="173" y="116"/>
                </a:cubicBezTo>
                <a:cubicBezTo>
                  <a:pt x="180" y="116"/>
                  <a:pt x="186" y="113"/>
                  <a:pt x="191" y="106"/>
                </a:cubicBezTo>
                <a:cubicBezTo>
                  <a:pt x="195" y="99"/>
                  <a:pt x="198" y="85"/>
                  <a:pt x="198" y="64"/>
                </a:cubicBezTo>
                <a:cubicBezTo>
                  <a:pt x="198" y="44"/>
                  <a:pt x="195" y="30"/>
                  <a:pt x="191" y="23"/>
                </a:cubicBezTo>
                <a:cubicBezTo>
                  <a:pt x="186" y="16"/>
                  <a:pt x="180" y="13"/>
                  <a:pt x="173" y="13"/>
                </a:cubicBezTo>
                <a:cubicBezTo>
                  <a:pt x="165" y="13"/>
                  <a:pt x="160" y="16"/>
                  <a:pt x="156" y="22"/>
                </a:cubicBezTo>
                <a:cubicBezTo>
                  <a:pt x="150" y="30"/>
                  <a:pt x="148" y="44"/>
                  <a:pt x="148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1" name="Freeform 28"/>
          <p:cNvSpPr>
            <a:spLocks noEditPoints="1"/>
          </p:cNvSpPr>
          <p:nvPr/>
        </p:nvSpPr>
        <p:spPr bwMode="auto">
          <a:xfrm>
            <a:off x="5920257" y="2670183"/>
            <a:ext cx="136979" cy="91319"/>
          </a:xfrm>
          <a:custGeom>
            <a:avLst/>
            <a:gdLst>
              <a:gd name="T0" fmla="*/ 4 w 227"/>
              <a:gd name="T1" fmla="*/ 29 h 152"/>
              <a:gd name="T2" fmla="*/ 41 w 227"/>
              <a:gd name="T3" fmla="*/ 0 h 152"/>
              <a:gd name="T4" fmla="*/ 71 w 227"/>
              <a:gd name="T5" fmla="*/ 16 h 152"/>
              <a:gd name="T6" fmla="*/ 82 w 227"/>
              <a:gd name="T7" fmla="*/ 65 h 152"/>
              <a:gd name="T8" fmla="*/ 64 w 227"/>
              <a:gd name="T9" fmla="*/ 122 h 152"/>
              <a:gd name="T10" fmla="*/ 12 w 227"/>
              <a:gd name="T11" fmla="*/ 116 h 152"/>
              <a:gd name="T12" fmla="*/ 16 w 227"/>
              <a:gd name="T13" fmla="*/ 65 h 152"/>
              <a:gd name="T14" fmla="*/ 41 w 227"/>
              <a:gd name="T15" fmla="*/ 116 h 152"/>
              <a:gd name="T16" fmla="*/ 66 w 227"/>
              <a:gd name="T17" fmla="*/ 65 h 152"/>
              <a:gd name="T18" fmla="*/ 41 w 227"/>
              <a:gd name="T19" fmla="*/ 13 h 152"/>
              <a:gd name="T20" fmla="*/ 16 w 227"/>
              <a:gd name="T21" fmla="*/ 65 h 152"/>
              <a:gd name="T22" fmla="*/ 104 w 227"/>
              <a:gd name="T23" fmla="*/ 109 h 152"/>
              <a:gd name="T24" fmla="*/ 122 w 227"/>
              <a:gd name="T25" fmla="*/ 127 h 152"/>
              <a:gd name="T26" fmla="*/ 107 w 227"/>
              <a:gd name="T27" fmla="*/ 152 h 152"/>
              <a:gd name="T28" fmla="*/ 110 w 227"/>
              <a:gd name="T29" fmla="*/ 139 h 152"/>
              <a:gd name="T30" fmla="*/ 104 w 227"/>
              <a:gd name="T31" fmla="*/ 127 h 152"/>
              <a:gd name="T32" fmla="*/ 153 w 227"/>
              <a:gd name="T33" fmla="*/ 48 h 152"/>
              <a:gd name="T34" fmla="*/ 158 w 227"/>
              <a:gd name="T35" fmla="*/ 10 h 152"/>
              <a:gd name="T36" fmla="*/ 211 w 227"/>
              <a:gd name="T37" fmla="*/ 10 h 152"/>
              <a:gd name="T38" fmla="*/ 217 w 227"/>
              <a:gd name="T39" fmla="*/ 49 h 152"/>
              <a:gd name="T40" fmla="*/ 220 w 227"/>
              <a:gd name="T41" fmla="*/ 71 h 152"/>
              <a:gd name="T42" fmla="*/ 215 w 227"/>
              <a:gd name="T43" fmla="*/ 118 h 152"/>
              <a:gd name="T44" fmla="*/ 155 w 227"/>
              <a:gd name="T45" fmla="*/ 118 h 152"/>
              <a:gd name="T46" fmla="*/ 150 w 227"/>
              <a:gd name="T47" fmla="*/ 70 h 152"/>
              <a:gd name="T48" fmla="*/ 164 w 227"/>
              <a:gd name="T49" fmla="*/ 32 h 152"/>
              <a:gd name="T50" fmla="*/ 185 w 227"/>
              <a:gd name="T51" fmla="*/ 53 h 152"/>
              <a:gd name="T52" fmla="*/ 205 w 227"/>
              <a:gd name="T53" fmla="*/ 33 h 152"/>
              <a:gd name="T54" fmla="*/ 185 w 227"/>
              <a:gd name="T55" fmla="*/ 13 h 152"/>
              <a:gd name="T56" fmla="*/ 164 w 227"/>
              <a:gd name="T57" fmla="*/ 32 h 152"/>
              <a:gd name="T58" fmla="*/ 162 w 227"/>
              <a:gd name="T59" fmla="*/ 103 h 152"/>
              <a:gd name="T60" fmla="*/ 185 w 227"/>
              <a:gd name="T61" fmla="*/ 116 h 152"/>
              <a:gd name="T62" fmla="*/ 211 w 227"/>
              <a:gd name="T63" fmla="*/ 91 h 152"/>
              <a:gd name="T64" fmla="*/ 185 w 227"/>
              <a:gd name="T65" fmla="*/ 65 h 152"/>
              <a:gd name="T66" fmla="*/ 159 w 227"/>
              <a:gd name="T67" fmla="*/ 91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227" h="152">
                <a:moveTo>
                  <a:pt x="0" y="65"/>
                </a:moveTo>
                <a:cubicBezTo>
                  <a:pt x="0" y="50"/>
                  <a:pt x="1" y="38"/>
                  <a:pt x="4" y="29"/>
                </a:cubicBezTo>
                <a:cubicBezTo>
                  <a:pt x="7" y="20"/>
                  <a:pt x="12" y="13"/>
                  <a:pt x="18" y="8"/>
                </a:cubicBezTo>
                <a:cubicBezTo>
                  <a:pt x="24" y="3"/>
                  <a:pt x="32" y="0"/>
                  <a:pt x="41" y="0"/>
                </a:cubicBezTo>
                <a:cubicBezTo>
                  <a:pt x="48" y="0"/>
                  <a:pt x="53" y="2"/>
                  <a:pt x="58" y="4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7"/>
                  <a:pt x="79" y="35"/>
                </a:cubicBezTo>
                <a:cubicBezTo>
                  <a:pt x="81" y="42"/>
                  <a:pt x="82" y="52"/>
                  <a:pt x="82" y="65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7"/>
                  <a:pt x="64" y="122"/>
                </a:cubicBezTo>
                <a:cubicBezTo>
                  <a:pt x="58" y="127"/>
                  <a:pt x="50" y="129"/>
                  <a:pt x="41" y="129"/>
                </a:cubicBezTo>
                <a:cubicBezTo>
                  <a:pt x="29" y="129"/>
                  <a:pt x="19" y="125"/>
                  <a:pt x="12" y="116"/>
                </a:cubicBezTo>
                <a:cubicBezTo>
                  <a:pt x="4" y="105"/>
                  <a:pt x="0" y="88"/>
                  <a:pt x="0" y="65"/>
                </a:cubicBezTo>
                <a:close/>
                <a:moveTo>
                  <a:pt x="16" y="65"/>
                </a:moveTo>
                <a:cubicBezTo>
                  <a:pt x="16" y="85"/>
                  <a:pt x="18" y="99"/>
                  <a:pt x="23" y="106"/>
                </a:cubicBezTo>
                <a:cubicBezTo>
                  <a:pt x="28" y="113"/>
                  <a:pt x="34" y="116"/>
                  <a:pt x="41" y="116"/>
                </a:cubicBezTo>
                <a:cubicBezTo>
                  <a:pt x="48" y="116"/>
                  <a:pt x="54" y="113"/>
                  <a:pt x="59" y="106"/>
                </a:cubicBezTo>
                <a:cubicBezTo>
                  <a:pt x="63" y="99"/>
                  <a:pt x="66" y="85"/>
                  <a:pt x="66" y="65"/>
                </a:cubicBezTo>
                <a:cubicBezTo>
                  <a:pt x="66" y="44"/>
                  <a:pt x="63" y="30"/>
                  <a:pt x="59" y="23"/>
                </a:cubicBezTo>
                <a:cubicBezTo>
                  <a:pt x="54" y="16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30"/>
                  <a:pt x="16" y="44"/>
                  <a:pt x="16" y="65"/>
                </a:cubicBezTo>
                <a:close/>
                <a:moveTo>
                  <a:pt x="104" y="127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7"/>
                </a:lnTo>
                <a:cubicBezTo>
                  <a:pt x="122" y="133"/>
                  <a:pt x="120" y="139"/>
                  <a:pt x="118" y="143"/>
                </a:cubicBezTo>
                <a:cubicBezTo>
                  <a:pt x="116" y="147"/>
                  <a:pt x="112" y="150"/>
                  <a:pt x="107" y="152"/>
                </a:cubicBezTo>
                <a:lnTo>
                  <a:pt x="103" y="145"/>
                </a:lnTo>
                <a:cubicBezTo>
                  <a:pt x="106" y="144"/>
                  <a:pt x="109" y="142"/>
                  <a:pt x="110" y="139"/>
                </a:cubicBezTo>
                <a:cubicBezTo>
                  <a:pt x="112" y="136"/>
                  <a:pt x="113" y="132"/>
                  <a:pt x="113" y="127"/>
                </a:cubicBezTo>
                <a:lnTo>
                  <a:pt x="104" y="127"/>
                </a:lnTo>
                <a:close/>
                <a:moveTo>
                  <a:pt x="167" y="59"/>
                </a:moveTo>
                <a:cubicBezTo>
                  <a:pt x="161" y="56"/>
                  <a:pt x="156" y="53"/>
                  <a:pt x="153" y="48"/>
                </a:cubicBezTo>
                <a:cubicBezTo>
                  <a:pt x="150" y="44"/>
                  <a:pt x="149" y="39"/>
                  <a:pt x="149" y="33"/>
                </a:cubicBezTo>
                <a:cubicBezTo>
                  <a:pt x="149" y="24"/>
                  <a:pt x="152" y="16"/>
                  <a:pt x="158" y="10"/>
                </a:cubicBezTo>
                <a:cubicBezTo>
                  <a:pt x="165" y="3"/>
                  <a:pt x="174" y="0"/>
                  <a:pt x="185" y="0"/>
                </a:cubicBezTo>
                <a:cubicBezTo>
                  <a:pt x="196" y="0"/>
                  <a:pt x="205" y="3"/>
                  <a:pt x="211" y="10"/>
                </a:cubicBezTo>
                <a:cubicBezTo>
                  <a:pt x="218" y="16"/>
                  <a:pt x="221" y="24"/>
                  <a:pt x="221" y="33"/>
                </a:cubicBezTo>
                <a:cubicBezTo>
                  <a:pt x="221" y="39"/>
                  <a:pt x="220" y="44"/>
                  <a:pt x="217" y="49"/>
                </a:cubicBezTo>
                <a:cubicBezTo>
                  <a:pt x="214" y="53"/>
                  <a:pt x="209" y="56"/>
                  <a:pt x="203" y="59"/>
                </a:cubicBezTo>
                <a:cubicBezTo>
                  <a:pt x="211" y="61"/>
                  <a:pt x="216" y="65"/>
                  <a:pt x="220" y="71"/>
                </a:cubicBezTo>
                <a:cubicBezTo>
                  <a:pt x="225" y="76"/>
                  <a:pt x="227" y="83"/>
                  <a:pt x="227" y="91"/>
                </a:cubicBezTo>
                <a:cubicBezTo>
                  <a:pt x="227" y="102"/>
                  <a:pt x="223" y="111"/>
                  <a:pt x="215" y="118"/>
                </a:cubicBezTo>
                <a:cubicBezTo>
                  <a:pt x="207" y="125"/>
                  <a:pt x="197" y="129"/>
                  <a:pt x="185" y="129"/>
                </a:cubicBezTo>
                <a:cubicBezTo>
                  <a:pt x="173" y="129"/>
                  <a:pt x="163" y="125"/>
                  <a:pt x="155" y="118"/>
                </a:cubicBezTo>
                <a:cubicBezTo>
                  <a:pt x="147" y="110"/>
                  <a:pt x="144" y="101"/>
                  <a:pt x="144" y="90"/>
                </a:cubicBezTo>
                <a:cubicBezTo>
                  <a:pt x="144" y="82"/>
                  <a:pt x="146" y="75"/>
                  <a:pt x="150" y="70"/>
                </a:cubicBezTo>
                <a:cubicBezTo>
                  <a:pt x="154" y="64"/>
                  <a:pt x="160" y="61"/>
                  <a:pt x="167" y="59"/>
                </a:cubicBezTo>
                <a:close/>
                <a:moveTo>
                  <a:pt x="164" y="32"/>
                </a:moveTo>
                <a:cubicBezTo>
                  <a:pt x="164" y="38"/>
                  <a:pt x="166" y="43"/>
                  <a:pt x="170" y="47"/>
                </a:cubicBezTo>
                <a:cubicBezTo>
                  <a:pt x="174" y="51"/>
                  <a:pt x="179" y="53"/>
                  <a:pt x="185" y="53"/>
                </a:cubicBezTo>
                <a:cubicBezTo>
                  <a:pt x="191" y="53"/>
                  <a:pt x="196" y="51"/>
                  <a:pt x="200" y="47"/>
                </a:cubicBezTo>
                <a:cubicBezTo>
                  <a:pt x="203" y="43"/>
                  <a:pt x="205" y="39"/>
                  <a:pt x="205" y="33"/>
                </a:cubicBezTo>
                <a:cubicBezTo>
                  <a:pt x="205" y="27"/>
                  <a:pt x="203" y="23"/>
                  <a:pt x="199" y="19"/>
                </a:cubicBezTo>
                <a:cubicBezTo>
                  <a:pt x="196" y="15"/>
                  <a:pt x="191" y="13"/>
                  <a:pt x="185" y="13"/>
                </a:cubicBezTo>
                <a:cubicBezTo>
                  <a:pt x="179" y="13"/>
                  <a:pt x="174" y="15"/>
                  <a:pt x="170" y="19"/>
                </a:cubicBezTo>
                <a:cubicBezTo>
                  <a:pt x="166" y="22"/>
                  <a:pt x="164" y="27"/>
                  <a:pt x="164" y="32"/>
                </a:cubicBezTo>
                <a:close/>
                <a:moveTo>
                  <a:pt x="159" y="91"/>
                </a:moveTo>
                <a:cubicBezTo>
                  <a:pt x="159" y="95"/>
                  <a:pt x="160" y="99"/>
                  <a:pt x="162" y="103"/>
                </a:cubicBezTo>
                <a:cubicBezTo>
                  <a:pt x="165" y="107"/>
                  <a:pt x="168" y="111"/>
                  <a:pt x="172" y="113"/>
                </a:cubicBezTo>
                <a:cubicBezTo>
                  <a:pt x="176" y="115"/>
                  <a:pt x="180" y="116"/>
                  <a:pt x="185" y="116"/>
                </a:cubicBezTo>
                <a:cubicBezTo>
                  <a:pt x="193" y="116"/>
                  <a:pt x="199" y="114"/>
                  <a:pt x="203" y="109"/>
                </a:cubicBezTo>
                <a:cubicBezTo>
                  <a:pt x="208" y="104"/>
                  <a:pt x="211" y="98"/>
                  <a:pt x="211" y="91"/>
                </a:cubicBezTo>
                <a:cubicBezTo>
                  <a:pt x="211" y="84"/>
                  <a:pt x="208" y="77"/>
                  <a:pt x="203" y="73"/>
                </a:cubicBezTo>
                <a:cubicBezTo>
                  <a:pt x="198" y="68"/>
                  <a:pt x="192" y="65"/>
                  <a:pt x="185" y="65"/>
                </a:cubicBezTo>
                <a:cubicBezTo>
                  <a:pt x="177" y="65"/>
                  <a:pt x="171" y="68"/>
                  <a:pt x="167" y="72"/>
                </a:cubicBezTo>
                <a:cubicBezTo>
                  <a:pt x="162" y="77"/>
                  <a:pt x="159" y="83"/>
                  <a:pt x="159" y="9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2" name="Freeform 29"/>
          <p:cNvSpPr>
            <a:spLocks noEditPoints="1"/>
          </p:cNvSpPr>
          <p:nvPr/>
        </p:nvSpPr>
        <p:spPr bwMode="auto">
          <a:xfrm>
            <a:off x="5920257" y="3380762"/>
            <a:ext cx="136979" cy="94173"/>
          </a:xfrm>
          <a:custGeom>
            <a:avLst/>
            <a:gdLst>
              <a:gd name="T0" fmla="*/ 0 w 226"/>
              <a:gd name="T1" fmla="*/ 65 h 152"/>
              <a:gd name="T2" fmla="*/ 4 w 226"/>
              <a:gd name="T3" fmla="*/ 29 h 152"/>
              <a:gd name="T4" fmla="*/ 18 w 226"/>
              <a:gd name="T5" fmla="*/ 8 h 152"/>
              <a:gd name="T6" fmla="*/ 41 w 226"/>
              <a:gd name="T7" fmla="*/ 0 h 152"/>
              <a:gd name="T8" fmla="*/ 58 w 226"/>
              <a:gd name="T9" fmla="*/ 5 h 152"/>
              <a:gd name="T10" fmla="*/ 71 w 226"/>
              <a:gd name="T11" fmla="*/ 16 h 152"/>
              <a:gd name="T12" fmla="*/ 79 w 226"/>
              <a:gd name="T13" fmla="*/ 35 h 152"/>
              <a:gd name="T14" fmla="*/ 82 w 226"/>
              <a:gd name="T15" fmla="*/ 65 h 152"/>
              <a:gd name="T16" fmla="*/ 77 w 226"/>
              <a:gd name="T17" fmla="*/ 101 h 152"/>
              <a:gd name="T18" fmla="*/ 64 w 226"/>
              <a:gd name="T19" fmla="*/ 122 h 152"/>
              <a:gd name="T20" fmla="*/ 41 w 226"/>
              <a:gd name="T21" fmla="*/ 129 h 152"/>
              <a:gd name="T22" fmla="*/ 12 w 226"/>
              <a:gd name="T23" fmla="*/ 116 h 152"/>
              <a:gd name="T24" fmla="*/ 0 w 226"/>
              <a:gd name="T25" fmla="*/ 65 h 152"/>
              <a:gd name="T26" fmla="*/ 16 w 226"/>
              <a:gd name="T27" fmla="*/ 65 h 152"/>
              <a:gd name="T28" fmla="*/ 23 w 226"/>
              <a:gd name="T29" fmla="*/ 106 h 152"/>
              <a:gd name="T30" fmla="*/ 41 w 226"/>
              <a:gd name="T31" fmla="*/ 116 h 152"/>
              <a:gd name="T32" fmla="*/ 59 w 226"/>
              <a:gd name="T33" fmla="*/ 106 h 152"/>
              <a:gd name="T34" fmla="*/ 66 w 226"/>
              <a:gd name="T35" fmla="*/ 65 h 152"/>
              <a:gd name="T36" fmla="*/ 59 w 226"/>
              <a:gd name="T37" fmla="*/ 23 h 152"/>
              <a:gd name="T38" fmla="*/ 41 w 226"/>
              <a:gd name="T39" fmla="*/ 13 h 152"/>
              <a:gd name="T40" fmla="*/ 24 w 226"/>
              <a:gd name="T41" fmla="*/ 22 h 152"/>
              <a:gd name="T42" fmla="*/ 16 w 226"/>
              <a:gd name="T43" fmla="*/ 65 h 152"/>
              <a:gd name="T44" fmla="*/ 104 w 226"/>
              <a:gd name="T45" fmla="*/ 127 h 152"/>
              <a:gd name="T46" fmla="*/ 104 w 226"/>
              <a:gd name="T47" fmla="*/ 109 h 152"/>
              <a:gd name="T48" fmla="*/ 122 w 226"/>
              <a:gd name="T49" fmla="*/ 109 h 152"/>
              <a:gd name="T50" fmla="*/ 122 w 226"/>
              <a:gd name="T51" fmla="*/ 127 h 152"/>
              <a:gd name="T52" fmla="*/ 118 w 226"/>
              <a:gd name="T53" fmla="*/ 143 h 152"/>
              <a:gd name="T54" fmla="*/ 107 w 226"/>
              <a:gd name="T55" fmla="*/ 152 h 152"/>
              <a:gd name="T56" fmla="*/ 103 w 226"/>
              <a:gd name="T57" fmla="*/ 145 h 152"/>
              <a:gd name="T58" fmla="*/ 110 w 226"/>
              <a:gd name="T59" fmla="*/ 139 h 152"/>
              <a:gd name="T60" fmla="*/ 113 w 226"/>
              <a:gd name="T61" fmla="*/ 127 h 152"/>
              <a:gd name="T62" fmla="*/ 104 w 226"/>
              <a:gd name="T63" fmla="*/ 127 h 152"/>
              <a:gd name="T64" fmla="*/ 224 w 226"/>
              <a:gd name="T65" fmla="*/ 32 h 152"/>
              <a:gd name="T66" fmla="*/ 209 w 226"/>
              <a:gd name="T67" fmla="*/ 33 h 152"/>
              <a:gd name="T68" fmla="*/ 203 w 226"/>
              <a:gd name="T69" fmla="*/ 20 h 152"/>
              <a:gd name="T70" fmla="*/ 187 w 226"/>
              <a:gd name="T71" fmla="*/ 13 h 152"/>
              <a:gd name="T72" fmla="*/ 174 w 226"/>
              <a:gd name="T73" fmla="*/ 17 h 152"/>
              <a:gd name="T74" fmla="*/ 163 w 226"/>
              <a:gd name="T75" fmla="*/ 33 h 152"/>
              <a:gd name="T76" fmla="*/ 158 w 226"/>
              <a:gd name="T77" fmla="*/ 62 h 152"/>
              <a:gd name="T78" fmla="*/ 172 w 226"/>
              <a:gd name="T79" fmla="*/ 49 h 152"/>
              <a:gd name="T80" fmla="*/ 189 w 226"/>
              <a:gd name="T81" fmla="*/ 45 h 152"/>
              <a:gd name="T82" fmla="*/ 215 w 226"/>
              <a:gd name="T83" fmla="*/ 57 h 152"/>
              <a:gd name="T84" fmla="*/ 226 w 226"/>
              <a:gd name="T85" fmla="*/ 86 h 152"/>
              <a:gd name="T86" fmla="*/ 221 w 226"/>
              <a:gd name="T87" fmla="*/ 108 h 152"/>
              <a:gd name="T88" fmla="*/ 207 w 226"/>
              <a:gd name="T89" fmla="*/ 124 h 152"/>
              <a:gd name="T90" fmla="*/ 187 w 226"/>
              <a:gd name="T91" fmla="*/ 129 h 152"/>
              <a:gd name="T92" fmla="*/ 155 w 226"/>
              <a:gd name="T93" fmla="*/ 115 h 152"/>
              <a:gd name="T94" fmla="*/ 143 w 226"/>
              <a:gd name="T95" fmla="*/ 68 h 152"/>
              <a:gd name="T96" fmla="*/ 156 w 226"/>
              <a:gd name="T97" fmla="*/ 15 h 152"/>
              <a:gd name="T98" fmla="*/ 188 w 226"/>
              <a:gd name="T99" fmla="*/ 0 h 152"/>
              <a:gd name="T100" fmla="*/ 213 w 226"/>
              <a:gd name="T101" fmla="*/ 9 h 152"/>
              <a:gd name="T102" fmla="*/ 224 w 226"/>
              <a:gd name="T103" fmla="*/ 32 h 152"/>
              <a:gd name="T104" fmla="*/ 161 w 226"/>
              <a:gd name="T105" fmla="*/ 86 h 152"/>
              <a:gd name="T106" fmla="*/ 164 w 226"/>
              <a:gd name="T107" fmla="*/ 101 h 152"/>
              <a:gd name="T108" fmla="*/ 174 w 226"/>
              <a:gd name="T109" fmla="*/ 113 h 152"/>
              <a:gd name="T110" fmla="*/ 186 w 226"/>
              <a:gd name="T111" fmla="*/ 116 h 152"/>
              <a:gd name="T112" fmla="*/ 203 w 226"/>
              <a:gd name="T113" fmla="*/ 108 h 152"/>
              <a:gd name="T114" fmla="*/ 210 w 226"/>
              <a:gd name="T115" fmla="*/ 87 h 152"/>
              <a:gd name="T116" fmla="*/ 203 w 226"/>
              <a:gd name="T117" fmla="*/ 66 h 152"/>
              <a:gd name="T118" fmla="*/ 186 w 226"/>
              <a:gd name="T119" fmla="*/ 59 h 152"/>
              <a:gd name="T120" fmla="*/ 168 w 226"/>
              <a:gd name="T121" fmla="*/ 66 h 152"/>
              <a:gd name="T122" fmla="*/ 161 w 226"/>
              <a:gd name="T123" fmla="*/ 86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26" h="152">
                <a:moveTo>
                  <a:pt x="0" y="65"/>
                </a:moveTo>
                <a:cubicBezTo>
                  <a:pt x="0" y="50"/>
                  <a:pt x="1" y="38"/>
                  <a:pt x="4" y="29"/>
                </a:cubicBezTo>
                <a:cubicBezTo>
                  <a:pt x="7" y="20"/>
                  <a:pt x="12" y="13"/>
                  <a:pt x="18" y="8"/>
                </a:cubicBezTo>
                <a:cubicBezTo>
                  <a:pt x="24" y="3"/>
                  <a:pt x="32" y="0"/>
                  <a:pt x="41" y="0"/>
                </a:cubicBezTo>
                <a:cubicBezTo>
                  <a:pt x="48" y="0"/>
                  <a:pt x="53" y="2"/>
                  <a:pt x="58" y="5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8"/>
                  <a:pt x="79" y="35"/>
                </a:cubicBezTo>
                <a:cubicBezTo>
                  <a:pt x="81" y="43"/>
                  <a:pt x="82" y="52"/>
                  <a:pt x="82" y="65"/>
                </a:cubicBezTo>
                <a:cubicBezTo>
                  <a:pt x="82" y="80"/>
                  <a:pt x="80" y="92"/>
                  <a:pt x="77" y="101"/>
                </a:cubicBezTo>
                <a:cubicBezTo>
                  <a:pt x="74" y="110"/>
                  <a:pt x="70" y="117"/>
                  <a:pt x="64" y="122"/>
                </a:cubicBezTo>
                <a:cubicBezTo>
                  <a:pt x="58" y="127"/>
                  <a:pt x="50" y="129"/>
                  <a:pt x="41" y="129"/>
                </a:cubicBezTo>
                <a:cubicBezTo>
                  <a:pt x="29" y="129"/>
                  <a:pt x="19" y="125"/>
                  <a:pt x="12" y="116"/>
                </a:cubicBezTo>
                <a:cubicBezTo>
                  <a:pt x="4" y="105"/>
                  <a:pt x="0" y="88"/>
                  <a:pt x="0" y="65"/>
                </a:cubicBezTo>
                <a:close/>
                <a:moveTo>
                  <a:pt x="16" y="65"/>
                </a:moveTo>
                <a:cubicBezTo>
                  <a:pt x="16" y="86"/>
                  <a:pt x="18" y="99"/>
                  <a:pt x="23" y="106"/>
                </a:cubicBezTo>
                <a:cubicBezTo>
                  <a:pt x="28" y="113"/>
                  <a:pt x="34" y="116"/>
                  <a:pt x="41" y="116"/>
                </a:cubicBezTo>
                <a:cubicBezTo>
                  <a:pt x="48" y="116"/>
                  <a:pt x="54" y="113"/>
                  <a:pt x="59" y="106"/>
                </a:cubicBezTo>
                <a:cubicBezTo>
                  <a:pt x="63" y="99"/>
                  <a:pt x="66" y="85"/>
                  <a:pt x="66" y="65"/>
                </a:cubicBezTo>
                <a:cubicBezTo>
                  <a:pt x="66" y="44"/>
                  <a:pt x="63" y="30"/>
                  <a:pt x="59" y="23"/>
                </a:cubicBezTo>
                <a:cubicBezTo>
                  <a:pt x="54" y="17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30"/>
                  <a:pt x="16" y="44"/>
                  <a:pt x="16" y="65"/>
                </a:cubicBezTo>
                <a:close/>
                <a:moveTo>
                  <a:pt x="104" y="127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7"/>
                </a:lnTo>
                <a:cubicBezTo>
                  <a:pt x="122" y="133"/>
                  <a:pt x="120" y="139"/>
                  <a:pt x="118" y="143"/>
                </a:cubicBezTo>
                <a:cubicBezTo>
                  <a:pt x="116" y="147"/>
                  <a:pt x="112" y="150"/>
                  <a:pt x="107" y="152"/>
                </a:cubicBezTo>
                <a:lnTo>
                  <a:pt x="103" y="145"/>
                </a:lnTo>
                <a:cubicBezTo>
                  <a:pt x="106" y="144"/>
                  <a:pt x="109" y="142"/>
                  <a:pt x="110" y="139"/>
                </a:cubicBezTo>
                <a:cubicBezTo>
                  <a:pt x="112" y="136"/>
                  <a:pt x="113" y="132"/>
                  <a:pt x="113" y="127"/>
                </a:cubicBezTo>
                <a:lnTo>
                  <a:pt x="104" y="127"/>
                </a:lnTo>
                <a:close/>
                <a:moveTo>
                  <a:pt x="224" y="32"/>
                </a:moveTo>
                <a:lnTo>
                  <a:pt x="209" y="33"/>
                </a:lnTo>
                <a:cubicBezTo>
                  <a:pt x="207" y="27"/>
                  <a:pt x="205" y="23"/>
                  <a:pt x="203" y="20"/>
                </a:cubicBezTo>
                <a:cubicBezTo>
                  <a:pt x="198" y="15"/>
                  <a:pt x="193" y="13"/>
                  <a:pt x="187" y="13"/>
                </a:cubicBezTo>
                <a:cubicBezTo>
                  <a:pt x="182" y="13"/>
                  <a:pt x="178" y="15"/>
                  <a:pt x="174" y="17"/>
                </a:cubicBezTo>
                <a:cubicBezTo>
                  <a:pt x="169" y="21"/>
                  <a:pt x="165" y="26"/>
                  <a:pt x="163" y="33"/>
                </a:cubicBezTo>
                <a:cubicBezTo>
                  <a:pt x="160" y="40"/>
                  <a:pt x="159" y="49"/>
                  <a:pt x="158" y="62"/>
                </a:cubicBezTo>
                <a:cubicBezTo>
                  <a:pt x="162" y="56"/>
                  <a:pt x="167" y="52"/>
                  <a:pt x="172" y="49"/>
                </a:cubicBezTo>
                <a:cubicBezTo>
                  <a:pt x="177" y="47"/>
                  <a:pt x="183" y="45"/>
                  <a:pt x="189" y="45"/>
                </a:cubicBezTo>
                <a:cubicBezTo>
                  <a:pt x="199" y="45"/>
                  <a:pt x="208" y="49"/>
                  <a:pt x="215" y="57"/>
                </a:cubicBezTo>
                <a:cubicBezTo>
                  <a:pt x="222" y="64"/>
                  <a:pt x="226" y="74"/>
                  <a:pt x="226" y="86"/>
                </a:cubicBezTo>
                <a:cubicBezTo>
                  <a:pt x="226" y="94"/>
                  <a:pt x="224" y="101"/>
                  <a:pt x="221" y="108"/>
                </a:cubicBezTo>
                <a:cubicBezTo>
                  <a:pt x="218" y="115"/>
                  <a:pt x="213" y="120"/>
                  <a:pt x="207" y="124"/>
                </a:cubicBezTo>
                <a:cubicBezTo>
                  <a:pt x="201" y="127"/>
                  <a:pt x="194" y="129"/>
                  <a:pt x="187" y="129"/>
                </a:cubicBezTo>
                <a:cubicBezTo>
                  <a:pt x="174" y="129"/>
                  <a:pt x="163" y="124"/>
                  <a:pt x="155" y="115"/>
                </a:cubicBezTo>
                <a:cubicBezTo>
                  <a:pt x="147" y="105"/>
                  <a:pt x="143" y="90"/>
                  <a:pt x="143" y="68"/>
                </a:cubicBezTo>
                <a:cubicBezTo>
                  <a:pt x="143" y="44"/>
                  <a:pt x="147" y="26"/>
                  <a:pt x="156" y="15"/>
                </a:cubicBezTo>
                <a:cubicBezTo>
                  <a:pt x="164" y="5"/>
                  <a:pt x="175" y="0"/>
                  <a:pt x="188" y="0"/>
                </a:cubicBezTo>
                <a:cubicBezTo>
                  <a:pt x="198" y="0"/>
                  <a:pt x="206" y="3"/>
                  <a:pt x="213" y="9"/>
                </a:cubicBezTo>
                <a:cubicBezTo>
                  <a:pt x="219" y="14"/>
                  <a:pt x="223" y="22"/>
                  <a:pt x="224" y="32"/>
                </a:cubicBezTo>
                <a:close/>
                <a:moveTo>
                  <a:pt x="161" y="86"/>
                </a:moveTo>
                <a:cubicBezTo>
                  <a:pt x="161" y="92"/>
                  <a:pt x="162" y="97"/>
                  <a:pt x="164" y="101"/>
                </a:cubicBezTo>
                <a:cubicBezTo>
                  <a:pt x="166" y="106"/>
                  <a:pt x="170" y="110"/>
                  <a:pt x="174" y="113"/>
                </a:cubicBezTo>
                <a:cubicBezTo>
                  <a:pt x="178" y="115"/>
                  <a:pt x="182" y="116"/>
                  <a:pt x="186" y="116"/>
                </a:cubicBezTo>
                <a:cubicBezTo>
                  <a:pt x="193" y="116"/>
                  <a:pt x="199" y="114"/>
                  <a:pt x="203" y="108"/>
                </a:cubicBezTo>
                <a:cubicBezTo>
                  <a:pt x="208" y="103"/>
                  <a:pt x="210" y="96"/>
                  <a:pt x="210" y="87"/>
                </a:cubicBezTo>
                <a:cubicBezTo>
                  <a:pt x="210" y="78"/>
                  <a:pt x="208" y="71"/>
                  <a:pt x="203" y="66"/>
                </a:cubicBezTo>
                <a:cubicBezTo>
                  <a:pt x="199" y="61"/>
                  <a:pt x="193" y="59"/>
                  <a:pt x="186" y="59"/>
                </a:cubicBezTo>
                <a:cubicBezTo>
                  <a:pt x="179" y="59"/>
                  <a:pt x="173" y="61"/>
                  <a:pt x="168" y="66"/>
                </a:cubicBezTo>
                <a:cubicBezTo>
                  <a:pt x="163" y="71"/>
                  <a:pt x="161" y="78"/>
                  <a:pt x="161" y="86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3" name="Freeform 30"/>
          <p:cNvSpPr>
            <a:spLocks noEditPoints="1"/>
          </p:cNvSpPr>
          <p:nvPr/>
        </p:nvSpPr>
        <p:spPr bwMode="auto">
          <a:xfrm>
            <a:off x="5920257" y="4094195"/>
            <a:ext cx="136979" cy="91319"/>
          </a:xfrm>
          <a:custGeom>
            <a:avLst/>
            <a:gdLst>
              <a:gd name="T0" fmla="*/ 0 w 226"/>
              <a:gd name="T1" fmla="*/ 64 h 151"/>
              <a:gd name="T2" fmla="*/ 4 w 226"/>
              <a:gd name="T3" fmla="*/ 28 h 151"/>
              <a:gd name="T4" fmla="*/ 18 w 226"/>
              <a:gd name="T5" fmla="*/ 7 h 151"/>
              <a:gd name="T6" fmla="*/ 41 w 226"/>
              <a:gd name="T7" fmla="*/ 0 h 151"/>
              <a:gd name="T8" fmla="*/ 58 w 226"/>
              <a:gd name="T9" fmla="*/ 4 h 151"/>
              <a:gd name="T10" fmla="*/ 71 w 226"/>
              <a:gd name="T11" fmla="*/ 16 h 151"/>
              <a:gd name="T12" fmla="*/ 79 w 226"/>
              <a:gd name="T13" fmla="*/ 34 h 151"/>
              <a:gd name="T14" fmla="*/ 82 w 226"/>
              <a:gd name="T15" fmla="*/ 64 h 151"/>
              <a:gd name="T16" fmla="*/ 77 w 226"/>
              <a:gd name="T17" fmla="*/ 100 h 151"/>
              <a:gd name="T18" fmla="*/ 64 w 226"/>
              <a:gd name="T19" fmla="*/ 121 h 151"/>
              <a:gd name="T20" fmla="*/ 41 w 226"/>
              <a:gd name="T21" fmla="*/ 128 h 151"/>
              <a:gd name="T22" fmla="*/ 12 w 226"/>
              <a:gd name="T23" fmla="*/ 115 h 151"/>
              <a:gd name="T24" fmla="*/ 0 w 226"/>
              <a:gd name="T25" fmla="*/ 64 h 151"/>
              <a:gd name="T26" fmla="*/ 16 w 226"/>
              <a:gd name="T27" fmla="*/ 64 h 151"/>
              <a:gd name="T28" fmla="*/ 23 w 226"/>
              <a:gd name="T29" fmla="*/ 105 h 151"/>
              <a:gd name="T30" fmla="*/ 41 w 226"/>
              <a:gd name="T31" fmla="*/ 116 h 151"/>
              <a:gd name="T32" fmla="*/ 59 w 226"/>
              <a:gd name="T33" fmla="*/ 105 h 151"/>
              <a:gd name="T34" fmla="*/ 66 w 226"/>
              <a:gd name="T35" fmla="*/ 64 h 151"/>
              <a:gd name="T36" fmla="*/ 59 w 226"/>
              <a:gd name="T37" fmla="*/ 23 h 151"/>
              <a:gd name="T38" fmla="*/ 41 w 226"/>
              <a:gd name="T39" fmla="*/ 12 h 151"/>
              <a:gd name="T40" fmla="*/ 24 w 226"/>
              <a:gd name="T41" fmla="*/ 21 h 151"/>
              <a:gd name="T42" fmla="*/ 16 w 226"/>
              <a:gd name="T43" fmla="*/ 64 h 151"/>
              <a:gd name="T44" fmla="*/ 104 w 226"/>
              <a:gd name="T45" fmla="*/ 126 h 151"/>
              <a:gd name="T46" fmla="*/ 104 w 226"/>
              <a:gd name="T47" fmla="*/ 109 h 151"/>
              <a:gd name="T48" fmla="*/ 122 w 226"/>
              <a:gd name="T49" fmla="*/ 109 h 151"/>
              <a:gd name="T50" fmla="*/ 122 w 226"/>
              <a:gd name="T51" fmla="*/ 126 h 151"/>
              <a:gd name="T52" fmla="*/ 118 w 226"/>
              <a:gd name="T53" fmla="*/ 142 h 151"/>
              <a:gd name="T54" fmla="*/ 107 w 226"/>
              <a:gd name="T55" fmla="*/ 151 h 151"/>
              <a:gd name="T56" fmla="*/ 103 w 226"/>
              <a:gd name="T57" fmla="*/ 144 h 151"/>
              <a:gd name="T58" fmla="*/ 110 w 226"/>
              <a:gd name="T59" fmla="*/ 138 h 151"/>
              <a:gd name="T60" fmla="*/ 113 w 226"/>
              <a:gd name="T61" fmla="*/ 126 h 151"/>
              <a:gd name="T62" fmla="*/ 104 w 226"/>
              <a:gd name="T63" fmla="*/ 126 h 151"/>
              <a:gd name="T64" fmla="*/ 193 w 226"/>
              <a:gd name="T65" fmla="*/ 126 h 151"/>
              <a:gd name="T66" fmla="*/ 193 w 226"/>
              <a:gd name="T67" fmla="*/ 96 h 151"/>
              <a:gd name="T68" fmla="*/ 139 w 226"/>
              <a:gd name="T69" fmla="*/ 96 h 151"/>
              <a:gd name="T70" fmla="*/ 139 w 226"/>
              <a:gd name="T71" fmla="*/ 82 h 151"/>
              <a:gd name="T72" fmla="*/ 196 w 226"/>
              <a:gd name="T73" fmla="*/ 0 h 151"/>
              <a:gd name="T74" fmla="*/ 209 w 226"/>
              <a:gd name="T75" fmla="*/ 0 h 151"/>
              <a:gd name="T76" fmla="*/ 209 w 226"/>
              <a:gd name="T77" fmla="*/ 82 h 151"/>
              <a:gd name="T78" fmla="*/ 226 w 226"/>
              <a:gd name="T79" fmla="*/ 82 h 151"/>
              <a:gd name="T80" fmla="*/ 226 w 226"/>
              <a:gd name="T81" fmla="*/ 96 h 151"/>
              <a:gd name="T82" fmla="*/ 209 w 226"/>
              <a:gd name="T83" fmla="*/ 96 h 151"/>
              <a:gd name="T84" fmla="*/ 209 w 226"/>
              <a:gd name="T85" fmla="*/ 126 h 151"/>
              <a:gd name="T86" fmla="*/ 193 w 226"/>
              <a:gd name="T87" fmla="*/ 126 h 151"/>
              <a:gd name="T88" fmla="*/ 193 w 226"/>
              <a:gd name="T89" fmla="*/ 82 h 151"/>
              <a:gd name="T90" fmla="*/ 193 w 226"/>
              <a:gd name="T91" fmla="*/ 25 h 151"/>
              <a:gd name="T92" fmla="*/ 154 w 226"/>
              <a:gd name="T93" fmla="*/ 82 h 151"/>
              <a:gd name="T94" fmla="*/ 193 w 226"/>
              <a:gd name="T95" fmla="*/ 82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226" h="151">
                <a:moveTo>
                  <a:pt x="0" y="64"/>
                </a:moveTo>
                <a:cubicBezTo>
                  <a:pt x="0" y="49"/>
                  <a:pt x="1" y="37"/>
                  <a:pt x="4" y="28"/>
                </a:cubicBezTo>
                <a:cubicBezTo>
                  <a:pt x="7" y="19"/>
                  <a:pt x="12" y="12"/>
                  <a:pt x="18" y="7"/>
                </a:cubicBezTo>
                <a:cubicBezTo>
                  <a:pt x="24" y="2"/>
                  <a:pt x="32" y="0"/>
                  <a:pt x="41" y="0"/>
                </a:cubicBezTo>
                <a:cubicBezTo>
                  <a:pt x="48" y="0"/>
                  <a:pt x="53" y="1"/>
                  <a:pt x="58" y="4"/>
                </a:cubicBezTo>
                <a:cubicBezTo>
                  <a:pt x="64" y="7"/>
                  <a:pt x="68" y="10"/>
                  <a:pt x="71" y="16"/>
                </a:cubicBezTo>
                <a:cubicBezTo>
                  <a:pt x="74" y="21"/>
                  <a:pt x="77" y="27"/>
                  <a:pt x="79" y="34"/>
                </a:cubicBezTo>
                <a:cubicBezTo>
                  <a:pt x="81" y="42"/>
                  <a:pt x="82" y="52"/>
                  <a:pt x="82" y="64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6"/>
                  <a:pt x="64" y="121"/>
                </a:cubicBezTo>
                <a:cubicBezTo>
                  <a:pt x="58" y="126"/>
                  <a:pt x="50" y="128"/>
                  <a:pt x="41" y="128"/>
                </a:cubicBezTo>
                <a:cubicBezTo>
                  <a:pt x="29" y="128"/>
                  <a:pt x="19" y="124"/>
                  <a:pt x="12" y="115"/>
                </a:cubicBezTo>
                <a:cubicBezTo>
                  <a:pt x="4" y="105"/>
                  <a:pt x="0" y="88"/>
                  <a:pt x="0" y="64"/>
                </a:cubicBezTo>
                <a:close/>
                <a:moveTo>
                  <a:pt x="16" y="64"/>
                </a:moveTo>
                <a:cubicBezTo>
                  <a:pt x="16" y="85"/>
                  <a:pt x="18" y="99"/>
                  <a:pt x="23" y="105"/>
                </a:cubicBezTo>
                <a:cubicBezTo>
                  <a:pt x="28" y="112"/>
                  <a:pt x="34" y="116"/>
                  <a:pt x="41" y="116"/>
                </a:cubicBezTo>
                <a:cubicBezTo>
                  <a:pt x="48" y="116"/>
                  <a:pt x="54" y="112"/>
                  <a:pt x="59" y="105"/>
                </a:cubicBezTo>
                <a:cubicBezTo>
                  <a:pt x="63" y="98"/>
                  <a:pt x="66" y="85"/>
                  <a:pt x="66" y="64"/>
                </a:cubicBezTo>
                <a:cubicBezTo>
                  <a:pt x="66" y="43"/>
                  <a:pt x="63" y="29"/>
                  <a:pt x="59" y="23"/>
                </a:cubicBezTo>
                <a:cubicBezTo>
                  <a:pt x="54" y="16"/>
                  <a:pt x="48" y="12"/>
                  <a:pt x="41" y="12"/>
                </a:cubicBezTo>
                <a:cubicBezTo>
                  <a:pt x="33" y="12"/>
                  <a:pt x="28" y="15"/>
                  <a:pt x="24" y="21"/>
                </a:cubicBezTo>
                <a:cubicBezTo>
                  <a:pt x="18" y="29"/>
                  <a:pt x="16" y="43"/>
                  <a:pt x="16" y="64"/>
                </a:cubicBezTo>
                <a:close/>
                <a:moveTo>
                  <a:pt x="104" y="126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6"/>
                </a:lnTo>
                <a:cubicBezTo>
                  <a:pt x="122" y="133"/>
                  <a:pt x="120" y="138"/>
                  <a:pt x="118" y="142"/>
                </a:cubicBezTo>
                <a:cubicBezTo>
                  <a:pt x="116" y="146"/>
                  <a:pt x="112" y="149"/>
                  <a:pt x="107" y="151"/>
                </a:cubicBezTo>
                <a:lnTo>
                  <a:pt x="103" y="144"/>
                </a:lnTo>
                <a:cubicBezTo>
                  <a:pt x="106" y="143"/>
                  <a:pt x="109" y="141"/>
                  <a:pt x="110" y="138"/>
                </a:cubicBezTo>
                <a:cubicBezTo>
                  <a:pt x="112" y="135"/>
                  <a:pt x="113" y="131"/>
                  <a:pt x="113" y="126"/>
                </a:cubicBezTo>
                <a:lnTo>
                  <a:pt x="104" y="126"/>
                </a:lnTo>
                <a:close/>
                <a:moveTo>
                  <a:pt x="193" y="126"/>
                </a:moveTo>
                <a:lnTo>
                  <a:pt x="193" y="96"/>
                </a:lnTo>
                <a:lnTo>
                  <a:pt x="139" y="96"/>
                </a:lnTo>
                <a:lnTo>
                  <a:pt x="139" y="82"/>
                </a:lnTo>
                <a:lnTo>
                  <a:pt x="196" y="0"/>
                </a:lnTo>
                <a:lnTo>
                  <a:pt x="209" y="0"/>
                </a:lnTo>
                <a:lnTo>
                  <a:pt x="209" y="82"/>
                </a:lnTo>
                <a:lnTo>
                  <a:pt x="226" y="82"/>
                </a:lnTo>
                <a:lnTo>
                  <a:pt x="226" y="96"/>
                </a:lnTo>
                <a:lnTo>
                  <a:pt x="209" y="96"/>
                </a:lnTo>
                <a:lnTo>
                  <a:pt x="209" y="126"/>
                </a:lnTo>
                <a:lnTo>
                  <a:pt x="193" y="126"/>
                </a:lnTo>
                <a:close/>
                <a:moveTo>
                  <a:pt x="193" y="82"/>
                </a:moveTo>
                <a:lnTo>
                  <a:pt x="193" y="25"/>
                </a:lnTo>
                <a:lnTo>
                  <a:pt x="154" y="82"/>
                </a:lnTo>
                <a:lnTo>
                  <a:pt x="193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4" name="Freeform 31"/>
          <p:cNvSpPr>
            <a:spLocks noEditPoints="1"/>
          </p:cNvSpPr>
          <p:nvPr/>
        </p:nvSpPr>
        <p:spPr bwMode="auto">
          <a:xfrm>
            <a:off x="5920257" y="4804774"/>
            <a:ext cx="136979" cy="91319"/>
          </a:xfrm>
          <a:custGeom>
            <a:avLst/>
            <a:gdLst>
              <a:gd name="T0" fmla="*/ 0 w 225"/>
              <a:gd name="T1" fmla="*/ 64 h 151"/>
              <a:gd name="T2" fmla="*/ 4 w 225"/>
              <a:gd name="T3" fmla="*/ 28 h 151"/>
              <a:gd name="T4" fmla="*/ 18 w 225"/>
              <a:gd name="T5" fmla="*/ 7 h 151"/>
              <a:gd name="T6" fmla="*/ 41 w 225"/>
              <a:gd name="T7" fmla="*/ 0 h 151"/>
              <a:gd name="T8" fmla="*/ 58 w 225"/>
              <a:gd name="T9" fmla="*/ 4 h 151"/>
              <a:gd name="T10" fmla="*/ 71 w 225"/>
              <a:gd name="T11" fmla="*/ 16 h 151"/>
              <a:gd name="T12" fmla="*/ 79 w 225"/>
              <a:gd name="T13" fmla="*/ 34 h 151"/>
              <a:gd name="T14" fmla="*/ 82 w 225"/>
              <a:gd name="T15" fmla="*/ 64 h 151"/>
              <a:gd name="T16" fmla="*/ 77 w 225"/>
              <a:gd name="T17" fmla="*/ 100 h 151"/>
              <a:gd name="T18" fmla="*/ 64 w 225"/>
              <a:gd name="T19" fmla="*/ 121 h 151"/>
              <a:gd name="T20" fmla="*/ 41 w 225"/>
              <a:gd name="T21" fmla="*/ 129 h 151"/>
              <a:gd name="T22" fmla="*/ 12 w 225"/>
              <a:gd name="T23" fmla="*/ 115 h 151"/>
              <a:gd name="T24" fmla="*/ 0 w 225"/>
              <a:gd name="T25" fmla="*/ 64 h 151"/>
              <a:gd name="T26" fmla="*/ 16 w 225"/>
              <a:gd name="T27" fmla="*/ 64 h 151"/>
              <a:gd name="T28" fmla="*/ 23 w 225"/>
              <a:gd name="T29" fmla="*/ 106 h 151"/>
              <a:gd name="T30" fmla="*/ 41 w 225"/>
              <a:gd name="T31" fmla="*/ 116 h 151"/>
              <a:gd name="T32" fmla="*/ 59 w 225"/>
              <a:gd name="T33" fmla="*/ 105 h 151"/>
              <a:gd name="T34" fmla="*/ 66 w 225"/>
              <a:gd name="T35" fmla="*/ 64 h 151"/>
              <a:gd name="T36" fmla="*/ 59 w 225"/>
              <a:gd name="T37" fmla="*/ 23 h 151"/>
              <a:gd name="T38" fmla="*/ 41 w 225"/>
              <a:gd name="T39" fmla="*/ 13 h 151"/>
              <a:gd name="T40" fmla="*/ 24 w 225"/>
              <a:gd name="T41" fmla="*/ 22 h 151"/>
              <a:gd name="T42" fmla="*/ 16 w 225"/>
              <a:gd name="T43" fmla="*/ 64 h 151"/>
              <a:gd name="T44" fmla="*/ 104 w 225"/>
              <a:gd name="T45" fmla="*/ 126 h 151"/>
              <a:gd name="T46" fmla="*/ 104 w 225"/>
              <a:gd name="T47" fmla="*/ 109 h 151"/>
              <a:gd name="T48" fmla="*/ 122 w 225"/>
              <a:gd name="T49" fmla="*/ 109 h 151"/>
              <a:gd name="T50" fmla="*/ 122 w 225"/>
              <a:gd name="T51" fmla="*/ 126 h 151"/>
              <a:gd name="T52" fmla="*/ 118 w 225"/>
              <a:gd name="T53" fmla="*/ 142 h 151"/>
              <a:gd name="T54" fmla="*/ 107 w 225"/>
              <a:gd name="T55" fmla="*/ 151 h 151"/>
              <a:gd name="T56" fmla="*/ 103 w 225"/>
              <a:gd name="T57" fmla="*/ 145 h 151"/>
              <a:gd name="T58" fmla="*/ 110 w 225"/>
              <a:gd name="T59" fmla="*/ 138 h 151"/>
              <a:gd name="T60" fmla="*/ 113 w 225"/>
              <a:gd name="T61" fmla="*/ 126 h 151"/>
              <a:gd name="T62" fmla="*/ 104 w 225"/>
              <a:gd name="T63" fmla="*/ 126 h 151"/>
              <a:gd name="T64" fmla="*/ 225 w 225"/>
              <a:gd name="T65" fmla="*/ 112 h 151"/>
              <a:gd name="T66" fmla="*/ 225 w 225"/>
              <a:gd name="T67" fmla="*/ 126 h 151"/>
              <a:gd name="T68" fmla="*/ 142 w 225"/>
              <a:gd name="T69" fmla="*/ 126 h 151"/>
              <a:gd name="T70" fmla="*/ 144 w 225"/>
              <a:gd name="T71" fmla="*/ 116 h 151"/>
              <a:gd name="T72" fmla="*/ 154 w 225"/>
              <a:gd name="T73" fmla="*/ 99 h 151"/>
              <a:gd name="T74" fmla="*/ 174 w 225"/>
              <a:gd name="T75" fmla="*/ 80 h 151"/>
              <a:gd name="T76" fmla="*/ 202 w 225"/>
              <a:gd name="T77" fmla="*/ 53 h 151"/>
              <a:gd name="T78" fmla="*/ 209 w 225"/>
              <a:gd name="T79" fmla="*/ 35 h 151"/>
              <a:gd name="T80" fmla="*/ 202 w 225"/>
              <a:gd name="T81" fmla="*/ 19 h 151"/>
              <a:gd name="T82" fmla="*/ 185 w 225"/>
              <a:gd name="T83" fmla="*/ 13 h 151"/>
              <a:gd name="T84" fmla="*/ 167 w 225"/>
              <a:gd name="T85" fmla="*/ 19 h 151"/>
              <a:gd name="T86" fmla="*/ 161 w 225"/>
              <a:gd name="T87" fmla="*/ 38 h 151"/>
              <a:gd name="T88" fmla="*/ 145 w 225"/>
              <a:gd name="T89" fmla="*/ 36 h 151"/>
              <a:gd name="T90" fmla="*/ 157 w 225"/>
              <a:gd name="T91" fmla="*/ 9 h 151"/>
              <a:gd name="T92" fmla="*/ 186 w 225"/>
              <a:gd name="T93" fmla="*/ 0 h 151"/>
              <a:gd name="T94" fmla="*/ 214 w 225"/>
              <a:gd name="T95" fmla="*/ 10 h 151"/>
              <a:gd name="T96" fmla="*/ 225 w 225"/>
              <a:gd name="T97" fmla="*/ 35 h 151"/>
              <a:gd name="T98" fmla="*/ 222 w 225"/>
              <a:gd name="T99" fmla="*/ 50 h 151"/>
              <a:gd name="T100" fmla="*/ 211 w 225"/>
              <a:gd name="T101" fmla="*/ 65 h 151"/>
              <a:gd name="T102" fmla="*/ 188 w 225"/>
              <a:gd name="T103" fmla="*/ 87 h 151"/>
              <a:gd name="T104" fmla="*/ 170 w 225"/>
              <a:gd name="T105" fmla="*/ 103 h 151"/>
              <a:gd name="T106" fmla="*/ 163 w 225"/>
              <a:gd name="T107" fmla="*/ 112 h 151"/>
              <a:gd name="T108" fmla="*/ 225 w 225"/>
              <a:gd name="T109" fmla="*/ 112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225" h="151">
                <a:moveTo>
                  <a:pt x="0" y="64"/>
                </a:moveTo>
                <a:cubicBezTo>
                  <a:pt x="0" y="49"/>
                  <a:pt x="1" y="37"/>
                  <a:pt x="4" y="28"/>
                </a:cubicBezTo>
                <a:cubicBezTo>
                  <a:pt x="7" y="19"/>
                  <a:pt x="12" y="12"/>
                  <a:pt x="18" y="7"/>
                </a:cubicBezTo>
                <a:cubicBezTo>
                  <a:pt x="24" y="2"/>
                  <a:pt x="32" y="0"/>
                  <a:pt x="41" y="0"/>
                </a:cubicBezTo>
                <a:cubicBezTo>
                  <a:pt x="48" y="0"/>
                  <a:pt x="53" y="1"/>
                  <a:pt x="58" y="4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7"/>
                  <a:pt x="79" y="34"/>
                </a:cubicBezTo>
                <a:cubicBezTo>
                  <a:pt x="81" y="42"/>
                  <a:pt x="82" y="52"/>
                  <a:pt x="82" y="64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6"/>
                  <a:pt x="64" y="121"/>
                </a:cubicBezTo>
                <a:cubicBezTo>
                  <a:pt x="58" y="126"/>
                  <a:pt x="50" y="129"/>
                  <a:pt x="41" y="129"/>
                </a:cubicBezTo>
                <a:cubicBezTo>
                  <a:pt x="29" y="129"/>
                  <a:pt x="19" y="124"/>
                  <a:pt x="12" y="115"/>
                </a:cubicBezTo>
                <a:cubicBezTo>
                  <a:pt x="4" y="105"/>
                  <a:pt x="0" y="88"/>
                  <a:pt x="0" y="64"/>
                </a:cubicBezTo>
                <a:close/>
                <a:moveTo>
                  <a:pt x="16" y="64"/>
                </a:moveTo>
                <a:cubicBezTo>
                  <a:pt x="16" y="85"/>
                  <a:pt x="18" y="99"/>
                  <a:pt x="23" y="106"/>
                </a:cubicBezTo>
                <a:cubicBezTo>
                  <a:pt x="28" y="112"/>
                  <a:pt x="34" y="116"/>
                  <a:pt x="41" y="116"/>
                </a:cubicBezTo>
                <a:cubicBezTo>
                  <a:pt x="48" y="116"/>
                  <a:pt x="54" y="112"/>
                  <a:pt x="59" y="105"/>
                </a:cubicBezTo>
                <a:cubicBezTo>
                  <a:pt x="63" y="99"/>
                  <a:pt x="66" y="85"/>
                  <a:pt x="66" y="64"/>
                </a:cubicBezTo>
                <a:cubicBezTo>
                  <a:pt x="66" y="43"/>
                  <a:pt x="63" y="30"/>
                  <a:pt x="59" y="23"/>
                </a:cubicBezTo>
                <a:cubicBezTo>
                  <a:pt x="54" y="16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29"/>
                  <a:pt x="16" y="43"/>
                  <a:pt x="16" y="64"/>
                </a:cubicBezTo>
                <a:close/>
                <a:moveTo>
                  <a:pt x="104" y="126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6"/>
                </a:lnTo>
                <a:cubicBezTo>
                  <a:pt x="122" y="133"/>
                  <a:pt x="120" y="138"/>
                  <a:pt x="118" y="142"/>
                </a:cubicBezTo>
                <a:cubicBezTo>
                  <a:pt x="116" y="146"/>
                  <a:pt x="112" y="149"/>
                  <a:pt x="107" y="151"/>
                </a:cubicBezTo>
                <a:lnTo>
                  <a:pt x="103" y="145"/>
                </a:lnTo>
                <a:cubicBezTo>
                  <a:pt x="106" y="143"/>
                  <a:pt x="109" y="141"/>
                  <a:pt x="110" y="138"/>
                </a:cubicBezTo>
                <a:cubicBezTo>
                  <a:pt x="112" y="136"/>
                  <a:pt x="113" y="132"/>
                  <a:pt x="113" y="126"/>
                </a:cubicBezTo>
                <a:lnTo>
                  <a:pt x="104" y="126"/>
                </a:lnTo>
                <a:close/>
                <a:moveTo>
                  <a:pt x="225" y="112"/>
                </a:moveTo>
                <a:lnTo>
                  <a:pt x="225" y="126"/>
                </a:lnTo>
                <a:lnTo>
                  <a:pt x="142" y="126"/>
                </a:lnTo>
                <a:cubicBezTo>
                  <a:pt x="142" y="123"/>
                  <a:pt x="142" y="119"/>
                  <a:pt x="144" y="116"/>
                </a:cubicBezTo>
                <a:cubicBezTo>
                  <a:pt x="146" y="110"/>
                  <a:pt x="149" y="104"/>
                  <a:pt x="154" y="99"/>
                </a:cubicBezTo>
                <a:cubicBezTo>
                  <a:pt x="158" y="93"/>
                  <a:pt x="165" y="87"/>
                  <a:pt x="174" y="80"/>
                </a:cubicBezTo>
                <a:cubicBezTo>
                  <a:pt x="188" y="69"/>
                  <a:pt x="197" y="60"/>
                  <a:pt x="202" y="53"/>
                </a:cubicBezTo>
                <a:cubicBezTo>
                  <a:pt x="206" y="47"/>
                  <a:pt x="209" y="40"/>
                  <a:pt x="209" y="35"/>
                </a:cubicBezTo>
                <a:cubicBezTo>
                  <a:pt x="209" y="28"/>
                  <a:pt x="207" y="23"/>
                  <a:pt x="202" y="19"/>
                </a:cubicBezTo>
                <a:cubicBezTo>
                  <a:pt x="198" y="15"/>
                  <a:pt x="192" y="13"/>
                  <a:pt x="185" y="13"/>
                </a:cubicBezTo>
                <a:cubicBezTo>
                  <a:pt x="178" y="13"/>
                  <a:pt x="172" y="15"/>
                  <a:pt x="167" y="19"/>
                </a:cubicBezTo>
                <a:cubicBezTo>
                  <a:pt x="163" y="24"/>
                  <a:pt x="161" y="30"/>
                  <a:pt x="161" y="38"/>
                </a:cubicBezTo>
                <a:lnTo>
                  <a:pt x="145" y="36"/>
                </a:lnTo>
                <a:cubicBezTo>
                  <a:pt x="146" y="25"/>
                  <a:pt x="150" y="15"/>
                  <a:pt x="157" y="9"/>
                </a:cubicBezTo>
                <a:cubicBezTo>
                  <a:pt x="164" y="3"/>
                  <a:pt x="174" y="0"/>
                  <a:pt x="186" y="0"/>
                </a:cubicBezTo>
                <a:cubicBezTo>
                  <a:pt x="198" y="0"/>
                  <a:pt x="207" y="3"/>
                  <a:pt x="214" y="10"/>
                </a:cubicBezTo>
                <a:cubicBezTo>
                  <a:pt x="221" y="17"/>
                  <a:pt x="225" y="25"/>
                  <a:pt x="225" y="35"/>
                </a:cubicBezTo>
                <a:cubicBezTo>
                  <a:pt x="225" y="40"/>
                  <a:pt x="224" y="45"/>
                  <a:pt x="222" y="50"/>
                </a:cubicBezTo>
                <a:cubicBezTo>
                  <a:pt x="220" y="55"/>
                  <a:pt x="216" y="60"/>
                  <a:pt x="211" y="65"/>
                </a:cubicBezTo>
                <a:cubicBezTo>
                  <a:pt x="207" y="70"/>
                  <a:pt x="199" y="78"/>
                  <a:pt x="188" y="87"/>
                </a:cubicBezTo>
                <a:cubicBezTo>
                  <a:pt x="178" y="95"/>
                  <a:pt x="172" y="100"/>
                  <a:pt x="170" y="103"/>
                </a:cubicBezTo>
                <a:cubicBezTo>
                  <a:pt x="167" y="106"/>
                  <a:pt x="165" y="109"/>
                  <a:pt x="163" y="112"/>
                </a:cubicBezTo>
                <a:lnTo>
                  <a:pt x="225" y="11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5" name="Freeform 32"/>
          <p:cNvSpPr>
            <a:spLocks noEditPoints="1"/>
          </p:cNvSpPr>
          <p:nvPr/>
        </p:nvSpPr>
        <p:spPr bwMode="auto">
          <a:xfrm>
            <a:off x="5920257" y="5515353"/>
            <a:ext cx="136979" cy="94173"/>
          </a:xfrm>
          <a:custGeom>
            <a:avLst/>
            <a:gdLst>
              <a:gd name="T0" fmla="*/ 0 w 226"/>
              <a:gd name="T1" fmla="*/ 64 h 152"/>
              <a:gd name="T2" fmla="*/ 4 w 226"/>
              <a:gd name="T3" fmla="*/ 28 h 152"/>
              <a:gd name="T4" fmla="*/ 18 w 226"/>
              <a:gd name="T5" fmla="*/ 7 h 152"/>
              <a:gd name="T6" fmla="*/ 41 w 226"/>
              <a:gd name="T7" fmla="*/ 0 h 152"/>
              <a:gd name="T8" fmla="*/ 58 w 226"/>
              <a:gd name="T9" fmla="*/ 4 h 152"/>
              <a:gd name="T10" fmla="*/ 71 w 226"/>
              <a:gd name="T11" fmla="*/ 16 h 152"/>
              <a:gd name="T12" fmla="*/ 79 w 226"/>
              <a:gd name="T13" fmla="*/ 35 h 152"/>
              <a:gd name="T14" fmla="*/ 82 w 226"/>
              <a:gd name="T15" fmla="*/ 64 h 152"/>
              <a:gd name="T16" fmla="*/ 77 w 226"/>
              <a:gd name="T17" fmla="*/ 100 h 152"/>
              <a:gd name="T18" fmla="*/ 64 w 226"/>
              <a:gd name="T19" fmla="*/ 121 h 152"/>
              <a:gd name="T20" fmla="*/ 41 w 226"/>
              <a:gd name="T21" fmla="*/ 129 h 152"/>
              <a:gd name="T22" fmla="*/ 12 w 226"/>
              <a:gd name="T23" fmla="*/ 116 h 152"/>
              <a:gd name="T24" fmla="*/ 0 w 226"/>
              <a:gd name="T25" fmla="*/ 64 h 152"/>
              <a:gd name="T26" fmla="*/ 16 w 226"/>
              <a:gd name="T27" fmla="*/ 64 h 152"/>
              <a:gd name="T28" fmla="*/ 23 w 226"/>
              <a:gd name="T29" fmla="*/ 106 h 152"/>
              <a:gd name="T30" fmla="*/ 41 w 226"/>
              <a:gd name="T31" fmla="*/ 116 h 152"/>
              <a:gd name="T32" fmla="*/ 59 w 226"/>
              <a:gd name="T33" fmla="*/ 106 h 152"/>
              <a:gd name="T34" fmla="*/ 66 w 226"/>
              <a:gd name="T35" fmla="*/ 64 h 152"/>
              <a:gd name="T36" fmla="*/ 59 w 226"/>
              <a:gd name="T37" fmla="*/ 23 h 152"/>
              <a:gd name="T38" fmla="*/ 41 w 226"/>
              <a:gd name="T39" fmla="*/ 13 h 152"/>
              <a:gd name="T40" fmla="*/ 24 w 226"/>
              <a:gd name="T41" fmla="*/ 22 h 152"/>
              <a:gd name="T42" fmla="*/ 16 w 226"/>
              <a:gd name="T43" fmla="*/ 64 h 152"/>
              <a:gd name="T44" fmla="*/ 104 w 226"/>
              <a:gd name="T45" fmla="*/ 127 h 152"/>
              <a:gd name="T46" fmla="*/ 104 w 226"/>
              <a:gd name="T47" fmla="*/ 109 h 152"/>
              <a:gd name="T48" fmla="*/ 122 w 226"/>
              <a:gd name="T49" fmla="*/ 109 h 152"/>
              <a:gd name="T50" fmla="*/ 122 w 226"/>
              <a:gd name="T51" fmla="*/ 127 h 152"/>
              <a:gd name="T52" fmla="*/ 118 w 226"/>
              <a:gd name="T53" fmla="*/ 142 h 152"/>
              <a:gd name="T54" fmla="*/ 107 w 226"/>
              <a:gd name="T55" fmla="*/ 152 h 152"/>
              <a:gd name="T56" fmla="*/ 103 w 226"/>
              <a:gd name="T57" fmla="*/ 145 h 152"/>
              <a:gd name="T58" fmla="*/ 110 w 226"/>
              <a:gd name="T59" fmla="*/ 139 h 152"/>
              <a:gd name="T60" fmla="*/ 113 w 226"/>
              <a:gd name="T61" fmla="*/ 127 h 152"/>
              <a:gd name="T62" fmla="*/ 104 w 226"/>
              <a:gd name="T63" fmla="*/ 127 h 152"/>
              <a:gd name="T64" fmla="*/ 144 w 226"/>
              <a:gd name="T65" fmla="*/ 64 h 152"/>
              <a:gd name="T66" fmla="*/ 148 w 226"/>
              <a:gd name="T67" fmla="*/ 28 h 152"/>
              <a:gd name="T68" fmla="*/ 162 w 226"/>
              <a:gd name="T69" fmla="*/ 7 h 152"/>
              <a:gd name="T70" fmla="*/ 185 w 226"/>
              <a:gd name="T71" fmla="*/ 0 h 152"/>
              <a:gd name="T72" fmla="*/ 202 w 226"/>
              <a:gd name="T73" fmla="*/ 4 h 152"/>
              <a:gd name="T74" fmla="*/ 215 w 226"/>
              <a:gd name="T75" fmla="*/ 16 h 152"/>
              <a:gd name="T76" fmla="*/ 223 w 226"/>
              <a:gd name="T77" fmla="*/ 35 h 152"/>
              <a:gd name="T78" fmla="*/ 226 w 226"/>
              <a:gd name="T79" fmla="*/ 64 h 152"/>
              <a:gd name="T80" fmla="*/ 221 w 226"/>
              <a:gd name="T81" fmla="*/ 100 h 152"/>
              <a:gd name="T82" fmla="*/ 208 w 226"/>
              <a:gd name="T83" fmla="*/ 121 h 152"/>
              <a:gd name="T84" fmla="*/ 185 w 226"/>
              <a:gd name="T85" fmla="*/ 129 h 152"/>
              <a:gd name="T86" fmla="*/ 156 w 226"/>
              <a:gd name="T87" fmla="*/ 116 h 152"/>
              <a:gd name="T88" fmla="*/ 144 w 226"/>
              <a:gd name="T89" fmla="*/ 64 h 152"/>
              <a:gd name="T90" fmla="*/ 160 w 226"/>
              <a:gd name="T91" fmla="*/ 64 h 152"/>
              <a:gd name="T92" fmla="*/ 167 w 226"/>
              <a:gd name="T93" fmla="*/ 106 h 152"/>
              <a:gd name="T94" fmla="*/ 185 w 226"/>
              <a:gd name="T95" fmla="*/ 116 h 152"/>
              <a:gd name="T96" fmla="*/ 203 w 226"/>
              <a:gd name="T97" fmla="*/ 106 h 152"/>
              <a:gd name="T98" fmla="*/ 210 w 226"/>
              <a:gd name="T99" fmla="*/ 64 h 152"/>
              <a:gd name="T100" fmla="*/ 203 w 226"/>
              <a:gd name="T101" fmla="*/ 23 h 152"/>
              <a:gd name="T102" fmla="*/ 185 w 226"/>
              <a:gd name="T103" fmla="*/ 13 h 152"/>
              <a:gd name="T104" fmla="*/ 168 w 226"/>
              <a:gd name="T105" fmla="*/ 22 h 152"/>
              <a:gd name="T106" fmla="*/ 160 w 226"/>
              <a:gd name="T107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226" h="152">
                <a:moveTo>
                  <a:pt x="0" y="64"/>
                </a:moveTo>
                <a:cubicBezTo>
                  <a:pt x="0" y="49"/>
                  <a:pt x="1" y="37"/>
                  <a:pt x="4" y="28"/>
                </a:cubicBezTo>
                <a:cubicBezTo>
                  <a:pt x="7" y="19"/>
                  <a:pt x="12" y="12"/>
                  <a:pt x="18" y="7"/>
                </a:cubicBezTo>
                <a:cubicBezTo>
                  <a:pt x="24" y="2"/>
                  <a:pt x="32" y="0"/>
                  <a:pt x="41" y="0"/>
                </a:cubicBezTo>
                <a:cubicBezTo>
                  <a:pt x="48" y="0"/>
                  <a:pt x="53" y="1"/>
                  <a:pt x="58" y="4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7"/>
                  <a:pt x="79" y="35"/>
                </a:cubicBezTo>
                <a:cubicBezTo>
                  <a:pt x="81" y="42"/>
                  <a:pt x="82" y="52"/>
                  <a:pt x="82" y="64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6"/>
                  <a:pt x="64" y="121"/>
                </a:cubicBezTo>
                <a:cubicBezTo>
                  <a:pt x="58" y="126"/>
                  <a:pt x="50" y="129"/>
                  <a:pt x="41" y="129"/>
                </a:cubicBezTo>
                <a:cubicBezTo>
                  <a:pt x="29" y="129"/>
                  <a:pt x="19" y="124"/>
                  <a:pt x="12" y="116"/>
                </a:cubicBezTo>
                <a:cubicBezTo>
                  <a:pt x="4" y="105"/>
                  <a:pt x="0" y="88"/>
                  <a:pt x="0" y="64"/>
                </a:cubicBezTo>
                <a:close/>
                <a:moveTo>
                  <a:pt x="16" y="64"/>
                </a:moveTo>
                <a:cubicBezTo>
                  <a:pt x="16" y="85"/>
                  <a:pt x="18" y="99"/>
                  <a:pt x="23" y="106"/>
                </a:cubicBezTo>
                <a:cubicBezTo>
                  <a:pt x="28" y="113"/>
                  <a:pt x="34" y="116"/>
                  <a:pt x="41" y="116"/>
                </a:cubicBezTo>
                <a:cubicBezTo>
                  <a:pt x="48" y="116"/>
                  <a:pt x="54" y="113"/>
                  <a:pt x="59" y="106"/>
                </a:cubicBezTo>
                <a:cubicBezTo>
                  <a:pt x="63" y="99"/>
                  <a:pt x="66" y="85"/>
                  <a:pt x="66" y="64"/>
                </a:cubicBezTo>
                <a:cubicBezTo>
                  <a:pt x="66" y="44"/>
                  <a:pt x="63" y="30"/>
                  <a:pt x="59" y="23"/>
                </a:cubicBezTo>
                <a:cubicBezTo>
                  <a:pt x="54" y="16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29"/>
                  <a:pt x="16" y="44"/>
                  <a:pt x="16" y="64"/>
                </a:cubicBezTo>
                <a:close/>
                <a:moveTo>
                  <a:pt x="104" y="127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7"/>
                </a:lnTo>
                <a:cubicBezTo>
                  <a:pt x="122" y="133"/>
                  <a:pt x="120" y="138"/>
                  <a:pt x="118" y="142"/>
                </a:cubicBezTo>
                <a:cubicBezTo>
                  <a:pt x="116" y="146"/>
                  <a:pt x="112" y="149"/>
                  <a:pt x="107" y="152"/>
                </a:cubicBezTo>
                <a:lnTo>
                  <a:pt x="103" y="145"/>
                </a:lnTo>
                <a:cubicBezTo>
                  <a:pt x="106" y="143"/>
                  <a:pt x="109" y="141"/>
                  <a:pt x="110" y="139"/>
                </a:cubicBezTo>
                <a:cubicBezTo>
                  <a:pt x="112" y="136"/>
                  <a:pt x="113" y="132"/>
                  <a:pt x="113" y="127"/>
                </a:cubicBezTo>
                <a:lnTo>
                  <a:pt x="104" y="127"/>
                </a:lnTo>
                <a:close/>
                <a:moveTo>
                  <a:pt x="144" y="64"/>
                </a:moveTo>
                <a:cubicBezTo>
                  <a:pt x="144" y="49"/>
                  <a:pt x="145" y="37"/>
                  <a:pt x="148" y="28"/>
                </a:cubicBezTo>
                <a:cubicBezTo>
                  <a:pt x="151" y="19"/>
                  <a:pt x="156" y="12"/>
                  <a:pt x="162" y="7"/>
                </a:cubicBezTo>
                <a:cubicBezTo>
                  <a:pt x="168" y="2"/>
                  <a:pt x="176" y="0"/>
                  <a:pt x="185" y="0"/>
                </a:cubicBezTo>
                <a:cubicBezTo>
                  <a:pt x="192" y="0"/>
                  <a:pt x="197" y="1"/>
                  <a:pt x="202" y="4"/>
                </a:cubicBezTo>
                <a:cubicBezTo>
                  <a:pt x="208" y="7"/>
                  <a:pt x="212" y="11"/>
                  <a:pt x="215" y="16"/>
                </a:cubicBezTo>
                <a:cubicBezTo>
                  <a:pt x="218" y="21"/>
                  <a:pt x="221" y="27"/>
                  <a:pt x="223" y="35"/>
                </a:cubicBezTo>
                <a:cubicBezTo>
                  <a:pt x="225" y="42"/>
                  <a:pt x="226" y="52"/>
                  <a:pt x="226" y="64"/>
                </a:cubicBezTo>
                <a:cubicBezTo>
                  <a:pt x="226" y="79"/>
                  <a:pt x="224" y="91"/>
                  <a:pt x="221" y="100"/>
                </a:cubicBezTo>
                <a:cubicBezTo>
                  <a:pt x="218" y="109"/>
                  <a:pt x="214" y="116"/>
                  <a:pt x="208" y="121"/>
                </a:cubicBezTo>
                <a:cubicBezTo>
                  <a:pt x="202" y="126"/>
                  <a:pt x="194" y="129"/>
                  <a:pt x="185" y="129"/>
                </a:cubicBezTo>
                <a:cubicBezTo>
                  <a:pt x="173" y="129"/>
                  <a:pt x="163" y="124"/>
                  <a:pt x="156" y="116"/>
                </a:cubicBezTo>
                <a:cubicBezTo>
                  <a:pt x="148" y="105"/>
                  <a:pt x="144" y="88"/>
                  <a:pt x="144" y="64"/>
                </a:cubicBezTo>
                <a:close/>
                <a:moveTo>
                  <a:pt x="160" y="64"/>
                </a:moveTo>
                <a:cubicBezTo>
                  <a:pt x="160" y="85"/>
                  <a:pt x="162" y="99"/>
                  <a:pt x="167" y="106"/>
                </a:cubicBezTo>
                <a:cubicBezTo>
                  <a:pt x="172" y="113"/>
                  <a:pt x="178" y="116"/>
                  <a:pt x="185" y="116"/>
                </a:cubicBezTo>
                <a:cubicBezTo>
                  <a:pt x="192" y="116"/>
                  <a:pt x="198" y="113"/>
                  <a:pt x="203" y="106"/>
                </a:cubicBezTo>
                <a:cubicBezTo>
                  <a:pt x="207" y="99"/>
                  <a:pt x="210" y="85"/>
                  <a:pt x="210" y="64"/>
                </a:cubicBezTo>
                <a:cubicBezTo>
                  <a:pt x="210" y="44"/>
                  <a:pt x="207" y="30"/>
                  <a:pt x="203" y="23"/>
                </a:cubicBezTo>
                <a:cubicBezTo>
                  <a:pt x="198" y="16"/>
                  <a:pt x="192" y="13"/>
                  <a:pt x="185" y="13"/>
                </a:cubicBezTo>
                <a:cubicBezTo>
                  <a:pt x="177" y="13"/>
                  <a:pt x="172" y="16"/>
                  <a:pt x="168" y="22"/>
                </a:cubicBezTo>
                <a:cubicBezTo>
                  <a:pt x="162" y="29"/>
                  <a:pt x="160" y="44"/>
                  <a:pt x="160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6" name="Freeform 33"/>
          <p:cNvSpPr>
            <a:spLocks/>
          </p:cNvSpPr>
          <p:nvPr/>
        </p:nvSpPr>
        <p:spPr bwMode="auto">
          <a:xfrm>
            <a:off x="6165310" y="1982433"/>
            <a:ext cx="3427331" cy="1523892"/>
          </a:xfrm>
          <a:custGeom>
            <a:avLst/>
            <a:gdLst>
              <a:gd name="T0" fmla="*/ 0 w 1201"/>
              <a:gd name="T1" fmla="*/ 0 h 534"/>
              <a:gd name="T2" fmla="*/ 25 w 1201"/>
              <a:gd name="T3" fmla="*/ 12 h 534"/>
              <a:gd name="T4" fmla="*/ 62 w 1201"/>
              <a:gd name="T5" fmla="*/ 25 h 534"/>
              <a:gd name="T6" fmla="*/ 114 w 1201"/>
              <a:gd name="T7" fmla="*/ 38 h 534"/>
              <a:gd name="T8" fmla="*/ 134 w 1201"/>
              <a:gd name="T9" fmla="*/ 51 h 534"/>
              <a:gd name="T10" fmla="*/ 156 w 1201"/>
              <a:gd name="T11" fmla="*/ 65 h 534"/>
              <a:gd name="T12" fmla="*/ 160 w 1201"/>
              <a:gd name="T13" fmla="*/ 78 h 534"/>
              <a:gd name="T14" fmla="*/ 182 w 1201"/>
              <a:gd name="T15" fmla="*/ 93 h 534"/>
              <a:gd name="T16" fmla="*/ 213 w 1201"/>
              <a:gd name="T17" fmla="*/ 108 h 534"/>
              <a:gd name="T18" fmla="*/ 219 w 1201"/>
              <a:gd name="T19" fmla="*/ 123 h 534"/>
              <a:gd name="T20" fmla="*/ 233 w 1201"/>
              <a:gd name="T21" fmla="*/ 139 h 534"/>
              <a:gd name="T22" fmla="*/ 307 w 1201"/>
              <a:gd name="T23" fmla="*/ 157 h 534"/>
              <a:gd name="T24" fmla="*/ 349 w 1201"/>
              <a:gd name="T25" fmla="*/ 177 h 534"/>
              <a:gd name="T26" fmla="*/ 402 w 1201"/>
              <a:gd name="T27" fmla="*/ 199 h 534"/>
              <a:gd name="T28" fmla="*/ 458 w 1201"/>
              <a:gd name="T29" fmla="*/ 224 h 534"/>
              <a:gd name="T30" fmla="*/ 527 w 1201"/>
              <a:gd name="T31" fmla="*/ 249 h 534"/>
              <a:gd name="T32" fmla="*/ 543 w 1201"/>
              <a:gd name="T33" fmla="*/ 277 h 534"/>
              <a:gd name="T34" fmla="*/ 649 w 1201"/>
              <a:gd name="T35" fmla="*/ 323 h 534"/>
              <a:gd name="T36" fmla="*/ 735 w 1201"/>
              <a:gd name="T37" fmla="*/ 372 h 534"/>
              <a:gd name="T38" fmla="*/ 777 w 1201"/>
              <a:gd name="T39" fmla="*/ 420 h 534"/>
              <a:gd name="T40" fmla="*/ 811 w 1201"/>
              <a:gd name="T41" fmla="*/ 469 h 534"/>
              <a:gd name="T42" fmla="*/ 878 w 1201"/>
              <a:gd name="T43" fmla="*/ 534 h 534"/>
              <a:gd name="T44" fmla="*/ 1201 w 1201"/>
              <a:gd name="T45" fmla="*/ 534 h 5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</a:cxnLst>
            <a:rect l="0" t="0" r="r" b="b"/>
            <a:pathLst>
              <a:path w="1201" h="534">
                <a:moveTo>
                  <a:pt x="0" y="0"/>
                </a:moveTo>
                <a:lnTo>
                  <a:pt x="25" y="12"/>
                </a:lnTo>
                <a:lnTo>
                  <a:pt x="62" y="25"/>
                </a:lnTo>
                <a:lnTo>
                  <a:pt x="114" y="38"/>
                </a:lnTo>
                <a:lnTo>
                  <a:pt x="134" y="51"/>
                </a:lnTo>
                <a:lnTo>
                  <a:pt x="156" y="65"/>
                </a:lnTo>
                <a:lnTo>
                  <a:pt x="160" y="78"/>
                </a:lnTo>
                <a:lnTo>
                  <a:pt x="182" y="93"/>
                </a:lnTo>
                <a:lnTo>
                  <a:pt x="213" y="108"/>
                </a:lnTo>
                <a:lnTo>
                  <a:pt x="219" y="123"/>
                </a:lnTo>
                <a:lnTo>
                  <a:pt x="233" y="139"/>
                </a:lnTo>
                <a:lnTo>
                  <a:pt x="307" y="157"/>
                </a:lnTo>
                <a:lnTo>
                  <a:pt x="349" y="177"/>
                </a:lnTo>
                <a:lnTo>
                  <a:pt x="402" y="199"/>
                </a:lnTo>
                <a:lnTo>
                  <a:pt x="458" y="224"/>
                </a:lnTo>
                <a:lnTo>
                  <a:pt x="527" y="249"/>
                </a:lnTo>
                <a:lnTo>
                  <a:pt x="543" y="277"/>
                </a:lnTo>
                <a:lnTo>
                  <a:pt x="649" y="323"/>
                </a:lnTo>
                <a:lnTo>
                  <a:pt x="735" y="372"/>
                </a:lnTo>
                <a:lnTo>
                  <a:pt x="777" y="420"/>
                </a:lnTo>
                <a:lnTo>
                  <a:pt x="811" y="469"/>
                </a:lnTo>
                <a:lnTo>
                  <a:pt x="878" y="534"/>
                </a:lnTo>
                <a:lnTo>
                  <a:pt x="1201" y="534"/>
                </a:lnTo>
              </a:path>
            </a:pathLst>
          </a:cu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2" name="Line 50"/>
          <p:cNvSpPr>
            <a:spLocks noChangeShapeType="1"/>
          </p:cNvSpPr>
          <p:nvPr/>
        </p:nvSpPr>
        <p:spPr bwMode="auto">
          <a:xfrm>
            <a:off x="1379542" y="5546562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3" name="Line 51"/>
          <p:cNvSpPr>
            <a:spLocks noChangeShapeType="1"/>
          </p:cNvSpPr>
          <p:nvPr/>
        </p:nvSpPr>
        <p:spPr bwMode="auto">
          <a:xfrm>
            <a:off x="2262818" y="5553650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4" name="Line 52"/>
          <p:cNvSpPr>
            <a:spLocks noChangeShapeType="1"/>
          </p:cNvSpPr>
          <p:nvPr/>
        </p:nvSpPr>
        <p:spPr bwMode="auto">
          <a:xfrm>
            <a:off x="3153182" y="5553650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5" name="Line 53"/>
          <p:cNvSpPr>
            <a:spLocks noChangeShapeType="1"/>
          </p:cNvSpPr>
          <p:nvPr/>
        </p:nvSpPr>
        <p:spPr bwMode="auto">
          <a:xfrm>
            <a:off x="4043546" y="5553650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6" name="Line 54"/>
          <p:cNvSpPr>
            <a:spLocks noChangeShapeType="1"/>
          </p:cNvSpPr>
          <p:nvPr/>
        </p:nvSpPr>
        <p:spPr bwMode="auto">
          <a:xfrm>
            <a:off x="4933911" y="5553650"/>
            <a:ext cx="0" cy="6849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8" name="Freeform 56"/>
          <p:cNvSpPr>
            <a:spLocks noEditPoints="1"/>
          </p:cNvSpPr>
          <p:nvPr/>
        </p:nvSpPr>
        <p:spPr bwMode="auto">
          <a:xfrm>
            <a:off x="4774102" y="5650677"/>
            <a:ext cx="316764" cy="91319"/>
          </a:xfrm>
          <a:custGeom>
            <a:avLst/>
            <a:gdLst>
              <a:gd name="T0" fmla="*/ 55 w 519"/>
              <a:gd name="T1" fmla="*/ 96 h 152"/>
              <a:gd name="T2" fmla="*/ 0 w 519"/>
              <a:gd name="T3" fmla="*/ 82 h 152"/>
              <a:gd name="T4" fmla="*/ 70 w 519"/>
              <a:gd name="T5" fmla="*/ 1 h 152"/>
              <a:gd name="T6" fmla="*/ 87 w 519"/>
              <a:gd name="T7" fmla="*/ 82 h 152"/>
              <a:gd name="T8" fmla="*/ 70 w 519"/>
              <a:gd name="T9" fmla="*/ 96 h 152"/>
              <a:gd name="T10" fmla="*/ 55 w 519"/>
              <a:gd name="T11" fmla="*/ 127 h 152"/>
              <a:gd name="T12" fmla="*/ 55 w 519"/>
              <a:gd name="T13" fmla="*/ 25 h 152"/>
              <a:gd name="T14" fmla="*/ 55 w 519"/>
              <a:gd name="T15" fmla="*/ 82 h 152"/>
              <a:gd name="T16" fmla="*/ 105 w 519"/>
              <a:gd name="T17" fmla="*/ 28 h 152"/>
              <a:gd name="T18" fmla="*/ 142 w 519"/>
              <a:gd name="T19" fmla="*/ 0 h 152"/>
              <a:gd name="T20" fmla="*/ 172 w 519"/>
              <a:gd name="T21" fmla="*/ 16 h 152"/>
              <a:gd name="T22" fmla="*/ 183 w 519"/>
              <a:gd name="T23" fmla="*/ 64 h 152"/>
              <a:gd name="T24" fmla="*/ 165 w 519"/>
              <a:gd name="T25" fmla="*/ 121 h 152"/>
              <a:gd name="T26" fmla="*/ 113 w 519"/>
              <a:gd name="T27" fmla="*/ 116 h 152"/>
              <a:gd name="T28" fmla="*/ 117 w 519"/>
              <a:gd name="T29" fmla="*/ 64 h 152"/>
              <a:gd name="T30" fmla="*/ 142 w 519"/>
              <a:gd name="T31" fmla="*/ 116 h 152"/>
              <a:gd name="T32" fmla="*/ 167 w 519"/>
              <a:gd name="T33" fmla="*/ 64 h 152"/>
              <a:gd name="T34" fmla="*/ 142 w 519"/>
              <a:gd name="T35" fmla="*/ 13 h 152"/>
              <a:gd name="T36" fmla="*/ 117 w 519"/>
              <a:gd name="T37" fmla="*/ 64 h 152"/>
              <a:gd name="T38" fmla="*/ 201 w 519"/>
              <a:gd name="T39" fmla="*/ 28 h 152"/>
              <a:gd name="T40" fmla="*/ 238 w 519"/>
              <a:gd name="T41" fmla="*/ 0 h 152"/>
              <a:gd name="T42" fmla="*/ 268 w 519"/>
              <a:gd name="T43" fmla="*/ 16 h 152"/>
              <a:gd name="T44" fmla="*/ 279 w 519"/>
              <a:gd name="T45" fmla="*/ 64 h 152"/>
              <a:gd name="T46" fmla="*/ 261 w 519"/>
              <a:gd name="T47" fmla="*/ 121 h 152"/>
              <a:gd name="T48" fmla="*/ 209 w 519"/>
              <a:gd name="T49" fmla="*/ 116 h 152"/>
              <a:gd name="T50" fmla="*/ 213 w 519"/>
              <a:gd name="T51" fmla="*/ 64 h 152"/>
              <a:gd name="T52" fmla="*/ 238 w 519"/>
              <a:gd name="T53" fmla="*/ 116 h 152"/>
              <a:gd name="T54" fmla="*/ 263 w 519"/>
              <a:gd name="T55" fmla="*/ 64 h 152"/>
              <a:gd name="T56" fmla="*/ 238 w 519"/>
              <a:gd name="T57" fmla="*/ 13 h 152"/>
              <a:gd name="T58" fmla="*/ 213 w 519"/>
              <a:gd name="T59" fmla="*/ 64 h 152"/>
              <a:gd name="T60" fmla="*/ 297 w 519"/>
              <a:gd name="T61" fmla="*/ 28 h 152"/>
              <a:gd name="T62" fmla="*/ 334 w 519"/>
              <a:gd name="T63" fmla="*/ 0 h 152"/>
              <a:gd name="T64" fmla="*/ 364 w 519"/>
              <a:gd name="T65" fmla="*/ 16 h 152"/>
              <a:gd name="T66" fmla="*/ 375 w 519"/>
              <a:gd name="T67" fmla="*/ 64 h 152"/>
              <a:gd name="T68" fmla="*/ 357 w 519"/>
              <a:gd name="T69" fmla="*/ 121 h 152"/>
              <a:gd name="T70" fmla="*/ 305 w 519"/>
              <a:gd name="T71" fmla="*/ 116 h 152"/>
              <a:gd name="T72" fmla="*/ 309 w 519"/>
              <a:gd name="T73" fmla="*/ 64 h 152"/>
              <a:gd name="T74" fmla="*/ 334 w 519"/>
              <a:gd name="T75" fmla="*/ 116 h 152"/>
              <a:gd name="T76" fmla="*/ 359 w 519"/>
              <a:gd name="T77" fmla="*/ 64 h 152"/>
              <a:gd name="T78" fmla="*/ 334 w 519"/>
              <a:gd name="T79" fmla="*/ 13 h 152"/>
              <a:gd name="T80" fmla="*/ 309 w 519"/>
              <a:gd name="T81" fmla="*/ 64 h 152"/>
              <a:gd name="T82" fmla="*/ 397 w 519"/>
              <a:gd name="T83" fmla="*/ 109 h 152"/>
              <a:gd name="T84" fmla="*/ 415 w 519"/>
              <a:gd name="T85" fmla="*/ 127 h 152"/>
              <a:gd name="T86" fmla="*/ 401 w 519"/>
              <a:gd name="T87" fmla="*/ 152 h 152"/>
              <a:gd name="T88" fmla="*/ 403 w 519"/>
              <a:gd name="T89" fmla="*/ 139 h 152"/>
              <a:gd name="T90" fmla="*/ 397 w 519"/>
              <a:gd name="T91" fmla="*/ 127 h 152"/>
              <a:gd name="T92" fmla="*/ 441 w 519"/>
              <a:gd name="T93" fmla="*/ 28 h 152"/>
              <a:gd name="T94" fmla="*/ 478 w 519"/>
              <a:gd name="T95" fmla="*/ 0 h 152"/>
              <a:gd name="T96" fmla="*/ 508 w 519"/>
              <a:gd name="T97" fmla="*/ 16 h 152"/>
              <a:gd name="T98" fmla="*/ 519 w 519"/>
              <a:gd name="T99" fmla="*/ 64 h 152"/>
              <a:gd name="T100" fmla="*/ 501 w 519"/>
              <a:gd name="T101" fmla="*/ 121 h 152"/>
              <a:gd name="T102" fmla="*/ 449 w 519"/>
              <a:gd name="T103" fmla="*/ 116 h 152"/>
              <a:gd name="T104" fmla="*/ 453 w 519"/>
              <a:gd name="T105" fmla="*/ 64 h 152"/>
              <a:gd name="T106" fmla="*/ 478 w 519"/>
              <a:gd name="T107" fmla="*/ 116 h 152"/>
              <a:gd name="T108" fmla="*/ 503 w 519"/>
              <a:gd name="T109" fmla="*/ 64 h 152"/>
              <a:gd name="T110" fmla="*/ 478 w 519"/>
              <a:gd name="T111" fmla="*/ 13 h 152"/>
              <a:gd name="T112" fmla="*/ 453 w 519"/>
              <a:gd name="T113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519" h="152">
                <a:moveTo>
                  <a:pt x="55" y="127"/>
                </a:moveTo>
                <a:lnTo>
                  <a:pt x="55" y="96"/>
                </a:lnTo>
                <a:lnTo>
                  <a:pt x="0" y="96"/>
                </a:lnTo>
                <a:lnTo>
                  <a:pt x="0" y="82"/>
                </a:lnTo>
                <a:lnTo>
                  <a:pt x="57" y="1"/>
                </a:lnTo>
                <a:lnTo>
                  <a:pt x="70" y="1"/>
                </a:lnTo>
                <a:lnTo>
                  <a:pt x="70" y="82"/>
                </a:lnTo>
                <a:lnTo>
                  <a:pt x="87" y="82"/>
                </a:lnTo>
                <a:lnTo>
                  <a:pt x="87" y="96"/>
                </a:lnTo>
                <a:lnTo>
                  <a:pt x="70" y="96"/>
                </a:lnTo>
                <a:lnTo>
                  <a:pt x="70" y="127"/>
                </a:lnTo>
                <a:lnTo>
                  <a:pt x="55" y="127"/>
                </a:lnTo>
                <a:close/>
                <a:moveTo>
                  <a:pt x="55" y="82"/>
                </a:moveTo>
                <a:lnTo>
                  <a:pt x="55" y="25"/>
                </a:lnTo>
                <a:lnTo>
                  <a:pt x="15" y="82"/>
                </a:lnTo>
                <a:lnTo>
                  <a:pt x="55" y="82"/>
                </a:lnTo>
                <a:close/>
                <a:moveTo>
                  <a:pt x="101" y="64"/>
                </a:moveTo>
                <a:cubicBezTo>
                  <a:pt x="101" y="49"/>
                  <a:pt x="102" y="38"/>
                  <a:pt x="105" y="28"/>
                </a:cubicBezTo>
                <a:cubicBezTo>
                  <a:pt x="109" y="19"/>
                  <a:pt x="113" y="12"/>
                  <a:pt x="119" y="7"/>
                </a:cubicBezTo>
                <a:cubicBezTo>
                  <a:pt x="125" y="3"/>
                  <a:pt x="133" y="0"/>
                  <a:pt x="142" y="0"/>
                </a:cubicBezTo>
                <a:cubicBezTo>
                  <a:pt x="149" y="0"/>
                  <a:pt x="155" y="1"/>
                  <a:pt x="160" y="4"/>
                </a:cubicBezTo>
                <a:cubicBezTo>
                  <a:pt x="165" y="7"/>
                  <a:pt x="169" y="11"/>
                  <a:pt x="172" y="16"/>
                </a:cubicBezTo>
                <a:cubicBezTo>
                  <a:pt x="176" y="21"/>
                  <a:pt x="178" y="27"/>
                  <a:pt x="180" y="35"/>
                </a:cubicBezTo>
                <a:cubicBezTo>
                  <a:pt x="182" y="42"/>
                  <a:pt x="183" y="52"/>
                  <a:pt x="183" y="64"/>
                </a:cubicBezTo>
                <a:cubicBezTo>
                  <a:pt x="183" y="79"/>
                  <a:pt x="182" y="91"/>
                  <a:pt x="178" y="100"/>
                </a:cubicBezTo>
                <a:cubicBezTo>
                  <a:pt x="175" y="109"/>
                  <a:pt x="171" y="116"/>
                  <a:pt x="165" y="121"/>
                </a:cubicBezTo>
                <a:cubicBezTo>
                  <a:pt x="159" y="126"/>
                  <a:pt x="151" y="129"/>
                  <a:pt x="142" y="129"/>
                </a:cubicBezTo>
                <a:cubicBezTo>
                  <a:pt x="130" y="129"/>
                  <a:pt x="120" y="124"/>
                  <a:pt x="113" y="116"/>
                </a:cubicBezTo>
                <a:cubicBezTo>
                  <a:pt x="105" y="105"/>
                  <a:pt x="101" y="88"/>
                  <a:pt x="101" y="64"/>
                </a:cubicBezTo>
                <a:close/>
                <a:moveTo>
                  <a:pt x="117" y="64"/>
                </a:moveTo>
                <a:cubicBezTo>
                  <a:pt x="117" y="85"/>
                  <a:pt x="119" y="99"/>
                  <a:pt x="124" y="106"/>
                </a:cubicBezTo>
                <a:cubicBezTo>
                  <a:pt x="129" y="113"/>
                  <a:pt x="135" y="116"/>
                  <a:pt x="142" y="116"/>
                </a:cubicBezTo>
                <a:cubicBezTo>
                  <a:pt x="149" y="116"/>
                  <a:pt x="155" y="113"/>
                  <a:pt x="160" y="106"/>
                </a:cubicBezTo>
                <a:cubicBezTo>
                  <a:pt x="165" y="99"/>
                  <a:pt x="167" y="85"/>
                  <a:pt x="167" y="64"/>
                </a:cubicBezTo>
                <a:cubicBezTo>
                  <a:pt x="167" y="44"/>
                  <a:pt x="165" y="30"/>
                  <a:pt x="160" y="23"/>
                </a:cubicBezTo>
                <a:cubicBezTo>
                  <a:pt x="155" y="16"/>
                  <a:pt x="149" y="13"/>
                  <a:pt x="142" y="13"/>
                </a:cubicBezTo>
                <a:cubicBezTo>
                  <a:pt x="135" y="13"/>
                  <a:pt x="129" y="16"/>
                  <a:pt x="125" y="22"/>
                </a:cubicBezTo>
                <a:cubicBezTo>
                  <a:pt x="120" y="29"/>
                  <a:pt x="117" y="44"/>
                  <a:pt x="117" y="64"/>
                </a:cubicBezTo>
                <a:close/>
                <a:moveTo>
                  <a:pt x="197" y="64"/>
                </a:moveTo>
                <a:cubicBezTo>
                  <a:pt x="197" y="49"/>
                  <a:pt x="198" y="38"/>
                  <a:pt x="201" y="28"/>
                </a:cubicBezTo>
                <a:cubicBezTo>
                  <a:pt x="205" y="19"/>
                  <a:pt x="209" y="12"/>
                  <a:pt x="215" y="7"/>
                </a:cubicBezTo>
                <a:cubicBezTo>
                  <a:pt x="221" y="3"/>
                  <a:pt x="229" y="0"/>
                  <a:pt x="238" y="0"/>
                </a:cubicBezTo>
                <a:cubicBezTo>
                  <a:pt x="245" y="0"/>
                  <a:pt x="251" y="1"/>
                  <a:pt x="256" y="4"/>
                </a:cubicBezTo>
                <a:cubicBezTo>
                  <a:pt x="261" y="7"/>
                  <a:pt x="265" y="11"/>
                  <a:pt x="268" y="16"/>
                </a:cubicBezTo>
                <a:cubicBezTo>
                  <a:pt x="272" y="21"/>
                  <a:pt x="274" y="27"/>
                  <a:pt x="276" y="35"/>
                </a:cubicBezTo>
                <a:cubicBezTo>
                  <a:pt x="278" y="42"/>
                  <a:pt x="279" y="52"/>
                  <a:pt x="279" y="64"/>
                </a:cubicBezTo>
                <a:cubicBezTo>
                  <a:pt x="279" y="79"/>
                  <a:pt x="278" y="91"/>
                  <a:pt x="274" y="100"/>
                </a:cubicBezTo>
                <a:cubicBezTo>
                  <a:pt x="271" y="109"/>
                  <a:pt x="267" y="116"/>
                  <a:pt x="261" y="121"/>
                </a:cubicBezTo>
                <a:cubicBezTo>
                  <a:pt x="255" y="126"/>
                  <a:pt x="247" y="129"/>
                  <a:pt x="238" y="129"/>
                </a:cubicBezTo>
                <a:cubicBezTo>
                  <a:pt x="226" y="129"/>
                  <a:pt x="216" y="124"/>
                  <a:pt x="209" y="116"/>
                </a:cubicBezTo>
                <a:cubicBezTo>
                  <a:pt x="201" y="105"/>
                  <a:pt x="197" y="88"/>
                  <a:pt x="197" y="64"/>
                </a:cubicBezTo>
                <a:close/>
                <a:moveTo>
                  <a:pt x="213" y="64"/>
                </a:moveTo>
                <a:cubicBezTo>
                  <a:pt x="213" y="85"/>
                  <a:pt x="215" y="99"/>
                  <a:pt x="220" y="106"/>
                </a:cubicBezTo>
                <a:cubicBezTo>
                  <a:pt x="225" y="113"/>
                  <a:pt x="231" y="116"/>
                  <a:pt x="238" y="116"/>
                </a:cubicBezTo>
                <a:cubicBezTo>
                  <a:pt x="245" y="116"/>
                  <a:pt x="251" y="113"/>
                  <a:pt x="256" y="106"/>
                </a:cubicBezTo>
                <a:cubicBezTo>
                  <a:pt x="261" y="99"/>
                  <a:pt x="263" y="85"/>
                  <a:pt x="263" y="64"/>
                </a:cubicBezTo>
                <a:cubicBezTo>
                  <a:pt x="263" y="44"/>
                  <a:pt x="261" y="30"/>
                  <a:pt x="256" y="23"/>
                </a:cubicBezTo>
                <a:cubicBezTo>
                  <a:pt x="251" y="16"/>
                  <a:pt x="245" y="13"/>
                  <a:pt x="238" y="13"/>
                </a:cubicBezTo>
                <a:cubicBezTo>
                  <a:pt x="231" y="13"/>
                  <a:pt x="225" y="16"/>
                  <a:pt x="221" y="22"/>
                </a:cubicBezTo>
                <a:cubicBezTo>
                  <a:pt x="216" y="29"/>
                  <a:pt x="213" y="44"/>
                  <a:pt x="213" y="64"/>
                </a:cubicBezTo>
                <a:close/>
                <a:moveTo>
                  <a:pt x="293" y="64"/>
                </a:moveTo>
                <a:cubicBezTo>
                  <a:pt x="293" y="49"/>
                  <a:pt x="294" y="38"/>
                  <a:pt x="297" y="28"/>
                </a:cubicBezTo>
                <a:cubicBezTo>
                  <a:pt x="301" y="19"/>
                  <a:pt x="305" y="12"/>
                  <a:pt x="311" y="7"/>
                </a:cubicBezTo>
                <a:cubicBezTo>
                  <a:pt x="317" y="3"/>
                  <a:pt x="325" y="0"/>
                  <a:pt x="334" y="0"/>
                </a:cubicBezTo>
                <a:cubicBezTo>
                  <a:pt x="341" y="0"/>
                  <a:pt x="347" y="1"/>
                  <a:pt x="352" y="4"/>
                </a:cubicBezTo>
                <a:cubicBezTo>
                  <a:pt x="357" y="7"/>
                  <a:pt x="361" y="11"/>
                  <a:pt x="364" y="16"/>
                </a:cubicBezTo>
                <a:cubicBezTo>
                  <a:pt x="368" y="21"/>
                  <a:pt x="370" y="27"/>
                  <a:pt x="372" y="35"/>
                </a:cubicBezTo>
                <a:cubicBezTo>
                  <a:pt x="374" y="42"/>
                  <a:pt x="375" y="52"/>
                  <a:pt x="375" y="64"/>
                </a:cubicBezTo>
                <a:cubicBezTo>
                  <a:pt x="375" y="79"/>
                  <a:pt x="374" y="91"/>
                  <a:pt x="370" y="100"/>
                </a:cubicBezTo>
                <a:cubicBezTo>
                  <a:pt x="367" y="109"/>
                  <a:pt x="363" y="116"/>
                  <a:pt x="357" y="121"/>
                </a:cubicBezTo>
                <a:cubicBezTo>
                  <a:pt x="351" y="126"/>
                  <a:pt x="343" y="129"/>
                  <a:pt x="334" y="129"/>
                </a:cubicBezTo>
                <a:cubicBezTo>
                  <a:pt x="322" y="129"/>
                  <a:pt x="312" y="124"/>
                  <a:pt x="305" y="116"/>
                </a:cubicBezTo>
                <a:cubicBezTo>
                  <a:pt x="297" y="105"/>
                  <a:pt x="293" y="88"/>
                  <a:pt x="293" y="64"/>
                </a:cubicBezTo>
                <a:close/>
                <a:moveTo>
                  <a:pt x="309" y="64"/>
                </a:moveTo>
                <a:cubicBezTo>
                  <a:pt x="309" y="85"/>
                  <a:pt x="311" y="99"/>
                  <a:pt x="316" y="106"/>
                </a:cubicBezTo>
                <a:cubicBezTo>
                  <a:pt x="321" y="113"/>
                  <a:pt x="327" y="116"/>
                  <a:pt x="334" y="116"/>
                </a:cubicBezTo>
                <a:cubicBezTo>
                  <a:pt x="341" y="116"/>
                  <a:pt x="347" y="113"/>
                  <a:pt x="352" y="106"/>
                </a:cubicBezTo>
                <a:cubicBezTo>
                  <a:pt x="357" y="99"/>
                  <a:pt x="359" y="85"/>
                  <a:pt x="359" y="64"/>
                </a:cubicBezTo>
                <a:cubicBezTo>
                  <a:pt x="359" y="44"/>
                  <a:pt x="357" y="30"/>
                  <a:pt x="352" y="23"/>
                </a:cubicBezTo>
                <a:cubicBezTo>
                  <a:pt x="347" y="16"/>
                  <a:pt x="341" y="13"/>
                  <a:pt x="334" y="13"/>
                </a:cubicBezTo>
                <a:cubicBezTo>
                  <a:pt x="327" y="13"/>
                  <a:pt x="321" y="16"/>
                  <a:pt x="317" y="22"/>
                </a:cubicBezTo>
                <a:cubicBezTo>
                  <a:pt x="312" y="29"/>
                  <a:pt x="309" y="44"/>
                  <a:pt x="309" y="64"/>
                </a:cubicBezTo>
                <a:close/>
                <a:moveTo>
                  <a:pt x="397" y="127"/>
                </a:moveTo>
                <a:lnTo>
                  <a:pt x="397" y="109"/>
                </a:lnTo>
                <a:lnTo>
                  <a:pt x="415" y="109"/>
                </a:lnTo>
                <a:lnTo>
                  <a:pt x="415" y="127"/>
                </a:lnTo>
                <a:cubicBezTo>
                  <a:pt x="415" y="133"/>
                  <a:pt x="414" y="138"/>
                  <a:pt x="411" y="142"/>
                </a:cubicBezTo>
                <a:cubicBezTo>
                  <a:pt x="409" y="146"/>
                  <a:pt x="406" y="149"/>
                  <a:pt x="401" y="152"/>
                </a:cubicBezTo>
                <a:lnTo>
                  <a:pt x="396" y="145"/>
                </a:lnTo>
                <a:cubicBezTo>
                  <a:pt x="399" y="143"/>
                  <a:pt x="402" y="141"/>
                  <a:pt x="403" y="139"/>
                </a:cubicBezTo>
                <a:cubicBezTo>
                  <a:pt x="405" y="136"/>
                  <a:pt x="406" y="132"/>
                  <a:pt x="406" y="127"/>
                </a:cubicBezTo>
                <a:lnTo>
                  <a:pt x="397" y="127"/>
                </a:lnTo>
                <a:close/>
                <a:moveTo>
                  <a:pt x="437" y="64"/>
                </a:moveTo>
                <a:cubicBezTo>
                  <a:pt x="437" y="49"/>
                  <a:pt x="438" y="38"/>
                  <a:pt x="441" y="28"/>
                </a:cubicBezTo>
                <a:cubicBezTo>
                  <a:pt x="445" y="19"/>
                  <a:pt x="449" y="12"/>
                  <a:pt x="455" y="7"/>
                </a:cubicBezTo>
                <a:cubicBezTo>
                  <a:pt x="461" y="3"/>
                  <a:pt x="469" y="0"/>
                  <a:pt x="478" y="0"/>
                </a:cubicBezTo>
                <a:cubicBezTo>
                  <a:pt x="485" y="0"/>
                  <a:pt x="491" y="1"/>
                  <a:pt x="496" y="4"/>
                </a:cubicBezTo>
                <a:cubicBezTo>
                  <a:pt x="501" y="7"/>
                  <a:pt x="505" y="11"/>
                  <a:pt x="508" y="16"/>
                </a:cubicBezTo>
                <a:cubicBezTo>
                  <a:pt x="512" y="21"/>
                  <a:pt x="514" y="27"/>
                  <a:pt x="516" y="35"/>
                </a:cubicBezTo>
                <a:cubicBezTo>
                  <a:pt x="518" y="42"/>
                  <a:pt x="519" y="52"/>
                  <a:pt x="519" y="64"/>
                </a:cubicBezTo>
                <a:cubicBezTo>
                  <a:pt x="519" y="79"/>
                  <a:pt x="518" y="91"/>
                  <a:pt x="514" y="100"/>
                </a:cubicBezTo>
                <a:cubicBezTo>
                  <a:pt x="511" y="109"/>
                  <a:pt x="507" y="116"/>
                  <a:pt x="501" y="121"/>
                </a:cubicBezTo>
                <a:cubicBezTo>
                  <a:pt x="495" y="126"/>
                  <a:pt x="487" y="129"/>
                  <a:pt x="478" y="129"/>
                </a:cubicBezTo>
                <a:cubicBezTo>
                  <a:pt x="466" y="129"/>
                  <a:pt x="456" y="124"/>
                  <a:pt x="449" y="116"/>
                </a:cubicBezTo>
                <a:cubicBezTo>
                  <a:pt x="441" y="105"/>
                  <a:pt x="437" y="88"/>
                  <a:pt x="437" y="64"/>
                </a:cubicBezTo>
                <a:close/>
                <a:moveTo>
                  <a:pt x="453" y="64"/>
                </a:moveTo>
                <a:cubicBezTo>
                  <a:pt x="453" y="85"/>
                  <a:pt x="455" y="99"/>
                  <a:pt x="460" y="106"/>
                </a:cubicBezTo>
                <a:cubicBezTo>
                  <a:pt x="465" y="113"/>
                  <a:pt x="471" y="116"/>
                  <a:pt x="478" y="116"/>
                </a:cubicBezTo>
                <a:cubicBezTo>
                  <a:pt x="485" y="116"/>
                  <a:pt x="491" y="113"/>
                  <a:pt x="496" y="106"/>
                </a:cubicBezTo>
                <a:cubicBezTo>
                  <a:pt x="501" y="99"/>
                  <a:pt x="503" y="85"/>
                  <a:pt x="503" y="64"/>
                </a:cubicBezTo>
                <a:cubicBezTo>
                  <a:pt x="503" y="44"/>
                  <a:pt x="501" y="30"/>
                  <a:pt x="496" y="23"/>
                </a:cubicBezTo>
                <a:cubicBezTo>
                  <a:pt x="491" y="16"/>
                  <a:pt x="485" y="13"/>
                  <a:pt x="478" y="13"/>
                </a:cubicBezTo>
                <a:cubicBezTo>
                  <a:pt x="471" y="13"/>
                  <a:pt x="465" y="16"/>
                  <a:pt x="461" y="22"/>
                </a:cubicBezTo>
                <a:cubicBezTo>
                  <a:pt x="456" y="29"/>
                  <a:pt x="453" y="44"/>
                  <a:pt x="453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9" name="Freeform 57"/>
          <p:cNvSpPr>
            <a:spLocks noEditPoints="1"/>
          </p:cNvSpPr>
          <p:nvPr/>
        </p:nvSpPr>
        <p:spPr bwMode="auto">
          <a:xfrm>
            <a:off x="3886591" y="5650677"/>
            <a:ext cx="313910" cy="91319"/>
          </a:xfrm>
          <a:custGeom>
            <a:avLst/>
            <a:gdLst>
              <a:gd name="T0" fmla="*/ 24 w 514"/>
              <a:gd name="T1" fmla="*/ 110 h 152"/>
              <a:gd name="T2" fmla="*/ 66 w 514"/>
              <a:gd name="T3" fmla="*/ 90 h 152"/>
              <a:gd name="T4" fmla="*/ 30 w 514"/>
              <a:gd name="T5" fmla="*/ 67 h 152"/>
              <a:gd name="T6" fmla="*/ 52 w 514"/>
              <a:gd name="T7" fmla="*/ 48 h 152"/>
              <a:gd name="T8" fmla="*/ 39 w 514"/>
              <a:gd name="T9" fmla="*/ 13 h 152"/>
              <a:gd name="T10" fmla="*/ 1 w 514"/>
              <a:gd name="T11" fmla="*/ 33 h 152"/>
              <a:gd name="T12" fmla="*/ 58 w 514"/>
              <a:gd name="T13" fmla="*/ 4 h 152"/>
              <a:gd name="T14" fmla="*/ 72 w 514"/>
              <a:gd name="T15" fmla="*/ 48 h 152"/>
              <a:gd name="T16" fmla="*/ 82 w 514"/>
              <a:gd name="T17" fmla="*/ 89 h 152"/>
              <a:gd name="T18" fmla="*/ 12 w 514"/>
              <a:gd name="T19" fmla="*/ 119 h 152"/>
              <a:gd name="T20" fmla="*/ 100 w 514"/>
              <a:gd name="T21" fmla="*/ 28 h 152"/>
              <a:gd name="T22" fmla="*/ 154 w 514"/>
              <a:gd name="T23" fmla="*/ 4 h 152"/>
              <a:gd name="T24" fmla="*/ 178 w 514"/>
              <a:gd name="T25" fmla="*/ 64 h 152"/>
              <a:gd name="T26" fmla="*/ 137 w 514"/>
              <a:gd name="T27" fmla="*/ 129 h 152"/>
              <a:gd name="T28" fmla="*/ 111 w 514"/>
              <a:gd name="T29" fmla="*/ 64 h 152"/>
              <a:gd name="T30" fmla="*/ 154 w 514"/>
              <a:gd name="T31" fmla="*/ 106 h 152"/>
              <a:gd name="T32" fmla="*/ 136 w 514"/>
              <a:gd name="T33" fmla="*/ 13 h 152"/>
              <a:gd name="T34" fmla="*/ 191 w 514"/>
              <a:gd name="T35" fmla="*/ 64 h 152"/>
              <a:gd name="T36" fmla="*/ 233 w 514"/>
              <a:gd name="T37" fmla="*/ 0 h 152"/>
              <a:gd name="T38" fmla="*/ 271 w 514"/>
              <a:gd name="T39" fmla="*/ 35 h 152"/>
              <a:gd name="T40" fmla="*/ 255 w 514"/>
              <a:gd name="T41" fmla="*/ 121 h 152"/>
              <a:gd name="T42" fmla="*/ 191 w 514"/>
              <a:gd name="T43" fmla="*/ 64 h 152"/>
              <a:gd name="T44" fmla="*/ 233 w 514"/>
              <a:gd name="T45" fmla="*/ 116 h 152"/>
              <a:gd name="T46" fmla="*/ 250 w 514"/>
              <a:gd name="T47" fmla="*/ 23 h 152"/>
              <a:gd name="T48" fmla="*/ 207 w 514"/>
              <a:gd name="T49" fmla="*/ 64 h 152"/>
              <a:gd name="T50" fmla="*/ 306 w 514"/>
              <a:gd name="T51" fmla="*/ 7 h 152"/>
              <a:gd name="T52" fmla="*/ 359 w 514"/>
              <a:gd name="T53" fmla="*/ 16 h 152"/>
              <a:gd name="T54" fmla="*/ 365 w 514"/>
              <a:gd name="T55" fmla="*/ 100 h 152"/>
              <a:gd name="T56" fmla="*/ 300 w 514"/>
              <a:gd name="T57" fmla="*/ 116 h 152"/>
              <a:gd name="T58" fmla="*/ 311 w 514"/>
              <a:gd name="T59" fmla="*/ 106 h 152"/>
              <a:gd name="T60" fmla="*/ 354 w 514"/>
              <a:gd name="T61" fmla="*/ 64 h 152"/>
              <a:gd name="T62" fmla="*/ 311 w 514"/>
              <a:gd name="T63" fmla="*/ 22 h 152"/>
              <a:gd name="T64" fmla="*/ 392 w 514"/>
              <a:gd name="T65" fmla="*/ 109 h 152"/>
              <a:gd name="T66" fmla="*/ 406 w 514"/>
              <a:gd name="T67" fmla="*/ 142 h 152"/>
              <a:gd name="T68" fmla="*/ 398 w 514"/>
              <a:gd name="T69" fmla="*/ 139 h 152"/>
              <a:gd name="T70" fmla="*/ 431 w 514"/>
              <a:gd name="T71" fmla="*/ 64 h 152"/>
              <a:gd name="T72" fmla="*/ 473 w 514"/>
              <a:gd name="T73" fmla="*/ 0 h 152"/>
              <a:gd name="T74" fmla="*/ 511 w 514"/>
              <a:gd name="T75" fmla="*/ 35 h 152"/>
              <a:gd name="T76" fmla="*/ 495 w 514"/>
              <a:gd name="T77" fmla="*/ 121 h 152"/>
              <a:gd name="T78" fmla="*/ 431 w 514"/>
              <a:gd name="T79" fmla="*/ 64 h 152"/>
              <a:gd name="T80" fmla="*/ 473 w 514"/>
              <a:gd name="T81" fmla="*/ 116 h 152"/>
              <a:gd name="T82" fmla="*/ 490 w 514"/>
              <a:gd name="T83" fmla="*/ 23 h 152"/>
              <a:gd name="T84" fmla="*/ 447 w 514"/>
              <a:gd name="T85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514" h="152">
                <a:moveTo>
                  <a:pt x="0" y="93"/>
                </a:moveTo>
                <a:lnTo>
                  <a:pt x="15" y="91"/>
                </a:lnTo>
                <a:cubicBezTo>
                  <a:pt x="17" y="100"/>
                  <a:pt x="20" y="106"/>
                  <a:pt x="24" y="110"/>
                </a:cubicBezTo>
                <a:cubicBezTo>
                  <a:pt x="28" y="114"/>
                  <a:pt x="33" y="116"/>
                  <a:pt x="40" y="116"/>
                </a:cubicBezTo>
                <a:cubicBezTo>
                  <a:pt x="47" y="116"/>
                  <a:pt x="53" y="114"/>
                  <a:pt x="58" y="108"/>
                </a:cubicBezTo>
                <a:cubicBezTo>
                  <a:pt x="63" y="103"/>
                  <a:pt x="66" y="97"/>
                  <a:pt x="66" y="90"/>
                </a:cubicBezTo>
                <a:cubicBezTo>
                  <a:pt x="66" y="83"/>
                  <a:pt x="63" y="77"/>
                  <a:pt x="59" y="72"/>
                </a:cubicBezTo>
                <a:cubicBezTo>
                  <a:pt x="54" y="68"/>
                  <a:pt x="48" y="65"/>
                  <a:pt x="41" y="65"/>
                </a:cubicBezTo>
                <a:cubicBezTo>
                  <a:pt x="38" y="65"/>
                  <a:pt x="34" y="66"/>
                  <a:pt x="30" y="67"/>
                </a:cubicBezTo>
                <a:lnTo>
                  <a:pt x="32" y="53"/>
                </a:lnTo>
                <a:cubicBezTo>
                  <a:pt x="33" y="53"/>
                  <a:pt x="34" y="54"/>
                  <a:pt x="34" y="54"/>
                </a:cubicBezTo>
                <a:cubicBezTo>
                  <a:pt x="41" y="54"/>
                  <a:pt x="47" y="52"/>
                  <a:pt x="52" y="48"/>
                </a:cubicBezTo>
                <a:cubicBezTo>
                  <a:pt x="57" y="45"/>
                  <a:pt x="60" y="40"/>
                  <a:pt x="60" y="33"/>
                </a:cubicBezTo>
                <a:cubicBezTo>
                  <a:pt x="60" y="27"/>
                  <a:pt x="58" y="22"/>
                  <a:pt x="54" y="18"/>
                </a:cubicBezTo>
                <a:cubicBezTo>
                  <a:pt x="50" y="15"/>
                  <a:pt x="45" y="13"/>
                  <a:pt x="39" y="13"/>
                </a:cubicBezTo>
                <a:cubicBezTo>
                  <a:pt x="33" y="13"/>
                  <a:pt x="28" y="15"/>
                  <a:pt x="24" y="18"/>
                </a:cubicBezTo>
                <a:cubicBezTo>
                  <a:pt x="20" y="22"/>
                  <a:pt x="18" y="28"/>
                  <a:pt x="17" y="36"/>
                </a:cubicBezTo>
                <a:lnTo>
                  <a:pt x="1" y="33"/>
                </a:lnTo>
                <a:cubicBezTo>
                  <a:pt x="3" y="22"/>
                  <a:pt x="7" y="14"/>
                  <a:pt x="14" y="9"/>
                </a:cubicBezTo>
                <a:cubicBezTo>
                  <a:pt x="21" y="3"/>
                  <a:pt x="29" y="0"/>
                  <a:pt x="39" y="0"/>
                </a:cubicBezTo>
                <a:cubicBezTo>
                  <a:pt x="46" y="0"/>
                  <a:pt x="52" y="2"/>
                  <a:pt x="58" y="4"/>
                </a:cubicBezTo>
                <a:cubicBezTo>
                  <a:pt x="64" y="7"/>
                  <a:pt x="68" y="11"/>
                  <a:pt x="71" y="17"/>
                </a:cubicBezTo>
                <a:cubicBezTo>
                  <a:pt x="74" y="22"/>
                  <a:pt x="76" y="27"/>
                  <a:pt x="76" y="33"/>
                </a:cubicBezTo>
                <a:cubicBezTo>
                  <a:pt x="76" y="38"/>
                  <a:pt x="74" y="43"/>
                  <a:pt x="72" y="48"/>
                </a:cubicBezTo>
                <a:cubicBezTo>
                  <a:pt x="69" y="52"/>
                  <a:pt x="64" y="56"/>
                  <a:pt x="58" y="58"/>
                </a:cubicBezTo>
                <a:cubicBezTo>
                  <a:pt x="66" y="60"/>
                  <a:pt x="72" y="64"/>
                  <a:pt x="76" y="69"/>
                </a:cubicBezTo>
                <a:cubicBezTo>
                  <a:pt x="80" y="74"/>
                  <a:pt x="82" y="81"/>
                  <a:pt x="82" y="89"/>
                </a:cubicBezTo>
                <a:cubicBezTo>
                  <a:pt x="82" y="100"/>
                  <a:pt x="78" y="110"/>
                  <a:pt x="70" y="117"/>
                </a:cubicBezTo>
                <a:cubicBezTo>
                  <a:pt x="62" y="125"/>
                  <a:pt x="52" y="129"/>
                  <a:pt x="40" y="129"/>
                </a:cubicBezTo>
                <a:cubicBezTo>
                  <a:pt x="28" y="129"/>
                  <a:pt x="19" y="126"/>
                  <a:pt x="12" y="119"/>
                </a:cubicBezTo>
                <a:cubicBezTo>
                  <a:pt x="5" y="112"/>
                  <a:pt x="1" y="104"/>
                  <a:pt x="0" y="93"/>
                </a:cubicBezTo>
                <a:close/>
                <a:moveTo>
                  <a:pt x="95" y="64"/>
                </a:moveTo>
                <a:cubicBezTo>
                  <a:pt x="95" y="49"/>
                  <a:pt x="97" y="38"/>
                  <a:pt x="100" y="28"/>
                </a:cubicBezTo>
                <a:cubicBezTo>
                  <a:pt x="103" y="19"/>
                  <a:pt x="108" y="12"/>
                  <a:pt x="114" y="7"/>
                </a:cubicBezTo>
                <a:cubicBezTo>
                  <a:pt x="120" y="3"/>
                  <a:pt x="127" y="0"/>
                  <a:pt x="137" y="0"/>
                </a:cubicBezTo>
                <a:cubicBezTo>
                  <a:pt x="143" y="0"/>
                  <a:pt x="149" y="1"/>
                  <a:pt x="154" y="4"/>
                </a:cubicBezTo>
                <a:cubicBezTo>
                  <a:pt x="159" y="7"/>
                  <a:pt x="164" y="11"/>
                  <a:pt x="167" y="16"/>
                </a:cubicBezTo>
                <a:cubicBezTo>
                  <a:pt x="170" y="21"/>
                  <a:pt x="173" y="27"/>
                  <a:pt x="175" y="35"/>
                </a:cubicBezTo>
                <a:cubicBezTo>
                  <a:pt x="177" y="42"/>
                  <a:pt x="178" y="52"/>
                  <a:pt x="178" y="64"/>
                </a:cubicBezTo>
                <a:cubicBezTo>
                  <a:pt x="178" y="79"/>
                  <a:pt x="176" y="91"/>
                  <a:pt x="173" y="100"/>
                </a:cubicBezTo>
                <a:cubicBezTo>
                  <a:pt x="170" y="109"/>
                  <a:pt x="165" y="116"/>
                  <a:pt x="159" y="121"/>
                </a:cubicBezTo>
                <a:cubicBezTo>
                  <a:pt x="153" y="126"/>
                  <a:pt x="146" y="129"/>
                  <a:pt x="137" y="129"/>
                </a:cubicBezTo>
                <a:cubicBezTo>
                  <a:pt x="124" y="129"/>
                  <a:pt x="115" y="124"/>
                  <a:pt x="108" y="116"/>
                </a:cubicBezTo>
                <a:cubicBezTo>
                  <a:pt x="100" y="105"/>
                  <a:pt x="95" y="88"/>
                  <a:pt x="95" y="64"/>
                </a:cubicBezTo>
                <a:close/>
                <a:moveTo>
                  <a:pt x="111" y="64"/>
                </a:moveTo>
                <a:cubicBezTo>
                  <a:pt x="111" y="85"/>
                  <a:pt x="114" y="99"/>
                  <a:pt x="119" y="106"/>
                </a:cubicBezTo>
                <a:cubicBezTo>
                  <a:pt x="123" y="113"/>
                  <a:pt x="129" y="116"/>
                  <a:pt x="137" y="116"/>
                </a:cubicBezTo>
                <a:cubicBezTo>
                  <a:pt x="144" y="116"/>
                  <a:pt x="150" y="113"/>
                  <a:pt x="154" y="106"/>
                </a:cubicBezTo>
                <a:cubicBezTo>
                  <a:pt x="159" y="99"/>
                  <a:pt x="162" y="85"/>
                  <a:pt x="162" y="64"/>
                </a:cubicBezTo>
                <a:cubicBezTo>
                  <a:pt x="162" y="44"/>
                  <a:pt x="159" y="30"/>
                  <a:pt x="154" y="23"/>
                </a:cubicBezTo>
                <a:cubicBezTo>
                  <a:pt x="150" y="16"/>
                  <a:pt x="144" y="13"/>
                  <a:pt x="136" y="13"/>
                </a:cubicBezTo>
                <a:cubicBezTo>
                  <a:pt x="129" y="13"/>
                  <a:pt x="124" y="16"/>
                  <a:pt x="119" y="22"/>
                </a:cubicBezTo>
                <a:cubicBezTo>
                  <a:pt x="114" y="29"/>
                  <a:pt x="111" y="44"/>
                  <a:pt x="111" y="64"/>
                </a:cubicBezTo>
                <a:close/>
                <a:moveTo>
                  <a:pt x="191" y="64"/>
                </a:moveTo>
                <a:cubicBezTo>
                  <a:pt x="191" y="49"/>
                  <a:pt x="193" y="38"/>
                  <a:pt x="196" y="28"/>
                </a:cubicBezTo>
                <a:cubicBezTo>
                  <a:pt x="199" y="19"/>
                  <a:pt x="204" y="12"/>
                  <a:pt x="210" y="7"/>
                </a:cubicBezTo>
                <a:cubicBezTo>
                  <a:pt x="216" y="3"/>
                  <a:pt x="223" y="0"/>
                  <a:pt x="233" y="0"/>
                </a:cubicBezTo>
                <a:cubicBezTo>
                  <a:pt x="239" y="0"/>
                  <a:pt x="245" y="1"/>
                  <a:pt x="250" y="4"/>
                </a:cubicBezTo>
                <a:cubicBezTo>
                  <a:pt x="255" y="7"/>
                  <a:pt x="260" y="11"/>
                  <a:pt x="263" y="16"/>
                </a:cubicBezTo>
                <a:cubicBezTo>
                  <a:pt x="266" y="21"/>
                  <a:pt x="269" y="27"/>
                  <a:pt x="271" y="35"/>
                </a:cubicBezTo>
                <a:cubicBezTo>
                  <a:pt x="273" y="42"/>
                  <a:pt x="274" y="52"/>
                  <a:pt x="274" y="64"/>
                </a:cubicBezTo>
                <a:cubicBezTo>
                  <a:pt x="274" y="79"/>
                  <a:pt x="272" y="91"/>
                  <a:pt x="269" y="100"/>
                </a:cubicBezTo>
                <a:cubicBezTo>
                  <a:pt x="266" y="109"/>
                  <a:pt x="261" y="116"/>
                  <a:pt x="255" y="121"/>
                </a:cubicBezTo>
                <a:cubicBezTo>
                  <a:pt x="249" y="126"/>
                  <a:pt x="242" y="129"/>
                  <a:pt x="233" y="129"/>
                </a:cubicBezTo>
                <a:cubicBezTo>
                  <a:pt x="220" y="129"/>
                  <a:pt x="211" y="124"/>
                  <a:pt x="204" y="116"/>
                </a:cubicBezTo>
                <a:cubicBezTo>
                  <a:pt x="196" y="105"/>
                  <a:pt x="191" y="88"/>
                  <a:pt x="191" y="64"/>
                </a:cubicBezTo>
                <a:close/>
                <a:moveTo>
                  <a:pt x="207" y="64"/>
                </a:moveTo>
                <a:cubicBezTo>
                  <a:pt x="207" y="85"/>
                  <a:pt x="210" y="99"/>
                  <a:pt x="215" y="106"/>
                </a:cubicBezTo>
                <a:cubicBezTo>
                  <a:pt x="219" y="113"/>
                  <a:pt x="225" y="116"/>
                  <a:pt x="233" y="116"/>
                </a:cubicBezTo>
                <a:cubicBezTo>
                  <a:pt x="240" y="116"/>
                  <a:pt x="246" y="113"/>
                  <a:pt x="250" y="106"/>
                </a:cubicBezTo>
                <a:cubicBezTo>
                  <a:pt x="255" y="99"/>
                  <a:pt x="258" y="85"/>
                  <a:pt x="258" y="64"/>
                </a:cubicBezTo>
                <a:cubicBezTo>
                  <a:pt x="258" y="44"/>
                  <a:pt x="255" y="30"/>
                  <a:pt x="250" y="23"/>
                </a:cubicBezTo>
                <a:cubicBezTo>
                  <a:pt x="246" y="16"/>
                  <a:pt x="240" y="13"/>
                  <a:pt x="232" y="13"/>
                </a:cubicBezTo>
                <a:cubicBezTo>
                  <a:pt x="225" y="13"/>
                  <a:pt x="220" y="16"/>
                  <a:pt x="215" y="22"/>
                </a:cubicBezTo>
                <a:cubicBezTo>
                  <a:pt x="210" y="29"/>
                  <a:pt x="207" y="44"/>
                  <a:pt x="207" y="64"/>
                </a:cubicBezTo>
                <a:close/>
                <a:moveTo>
                  <a:pt x="287" y="64"/>
                </a:moveTo>
                <a:cubicBezTo>
                  <a:pt x="287" y="49"/>
                  <a:pt x="289" y="38"/>
                  <a:pt x="292" y="28"/>
                </a:cubicBezTo>
                <a:cubicBezTo>
                  <a:pt x="295" y="19"/>
                  <a:pt x="300" y="12"/>
                  <a:pt x="306" y="7"/>
                </a:cubicBezTo>
                <a:cubicBezTo>
                  <a:pt x="312" y="3"/>
                  <a:pt x="319" y="0"/>
                  <a:pt x="329" y="0"/>
                </a:cubicBezTo>
                <a:cubicBezTo>
                  <a:pt x="335" y="0"/>
                  <a:pt x="341" y="1"/>
                  <a:pt x="346" y="4"/>
                </a:cubicBezTo>
                <a:cubicBezTo>
                  <a:pt x="351" y="7"/>
                  <a:pt x="356" y="11"/>
                  <a:pt x="359" y="16"/>
                </a:cubicBezTo>
                <a:cubicBezTo>
                  <a:pt x="362" y="21"/>
                  <a:pt x="365" y="27"/>
                  <a:pt x="367" y="35"/>
                </a:cubicBezTo>
                <a:cubicBezTo>
                  <a:pt x="369" y="42"/>
                  <a:pt x="370" y="52"/>
                  <a:pt x="370" y="64"/>
                </a:cubicBezTo>
                <a:cubicBezTo>
                  <a:pt x="370" y="79"/>
                  <a:pt x="368" y="91"/>
                  <a:pt x="365" y="100"/>
                </a:cubicBezTo>
                <a:cubicBezTo>
                  <a:pt x="362" y="109"/>
                  <a:pt x="357" y="116"/>
                  <a:pt x="351" y="121"/>
                </a:cubicBezTo>
                <a:cubicBezTo>
                  <a:pt x="345" y="126"/>
                  <a:pt x="338" y="129"/>
                  <a:pt x="329" y="129"/>
                </a:cubicBezTo>
                <a:cubicBezTo>
                  <a:pt x="316" y="129"/>
                  <a:pt x="307" y="124"/>
                  <a:pt x="300" y="116"/>
                </a:cubicBezTo>
                <a:cubicBezTo>
                  <a:pt x="292" y="105"/>
                  <a:pt x="287" y="88"/>
                  <a:pt x="287" y="64"/>
                </a:cubicBezTo>
                <a:close/>
                <a:moveTo>
                  <a:pt x="303" y="64"/>
                </a:moveTo>
                <a:cubicBezTo>
                  <a:pt x="303" y="85"/>
                  <a:pt x="306" y="99"/>
                  <a:pt x="311" y="106"/>
                </a:cubicBezTo>
                <a:cubicBezTo>
                  <a:pt x="315" y="113"/>
                  <a:pt x="321" y="116"/>
                  <a:pt x="329" y="116"/>
                </a:cubicBezTo>
                <a:cubicBezTo>
                  <a:pt x="336" y="116"/>
                  <a:pt x="342" y="113"/>
                  <a:pt x="346" y="106"/>
                </a:cubicBezTo>
                <a:cubicBezTo>
                  <a:pt x="351" y="99"/>
                  <a:pt x="354" y="85"/>
                  <a:pt x="354" y="64"/>
                </a:cubicBezTo>
                <a:cubicBezTo>
                  <a:pt x="354" y="44"/>
                  <a:pt x="351" y="30"/>
                  <a:pt x="346" y="23"/>
                </a:cubicBezTo>
                <a:cubicBezTo>
                  <a:pt x="342" y="16"/>
                  <a:pt x="336" y="13"/>
                  <a:pt x="328" y="13"/>
                </a:cubicBezTo>
                <a:cubicBezTo>
                  <a:pt x="321" y="13"/>
                  <a:pt x="316" y="16"/>
                  <a:pt x="311" y="22"/>
                </a:cubicBezTo>
                <a:cubicBezTo>
                  <a:pt x="306" y="29"/>
                  <a:pt x="303" y="44"/>
                  <a:pt x="303" y="64"/>
                </a:cubicBezTo>
                <a:close/>
                <a:moveTo>
                  <a:pt x="392" y="127"/>
                </a:moveTo>
                <a:lnTo>
                  <a:pt x="392" y="109"/>
                </a:lnTo>
                <a:lnTo>
                  <a:pt x="409" y="109"/>
                </a:lnTo>
                <a:lnTo>
                  <a:pt x="409" y="127"/>
                </a:lnTo>
                <a:cubicBezTo>
                  <a:pt x="409" y="133"/>
                  <a:pt x="408" y="138"/>
                  <a:pt x="406" y="142"/>
                </a:cubicBezTo>
                <a:cubicBezTo>
                  <a:pt x="404" y="146"/>
                  <a:pt x="400" y="149"/>
                  <a:pt x="395" y="152"/>
                </a:cubicBezTo>
                <a:lnTo>
                  <a:pt x="391" y="145"/>
                </a:lnTo>
                <a:cubicBezTo>
                  <a:pt x="394" y="143"/>
                  <a:pt x="396" y="141"/>
                  <a:pt x="398" y="139"/>
                </a:cubicBezTo>
                <a:cubicBezTo>
                  <a:pt x="400" y="136"/>
                  <a:pt x="400" y="132"/>
                  <a:pt x="401" y="127"/>
                </a:cubicBezTo>
                <a:lnTo>
                  <a:pt x="392" y="127"/>
                </a:lnTo>
                <a:close/>
                <a:moveTo>
                  <a:pt x="431" y="64"/>
                </a:moveTo>
                <a:cubicBezTo>
                  <a:pt x="431" y="49"/>
                  <a:pt x="433" y="38"/>
                  <a:pt x="436" y="28"/>
                </a:cubicBezTo>
                <a:cubicBezTo>
                  <a:pt x="439" y="19"/>
                  <a:pt x="444" y="12"/>
                  <a:pt x="450" y="7"/>
                </a:cubicBezTo>
                <a:cubicBezTo>
                  <a:pt x="456" y="3"/>
                  <a:pt x="463" y="0"/>
                  <a:pt x="473" y="0"/>
                </a:cubicBezTo>
                <a:cubicBezTo>
                  <a:pt x="479" y="0"/>
                  <a:pt x="485" y="1"/>
                  <a:pt x="490" y="4"/>
                </a:cubicBezTo>
                <a:cubicBezTo>
                  <a:pt x="495" y="7"/>
                  <a:pt x="500" y="11"/>
                  <a:pt x="503" y="16"/>
                </a:cubicBezTo>
                <a:cubicBezTo>
                  <a:pt x="506" y="21"/>
                  <a:pt x="509" y="27"/>
                  <a:pt x="511" y="35"/>
                </a:cubicBezTo>
                <a:cubicBezTo>
                  <a:pt x="513" y="42"/>
                  <a:pt x="514" y="52"/>
                  <a:pt x="514" y="64"/>
                </a:cubicBezTo>
                <a:cubicBezTo>
                  <a:pt x="514" y="79"/>
                  <a:pt x="512" y="91"/>
                  <a:pt x="509" y="100"/>
                </a:cubicBezTo>
                <a:cubicBezTo>
                  <a:pt x="506" y="109"/>
                  <a:pt x="501" y="116"/>
                  <a:pt x="495" y="121"/>
                </a:cubicBezTo>
                <a:cubicBezTo>
                  <a:pt x="489" y="126"/>
                  <a:pt x="482" y="129"/>
                  <a:pt x="473" y="129"/>
                </a:cubicBezTo>
                <a:cubicBezTo>
                  <a:pt x="460" y="129"/>
                  <a:pt x="451" y="124"/>
                  <a:pt x="444" y="116"/>
                </a:cubicBezTo>
                <a:cubicBezTo>
                  <a:pt x="436" y="105"/>
                  <a:pt x="431" y="88"/>
                  <a:pt x="431" y="64"/>
                </a:cubicBezTo>
                <a:close/>
                <a:moveTo>
                  <a:pt x="447" y="64"/>
                </a:moveTo>
                <a:cubicBezTo>
                  <a:pt x="447" y="85"/>
                  <a:pt x="450" y="99"/>
                  <a:pt x="455" y="106"/>
                </a:cubicBezTo>
                <a:cubicBezTo>
                  <a:pt x="459" y="113"/>
                  <a:pt x="465" y="116"/>
                  <a:pt x="473" y="116"/>
                </a:cubicBezTo>
                <a:cubicBezTo>
                  <a:pt x="480" y="116"/>
                  <a:pt x="486" y="113"/>
                  <a:pt x="490" y="106"/>
                </a:cubicBezTo>
                <a:cubicBezTo>
                  <a:pt x="495" y="99"/>
                  <a:pt x="498" y="85"/>
                  <a:pt x="498" y="64"/>
                </a:cubicBezTo>
                <a:cubicBezTo>
                  <a:pt x="498" y="44"/>
                  <a:pt x="495" y="30"/>
                  <a:pt x="490" y="23"/>
                </a:cubicBezTo>
                <a:cubicBezTo>
                  <a:pt x="486" y="16"/>
                  <a:pt x="480" y="13"/>
                  <a:pt x="472" y="13"/>
                </a:cubicBezTo>
                <a:cubicBezTo>
                  <a:pt x="465" y="13"/>
                  <a:pt x="460" y="16"/>
                  <a:pt x="455" y="22"/>
                </a:cubicBezTo>
                <a:cubicBezTo>
                  <a:pt x="450" y="29"/>
                  <a:pt x="447" y="44"/>
                  <a:pt x="447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0" name="Freeform 58"/>
          <p:cNvSpPr>
            <a:spLocks noEditPoints="1"/>
          </p:cNvSpPr>
          <p:nvPr/>
        </p:nvSpPr>
        <p:spPr bwMode="auto">
          <a:xfrm>
            <a:off x="2996227" y="5650677"/>
            <a:ext cx="311057" cy="91319"/>
          </a:xfrm>
          <a:custGeom>
            <a:avLst/>
            <a:gdLst>
              <a:gd name="T0" fmla="*/ 83 w 516"/>
              <a:gd name="T1" fmla="*/ 127 h 152"/>
              <a:gd name="T2" fmla="*/ 2 w 516"/>
              <a:gd name="T3" fmla="*/ 116 h 152"/>
              <a:gd name="T4" fmla="*/ 32 w 516"/>
              <a:gd name="T5" fmla="*/ 80 h 152"/>
              <a:gd name="T6" fmla="*/ 67 w 516"/>
              <a:gd name="T7" fmla="*/ 35 h 152"/>
              <a:gd name="T8" fmla="*/ 43 w 516"/>
              <a:gd name="T9" fmla="*/ 13 h 152"/>
              <a:gd name="T10" fmla="*/ 19 w 516"/>
              <a:gd name="T11" fmla="*/ 38 h 152"/>
              <a:gd name="T12" fmla="*/ 15 w 516"/>
              <a:gd name="T13" fmla="*/ 9 h 152"/>
              <a:gd name="T14" fmla="*/ 73 w 516"/>
              <a:gd name="T15" fmla="*/ 10 h 152"/>
              <a:gd name="T16" fmla="*/ 80 w 516"/>
              <a:gd name="T17" fmla="*/ 50 h 152"/>
              <a:gd name="T18" fmla="*/ 46 w 516"/>
              <a:gd name="T19" fmla="*/ 88 h 152"/>
              <a:gd name="T20" fmla="*/ 21 w 516"/>
              <a:gd name="T21" fmla="*/ 112 h 152"/>
              <a:gd name="T22" fmla="*/ 98 w 516"/>
              <a:gd name="T23" fmla="*/ 64 h 152"/>
              <a:gd name="T24" fmla="*/ 116 w 516"/>
              <a:gd name="T25" fmla="*/ 7 h 152"/>
              <a:gd name="T26" fmla="*/ 157 w 516"/>
              <a:gd name="T27" fmla="*/ 4 h 152"/>
              <a:gd name="T28" fmla="*/ 177 w 516"/>
              <a:gd name="T29" fmla="*/ 35 h 152"/>
              <a:gd name="T30" fmla="*/ 176 w 516"/>
              <a:gd name="T31" fmla="*/ 100 h 152"/>
              <a:gd name="T32" fmla="*/ 139 w 516"/>
              <a:gd name="T33" fmla="*/ 129 h 152"/>
              <a:gd name="T34" fmla="*/ 98 w 516"/>
              <a:gd name="T35" fmla="*/ 64 h 152"/>
              <a:gd name="T36" fmla="*/ 121 w 516"/>
              <a:gd name="T37" fmla="*/ 106 h 152"/>
              <a:gd name="T38" fmla="*/ 157 w 516"/>
              <a:gd name="T39" fmla="*/ 106 h 152"/>
              <a:gd name="T40" fmla="*/ 157 w 516"/>
              <a:gd name="T41" fmla="*/ 23 h 152"/>
              <a:gd name="T42" fmla="*/ 122 w 516"/>
              <a:gd name="T43" fmla="*/ 22 h 152"/>
              <a:gd name="T44" fmla="*/ 194 w 516"/>
              <a:gd name="T45" fmla="*/ 64 h 152"/>
              <a:gd name="T46" fmla="*/ 212 w 516"/>
              <a:gd name="T47" fmla="*/ 7 h 152"/>
              <a:gd name="T48" fmla="*/ 253 w 516"/>
              <a:gd name="T49" fmla="*/ 4 h 152"/>
              <a:gd name="T50" fmla="*/ 273 w 516"/>
              <a:gd name="T51" fmla="*/ 35 h 152"/>
              <a:gd name="T52" fmla="*/ 272 w 516"/>
              <a:gd name="T53" fmla="*/ 100 h 152"/>
              <a:gd name="T54" fmla="*/ 235 w 516"/>
              <a:gd name="T55" fmla="*/ 129 h 152"/>
              <a:gd name="T56" fmla="*/ 194 w 516"/>
              <a:gd name="T57" fmla="*/ 64 h 152"/>
              <a:gd name="T58" fmla="*/ 217 w 516"/>
              <a:gd name="T59" fmla="*/ 106 h 152"/>
              <a:gd name="T60" fmla="*/ 253 w 516"/>
              <a:gd name="T61" fmla="*/ 106 h 152"/>
              <a:gd name="T62" fmla="*/ 253 w 516"/>
              <a:gd name="T63" fmla="*/ 23 h 152"/>
              <a:gd name="T64" fmla="*/ 218 w 516"/>
              <a:gd name="T65" fmla="*/ 22 h 152"/>
              <a:gd name="T66" fmla="*/ 290 w 516"/>
              <a:gd name="T67" fmla="*/ 64 h 152"/>
              <a:gd name="T68" fmla="*/ 308 w 516"/>
              <a:gd name="T69" fmla="*/ 7 h 152"/>
              <a:gd name="T70" fmla="*/ 349 w 516"/>
              <a:gd name="T71" fmla="*/ 4 h 152"/>
              <a:gd name="T72" fmla="*/ 369 w 516"/>
              <a:gd name="T73" fmla="*/ 35 h 152"/>
              <a:gd name="T74" fmla="*/ 368 w 516"/>
              <a:gd name="T75" fmla="*/ 100 h 152"/>
              <a:gd name="T76" fmla="*/ 331 w 516"/>
              <a:gd name="T77" fmla="*/ 129 h 152"/>
              <a:gd name="T78" fmla="*/ 290 w 516"/>
              <a:gd name="T79" fmla="*/ 64 h 152"/>
              <a:gd name="T80" fmla="*/ 313 w 516"/>
              <a:gd name="T81" fmla="*/ 106 h 152"/>
              <a:gd name="T82" fmla="*/ 349 w 516"/>
              <a:gd name="T83" fmla="*/ 106 h 152"/>
              <a:gd name="T84" fmla="*/ 349 w 516"/>
              <a:gd name="T85" fmla="*/ 23 h 152"/>
              <a:gd name="T86" fmla="*/ 314 w 516"/>
              <a:gd name="T87" fmla="*/ 22 h 152"/>
              <a:gd name="T88" fmla="*/ 394 w 516"/>
              <a:gd name="T89" fmla="*/ 127 h 152"/>
              <a:gd name="T90" fmla="*/ 412 w 516"/>
              <a:gd name="T91" fmla="*/ 109 h 152"/>
              <a:gd name="T92" fmla="*/ 409 w 516"/>
              <a:gd name="T93" fmla="*/ 142 h 152"/>
              <a:gd name="T94" fmla="*/ 393 w 516"/>
              <a:gd name="T95" fmla="*/ 145 h 152"/>
              <a:gd name="T96" fmla="*/ 403 w 516"/>
              <a:gd name="T97" fmla="*/ 127 h 152"/>
              <a:gd name="T98" fmla="*/ 434 w 516"/>
              <a:gd name="T99" fmla="*/ 64 h 152"/>
              <a:gd name="T100" fmla="*/ 452 w 516"/>
              <a:gd name="T101" fmla="*/ 7 h 152"/>
              <a:gd name="T102" fmla="*/ 493 w 516"/>
              <a:gd name="T103" fmla="*/ 4 h 152"/>
              <a:gd name="T104" fmla="*/ 513 w 516"/>
              <a:gd name="T105" fmla="*/ 35 h 152"/>
              <a:gd name="T106" fmla="*/ 512 w 516"/>
              <a:gd name="T107" fmla="*/ 100 h 152"/>
              <a:gd name="T108" fmla="*/ 475 w 516"/>
              <a:gd name="T109" fmla="*/ 129 h 152"/>
              <a:gd name="T110" fmla="*/ 434 w 516"/>
              <a:gd name="T111" fmla="*/ 64 h 152"/>
              <a:gd name="T112" fmla="*/ 457 w 516"/>
              <a:gd name="T113" fmla="*/ 106 h 152"/>
              <a:gd name="T114" fmla="*/ 493 w 516"/>
              <a:gd name="T115" fmla="*/ 106 h 152"/>
              <a:gd name="T116" fmla="*/ 493 w 516"/>
              <a:gd name="T117" fmla="*/ 23 h 152"/>
              <a:gd name="T118" fmla="*/ 458 w 516"/>
              <a:gd name="T119" fmla="*/ 22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516" h="152">
                <a:moveTo>
                  <a:pt x="83" y="112"/>
                </a:moveTo>
                <a:lnTo>
                  <a:pt x="83" y="127"/>
                </a:lnTo>
                <a:lnTo>
                  <a:pt x="0" y="127"/>
                </a:lnTo>
                <a:cubicBezTo>
                  <a:pt x="0" y="123"/>
                  <a:pt x="1" y="119"/>
                  <a:pt x="2" y="116"/>
                </a:cubicBezTo>
                <a:cubicBezTo>
                  <a:pt x="4" y="110"/>
                  <a:pt x="7" y="105"/>
                  <a:pt x="12" y="99"/>
                </a:cubicBezTo>
                <a:cubicBezTo>
                  <a:pt x="17" y="94"/>
                  <a:pt x="23" y="87"/>
                  <a:pt x="32" y="80"/>
                </a:cubicBezTo>
                <a:cubicBezTo>
                  <a:pt x="46" y="69"/>
                  <a:pt x="55" y="60"/>
                  <a:pt x="60" y="53"/>
                </a:cubicBezTo>
                <a:cubicBezTo>
                  <a:pt x="65" y="47"/>
                  <a:pt x="67" y="41"/>
                  <a:pt x="67" y="35"/>
                </a:cubicBezTo>
                <a:cubicBezTo>
                  <a:pt x="67" y="29"/>
                  <a:pt x="65" y="23"/>
                  <a:pt x="61" y="19"/>
                </a:cubicBezTo>
                <a:cubicBezTo>
                  <a:pt x="56" y="15"/>
                  <a:pt x="51" y="13"/>
                  <a:pt x="43" y="13"/>
                </a:cubicBezTo>
                <a:cubicBezTo>
                  <a:pt x="36" y="13"/>
                  <a:pt x="30" y="15"/>
                  <a:pt x="26" y="20"/>
                </a:cubicBezTo>
                <a:cubicBezTo>
                  <a:pt x="21" y="24"/>
                  <a:pt x="19" y="30"/>
                  <a:pt x="19" y="38"/>
                </a:cubicBezTo>
                <a:lnTo>
                  <a:pt x="3" y="37"/>
                </a:lnTo>
                <a:cubicBezTo>
                  <a:pt x="4" y="25"/>
                  <a:pt x="8" y="16"/>
                  <a:pt x="15" y="9"/>
                </a:cubicBezTo>
                <a:cubicBezTo>
                  <a:pt x="22" y="3"/>
                  <a:pt x="32" y="0"/>
                  <a:pt x="44" y="0"/>
                </a:cubicBezTo>
                <a:cubicBezTo>
                  <a:pt x="56" y="0"/>
                  <a:pt x="66" y="3"/>
                  <a:pt x="73" y="10"/>
                </a:cubicBezTo>
                <a:cubicBezTo>
                  <a:pt x="80" y="17"/>
                  <a:pt x="83" y="25"/>
                  <a:pt x="83" y="35"/>
                </a:cubicBezTo>
                <a:cubicBezTo>
                  <a:pt x="83" y="40"/>
                  <a:pt x="82" y="45"/>
                  <a:pt x="80" y="50"/>
                </a:cubicBezTo>
                <a:cubicBezTo>
                  <a:pt x="78" y="55"/>
                  <a:pt x="75" y="60"/>
                  <a:pt x="70" y="65"/>
                </a:cubicBezTo>
                <a:cubicBezTo>
                  <a:pt x="65" y="71"/>
                  <a:pt x="57" y="78"/>
                  <a:pt x="46" y="88"/>
                </a:cubicBezTo>
                <a:cubicBezTo>
                  <a:pt x="37" y="95"/>
                  <a:pt x="31" y="100"/>
                  <a:pt x="28" y="103"/>
                </a:cubicBezTo>
                <a:cubicBezTo>
                  <a:pt x="26" y="106"/>
                  <a:pt x="23" y="109"/>
                  <a:pt x="21" y="112"/>
                </a:cubicBezTo>
                <a:lnTo>
                  <a:pt x="83" y="112"/>
                </a:lnTo>
                <a:close/>
                <a:moveTo>
                  <a:pt x="98" y="64"/>
                </a:moveTo>
                <a:cubicBezTo>
                  <a:pt x="98" y="49"/>
                  <a:pt x="100" y="38"/>
                  <a:pt x="103" y="28"/>
                </a:cubicBezTo>
                <a:cubicBezTo>
                  <a:pt x="106" y="19"/>
                  <a:pt x="110" y="12"/>
                  <a:pt x="116" y="7"/>
                </a:cubicBezTo>
                <a:cubicBezTo>
                  <a:pt x="122" y="3"/>
                  <a:pt x="130" y="0"/>
                  <a:pt x="139" y="0"/>
                </a:cubicBezTo>
                <a:cubicBezTo>
                  <a:pt x="146" y="0"/>
                  <a:pt x="152" y="1"/>
                  <a:pt x="157" y="4"/>
                </a:cubicBezTo>
                <a:cubicBezTo>
                  <a:pt x="162" y="7"/>
                  <a:pt x="166" y="11"/>
                  <a:pt x="169" y="16"/>
                </a:cubicBezTo>
                <a:cubicBezTo>
                  <a:pt x="173" y="21"/>
                  <a:pt x="175" y="27"/>
                  <a:pt x="177" y="35"/>
                </a:cubicBezTo>
                <a:cubicBezTo>
                  <a:pt x="179" y="42"/>
                  <a:pt x="180" y="52"/>
                  <a:pt x="180" y="64"/>
                </a:cubicBezTo>
                <a:cubicBezTo>
                  <a:pt x="180" y="79"/>
                  <a:pt x="179" y="91"/>
                  <a:pt x="176" y="100"/>
                </a:cubicBezTo>
                <a:cubicBezTo>
                  <a:pt x="173" y="109"/>
                  <a:pt x="168" y="116"/>
                  <a:pt x="162" y="121"/>
                </a:cubicBezTo>
                <a:cubicBezTo>
                  <a:pt x="156" y="126"/>
                  <a:pt x="148" y="129"/>
                  <a:pt x="139" y="129"/>
                </a:cubicBezTo>
                <a:cubicBezTo>
                  <a:pt x="127" y="129"/>
                  <a:pt x="117" y="124"/>
                  <a:pt x="110" y="116"/>
                </a:cubicBezTo>
                <a:cubicBezTo>
                  <a:pt x="102" y="105"/>
                  <a:pt x="98" y="88"/>
                  <a:pt x="98" y="64"/>
                </a:cubicBezTo>
                <a:close/>
                <a:moveTo>
                  <a:pt x="114" y="64"/>
                </a:moveTo>
                <a:cubicBezTo>
                  <a:pt x="114" y="85"/>
                  <a:pt x="116" y="99"/>
                  <a:pt x="121" y="106"/>
                </a:cubicBezTo>
                <a:cubicBezTo>
                  <a:pt x="126" y="113"/>
                  <a:pt x="132" y="116"/>
                  <a:pt x="139" y="116"/>
                </a:cubicBezTo>
                <a:cubicBezTo>
                  <a:pt x="146" y="116"/>
                  <a:pt x="152" y="113"/>
                  <a:pt x="157" y="106"/>
                </a:cubicBezTo>
                <a:cubicBezTo>
                  <a:pt x="162" y="99"/>
                  <a:pt x="164" y="85"/>
                  <a:pt x="164" y="64"/>
                </a:cubicBezTo>
                <a:cubicBezTo>
                  <a:pt x="164" y="44"/>
                  <a:pt x="162" y="30"/>
                  <a:pt x="157" y="23"/>
                </a:cubicBezTo>
                <a:cubicBezTo>
                  <a:pt x="152" y="16"/>
                  <a:pt x="146" y="13"/>
                  <a:pt x="139" y="13"/>
                </a:cubicBezTo>
                <a:cubicBezTo>
                  <a:pt x="132" y="13"/>
                  <a:pt x="126" y="16"/>
                  <a:pt x="122" y="22"/>
                </a:cubicBezTo>
                <a:cubicBezTo>
                  <a:pt x="117" y="29"/>
                  <a:pt x="114" y="44"/>
                  <a:pt x="114" y="64"/>
                </a:cubicBezTo>
                <a:close/>
                <a:moveTo>
                  <a:pt x="194" y="64"/>
                </a:moveTo>
                <a:cubicBezTo>
                  <a:pt x="194" y="49"/>
                  <a:pt x="196" y="38"/>
                  <a:pt x="199" y="28"/>
                </a:cubicBezTo>
                <a:cubicBezTo>
                  <a:pt x="202" y="19"/>
                  <a:pt x="206" y="12"/>
                  <a:pt x="212" y="7"/>
                </a:cubicBezTo>
                <a:cubicBezTo>
                  <a:pt x="218" y="3"/>
                  <a:pt x="226" y="0"/>
                  <a:pt x="235" y="0"/>
                </a:cubicBezTo>
                <a:cubicBezTo>
                  <a:pt x="242" y="0"/>
                  <a:pt x="248" y="1"/>
                  <a:pt x="253" y="4"/>
                </a:cubicBezTo>
                <a:cubicBezTo>
                  <a:pt x="258" y="7"/>
                  <a:pt x="262" y="11"/>
                  <a:pt x="265" y="16"/>
                </a:cubicBezTo>
                <a:cubicBezTo>
                  <a:pt x="269" y="21"/>
                  <a:pt x="271" y="27"/>
                  <a:pt x="273" y="35"/>
                </a:cubicBezTo>
                <a:cubicBezTo>
                  <a:pt x="275" y="42"/>
                  <a:pt x="276" y="52"/>
                  <a:pt x="276" y="64"/>
                </a:cubicBezTo>
                <a:cubicBezTo>
                  <a:pt x="276" y="79"/>
                  <a:pt x="275" y="91"/>
                  <a:pt x="272" y="100"/>
                </a:cubicBezTo>
                <a:cubicBezTo>
                  <a:pt x="269" y="109"/>
                  <a:pt x="264" y="116"/>
                  <a:pt x="258" y="121"/>
                </a:cubicBezTo>
                <a:cubicBezTo>
                  <a:pt x="252" y="126"/>
                  <a:pt x="244" y="129"/>
                  <a:pt x="235" y="129"/>
                </a:cubicBezTo>
                <a:cubicBezTo>
                  <a:pt x="223" y="129"/>
                  <a:pt x="213" y="124"/>
                  <a:pt x="206" y="116"/>
                </a:cubicBezTo>
                <a:cubicBezTo>
                  <a:pt x="198" y="105"/>
                  <a:pt x="194" y="88"/>
                  <a:pt x="194" y="64"/>
                </a:cubicBezTo>
                <a:close/>
                <a:moveTo>
                  <a:pt x="210" y="64"/>
                </a:moveTo>
                <a:cubicBezTo>
                  <a:pt x="210" y="85"/>
                  <a:pt x="212" y="99"/>
                  <a:pt x="217" y="106"/>
                </a:cubicBezTo>
                <a:cubicBezTo>
                  <a:pt x="222" y="113"/>
                  <a:pt x="228" y="116"/>
                  <a:pt x="235" y="116"/>
                </a:cubicBezTo>
                <a:cubicBezTo>
                  <a:pt x="242" y="116"/>
                  <a:pt x="248" y="113"/>
                  <a:pt x="253" y="106"/>
                </a:cubicBezTo>
                <a:cubicBezTo>
                  <a:pt x="258" y="99"/>
                  <a:pt x="260" y="85"/>
                  <a:pt x="260" y="64"/>
                </a:cubicBezTo>
                <a:cubicBezTo>
                  <a:pt x="260" y="44"/>
                  <a:pt x="258" y="30"/>
                  <a:pt x="253" y="23"/>
                </a:cubicBezTo>
                <a:cubicBezTo>
                  <a:pt x="248" y="16"/>
                  <a:pt x="242" y="13"/>
                  <a:pt x="235" y="13"/>
                </a:cubicBezTo>
                <a:cubicBezTo>
                  <a:pt x="228" y="13"/>
                  <a:pt x="222" y="16"/>
                  <a:pt x="218" y="22"/>
                </a:cubicBezTo>
                <a:cubicBezTo>
                  <a:pt x="213" y="29"/>
                  <a:pt x="210" y="44"/>
                  <a:pt x="210" y="64"/>
                </a:cubicBezTo>
                <a:close/>
                <a:moveTo>
                  <a:pt x="290" y="64"/>
                </a:moveTo>
                <a:cubicBezTo>
                  <a:pt x="290" y="49"/>
                  <a:pt x="292" y="38"/>
                  <a:pt x="295" y="28"/>
                </a:cubicBezTo>
                <a:cubicBezTo>
                  <a:pt x="298" y="19"/>
                  <a:pt x="302" y="12"/>
                  <a:pt x="308" y="7"/>
                </a:cubicBezTo>
                <a:cubicBezTo>
                  <a:pt x="314" y="3"/>
                  <a:pt x="322" y="0"/>
                  <a:pt x="331" y="0"/>
                </a:cubicBezTo>
                <a:cubicBezTo>
                  <a:pt x="338" y="0"/>
                  <a:pt x="344" y="1"/>
                  <a:pt x="349" y="4"/>
                </a:cubicBezTo>
                <a:cubicBezTo>
                  <a:pt x="354" y="7"/>
                  <a:pt x="358" y="11"/>
                  <a:pt x="361" y="16"/>
                </a:cubicBezTo>
                <a:cubicBezTo>
                  <a:pt x="365" y="21"/>
                  <a:pt x="367" y="27"/>
                  <a:pt x="369" y="35"/>
                </a:cubicBezTo>
                <a:cubicBezTo>
                  <a:pt x="371" y="42"/>
                  <a:pt x="372" y="52"/>
                  <a:pt x="372" y="64"/>
                </a:cubicBezTo>
                <a:cubicBezTo>
                  <a:pt x="372" y="79"/>
                  <a:pt x="371" y="91"/>
                  <a:pt x="368" y="100"/>
                </a:cubicBezTo>
                <a:cubicBezTo>
                  <a:pt x="365" y="109"/>
                  <a:pt x="360" y="116"/>
                  <a:pt x="354" y="121"/>
                </a:cubicBezTo>
                <a:cubicBezTo>
                  <a:pt x="348" y="126"/>
                  <a:pt x="340" y="129"/>
                  <a:pt x="331" y="129"/>
                </a:cubicBezTo>
                <a:cubicBezTo>
                  <a:pt x="319" y="129"/>
                  <a:pt x="309" y="124"/>
                  <a:pt x="302" y="116"/>
                </a:cubicBezTo>
                <a:cubicBezTo>
                  <a:pt x="294" y="105"/>
                  <a:pt x="290" y="88"/>
                  <a:pt x="290" y="64"/>
                </a:cubicBezTo>
                <a:close/>
                <a:moveTo>
                  <a:pt x="306" y="64"/>
                </a:moveTo>
                <a:cubicBezTo>
                  <a:pt x="306" y="85"/>
                  <a:pt x="308" y="99"/>
                  <a:pt x="313" y="106"/>
                </a:cubicBezTo>
                <a:cubicBezTo>
                  <a:pt x="318" y="113"/>
                  <a:pt x="324" y="116"/>
                  <a:pt x="331" y="116"/>
                </a:cubicBezTo>
                <a:cubicBezTo>
                  <a:pt x="338" y="116"/>
                  <a:pt x="344" y="113"/>
                  <a:pt x="349" y="106"/>
                </a:cubicBezTo>
                <a:cubicBezTo>
                  <a:pt x="354" y="99"/>
                  <a:pt x="356" y="85"/>
                  <a:pt x="356" y="64"/>
                </a:cubicBezTo>
                <a:cubicBezTo>
                  <a:pt x="356" y="44"/>
                  <a:pt x="354" y="30"/>
                  <a:pt x="349" y="23"/>
                </a:cubicBezTo>
                <a:cubicBezTo>
                  <a:pt x="344" y="16"/>
                  <a:pt x="338" y="13"/>
                  <a:pt x="331" y="13"/>
                </a:cubicBezTo>
                <a:cubicBezTo>
                  <a:pt x="324" y="13"/>
                  <a:pt x="318" y="16"/>
                  <a:pt x="314" y="22"/>
                </a:cubicBezTo>
                <a:cubicBezTo>
                  <a:pt x="309" y="29"/>
                  <a:pt x="306" y="44"/>
                  <a:pt x="306" y="64"/>
                </a:cubicBezTo>
                <a:close/>
                <a:moveTo>
                  <a:pt x="394" y="127"/>
                </a:moveTo>
                <a:lnTo>
                  <a:pt x="394" y="109"/>
                </a:lnTo>
                <a:lnTo>
                  <a:pt x="412" y="109"/>
                </a:lnTo>
                <a:lnTo>
                  <a:pt x="412" y="127"/>
                </a:lnTo>
                <a:cubicBezTo>
                  <a:pt x="412" y="133"/>
                  <a:pt x="411" y="138"/>
                  <a:pt x="409" y="142"/>
                </a:cubicBezTo>
                <a:cubicBezTo>
                  <a:pt x="406" y="146"/>
                  <a:pt x="403" y="149"/>
                  <a:pt x="398" y="152"/>
                </a:cubicBezTo>
                <a:lnTo>
                  <a:pt x="393" y="145"/>
                </a:lnTo>
                <a:cubicBezTo>
                  <a:pt x="397" y="143"/>
                  <a:pt x="399" y="141"/>
                  <a:pt x="401" y="139"/>
                </a:cubicBezTo>
                <a:cubicBezTo>
                  <a:pt x="402" y="136"/>
                  <a:pt x="403" y="132"/>
                  <a:pt x="403" y="127"/>
                </a:cubicBezTo>
                <a:lnTo>
                  <a:pt x="394" y="127"/>
                </a:lnTo>
                <a:close/>
                <a:moveTo>
                  <a:pt x="434" y="64"/>
                </a:moveTo>
                <a:cubicBezTo>
                  <a:pt x="434" y="49"/>
                  <a:pt x="436" y="38"/>
                  <a:pt x="439" y="28"/>
                </a:cubicBezTo>
                <a:cubicBezTo>
                  <a:pt x="442" y="19"/>
                  <a:pt x="446" y="12"/>
                  <a:pt x="452" y="7"/>
                </a:cubicBezTo>
                <a:cubicBezTo>
                  <a:pt x="458" y="3"/>
                  <a:pt x="466" y="0"/>
                  <a:pt x="475" y="0"/>
                </a:cubicBezTo>
                <a:cubicBezTo>
                  <a:pt x="482" y="0"/>
                  <a:pt x="488" y="1"/>
                  <a:pt x="493" y="4"/>
                </a:cubicBezTo>
                <a:cubicBezTo>
                  <a:pt x="498" y="7"/>
                  <a:pt x="502" y="11"/>
                  <a:pt x="505" y="16"/>
                </a:cubicBezTo>
                <a:cubicBezTo>
                  <a:pt x="509" y="21"/>
                  <a:pt x="511" y="27"/>
                  <a:pt x="513" y="35"/>
                </a:cubicBezTo>
                <a:cubicBezTo>
                  <a:pt x="515" y="42"/>
                  <a:pt x="516" y="52"/>
                  <a:pt x="516" y="64"/>
                </a:cubicBezTo>
                <a:cubicBezTo>
                  <a:pt x="516" y="79"/>
                  <a:pt x="515" y="91"/>
                  <a:pt x="512" y="100"/>
                </a:cubicBezTo>
                <a:cubicBezTo>
                  <a:pt x="509" y="109"/>
                  <a:pt x="504" y="116"/>
                  <a:pt x="498" y="121"/>
                </a:cubicBezTo>
                <a:cubicBezTo>
                  <a:pt x="492" y="126"/>
                  <a:pt x="484" y="129"/>
                  <a:pt x="475" y="129"/>
                </a:cubicBezTo>
                <a:cubicBezTo>
                  <a:pt x="463" y="129"/>
                  <a:pt x="453" y="124"/>
                  <a:pt x="446" y="116"/>
                </a:cubicBezTo>
                <a:cubicBezTo>
                  <a:pt x="438" y="105"/>
                  <a:pt x="434" y="88"/>
                  <a:pt x="434" y="64"/>
                </a:cubicBezTo>
                <a:close/>
                <a:moveTo>
                  <a:pt x="450" y="64"/>
                </a:moveTo>
                <a:cubicBezTo>
                  <a:pt x="450" y="85"/>
                  <a:pt x="452" y="99"/>
                  <a:pt x="457" y="106"/>
                </a:cubicBezTo>
                <a:cubicBezTo>
                  <a:pt x="462" y="113"/>
                  <a:pt x="468" y="116"/>
                  <a:pt x="475" y="116"/>
                </a:cubicBezTo>
                <a:cubicBezTo>
                  <a:pt x="482" y="116"/>
                  <a:pt x="488" y="113"/>
                  <a:pt x="493" y="106"/>
                </a:cubicBezTo>
                <a:cubicBezTo>
                  <a:pt x="498" y="99"/>
                  <a:pt x="500" y="85"/>
                  <a:pt x="500" y="64"/>
                </a:cubicBezTo>
                <a:cubicBezTo>
                  <a:pt x="500" y="44"/>
                  <a:pt x="498" y="30"/>
                  <a:pt x="493" y="23"/>
                </a:cubicBezTo>
                <a:cubicBezTo>
                  <a:pt x="488" y="16"/>
                  <a:pt x="482" y="13"/>
                  <a:pt x="475" y="13"/>
                </a:cubicBezTo>
                <a:cubicBezTo>
                  <a:pt x="468" y="13"/>
                  <a:pt x="462" y="16"/>
                  <a:pt x="458" y="22"/>
                </a:cubicBezTo>
                <a:cubicBezTo>
                  <a:pt x="453" y="29"/>
                  <a:pt x="450" y="44"/>
                  <a:pt x="450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1" name="Freeform 59"/>
          <p:cNvSpPr>
            <a:spLocks noEditPoints="1"/>
          </p:cNvSpPr>
          <p:nvPr/>
        </p:nvSpPr>
        <p:spPr bwMode="auto">
          <a:xfrm>
            <a:off x="2114424" y="5650677"/>
            <a:ext cx="302496" cy="91319"/>
          </a:xfrm>
          <a:custGeom>
            <a:avLst/>
            <a:gdLst>
              <a:gd name="T0" fmla="*/ 30 w 502"/>
              <a:gd name="T1" fmla="*/ 127 h 152"/>
              <a:gd name="T2" fmla="*/ 16 w 502"/>
              <a:gd name="T3" fmla="*/ 39 h 152"/>
              <a:gd name="T4" fmla="*/ 0 w 502"/>
              <a:gd name="T5" fmla="*/ 32 h 152"/>
              <a:gd name="T6" fmla="*/ 36 w 502"/>
              <a:gd name="T7" fmla="*/ 0 h 152"/>
              <a:gd name="T8" fmla="*/ 46 w 502"/>
              <a:gd name="T9" fmla="*/ 127 h 152"/>
              <a:gd name="T10" fmla="*/ 88 w 502"/>
              <a:gd name="T11" fmla="*/ 28 h 152"/>
              <a:gd name="T12" fmla="*/ 125 w 502"/>
              <a:gd name="T13" fmla="*/ 0 h 152"/>
              <a:gd name="T14" fmla="*/ 155 w 502"/>
              <a:gd name="T15" fmla="*/ 16 h 152"/>
              <a:gd name="T16" fmla="*/ 166 w 502"/>
              <a:gd name="T17" fmla="*/ 64 h 152"/>
              <a:gd name="T18" fmla="*/ 148 w 502"/>
              <a:gd name="T19" fmla="*/ 121 h 152"/>
              <a:gd name="T20" fmla="*/ 96 w 502"/>
              <a:gd name="T21" fmla="*/ 116 h 152"/>
              <a:gd name="T22" fmla="*/ 100 w 502"/>
              <a:gd name="T23" fmla="*/ 64 h 152"/>
              <a:gd name="T24" fmla="*/ 125 w 502"/>
              <a:gd name="T25" fmla="*/ 116 h 152"/>
              <a:gd name="T26" fmla="*/ 150 w 502"/>
              <a:gd name="T27" fmla="*/ 64 h 152"/>
              <a:gd name="T28" fmla="*/ 125 w 502"/>
              <a:gd name="T29" fmla="*/ 13 h 152"/>
              <a:gd name="T30" fmla="*/ 100 w 502"/>
              <a:gd name="T31" fmla="*/ 64 h 152"/>
              <a:gd name="T32" fmla="*/ 184 w 502"/>
              <a:gd name="T33" fmla="*/ 28 h 152"/>
              <a:gd name="T34" fmla="*/ 221 w 502"/>
              <a:gd name="T35" fmla="*/ 0 h 152"/>
              <a:gd name="T36" fmla="*/ 251 w 502"/>
              <a:gd name="T37" fmla="*/ 16 h 152"/>
              <a:gd name="T38" fmla="*/ 262 w 502"/>
              <a:gd name="T39" fmla="*/ 64 h 152"/>
              <a:gd name="T40" fmla="*/ 244 w 502"/>
              <a:gd name="T41" fmla="*/ 121 h 152"/>
              <a:gd name="T42" fmla="*/ 192 w 502"/>
              <a:gd name="T43" fmla="*/ 116 h 152"/>
              <a:gd name="T44" fmla="*/ 196 w 502"/>
              <a:gd name="T45" fmla="*/ 64 h 152"/>
              <a:gd name="T46" fmla="*/ 221 w 502"/>
              <a:gd name="T47" fmla="*/ 116 h 152"/>
              <a:gd name="T48" fmla="*/ 246 w 502"/>
              <a:gd name="T49" fmla="*/ 64 h 152"/>
              <a:gd name="T50" fmla="*/ 221 w 502"/>
              <a:gd name="T51" fmla="*/ 13 h 152"/>
              <a:gd name="T52" fmla="*/ 196 w 502"/>
              <a:gd name="T53" fmla="*/ 64 h 152"/>
              <a:gd name="T54" fmla="*/ 280 w 502"/>
              <a:gd name="T55" fmla="*/ 28 h 152"/>
              <a:gd name="T56" fmla="*/ 317 w 502"/>
              <a:gd name="T57" fmla="*/ 0 h 152"/>
              <a:gd name="T58" fmla="*/ 347 w 502"/>
              <a:gd name="T59" fmla="*/ 16 h 152"/>
              <a:gd name="T60" fmla="*/ 358 w 502"/>
              <a:gd name="T61" fmla="*/ 64 h 152"/>
              <a:gd name="T62" fmla="*/ 340 w 502"/>
              <a:gd name="T63" fmla="*/ 121 h 152"/>
              <a:gd name="T64" fmla="*/ 288 w 502"/>
              <a:gd name="T65" fmla="*/ 116 h 152"/>
              <a:gd name="T66" fmla="*/ 292 w 502"/>
              <a:gd name="T67" fmla="*/ 64 h 152"/>
              <a:gd name="T68" fmla="*/ 317 w 502"/>
              <a:gd name="T69" fmla="*/ 116 h 152"/>
              <a:gd name="T70" fmla="*/ 342 w 502"/>
              <a:gd name="T71" fmla="*/ 64 h 152"/>
              <a:gd name="T72" fmla="*/ 317 w 502"/>
              <a:gd name="T73" fmla="*/ 13 h 152"/>
              <a:gd name="T74" fmla="*/ 292 w 502"/>
              <a:gd name="T75" fmla="*/ 64 h 152"/>
              <a:gd name="T76" fmla="*/ 380 w 502"/>
              <a:gd name="T77" fmla="*/ 109 h 152"/>
              <a:gd name="T78" fmla="*/ 398 w 502"/>
              <a:gd name="T79" fmla="*/ 127 h 152"/>
              <a:gd name="T80" fmla="*/ 383 w 502"/>
              <a:gd name="T81" fmla="*/ 152 h 152"/>
              <a:gd name="T82" fmla="*/ 386 w 502"/>
              <a:gd name="T83" fmla="*/ 139 h 152"/>
              <a:gd name="T84" fmla="*/ 380 w 502"/>
              <a:gd name="T85" fmla="*/ 127 h 152"/>
              <a:gd name="T86" fmla="*/ 424 w 502"/>
              <a:gd name="T87" fmla="*/ 28 h 152"/>
              <a:gd name="T88" fmla="*/ 461 w 502"/>
              <a:gd name="T89" fmla="*/ 0 h 152"/>
              <a:gd name="T90" fmla="*/ 491 w 502"/>
              <a:gd name="T91" fmla="*/ 16 h 152"/>
              <a:gd name="T92" fmla="*/ 502 w 502"/>
              <a:gd name="T93" fmla="*/ 64 h 152"/>
              <a:gd name="T94" fmla="*/ 484 w 502"/>
              <a:gd name="T95" fmla="*/ 121 h 152"/>
              <a:gd name="T96" fmla="*/ 432 w 502"/>
              <a:gd name="T97" fmla="*/ 116 h 152"/>
              <a:gd name="T98" fmla="*/ 436 w 502"/>
              <a:gd name="T99" fmla="*/ 64 h 152"/>
              <a:gd name="T100" fmla="*/ 461 w 502"/>
              <a:gd name="T101" fmla="*/ 116 h 152"/>
              <a:gd name="T102" fmla="*/ 486 w 502"/>
              <a:gd name="T103" fmla="*/ 64 h 152"/>
              <a:gd name="T104" fmla="*/ 461 w 502"/>
              <a:gd name="T105" fmla="*/ 13 h 152"/>
              <a:gd name="T106" fmla="*/ 436 w 502"/>
              <a:gd name="T107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02" h="152">
                <a:moveTo>
                  <a:pt x="46" y="127"/>
                </a:moveTo>
                <a:lnTo>
                  <a:pt x="30" y="127"/>
                </a:lnTo>
                <a:lnTo>
                  <a:pt x="30" y="28"/>
                </a:lnTo>
                <a:cubicBezTo>
                  <a:pt x="27" y="32"/>
                  <a:pt x="22" y="35"/>
                  <a:pt x="16" y="39"/>
                </a:cubicBezTo>
                <a:cubicBezTo>
                  <a:pt x="10" y="42"/>
                  <a:pt x="4" y="45"/>
                  <a:pt x="0" y="47"/>
                </a:cubicBezTo>
                <a:lnTo>
                  <a:pt x="0" y="32"/>
                </a:lnTo>
                <a:cubicBezTo>
                  <a:pt x="8" y="28"/>
                  <a:pt x="16" y="23"/>
                  <a:pt x="22" y="17"/>
                </a:cubicBezTo>
                <a:cubicBezTo>
                  <a:pt x="29" y="11"/>
                  <a:pt x="33" y="6"/>
                  <a:pt x="36" y="0"/>
                </a:cubicBezTo>
                <a:lnTo>
                  <a:pt x="46" y="0"/>
                </a:lnTo>
                <a:lnTo>
                  <a:pt x="46" y="127"/>
                </a:lnTo>
                <a:close/>
                <a:moveTo>
                  <a:pt x="84" y="64"/>
                </a:moveTo>
                <a:cubicBezTo>
                  <a:pt x="84" y="49"/>
                  <a:pt x="85" y="38"/>
                  <a:pt x="88" y="28"/>
                </a:cubicBezTo>
                <a:cubicBezTo>
                  <a:pt x="91" y="19"/>
                  <a:pt x="96" y="12"/>
                  <a:pt x="102" y="7"/>
                </a:cubicBezTo>
                <a:cubicBezTo>
                  <a:pt x="108" y="3"/>
                  <a:pt x="116" y="0"/>
                  <a:pt x="125" y="0"/>
                </a:cubicBezTo>
                <a:cubicBezTo>
                  <a:pt x="131" y="0"/>
                  <a:pt x="137" y="1"/>
                  <a:pt x="142" y="4"/>
                </a:cubicBezTo>
                <a:cubicBezTo>
                  <a:pt x="148" y="7"/>
                  <a:pt x="152" y="11"/>
                  <a:pt x="155" y="16"/>
                </a:cubicBezTo>
                <a:cubicBezTo>
                  <a:pt x="158" y="21"/>
                  <a:pt x="161" y="27"/>
                  <a:pt x="163" y="35"/>
                </a:cubicBezTo>
                <a:cubicBezTo>
                  <a:pt x="165" y="42"/>
                  <a:pt x="166" y="52"/>
                  <a:pt x="166" y="64"/>
                </a:cubicBezTo>
                <a:cubicBezTo>
                  <a:pt x="166" y="79"/>
                  <a:pt x="164" y="91"/>
                  <a:pt x="161" y="100"/>
                </a:cubicBezTo>
                <a:cubicBezTo>
                  <a:pt x="158" y="109"/>
                  <a:pt x="154" y="116"/>
                  <a:pt x="148" y="121"/>
                </a:cubicBezTo>
                <a:cubicBezTo>
                  <a:pt x="142" y="126"/>
                  <a:pt x="134" y="129"/>
                  <a:pt x="125" y="129"/>
                </a:cubicBezTo>
                <a:cubicBezTo>
                  <a:pt x="113" y="129"/>
                  <a:pt x="103" y="124"/>
                  <a:pt x="96" y="116"/>
                </a:cubicBezTo>
                <a:cubicBezTo>
                  <a:pt x="88" y="105"/>
                  <a:pt x="84" y="88"/>
                  <a:pt x="84" y="64"/>
                </a:cubicBezTo>
                <a:close/>
                <a:moveTo>
                  <a:pt x="100" y="64"/>
                </a:moveTo>
                <a:cubicBezTo>
                  <a:pt x="100" y="85"/>
                  <a:pt x="102" y="99"/>
                  <a:pt x="107" y="106"/>
                </a:cubicBezTo>
                <a:cubicBezTo>
                  <a:pt x="112" y="113"/>
                  <a:pt x="118" y="116"/>
                  <a:pt x="125" y="116"/>
                </a:cubicBezTo>
                <a:cubicBezTo>
                  <a:pt x="132" y="116"/>
                  <a:pt x="138" y="113"/>
                  <a:pt x="143" y="106"/>
                </a:cubicBezTo>
                <a:cubicBezTo>
                  <a:pt x="147" y="99"/>
                  <a:pt x="150" y="85"/>
                  <a:pt x="150" y="64"/>
                </a:cubicBezTo>
                <a:cubicBezTo>
                  <a:pt x="150" y="44"/>
                  <a:pt x="147" y="30"/>
                  <a:pt x="143" y="23"/>
                </a:cubicBezTo>
                <a:cubicBezTo>
                  <a:pt x="138" y="16"/>
                  <a:pt x="132" y="13"/>
                  <a:pt x="125" y="13"/>
                </a:cubicBezTo>
                <a:cubicBezTo>
                  <a:pt x="117" y="13"/>
                  <a:pt x="112" y="16"/>
                  <a:pt x="108" y="22"/>
                </a:cubicBezTo>
                <a:cubicBezTo>
                  <a:pt x="102" y="29"/>
                  <a:pt x="100" y="44"/>
                  <a:pt x="100" y="64"/>
                </a:cubicBezTo>
                <a:close/>
                <a:moveTo>
                  <a:pt x="180" y="64"/>
                </a:moveTo>
                <a:cubicBezTo>
                  <a:pt x="180" y="49"/>
                  <a:pt x="181" y="38"/>
                  <a:pt x="184" y="28"/>
                </a:cubicBezTo>
                <a:cubicBezTo>
                  <a:pt x="187" y="19"/>
                  <a:pt x="192" y="12"/>
                  <a:pt x="198" y="7"/>
                </a:cubicBezTo>
                <a:cubicBezTo>
                  <a:pt x="204" y="3"/>
                  <a:pt x="212" y="0"/>
                  <a:pt x="221" y="0"/>
                </a:cubicBezTo>
                <a:cubicBezTo>
                  <a:pt x="227" y="0"/>
                  <a:pt x="233" y="1"/>
                  <a:pt x="238" y="4"/>
                </a:cubicBezTo>
                <a:cubicBezTo>
                  <a:pt x="244" y="7"/>
                  <a:pt x="248" y="11"/>
                  <a:pt x="251" y="16"/>
                </a:cubicBezTo>
                <a:cubicBezTo>
                  <a:pt x="254" y="21"/>
                  <a:pt x="257" y="27"/>
                  <a:pt x="259" y="35"/>
                </a:cubicBezTo>
                <a:cubicBezTo>
                  <a:pt x="261" y="42"/>
                  <a:pt x="262" y="52"/>
                  <a:pt x="262" y="64"/>
                </a:cubicBezTo>
                <a:cubicBezTo>
                  <a:pt x="262" y="79"/>
                  <a:pt x="260" y="91"/>
                  <a:pt x="257" y="100"/>
                </a:cubicBezTo>
                <a:cubicBezTo>
                  <a:pt x="254" y="109"/>
                  <a:pt x="250" y="116"/>
                  <a:pt x="244" y="121"/>
                </a:cubicBezTo>
                <a:cubicBezTo>
                  <a:pt x="238" y="126"/>
                  <a:pt x="230" y="129"/>
                  <a:pt x="221" y="129"/>
                </a:cubicBezTo>
                <a:cubicBezTo>
                  <a:pt x="209" y="129"/>
                  <a:pt x="199" y="124"/>
                  <a:pt x="192" y="116"/>
                </a:cubicBezTo>
                <a:cubicBezTo>
                  <a:pt x="184" y="105"/>
                  <a:pt x="180" y="88"/>
                  <a:pt x="180" y="64"/>
                </a:cubicBezTo>
                <a:close/>
                <a:moveTo>
                  <a:pt x="196" y="64"/>
                </a:moveTo>
                <a:cubicBezTo>
                  <a:pt x="196" y="85"/>
                  <a:pt x="198" y="99"/>
                  <a:pt x="203" y="106"/>
                </a:cubicBezTo>
                <a:cubicBezTo>
                  <a:pt x="208" y="113"/>
                  <a:pt x="214" y="116"/>
                  <a:pt x="221" y="116"/>
                </a:cubicBezTo>
                <a:cubicBezTo>
                  <a:pt x="228" y="116"/>
                  <a:pt x="234" y="113"/>
                  <a:pt x="239" y="106"/>
                </a:cubicBezTo>
                <a:cubicBezTo>
                  <a:pt x="243" y="99"/>
                  <a:pt x="246" y="85"/>
                  <a:pt x="246" y="64"/>
                </a:cubicBezTo>
                <a:cubicBezTo>
                  <a:pt x="246" y="44"/>
                  <a:pt x="243" y="30"/>
                  <a:pt x="239" y="23"/>
                </a:cubicBezTo>
                <a:cubicBezTo>
                  <a:pt x="234" y="16"/>
                  <a:pt x="228" y="13"/>
                  <a:pt x="221" y="13"/>
                </a:cubicBezTo>
                <a:cubicBezTo>
                  <a:pt x="213" y="13"/>
                  <a:pt x="208" y="16"/>
                  <a:pt x="204" y="22"/>
                </a:cubicBezTo>
                <a:cubicBezTo>
                  <a:pt x="198" y="29"/>
                  <a:pt x="196" y="44"/>
                  <a:pt x="196" y="64"/>
                </a:cubicBezTo>
                <a:close/>
                <a:moveTo>
                  <a:pt x="276" y="64"/>
                </a:moveTo>
                <a:cubicBezTo>
                  <a:pt x="276" y="49"/>
                  <a:pt x="277" y="38"/>
                  <a:pt x="280" y="28"/>
                </a:cubicBezTo>
                <a:cubicBezTo>
                  <a:pt x="283" y="19"/>
                  <a:pt x="288" y="12"/>
                  <a:pt x="294" y="7"/>
                </a:cubicBezTo>
                <a:cubicBezTo>
                  <a:pt x="300" y="3"/>
                  <a:pt x="308" y="0"/>
                  <a:pt x="317" y="0"/>
                </a:cubicBezTo>
                <a:cubicBezTo>
                  <a:pt x="323" y="0"/>
                  <a:pt x="329" y="1"/>
                  <a:pt x="334" y="4"/>
                </a:cubicBezTo>
                <a:cubicBezTo>
                  <a:pt x="340" y="7"/>
                  <a:pt x="344" y="11"/>
                  <a:pt x="347" y="16"/>
                </a:cubicBezTo>
                <a:cubicBezTo>
                  <a:pt x="350" y="21"/>
                  <a:pt x="353" y="27"/>
                  <a:pt x="355" y="35"/>
                </a:cubicBezTo>
                <a:cubicBezTo>
                  <a:pt x="357" y="42"/>
                  <a:pt x="358" y="52"/>
                  <a:pt x="358" y="64"/>
                </a:cubicBezTo>
                <a:cubicBezTo>
                  <a:pt x="358" y="79"/>
                  <a:pt x="356" y="91"/>
                  <a:pt x="353" y="100"/>
                </a:cubicBezTo>
                <a:cubicBezTo>
                  <a:pt x="350" y="109"/>
                  <a:pt x="346" y="116"/>
                  <a:pt x="340" y="121"/>
                </a:cubicBezTo>
                <a:cubicBezTo>
                  <a:pt x="334" y="126"/>
                  <a:pt x="326" y="129"/>
                  <a:pt x="317" y="129"/>
                </a:cubicBezTo>
                <a:cubicBezTo>
                  <a:pt x="305" y="129"/>
                  <a:pt x="295" y="124"/>
                  <a:pt x="288" y="116"/>
                </a:cubicBezTo>
                <a:cubicBezTo>
                  <a:pt x="280" y="105"/>
                  <a:pt x="276" y="88"/>
                  <a:pt x="276" y="64"/>
                </a:cubicBezTo>
                <a:close/>
                <a:moveTo>
                  <a:pt x="292" y="64"/>
                </a:moveTo>
                <a:cubicBezTo>
                  <a:pt x="292" y="85"/>
                  <a:pt x="294" y="99"/>
                  <a:pt x="299" y="106"/>
                </a:cubicBezTo>
                <a:cubicBezTo>
                  <a:pt x="304" y="113"/>
                  <a:pt x="310" y="116"/>
                  <a:pt x="317" y="116"/>
                </a:cubicBezTo>
                <a:cubicBezTo>
                  <a:pt x="324" y="116"/>
                  <a:pt x="330" y="113"/>
                  <a:pt x="335" y="106"/>
                </a:cubicBezTo>
                <a:cubicBezTo>
                  <a:pt x="339" y="99"/>
                  <a:pt x="342" y="85"/>
                  <a:pt x="342" y="64"/>
                </a:cubicBezTo>
                <a:cubicBezTo>
                  <a:pt x="342" y="44"/>
                  <a:pt x="339" y="30"/>
                  <a:pt x="335" y="23"/>
                </a:cubicBezTo>
                <a:cubicBezTo>
                  <a:pt x="330" y="16"/>
                  <a:pt x="324" y="13"/>
                  <a:pt x="317" y="13"/>
                </a:cubicBezTo>
                <a:cubicBezTo>
                  <a:pt x="309" y="13"/>
                  <a:pt x="304" y="16"/>
                  <a:pt x="300" y="22"/>
                </a:cubicBezTo>
                <a:cubicBezTo>
                  <a:pt x="294" y="29"/>
                  <a:pt x="292" y="44"/>
                  <a:pt x="292" y="64"/>
                </a:cubicBezTo>
                <a:close/>
                <a:moveTo>
                  <a:pt x="380" y="127"/>
                </a:moveTo>
                <a:lnTo>
                  <a:pt x="380" y="109"/>
                </a:lnTo>
                <a:lnTo>
                  <a:pt x="398" y="109"/>
                </a:lnTo>
                <a:lnTo>
                  <a:pt x="398" y="127"/>
                </a:lnTo>
                <a:cubicBezTo>
                  <a:pt x="398" y="133"/>
                  <a:pt x="396" y="138"/>
                  <a:pt x="394" y="142"/>
                </a:cubicBezTo>
                <a:cubicBezTo>
                  <a:pt x="392" y="146"/>
                  <a:pt x="388" y="149"/>
                  <a:pt x="383" y="152"/>
                </a:cubicBezTo>
                <a:lnTo>
                  <a:pt x="379" y="145"/>
                </a:lnTo>
                <a:cubicBezTo>
                  <a:pt x="382" y="143"/>
                  <a:pt x="385" y="141"/>
                  <a:pt x="386" y="139"/>
                </a:cubicBezTo>
                <a:cubicBezTo>
                  <a:pt x="388" y="136"/>
                  <a:pt x="389" y="132"/>
                  <a:pt x="389" y="127"/>
                </a:cubicBezTo>
                <a:lnTo>
                  <a:pt x="380" y="127"/>
                </a:lnTo>
                <a:close/>
                <a:moveTo>
                  <a:pt x="420" y="64"/>
                </a:moveTo>
                <a:cubicBezTo>
                  <a:pt x="420" y="49"/>
                  <a:pt x="421" y="38"/>
                  <a:pt x="424" y="28"/>
                </a:cubicBezTo>
                <a:cubicBezTo>
                  <a:pt x="427" y="19"/>
                  <a:pt x="432" y="12"/>
                  <a:pt x="438" y="7"/>
                </a:cubicBezTo>
                <a:cubicBezTo>
                  <a:pt x="444" y="3"/>
                  <a:pt x="452" y="0"/>
                  <a:pt x="461" y="0"/>
                </a:cubicBezTo>
                <a:cubicBezTo>
                  <a:pt x="467" y="0"/>
                  <a:pt x="473" y="1"/>
                  <a:pt x="478" y="4"/>
                </a:cubicBezTo>
                <a:cubicBezTo>
                  <a:pt x="484" y="7"/>
                  <a:pt x="488" y="11"/>
                  <a:pt x="491" y="16"/>
                </a:cubicBezTo>
                <a:cubicBezTo>
                  <a:pt x="494" y="21"/>
                  <a:pt x="497" y="27"/>
                  <a:pt x="499" y="35"/>
                </a:cubicBezTo>
                <a:cubicBezTo>
                  <a:pt x="501" y="42"/>
                  <a:pt x="502" y="52"/>
                  <a:pt x="502" y="64"/>
                </a:cubicBezTo>
                <a:cubicBezTo>
                  <a:pt x="502" y="79"/>
                  <a:pt x="500" y="91"/>
                  <a:pt x="497" y="100"/>
                </a:cubicBezTo>
                <a:cubicBezTo>
                  <a:pt x="494" y="109"/>
                  <a:pt x="490" y="116"/>
                  <a:pt x="484" y="121"/>
                </a:cubicBezTo>
                <a:cubicBezTo>
                  <a:pt x="478" y="126"/>
                  <a:pt x="470" y="129"/>
                  <a:pt x="461" y="129"/>
                </a:cubicBezTo>
                <a:cubicBezTo>
                  <a:pt x="449" y="129"/>
                  <a:pt x="439" y="124"/>
                  <a:pt x="432" y="116"/>
                </a:cubicBezTo>
                <a:cubicBezTo>
                  <a:pt x="424" y="105"/>
                  <a:pt x="420" y="88"/>
                  <a:pt x="420" y="64"/>
                </a:cubicBezTo>
                <a:close/>
                <a:moveTo>
                  <a:pt x="436" y="64"/>
                </a:moveTo>
                <a:cubicBezTo>
                  <a:pt x="436" y="85"/>
                  <a:pt x="438" y="99"/>
                  <a:pt x="443" y="106"/>
                </a:cubicBezTo>
                <a:cubicBezTo>
                  <a:pt x="448" y="113"/>
                  <a:pt x="454" y="116"/>
                  <a:pt x="461" y="116"/>
                </a:cubicBezTo>
                <a:cubicBezTo>
                  <a:pt x="468" y="116"/>
                  <a:pt x="474" y="113"/>
                  <a:pt x="479" y="106"/>
                </a:cubicBezTo>
                <a:cubicBezTo>
                  <a:pt x="483" y="99"/>
                  <a:pt x="486" y="85"/>
                  <a:pt x="486" y="64"/>
                </a:cubicBezTo>
                <a:cubicBezTo>
                  <a:pt x="486" y="44"/>
                  <a:pt x="483" y="30"/>
                  <a:pt x="479" y="23"/>
                </a:cubicBezTo>
                <a:cubicBezTo>
                  <a:pt x="474" y="16"/>
                  <a:pt x="468" y="13"/>
                  <a:pt x="461" y="13"/>
                </a:cubicBezTo>
                <a:cubicBezTo>
                  <a:pt x="453" y="13"/>
                  <a:pt x="448" y="16"/>
                  <a:pt x="444" y="22"/>
                </a:cubicBezTo>
                <a:cubicBezTo>
                  <a:pt x="438" y="29"/>
                  <a:pt x="436" y="44"/>
                  <a:pt x="436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2" name="Freeform 60"/>
          <p:cNvSpPr>
            <a:spLocks noEditPoints="1"/>
          </p:cNvSpPr>
          <p:nvPr/>
        </p:nvSpPr>
        <p:spPr bwMode="auto">
          <a:xfrm>
            <a:off x="1335355" y="5650677"/>
            <a:ext cx="74197" cy="91319"/>
          </a:xfrm>
          <a:custGeom>
            <a:avLst/>
            <a:gdLst>
              <a:gd name="T0" fmla="*/ 2 w 123"/>
              <a:gd name="T1" fmla="*/ 127 h 152"/>
              <a:gd name="T2" fmla="*/ 2 w 123"/>
              <a:gd name="T3" fmla="*/ 109 h 152"/>
              <a:gd name="T4" fmla="*/ 19 w 123"/>
              <a:gd name="T5" fmla="*/ 109 h 152"/>
              <a:gd name="T6" fmla="*/ 19 w 123"/>
              <a:gd name="T7" fmla="*/ 127 h 152"/>
              <a:gd name="T8" fmla="*/ 16 w 123"/>
              <a:gd name="T9" fmla="*/ 142 h 152"/>
              <a:gd name="T10" fmla="*/ 5 w 123"/>
              <a:gd name="T11" fmla="*/ 152 h 152"/>
              <a:gd name="T12" fmla="*/ 0 w 123"/>
              <a:gd name="T13" fmla="*/ 145 h 152"/>
              <a:gd name="T14" fmla="*/ 8 w 123"/>
              <a:gd name="T15" fmla="*/ 139 h 152"/>
              <a:gd name="T16" fmla="*/ 10 w 123"/>
              <a:gd name="T17" fmla="*/ 127 h 152"/>
              <a:gd name="T18" fmla="*/ 2 w 123"/>
              <a:gd name="T19" fmla="*/ 127 h 152"/>
              <a:gd name="T20" fmla="*/ 41 w 123"/>
              <a:gd name="T21" fmla="*/ 64 h 152"/>
              <a:gd name="T22" fmla="*/ 46 w 123"/>
              <a:gd name="T23" fmla="*/ 28 h 152"/>
              <a:gd name="T24" fmla="*/ 59 w 123"/>
              <a:gd name="T25" fmla="*/ 7 h 152"/>
              <a:gd name="T26" fmla="*/ 82 w 123"/>
              <a:gd name="T27" fmla="*/ 0 h 152"/>
              <a:gd name="T28" fmla="*/ 100 w 123"/>
              <a:gd name="T29" fmla="*/ 4 h 152"/>
              <a:gd name="T30" fmla="*/ 113 w 123"/>
              <a:gd name="T31" fmla="*/ 16 h 152"/>
              <a:gd name="T32" fmla="*/ 120 w 123"/>
              <a:gd name="T33" fmla="*/ 35 h 152"/>
              <a:gd name="T34" fmla="*/ 123 w 123"/>
              <a:gd name="T35" fmla="*/ 64 h 152"/>
              <a:gd name="T36" fmla="*/ 119 w 123"/>
              <a:gd name="T37" fmla="*/ 100 h 152"/>
              <a:gd name="T38" fmla="*/ 105 w 123"/>
              <a:gd name="T39" fmla="*/ 121 h 152"/>
              <a:gd name="T40" fmla="*/ 82 w 123"/>
              <a:gd name="T41" fmla="*/ 129 h 152"/>
              <a:gd name="T42" fmla="*/ 54 w 123"/>
              <a:gd name="T43" fmla="*/ 116 h 152"/>
              <a:gd name="T44" fmla="*/ 41 w 123"/>
              <a:gd name="T45" fmla="*/ 64 h 152"/>
              <a:gd name="T46" fmla="*/ 57 w 123"/>
              <a:gd name="T47" fmla="*/ 64 h 152"/>
              <a:gd name="T48" fmla="*/ 64 w 123"/>
              <a:gd name="T49" fmla="*/ 106 h 152"/>
              <a:gd name="T50" fmla="*/ 82 w 123"/>
              <a:gd name="T51" fmla="*/ 116 h 152"/>
              <a:gd name="T52" fmla="*/ 100 w 123"/>
              <a:gd name="T53" fmla="*/ 106 h 152"/>
              <a:gd name="T54" fmla="*/ 107 w 123"/>
              <a:gd name="T55" fmla="*/ 64 h 152"/>
              <a:gd name="T56" fmla="*/ 100 w 123"/>
              <a:gd name="T57" fmla="*/ 23 h 152"/>
              <a:gd name="T58" fmla="*/ 82 w 123"/>
              <a:gd name="T59" fmla="*/ 13 h 152"/>
              <a:gd name="T60" fmla="*/ 65 w 123"/>
              <a:gd name="T61" fmla="*/ 22 h 152"/>
              <a:gd name="T62" fmla="*/ 57 w 123"/>
              <a:gd name="T63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123" h="152">
                <a:moveTo>
                  <a:pt x="2" y="127"/>
                </a:moveTo>
                <a:lnTo>
                  <a:pt x="2" y="109"/>
                </a:lnTo>
                <a:lnTo>
                  <a:pt x="19" y="109"/>
                </a:lnTo>
                <a:lnTo>
                  <a:pt x="19" y="127"/>
                </a:lnTo>
                <a:cubicBezTo>
                  <a:pt x="19" y="133"/>
                  <a:pt x="18" y="138"/>
                  <a:pt x="16" y="142"/>
                </a:cubicBezTo>
                <a:cubicBezTo>
                  <a:pt x="13" y="146"/>
                  <a:pt x="10" y="149"/>
                  <a:pt x="5" y="152"/>
                </a:cubicBezTo>
                <a:lnTo>
                  <a:pt x="0" y="145"/>
                </a:lnTo>
                <a:cubicBezTo>
                  <a:pt x="4" y="143"/>
                  <a:pt x="6" y="141"/>
                  <a:pt x="8" y="139"/>
                </a:cubicBezTo>
                <a:cubicBezTo>
                  <a:pt x="9" y="136"/>
                  <a:pt x="10" y="132"/>
                  <a:pt x="10" y="127"/>
                </a:cubicBezTo>
                <a:lnTo>
                  <a:pt x="2" y="127"/>
                </a:lnTo>
                <a:close/>
                <a:moveTo>
                  <a:pt x="41" y="64"/>
                </a:moveTo>
                <a:cubicBezTo>
                  <a:pt x="41" y="49"/>
                  <a:pt x="43" y="38"/>
                  <a:pt x="46" y="28"/>
                </a:cubicBezTo>
                <a:cubicBezTo>
                  <a:pt x="49" y="19"/>
                  <a:pt x="53" y="12"/>
                  <a:pt x="59" y="7"/>
                </a:cubicBezTo>
                <a:cubicBezTo>
                  <a:pt x="66" y="3"/>
                  <a:pt x="73" y="0"/>
                  <a:pt x="82" y="0"/>
                </a:cubicBezTo>
                <a:cubicBezTo>
                  <a:pt x="89" y="0"/>
                  <a:pt x="95" y="1"/>
                  <a:pt x="100" y="4"/>
                </a:cubicBezTo>
                <a:cubicBezTo>
                  <a:pt x="105" y="7"/>
                  <a:pt x="109" y="11"/>
                  <a:pt x="113" y="16"/>
                </a:cubicBezTo>
                <a:cubicBezTo>
                  <a:pt x="116" y="21"/>
                  <a:pt x="119" y="27"/>
                  <a:pt x="120" y="35"/>
                </a:cubicBezTo>
                <a:cubicBezTo>
                  <a:pt x="122" y="42"/>
                  <a:pt x="123" y="52"/>
                  <a:pt x="123" y="64"/>
                </a:cubicBezTo>
                <a:cubicBezTo>
                  <a:pt x="123" y="79"/>
                  <a:pt x="122" y="91"/>
                  <a:pt x="119" y="100"/>
                </a:cubicBezTo>
                <a:cubicBezTo>
                  <a:pt x="116" y="109"/>
                  <a:pt x="111" y="116"/>
                  <a:pt x="105" y="121"/>
                </a:cubicBezTo>
                <a:cubicBezTo>
                  <a:pt x="99" y="126"/>
                  <a:pt x="92" y="129"/>
                  <a:pt x="82" y="129"/>
                </a:cubicBezTo>
                <a:cubicBezTo>
                  <a:pt x="70" y="129"/>
                  <a:pt x="61" y="124"/>
                  <a:pt x="54" y="116"/>
                </a:cubicBezTo>
                <a:cubicBezTo>
                  <a:pt x="45" y="105"/>
                  <a:pt x="41" y="88"/>
                  <a:pt x="41" y="64"/>
                </a:cubicBezTo>
                <a:close/>
                <a:moveTo>
                  <a:pt x="57" y="64"/>
                </a:moveTo>
                <a:cubicBezTo>
                  <a:pt x="57" y="85"/>
                  <a:pt x="60" y="99"/>
                  <a:pt x="64" y="106"/>
                </a:cubicBezTo>
                <a:cubicBezTo>
                  <a:pt x="69" y="113"/>
                  <a:pt x="75" y="116"/>
                  <a:pt x="82" y="116"/>
                </a:cubicBezTo>
                <a:cubicBezTo>
                  <a:pt x="89" y="116"/>
                  <a:pt x="95" y="113"/>
                  <a:pt x="100" y="106"/>
                </a:cubicBezTo>
                <a:cubicBezTo>
                  <a:pt x="105" y="99"/>
                  <a:pt x="107" y="85"/>
                  <a:pt x="107" y="64"/>
                </a:cubicBezTo>
                <a:cubicBezTo>
                  <a:pt x="107" y="44"/>
                  <a:pt x="105" y="30"/>
                  <a:pt x="100" y="23"/>
                </a:cubicBezTo>
                <a:cubicBezTo>
                  <a:pt x="95" y="16"/>
                  <a:pt x="89" y="13"/>
                  <a:pt x="82" y="13"/>
                </a:cubicBezTo>
                <a:cubicBezTo>
                  <a:pt x="75" y="13"/>
                  <a:pt x="69" y="16"/>
                  <a:pt x="65" y="22"/>
                </a:cubicBezTo>
                <a:cubicBezTo>
                  <a:pt x="60" y="29"/>
                  <a:pt x="57" y="44"/>
                  <a:pt x="57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4" name="Line 62"/>
          <p:cNvSpPr>
            <a:spLocks noChangeShapeType="1"/>
          </p:cNvSpPr>
          <p:nvPr/>
        </p:nvSpPr>
        <p:spPr bwMode="auto">
          <a:xfrm flipH="1">
            <a:off x="1267233" y="5533949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5" name="Line 63"/>
          <p:cNvSpPr>
            <a:spLocks noChangeShapeType="1"/>
          </p:cNvSpPr>
          <p:nvPr/>
        </p:nvSpPr>
        <p:spPr bwMode="auto">
          <a:xfrm flipH="1">
            <a:off x="1267233" y="4820516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6" name="Line 64"/>
          <p:cNvSpPr>
            <a:spLocks noChangeShapeType="1"/>
          </p:cNvSpPr>
          <p:nvPr/>
        </p:nvSpPr>
        <p:spPr bwMode="auto">
          <a:xfrm flipH="1">
            <a:off x="1267233" y="4109937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7" name="Line 65"/>
          <p:cNvSpPr>
            <a:spLocks noChangeShapeType="1"/>
          </p:cNvSpPr>
          <p:nvPr/>
        </p:nvSpPr>
        <p:spPr bwMode="auto">
          <a:xfrm flipH="1">
            <a:off x="1267233" y="3399358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8" name="Line 66"/>
          <p:cNvSpPr>
            <a:spLocks noChangeShapeType="1"/>
          </p:cNvSpPr>
          <p:nvPr/>
        </p:nvSpPr>
        <p:spPr bwMode="auto">
          <a:xfrm flipH="1">
            <a:off x="1267233" y="2688779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9" name="Line 67"/>
          <p:cNvSpPr>
            <a:spLocks noChangeShapeType="1"/>
          </p:cNvSpPr>
          <p:nvPr/>
        </p:nvSpPr>
        <p:spPr bwMode="auto">
          <a:xfrm flipH="1">
            <a:off x="1267233" y="1975346"/>
            <a:ext cx="68490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1" name="Freeform 69"/>
          <p:cNvSpPr>
            <a:spLocks noEditPoints="1"/>
          </p:cNvSpPr>
          <p:nvPr/>
        </p:nvSpPr>
        <p:spPr bwMode="auto">
          <a:xfrm>
            <a:off x="1133107" y="1952516"/>
            <a:ext cx="131272" cy="91319"/>
          </a:xfrm>
          <a:custGeom>
            <a:avLst/>
            <a:gdLst>
              <a:gd name="T0" fmla="*/ 46 w 214"/>
              <a:gd name="T1" fmla="*/ 127 h 152"/>
              <a:gd name="T2" fmla="*/ 30 w 214"/>
              <a:gd name="T3" fmla="*/ 127 h 152"/>
              <a:gd name="T4" fmla="*/ 30 w 214"/>
              <a:gd name="T5" fmla="*/ 28 h 152"/>
              <a:gd name="T6" fmla="*/ 16 w 214"/>
              <a:gd name="T7" fmla="*/ 39 h 152"/>
              <a:gd name="T8" fmla="*/ 0 w 214"/>
              <a:gd name="T9" fmla="*/ 47 h 152"/>
              <a:gd name="T10" fmla="*/ 0 w 214"/>
              <a:gd name="T11" fmla="*/ 32 h 152"/>
              <a:gd name="T12" fmla="*/ 22 w 214"/>
              <a:gd name="T13" fmla="*/ 17 h 152"/>
              <a:gd name="T14" fmla="*/ 36 w 214"/>
              <a:gd name="T15" fmla="*/ 0 h 152"/>
              <a:gd name="T16" fmla="*/ 46 w 214"/>
              <a:gd name="T17" fmla="*/ 0 h 152"/>
              <a:gd name="T18" fmla="*/ 46 w 214"/>
              <a:gd name="T19" fmla="*/ 127 h 152"/>
              <a:gd name="T20" fmla="*/ 92 w 214"/>
              <a:gd name="T21" fmla="*/ 127 h 152"/>
              <a:gd name="T22" fmla="*/ 92 w 214"/>
              <a:gd name="T23" fmla="*/ 109 h 152"/>
              <a:gd name="T24" fmla="*/ 110 w 214"/>
              <a:gd name="T25" fmla="*/ 109 h 152"/>
              <a:gd name="T26" fmla="*/ 110 w 214"/>
              <a:gd name="T27" fmla="*/ 127 h 152"/>
              <a:gd name="T28" fmla="*/ 106 w 214"/>
              <a:gd name="T29" fmla="*/ 142 h 152"/>
              <a:gd name="T30" fmla="*/ 95 w 214"/>
              <a:gd name="T31" fmla="*/ 152 h 152"/>
              <a:gd name="T32" fmla="*/ 91 w 214"/>
              <a:gd name="T33" fmla="*/ 145 h 152"/>
              <a:gd name="T34" fmla="*/ 98 w 214"/>
              <a:gd name="T35" fmla="*/ 139 h 152"/>
              <a:gd name="T36" fmla="*/ 101 w 214"/>
              <a:gd name="T37" fmla="*/ 127 h 152"/>
              <a:gd name="T38" fmla="*/ 92 w 214"/>
              <a:gd name="T39" fmla="*/ 127 h 152"/>
              <a:gd name="T40" fmla="*/ 132 w 214"/>
              <a:gd name="T41" fmla="*/ 64 h 152"/>
              <a:gd name="T42" fmla="*/ 136 w 214"/>
              <a:gd name="T43" fmla="*/ 28 h 152"/>
              <a:gd name="T44" fmla="*/ 150 w 214"/>
              <a:gd name="T45" fmla="*/ 7 h 152"/>
              <a:gd name="T46" fmla="*/ 173 w 214"/>
              <a:gd name="T47" fmla="*/ 0 h 152"/>
              <a:gd name="T48" fmla="*/ 190 w 214"/>
              <a:gd name="T49" fmla="*/ 4 h 152"/>
              <a:gd name="T50" fmla="*/ 203 w 214"/>
              <a:gd name="T51" fmla="*/ 16 h 152"/>
              <a:gd name="T52" fmla="*/ 211 w 214"/>
              <a:gd name="T53" fmla="*/ 35 h 152"/>
              <a:gd name="T54" fmla="*/ 214 w 214"/>
              <a:gd name="T55" fmla="*/ 64 h 152"/>
              <a:gd name="T56" fmla="*/ 209 w 214"/>
              <a:gd name="T57" fmla="*/ 100 h 152"/>
              <a:gd name="T58" fmla="*/ 196 w 214"/>
              <a:gd name="T59" fmla="*/ 121 h 152"/>
              <a:gd name="T60" fmla="*/ 173 w 214"/>
              <a:gd name="T61" fmla="*/ 129 h 152"/>
              <a:gd name="T62" fmla="*/ 144 w 214"/>
              <a:gd name="T63" fmla="*/ 116 h 152"/>
              <a:gd name="T64" fmla="*/ 132 w 214"/>
              <a:gd name="T65" fmla="*/ 64 h 152"/>
              <a:gd name="T66" fmla="*/ 148 w 214"/>
              <a:gd name="T67" fmla="*/ 64 h 152"/>
              <a:gd name="T68" fmla="*/ 155 w 214"/>
              <a:gd name="T69" fmla="*/ 106 h 152"/>
              <a:gd name="T70" fmla="*/ 173 w 214"/>
              <a:gd name="T71" fmla="*/ 116 h 152"/>
              <a:gd name="T72" fmla="*/ 191 w 214"/>
              <a:gd name="T73" fmla="*/ 106 h 152"/>
              <a:gd name="T74" fmla="*/ 198 w 214"/>
              <a:gd name="T75" fmla="*/ 64 h 152"/>
              <a:gd name="T76" fmla="*/ 191 w 214"/>
              <a:gd name="T77" fmla="*/ 23 h 152"/>
              <a:gd name="T78" fmla="*/ 173 w 214"/>
              <a:gd name="T79" fmla="*/ 13 h 152"/>
              <a:gd name="T80" fmla="*/ 156 w 214"/>
              <a:gd name="T81" fmla="*/ 22 h 152"/>
              <a:gd name="T82" fmla="*/ 148 w 214"/>
              <a:gd name="T83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</a:cxnLst>
            <a:rect l="0" t="0" r="r" b="b"/>
            <a:pathLst>
              <a:path w="214" h="152">
                <a:moveTo>
                  <a:pt x="46" y="127"/>
                </a:moveTo>
                <a:lnTo>
                  <a:pt x="30" y="127"/>
                </a:lnTo>
                <a:lnTo>
                  <a:pt x="30" y="28"/>
                </a:lnTo>
                <a:cubicBezTo>
                  <a:pt x="27" y="32"/>
                  <a:pt x="22" y="35"/>
                  <a:pt x="16" y="39"/>
                </a:cubicBezTo>
                <a:cubicBezTo>
                  <a:pt x="10" y="42"/>
                  <a:pt x="4" y="45"/>
                  <a:pt x="0" y="47"/>
                </a:cubicBezTo>
                <a:lnTo>
                  <a:pt x="0" y="32"/>
                </a:lnTo>
                <a:cubicBezTo>
                  <a:pt x="8" y="28"/>
                  <a:pt x="16" y="23"/>
                  <a:pt x="22" y="17"/>
                </a:cubicBezTo>
                <a:cubicBezTo>
                  <a:pt x="29" y="11"/>
                  <a:pt x="33" y="6"/>
                  <a:pt x="36" y="0"/>
                </a:cubicBezTo>
                <a:lnTo>
                  <a:pt x="46" y="0"/>
                </a:lnTo>
                <a:lnTo>
                  <a:pt x="46" y="127"/>
                </a:lnTo>
                <a:close/>
                <a:moveTo>
                  <a:pt x="92" y="127"/>
                </a:moveTo>
                <a:lnTo>
                  <a:pt x="92" y="109"/>
                </a:lnTo>
                <a:lnTo>
                  <a:pt x="110" y="109"/>
                </a:lnTo>
                <a:lnTo>
                  <a:pt x="110" y="127"/>
                </a:lnTo>
                <a:cubicBezTo>
                  <a:pt x="110" y="133"/>
                  <a:pt x="108" y="138"/>
                  <a:pt x="106" y="142"/>
                </a:cubicBezTo>
                <a:cubicBezTo>
                  <a:pt x="104" y="146"/>
                  <a:pt x="100" y="149"/>
                  <a:pt x="95" y="152"/>
                </a:cubicBezTo>
                <a:lnTo>
                  <a:pt x="91" y="145"/>
                </a:lnTo>
                <a:cubicBezTo>
                  <a:pt x="94" y="144"/>
                  <a:pt x="97" y="141"/>
                  <a:pt x="98" y="139"/>
                </a:cubicBezTo>
                <a:cubicBezTo>
                  <a:pt x="100" y="136"/>
                  <a:pt x="101" y="132"/>
                  <a:pt x="101" y="127"/>
                </a:cubicBezTo>
                <a:lnTo>
                  <a:pt x="92" y="127"/>
                </a:lnTo>
                <a:close/>
                <a:moveTo>
                  <a:pt x="132" y="64"/>
                </a:moveTo>
                <a:cubicBezTo>
                  <a:pt x="132" y="50"/>
                  <a:pt x="133" y="38"/>
                  <a:pt x="136" y="28"/>
                </a:cubicBezTo>
                <a:cubicBezTo>
                  <a:pt x="139" y="19"/>
                  <a:pt x="144" y="12"/>
                  <a:pt x="150" y="7"/>
                </a:cubicBezTo>
                <a:cubicBezTo>
                  <a:pt x="156" y="3"/>
                  <a:pt x="164" y="0"/>
                  <a:pt x="173" y="0"/>
                </a:cubicBezTo>
                <a:cubicBezTo>
                  <a:pt x="180" y="0"/>
                  <a:pt x="185" y="1"/>
                  <a:pt x="190" y="4"/>
                </a:cubicBezTo>
                <a:cubicBezTo>
                  <a:pt x="196" y="7"/>
                  <a:pt x="200" y="11"/>
                  <a:pt x="203" y="16"/>
                </a:cubicBezTo>
                <a:cubicBezTo>
                  <a:pt x="206" y="21"/>
                  <a:pt x="209" y="27"/>
                  <a:pt x="211" y="35"/>
                </a:cubicBezTo>
                <a:cubicBezTo>
                  <a:pt x="213" y="42"/>
                  <a:pt x="214" y="52"/>
                  <a:pt x="214" y="64"/>
                </a:cubicBezTo>
                <a:cubicBezTo>
                  <a:pt x="214" y="79"/>
                  <a:pt x="212" y="91"/>
                  <a:pt x="209" y="100"/>
                </a:cubicBezTo>
                <a:cubicBezTo>
                  <a:pt x="206" y="109"/>
                  <a:pt x="202" y="116"/>
                  <a:pt x="196" y="121"/>
                </a:cubicBezTo>
                <a:cubicBezTo>
                  <a:pt x="190" y="126"/>
                  <a:pt x="182" y="129"/>
                  <a:pt x="173" y="129"/>
                </a:cubicBezTo>
                <a:cubicBezTo>
                  <a:pt x="161" y="129"/>
                  <a:pt x="151" y="124"/>
                  <a:pt x="144" y="116"/>
                </a:cubicBezTo>
                <a:cubicBezTo>
                  <a:pt x="136" y="105"/>
                  <a:pt x="132" y="88"/>
                  <a:pt x="132" y="64"/>
                </a:cubicBezTo>
                <a:close/>
                <a:moveTo>
                  <a:pt x="148" y="64"/>
                </a:moveTo>
                <a:cubicBezTo>
                  <a:pt x="148" y="85"/>
                  <a:pt x="150" y="99"/>
                  <a:pt x="155" y="106"/>
                </a:cubicBezTo>
                <a:cubicBezTo>
                  <a:pt x="160" y="113"/>
                  <a:pt x="166" y="116"/>
                  <a:pt x="173" y="116"/>
                </a:cubicBezTo>
                <a:cubicBezTo>
                  <a:pt x="180" y="116"/>
                  <a:pt x="186" y="113"/>
                  <a:pt x="191" y="106"/>
                </a:cubicBezTo>
                <a:cubicBezTo>
                  <a:pt x="195" y="99"/>
                  <a:pt x="198" y="85"/>
                  <a:pt x="198" y="64"/>
                </a:cubicBezTo>
                <a:cubicBezTo>
                  <a:pt x="198" y="44"/>
                  <a:pt x="195" y="30"/>
                  <a:pt x="191" y="23"/>
                </a:cubicBezTo>
                <a:cubicBezTo>
                  <a:pt x="186" y="16"/>
                  <a:pt x="180" y="13"/>
                  <a:pt x="173" y="13"/>
                </a:cubicBezTo>
                <a:cubicBezTo>
                  <a:pt x="165" y="13"/>
                  <a:pt x="160" y="16"/>
                  <a:pt x="156" y="22"/>
                </a:cubicBezTo>
                <a:cubicBezTo>
                  <a:pt x="150" y="30"/>
                  <a:pt x="148" y="44"/>
                  <a:pt x="148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2" name="Freeform 70"/>
          <p:cNvSpPr>
            <a:spLocks noEditPoints="1"/>
          </p:cNvSpPr>
          <p:nvPr/>
        </p:nvSpPr>
        <p:spPr bwMode="auto">
          <a:xfrm>
            <a:off x="1127400" y="2643119"/>
            <a:ext cx="136979" cy="91319"/>
          </a:xfrm>
          <a:custGeom>
            <a:avLst/>
            <a:gdLst>
              <a:gd name="T0" fmla="*/ 4 w 227"/>
              <a:gd name="T1" fmla="*/ 29 h 152"/>
              <a:gd name="T2" fmla="*/ 41 w 227"/>
              <a:gd name="T3" fmla="*/ 0 h 152"/>
              <a:gd name="T4" fmla="*/ 71 w 227"/>
              <a:gd name="T5" fmla="*/ 16 h 152"/>
              <a:gd name="T6" fmla="*/ 82 w 227"/>
              <a:gd name="T7" fmla="*/ 65 h 152"/>
              <a:gd name="T8" fmla="*/ 64 w 227"/>
              <a:gd name="T9" fmla="*/ 122 h 152"/>
              <a:gd name="T10" fmla="*/ 12 w 227"/>
              <a:gd name="T11" fmla="*/ 116 h 152"/>
              <a:gd name="T12" fmla="*/ 16 w 227"/>
              <a:gd name="T13" fmla="*/ 65 h 152"/>
              <a:gd name="T14" fmla="*/ 41 w 227"/>
              <a:gd name="T15" fmla="*/ 116 h 152"/>
              <a:gd name="T16" fmla="*/ 66 w 227"/>
              <a:gd name="T17" fmla="*/ 65 h 152"/>
              <a:gd name="T18" fmla="*/ 41 w 227"/>
              <a:gd name="T19" fmla="*/ 13 h 152"/>
              <a:gd name="T20" fmla="*/ 16 w 227"/>
              <a:gd name="T21" fmla="*/ 65 h 152"/>
              <a:gd name="T22" fmla="*/ 104 w 227"/>
              <a:gd name="T23" fmla="*/ 109 h 152"/>
              <a:gd name="T24" fmla="*/ 122 w 227"/>
              <a:gd name="T25" fmla="*/ 127 h 152"/>
              <a:gd name="T26" fmla="*/ 107 w 227"/>
              <a:gd name="T27" fmla="*/ 152 h 152"/>
              <a:gd name="T28" fmla="*/ 110 w 227"/>
              <a:gd name="T29" fmla="*/ 139 h 152"/>
              <a:gd name="T30" fmla="*/ 104 w 227"/>
              <a:gd name="T31" fmla="*/ 127 h 152"/>
              <a:gd name="T32" fmla="*/ 153 w 227"/>
              <a:gd name="T33" fmla="*/ 48 h 152"/>
              <a:gd name="T34" fmla="*/ 158 w 227"/>
              <a:gd name="T35" fmla="*/ 10 h 152"/>
              <a:gd name="T36" fmla="*/ 211 w 227"/>
              <a:gd name="T37" fmla="*/ 10 h 152"/>
              <a:gd name="T38" fmla="*/ 217 w 227"/>
              <a:gd name="T39" fmla="*/ 49 h 152"/>
              <a:gd name="T40" fmla="*/ 220 w 227"/>
              <a:gd name="T41" fmla="*/ 71 h 152"/>
              <a:gd name="T42" fmla="*/ 215 w 227"/>
              <a:gd name="T43" fmla="*/ 118 h 152"/>
              <a:gd name="T44" fmla="*/ 155 w 227"/>
              <a:gd name="T45" fmla="*/ 118 h 152"/>
              <a:gd name="T46" fmla="*/ 150 w 227"/>
              <a:gd name="T47" fmla="*/ 70 h 152"/>
              <a:gd name="T48" fmla="*/ 164 w 227"/>
              <a:gd name="T49" fmla="*/ 32 h 152"/>
              <a:gd name="T50" fmla="*/ 185 w 227"/>
              <a:gd name="T51" fmla="*/ 53 h 152"/>
              <a:gd name="T52" fmla="*/ 205 w 227"/>
              <a:gd name="T53" fmla="*/ 33 h 152"/>
              <a:gd name="T54" fmla="*/ 185 w 227"/>
              <a:gd name="T55" fmla="*/ 13 h 152"/>
              <a:gd name="T56" fmla="*/ 164 w 227"/>
              <a:gd name="T57" fmla="*/ 32 h 152"/>
              <a:gd name="T58" fmla="*/ 162 w 227"/>
              <a:gd name="T59" fmla="*/ 103 h 152"/>
              <a:gd name="T60" fmla="*/ 185 w 227"/>
              <a:gd name="T61" fmla="*/ 116 h 152"/>
              <a:gd name="T62" fmla="*/ 211 w 227"/>
              <a:gd name="T63" fmla="*/ 91 h 152"/>
              <a:gd name="T64" fmla="*/ 185 w 227"/>
              <a:gd name="T65" fmla="*/ 65 h 152"/>
              <a:gd name="T66" fmla="*/ 159 w 227"/>
              <a:gd name="T67" fmla="*/ 91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227" h="152">
                <a:moveTo>
                  <a:pt x="0" y="65"/>
                </a:moveTo>
                <a:cubicBezTo>
                  <a:pt x="0" y="50"/>
                  <a:pt x="1" y="38"/>
                  <a:pt x="4" y="29"/>
                </a:cubicBezTo>
                <a:cubicBezTo>
                  <a:pt x="7" y="20"/>
                  <a:pt x="12" y="13"/>
                  <a:pt x="18" y="8"/>
                </a:cubicBezTo>
                <a:cubicBezTo>
                  <a:pt x="24" y="3"/>
                  <a:pt x="32" y="0"/>
                  <a:pt x="41" y="0"/>
                </a:cubicBezTo>
                <a:cubicBezTo>
                  <a:pt x="48" y="0"/>
                  <a:pt x="53" y="2"/>
                  <a:pt x="58" y="4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7"/>
                  <a:pt x="79" y="35"/>
                </a:cubicBezTo>
                <a:cubicBezTo>
                  <a:pt x="81" y="42"/>
                  <a:pt x="82" y="52"/>
                  <a:pt x="82" y="65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7"/>
                  <a:pt x="64" y="122"/>
                </a:cubicBezTo>
                <a:cubicBezTo>
                  <a:pt x="58" y="127"/>
                  <a:pt x="50" y="129"/>
                  <a:pt x="41" y="129"/>
                </a:cubicBezTo>
                <a:cubicBezTo>
                  <a:pt x="29" y="129"/>
                  <a:pt x="19" y="125"/>
                  <a:pt x="12" y="116"/>
                </a:cubicBezTo>
                <a:cubicBezTo>
                  <a:pt x="4" y="105"/>
                  <a:pt x="0" y="88"/>
                  <a:pt x="0" y="65"/>
                </a:cubicBezTo>
                <a:close/>
                <a:moveTo>
                  <a:pt x="16" y="65"/>
                </a:moveTo>
                <a:cubicBezTo>
                  <a:pt x="16" y="85"/>
                  <a:pt x="18" y="99"/>
                  <a:pt x="23" y="106"/>
                </a:cubicBezTo>
                <a:cubicBezTo>
                  <a:pt x="28" y="113"/>
                  <a:pt x="34" y="116"/>
                  <a:pt x="41" y="116"/>
                </a:cubicBezTo>
                <a:cubicBezTo>
                  <a:pt x="48" y="116"/>
                  <a:pt x="54" y="113"/>
                  <a:pt x="59" y="106"/>
                </a:cubicBezTo>
                <a:cubicBezTo>
                  <a:pt x="63" y="99"/>
                  <a:pt x="66" y="85"/>
                  <a:pt x="66" y="65"/>
                </a:cubicBezTo>
                <a:cubicBezTo>
                  <a:pt x="66" y="44"/>
                  <a:pt x="63" y="30"/>
                  <a:pt x="59" y="23"/>
                </a:cubicBezTo>
                <a:cubicBezTo>
                  <a:pt x="54" y="16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30"/>
                  <a:pt x="16" y="44"/>
                  <a:pt x="16" y="65"/>
                </a:cubicBezTo>
                <a:close/>
                <a:moveTo>
                  <a:pt x="104" y="127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7"/>
                </a:lnTo>
                <a:cubicBezTo>
                  <a:pt x="122" y="133"/>
                  <a:pt x="120" y="139"/>
                  <a:pt x="118" y="143"/>
                </a:cubicBezTo>
                <a:cubicBezTo>
                  <a:pt x="116" y="147"/>
                  <a:pt x="112" y="150"/>
                  <a:pt x="107" y="152"/>
                </a:cubicBezTo>
                <a:lnTo>
                  <a:pt x="103" y="145"/>
                </a:lnTo>
                <a:cubicBezTo>
                  <a:pt x="106" y="144"/>
                  <a:pt x="109" y="142"/>
                  <a:pt x="110" y="139"/>
                </a:cubicBezTo>
                <a:cubicBezTo>
                  <a:pt x="112" y="136"/>
                  <a:pt x="113" y="132"/>
                  <a:pt x="113" y="127"/>
                </a:cubicBezTo>
                <a:lnTo>
                  <a:pt x="104" y="127"/>
                </a:lnTo>
                <a:close/>
                <a:moveTo>
                  <a:pt x="167" y="59"/>
                </a:moveTo>
                <a:cubicBezTo>
                  <a:pt x="161" y="56"/>
                  <a:pt x="156" y="53"/>
                  <a:pt x="153" y="48"/>
                </a:cubicBezTo>
                <a:cubicBezTo>
                  <a:pt x="150" y="44"/>
                  <a:pt x="149" y="39"/>
                  <a:pt x="149" y="33"/>
                </a:cubicBezTo>
                <a:cubicBezTo>
                  <a:pt x="149" y="24"/>
                  <a:pt x="152" y="16"/>
                  <a:pt x="158" y="10"/>
                </a:cubicBezTo>
                <a:cubicBezTo>
                  <a:pt x="165" y="3"/>
                  <a:pt x="174" y="0"/>
                  <a:pt x="185" y="0"/>
                </a:cubicBezTo>
                <a:cubicBezTo>
                  <a:pt x="196" y="0"/>
                  <a:pt x="205" y="3"/>
                  <a:pt x="211" y="10"/>
                </a:cubicBezTo>
                <a:cubicBezTo>
                  <a:pt x="218" y="16"/>
                  <a:pt x="221" y="24"/>
                  <a:pt x="221" y="33"/>
                </a:cubicBezTo>
                <a:cubicBezTo>
                  <a:pt x="221" y="39"/>
                  <a:pt x="220" y="44"/>
                  <a:pt x="217" y="49"/>
                </a:cubicBezTo>
                <a:cubicBezTo>
                  <a:pt x="214" y="53"/>
                  <a:pt x="209" y="56"/>
                  <a:pt x="203" y="59"/>
                </a:cubicBezTo>
                <a:cubicBezTo>
                  <a:pt x="211" y="61"/>
                  <a:pt x="216" y="65"/>
                  <a:pt x="220" y="71"/>
                </a:cubicBezTo>
                <a:cubicBezTo>
                  <a:pt x="225" y="76"/>
                  <a:pt x="227" y="83"/>
                  <a:pt x="227" y="91"/>
                </a:cubicBezTo>
                <a:cubicBezTo>
                  <a:pt x="227" y="102"/>
                  <a:pt x="223" y="111"/>
                  <a:pt x="215" y="118"/>
                </a:cubicBezTo>
                <a:cubicBezTo>
                  <a:pt x="207" y="125"/>
                  <a:pt x="197" y="129"/>
                  <a:pt x="185" y="129"/>
                </a:cubicBezTo>
                <a:cubicBezTo>
                  <a:pt x="173" y="129"/>
                  <a:pt x="163" y="125"/>
                  <a:pt x="155" y="118"/>
                </a:cubicBezTo>
                <a:cubicBezTo>
                  <a:pt x="147" y="110"/>
                  <a:pt x="144" y="101"/>
                  <a:pt x="144" y="90"/>
                </a:cubicBezTo>
                <a:cubicBezTo>
                  <a:pt x="144" y="82"/>
                  <a:pt x="146" y="75"/>
                  <a:pt x="150" y="70"/>
                </a:cubicBezTo>
                <a:cubicBezTo>
                  <a:pt x="154" y="64"/>
                  <a:pt x="160" y="61"/>
                  <a:pt x="167" y="59"/>
                </a:cubicBezTo>
                <a:close/>
                <a:moveTo>
                  <a:pt x="164" y="32"/>
                </a:moveTo>
                <a:cubicBezTo>
                  <a:pt x="164" y="38"/>
                  <a:pt x="166" y="43"/>
                  <a:pt x="170" y="47"/>
                </a:cubicBezTo>
                <a:cubicBezTo>
                  <a:pt x="174" y="51"/>
                  <a:pt x="179" y="53"/>
                  <a:pt x="185" y="53"/>
                </a:cubicBezTo>
                <a:cubicBezTo>
                  <a:pt x="191" y="53"/>
                  <a:pt x="196" y="51"/>
                  <a:pt x="200" y="47"/>
                </a:cubicBezTo>
                <a:cubicBezTo>
                  <a:pt x="203" y="43"/>
                  <a:pt x="205" y="39"/>
                  <a:pt x="205" y="33"/>
                </a:cubicBezTo>
                <a:cubicBezTo>
                  <a:pt x="205" y="27"/>
                  <a:pt x="203" y="23"/>
                  <a:pt x="199" y="19"/>
                </a:cubicBezTo>
                <a:cubicBezTo>
                  <a:pt x="196" y="15"/>
                  <a:pt x="191" y="13"/>
                  <a:pt x="185" y="13"/>
                </a:cubicBezTo>
                <a:cubicBezTo>
                  <a:pt x="179" y="13"/>
                  <a:pt x="174" y="15"/>
                  <a:pt x="170" y="19"/>
                </a:cubicBezTo>
                <a:cubicBezTo>
                  <a:pt x="166" y="22"/>
                  <a:pt x="164" y="27"/>
                  <a:pt x="164" y="32"/>
                </a:cubicBezTo>
                <a:close/>
                <a:moveTo>
                  <a:pt x="159" y="91"/>
                </a:moveTo>
                <a:cubicBezTo>
                  <a:pt x="159" y="95"/>
                  <a:pt x="160" y="99"/>
                  <a:pt x="162" y="103"/>
                </a:cubicBezTo>
                <a:cubicBezTo>
                  <a:pt x="165" y="107"/>
                  <a:pt x="168" y="111"/>
                  <a:pt x="172" y="113"/>
                </a:cubicBezTo>
                <a:cubicBezTo>
                  <a:pt x="176" y="115"/>
                  <a:pt x="180" y="116"/>
                  <a:pt x="185" y="116"/>
                </a:cubicBezTo>
                <a:cubicBezTo>
                  <a:pt x="193" y="116"/>
                  <a:pt x="199" y="114"/>
                  <a:pt x="203" y="109"/>
                </a:cubicBezTo>
                <a:cubicBezTo>
                  <a:pt x="208" y="104"/>
                  <a:pt x="211" y="98"/>
                  <a:pt x="211" y="91"/>
                </a:cubicBezTo>
                <a:cubicBezTo>
                  <a:pt x="211" y="84"/>
                  <a:pt x="208" y="77"/>
                  <a:pt x="203" y="73"/>
                </a:cubicBezTo>
                <a:cubicBezTo>
                  <a:pt x="198" y="68"/>
                  <a:pt x="192" y="65"/>
                  <a:pt x="185" y="65"/>
                </a:cubicBezTo>
                <a:cubicBezTo>
                  <a:pt x="177" y="65"/>
                  <a:pt x="171" y="68"/>
                  <a:pt x="167" y="72"/>
                </a:cubicBezTo>
                <a:cubicBezTo>
                  <a:pt x="162" y="77"/>
                  <a:pt x="159" y="83"/>
                  <a:pt x="159" y="91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3" name="Freeform 71"/>
          <p:cNvSpPr>
            <a:spLocks noEditPoints="1"/>
          </p:cNvSpPr>
          <p:nvPr/>
        </p:nvSpPr>
        <p:spPr bwMode="auto">
          <a:xfrm>
            <a:off x="1127400" y="3373674"/>
            <a:ext cx="136979" cy="94173"/>
          </a:xfrm>
          <a:custGeom>
            <a:avLst/>
            <a:gdLst>
              <a:gd name="T0" fmla="*/ 0 w 226"/>
              <a:gd name="T1" fmla="*/ 65 h 152"/>
              <a:gd name="T2" fmla="*/ 4 w 226"/>
              <a:gd name="T3" fmla="*/ 29 h 152"/>
              <a:gd name="T4" fmla="*/ 18 w 226"/>
              <a:gd name="T5" fmla="*/ 8 h 152"/>
              <a:gd name="T6" fmla="*/ 41 w 226"/>
              <a:gd name="T7" fmla="*/ 0 h 152"/>
              <a:gd name="T8" fmla="*/ 58 w 226"/>
              <a:gd name="T9" fmla="*/ 5 h 152"/>
              <a:gd name="T10" fmla="*/ 71 w 226"/>
              <a:gd name="T11" fmla="*/ 16 h 152"/>
              <a:gd name="T12" fmla="*/ 79 w 226"/>
              <a:gd name="T13" fmla="*/ 35 h 152"/>
              <a:gd name="T14" fmla="*/ 82 w 226"/>
              <a:gd name="T15" fmla="*/ 65 h 152"/>
              <a:gd name="T16" fmla="*/ 77 w 226"/>
              <a:gd name="T17" fmla="*/ 101 h 152"/>
              <a:gd name="T18" fmla="*/ 64 w 226"/>
              <a:gd name="T19" fmla="*/ 122 h 152"/>
              <a:gd name="T20" fmla="*/ 41 w 226"/>
              <a:gd name="T21" fmla="*/ 129 h 152"/>
              <a:gd name="T22" fmla="*/ 12 w 226"/>
              <a:gd name="T23" fmla="*/ 116 h 152"/>
              <a:gd name="T24" fmla="*/ 0 w 226"/>
              <a:gd name="T25" fmla="*/ 65 h 152"/>
              <a:gd name="T26" fmla="*/ 16 w 226"/>
              <a:gd name="T27" fmla="*/ 65 h 152"/>
              <a:gd name="T28" fmla="*/ 23 w 226"/>
              <a:gd name="T29" fmla="*/ 106 h 152"/>
              <a:gd name="T30" fmla="*/ 41 w 226"/>
              <a:gd name="T31" fmla="*/ 116 h 152"/>
              <a:gd name="T32" fmla="*/ 59 w 226"/>
              <a:gd name="T33" fmla="*/ 106 h 152"/>
              <a:gd name="T34" fmla="*/ 66 w 226"/>
              <a:gd name="T35" fmla="*/ 65 h 152"/>
              <a:gd name="T36" fmla="*/ 59 w 226"/>
              <a:gd name="T37" fmla="*/ 23 h 152"/>
              <a:gd name="T38" fmla="*/ 41 w 226"/>
              <a:gd name="T39" fmla="*/ 13 h 152"/>
              <a:gd name="T40" fmla="*/ 24 w 226"/>
              <a:gd name="T41" fmla="*/ 22 h 152"/>
              <a:gd name="T42" fmla="*/ 16 w 226"/>
              <a:gd name="T43" fmla="*/ 65 h 152"/>
              <a:gd name="T44" fmla="*/ 104 w 226"/>
              <a:gd name="T45" fmla="*/ 127 h 152"/>
              <a:gd name="T46" fmla="*/ 104 w 226"/>
              <a:gd name="T47" fmla="*/ 109 h 152"/>
              <a:gd name="T48" fmla="*/ 122 w 226"/>
              <a:gd name="T49" fmla="*/ 109 h 152"/>
              <a:gd name="T50" fmla="*/ 122 w 226"/>
              <a:gd name="T51" fmla="*/ 127 h 152"/>
              <a:gd name="T52" fmla="*/ 118 w 226"/>
              <a:gd name="T53" fmla="*/ 143 h 152"/>
              <a:gd name="T54" fmla="*/ 107 w 226"/>
              <a:gd name="T55" fmla="*/ 152 h 152"/>
              <a:gd name="T56" fmla="*/ 103 w 226"/>
              <a:gd name="T57" fmla="*/ 145 h 152"/>
              <a:gd name="T58" fmla="*/ 110 w 226"/>
              <a:gd name="T59" fmla="*/ 139 h 152"/>
              <a:gd name="T60" fmla="*/ 113 w 226"/>
              <a:gd name="T61" fmla="*/ 127 h 152"/>
              <a:gd name="T62" fmla="*/ 104 w 226"/>
              <a:gd name="T63" fmla="*/ 127 h 152"/>
              <a:gd name="T64" fmla="*/ 224 w 226"/>
              <a:gd name="T65" fmla="*/ 32 h 152"/>
              <a:gd name="T66" fmla="*/ 209 w 226"/>
              <a:gd name="T67" fmla="*/ 33 h 152"/>
              <a:gd name="T68" fmla="*/ 203 w 226"/>
              <a:gd name="T69" fmla="*/ 20 h 152"/>
              <a:gd name="T70" fmla="*/ 187 w 226"/>
              <a:gd name="T71" fmla="*/ 13 h 152"/>
              <a:gd name="T72" fmla="*/ 174 w 226"/>
              <a:gd name="T73" fmla="*/ 17 h 152"/>
              <a:gd name="T74" fmla="*/ 163 w 226"/>
              <a:gd name="T75" fmla="*/ 33 h 152"/>
              <a:gd name="T76" fmla="*/ 158 w 226"/>
              <a:gd name="T77" fmla="*/ 62 h 152"/>
              <a:gd name="T78" fmla="*/ 172 w 226"/>
              <a:gd name="T79" fmla="*/ 49 h 152"/>
              <a:gd name="T80" fmla="*/ 189 w 226"/>
              <a:gd name="T81" fmla="*/ 45 h 152"/>
              <a:gd name="T82" fmla="*/ 215 w 226"/>
              <a:gd name="T83" fmla="*/ 57 h 152"/>
              <a:gd name="T84" fmla="*/ 226 w 226"/>
              <a:gd name="T85" fmla="*/ 86 h 152"/>
              <a:gd name="T86" fmla="*/ 221 w 226"/>
              <a:gd name="T87" fmla="*/ 108 h 152"/>
              <a:gd name="T88" fmla="*/ 207 w 226"/>
              <a:gd name="T89" fmla="*/ 124 h 152"/>
              <a:gd name="T90" fmla="*/ 187 w 226"/>
              <a:gd name="T91" fmla="*/ 129 h 152"/>
              <a:gd name="T92" fmla="*/ 155 w 226"/>
              <a:gd name="T93" fmla="*/ 115 h 152"/>
              <a:gd name="T94" fmla="*/ 143 w 226"/>
              <a:gd name="T95" fmla="*/ 68 h 152"/>
              <a:gd name="T96" fmla="*/ 156 w 226"/>
              <a:gd name="T97" fmla="*/ 15 h 152"/>
              <a:gd name="T98" fmla="*/ 188 w 226"/>
              <a:gd name="T99" fmla="*/ 0 h 152"/>
              <a:gd name="T100" fmla="*/ 213 w 226"/>
              <a:gd name="T101" fmla="*/ 9 h 152"/>
              <a:gd name="T102" fmla="*/ 224 w 226"/>
              <a:gd name="T103" fmla="*/ 32 h 152"/>
              <a:gd name="T104" fmla="*/ 161 w 226"/>
              <a:gd name="T105" fmla="*/ 86 h 152"/>
              <a:gd name="T106" fmla="*/ 164 w 226"/>
              <a:gd name="T107" fmla="*/ 101 h 152"/>
              <a:gd name="T108" fmla="*/ 174 w 226"/>
              <a:gd name="T109" fmla="*/ 113 h 152"/>
              <a:gd name="T110" fmla="*/ 186 w 226"/>
              <a:gd name="T111" fmla="*/ 116 h 152"/>
              <a:gd name="T112" fmla="*/ 203 w 226"/>
              <a:gd name="T113" fmla="*/ 108 h 152"/>
              <a:gd name="T114" fmla="*/ 210 w 226"/>
              <a:gd name="T115" fmla="*/ 87 h 152"/>
              <a:gd name="T116" fmla="*/ 203 w 226"/>
              <a:gd name="T117" fmla="*/ 66 h 152"/>
              <a:gd name="T118" fmla="*/ 186 w 226"/>
              <a:gd name="T119" fmla="*/ 59 h 152"/>
              <a:gd name="T120" fmla="*/ 168 w 226"/>
              <a:gd name="T121" fmla="*/ 66 h 152"/>
              <a:gd name="T122" fmla="*/ 161 w 226"/>
              <a:gd name="T123" fmla="*/ 86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26" h="152">
                <a:moveTo>
                  <a:pt x="0" y="65"/>
                </a:moveTo>
                <a:cubicBezTo>
                  <a:pt x="0" y="50"/>
                  <a:pt x="1" y="38"/>
                  <a:pt x="4" y="29"/>
                </a:cubicBezTo>
                <a:cubicBezTo>
                  <a:pt x="7" y="20"/>
                  <a:pt x="12" y="13"/>
                  <a:pt x="18" y="8"/>
                </a:cubicBezTo>
                <a:cubicBezTo>
                  <a:pt x="24" y="3"/>
                  <a:pt x="32" y="0"/>
                  <a:pt x="41" y="0"/>
                </a:cubicBezTo>
                <a:cubicBezTo>
                  <a:pt x="48" y="0"/>
                  <a:pt x="53" y="2"/>
                  <a:pt x="58" y="5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8"/>
                  <a:pt x="79" y="35"/>
                </a:cubicBezTo>
                <a:cubicBezTo>
                  <a:pt x="81" y="43"/>
                  <a:pt x="82" y="52"/>
                  <a:pt x="82" y="65"/>
                </a:cubicBezTo>
                <a:cubicBezTo>
                  <a:pt x="82" y="80"/>
                  <a:pt x="80" y="92"/>
                  <a:pt x="77" y="101"/>
                </a:cubicBezTo>
                <a:cubicBezTo>
                  <a:pt x="74" y="110"/>
                  <a:pt x="70" y="117"/>
                  <a:pt x="64" y="122"/>
                </a:cubicBezTo>
                <a:cubicBezTo>
                  <a:pt x="58" y="127"/>
                  <a:pt x="50" y="129"/>
                  <a:pt x="41" y="129"/>
                </a:cubicBezTo>
                <a:cubicBezTo>
                  <a:pt x="29" y="129"/>
                  <a:pt x="19" y="125"/>
                  <a:pt x="12" y="116"/>
                </a:cubicBezTo>
                <a:cubicBezTo>
                  <a:pt x="4" y="105"/>
                  <a:pt x="0" y="88"/>
                  <a:pt x="0" y="65"/>
                </a:cubicBezTo>
                <a:close/>
                <a:moveTo>
                  <a:pt x="16" y="65"/>
                </a:moveTo>
                <a:cubicBezTo>
                  <a:pt x="16" y="86"/>
                  <a:pt x="18" y="99"/>
                  <a:pt x="23" y="106"/>
                </a:cubicBezTo>
                <a:cubicBezTo>
                  <a:pt x="28" y="113"/>
                  <a:pt x="34" y="116"/>
                  <a:pt x="41" y="116"/>
                </a:cubicBezTo>
                <a:cubicBezTo>
                  <a:pt x="48" y="116"/>
                  <a:pt x="54" y="113"/>
                  <a:pt x="59" y="106"/>
                </a:cubicBezTo>
                <a:cubicBezTo>
                  <a:pt x="63" y="99"/>
                  <a:pt x="66" y="85"/>
                  <a:pt x="66" y="65"/>
                </a:cubicBezTo>
                <a:cubicBezTo>
                  <a:pt x="66" y="44"/>
                  <a:pt x="63" y="30"/>
                  <a:pt x="59" y="23"/>
                </a:cubicBezTo>
                <a:cubicBezTo>
                  <a:pt x="54" y="17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30"/>
                  <a:pt x="16" y="44"/>
                  <a:pt x="16" y="65"/>
                </a:cubicBezTo>
                <a:close/>
                <a:moveTo>
                  <a:pt x="104" y="127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7"/>
                </a:lnTo>
                <a:cubicBezTo>
                  <a:pt x="122" y="133"/>
                  <a:pt x="120" y="139"/>
                  <a:pt x="118" y="143"/>
                </a:cubicBezTo>
                <a:cubicBezTo>
                  <a:pt x="116" y="147"/>
                  <a:pt x="112" y="150"/>
                  <a:pt x="107" y="152"/>
                </a:cubicBezTo>
                <a:lnTo>
                  <a:pt x="103" y="145"/>
                </a:lnTo>
                <a:cubicBezTo>
                  <a:pt x="106" y="144"/>
                  <a:pt x="109" y="142"/>
                  <a:pt x="110" y="139"/>
                </a:cubicBezTo>
                <a:cubicBezTo>
                  <a:pt x="112" y="136"/>
                  <a:pt x="113" y="132"/>
                  <a:pt x="113" y="127"/>
                </a:cubicBezTo>
                <a:lnTo>
                  <a:pt x="104" y="127"/>
                </a:lnTo>
                <a:close/>
                <a:moveTo>
                  <a:pt x="224" y="32"/>
                </a:moveTo>
                <a:lnTo>
                  <a:pt x="209" y="33"/>
                </a:lnTo>
                <a:cubicBezTo>
                  <a:pt x="207" y="27"/>
                  <a:pt x="205" y="23"/>
                  <a:pt x="203" y="20"/>
                </a:cubicBezTo>
                <a:cubicBezTo>
                  <a:pt x="198" y="15"/>
                  <a:pt x="193" y="13"/>
                  <a:pt x="187" y="13"/>
                </a:cubicBezTo>
                <a:cubicBezTo>
                  <a:pt x="182" y="13"/>
                  <a:pt x="178" y="15"/>
                  <a:pt x="174" y="17"/>
                </a:cubicBezTo>
                <a:cubicBezTo>
                  <a:pt x="169" y="21"/>
                  <a:pt x="165" y="26"/>
                  <a:pt x="163" y="33"/>
                </a:cubicBezTo>
                <a:cubicBezTo>
                  <a:pt x="160" y="40"/>
                  <a:pt x="159" y="49"/>
                  <a:pt x="158" y="62"/>
                </a:cubicBezTo>
                <a:cubicBezTo>
                  <a:pt x="162" y="56"/>
                  <a:pt x="167" y="52"/>
                  <a:pt x="172" y="49"/>
                </a:cubicBezTo>
                <a:cubicBezTo>
                  <a:pt x="177" y="47"/>
                  <a:pt x="183" y="45"/>
                  <a:pt x="189" y="45"/>
                </a:cubicBezTo>
                <a:cubicBezTo>
                  <a:pt x="199" y="45"/>
                  <a:pt x="208" y="49"/>
                  <a:pt x="215" y="57"/>
                </a:cubicBezTo>
                <a:cubicBezTo>
                  <a:pt x="222" y="64"/>
                  <a:pt x="226" y="74"/>
                  <a:pt x="226" y="86"/>
                </a:cubicBezTo>
                <a:cubicBezTo>
                  <a:pt x="226" y="94"/>
                  <a:pt x="224" y="101"/>
                  <a:pt x="221" y="108"/>
                </a:cubicBezTo>
                <a:cubicBezTo>
                  <a:pt x="218" y="115"/>
                  <a:pt x="213" y="120"/>
                  <a:pt x="207" y="124"/>
                </a:cubicBezTo>
                <a:cubicBezTo>
                  <a:pt x="201" y="127"/>
                  <a:pt x="194" y="129"/>
                  <a:pt x="187" y="129"/>
                </a:cubicBezTo>
                <a:cubicBezTo>
                  <a:pt x="174" y="129"/>
                  <a:pt x="163" y="124"/>
                  <a:pt x="155" y="115"/>
                </a:cubicBezTo>
                <a:cubicBezTo>
                  <a:pt x="147" y="105"/>
                  <a:pt x="143" y="90"/>
                  <a:pt x="143" y="68"/>
                </a:cubicBezTo>
                <a:cubicBezTo>
                  <a:pt x="143" y="44"/>
                  <a:pt x="147" y="26"/>
                  <a:pt x="156" y="15"/>
                </a:cubicBezTo>
                <a:cubicBezTo>
                  <a:pt x="164" y="5"/>
                  <a:pt x="175" y="0"/>
                  <a:pt x="188" y="0"/>
                </a:cubicBezTo>
                <a:cubicBezTo>
                  <a:pt x="198" y="0"/>
                  <a:pt x="206" y="3"/>
                  <a:pt x="213" y="9"/>
                </a:cubicBezTo>
                <a:cubicBezTo>
                  <a:pt x="219" y="14"/>
                  <a:pt x="223" y="22"/>
                  <a:pt x="224" y="32"/>
                </a:cubicBezTo>
                <a:close/>
                <a:moveTo>
                  <a:pt x="161" y="86"/>
                </a:moveTo>
                <a:cubicBezTo>
                  <a:pt x="161" y="92"/>
                  <a:pt x="162" y="97"/>
                  <a:pt x="164" y="101"/>
                </a:cubicBezTo>
                <a:cubicBezTo>
                  <a:pt x="166" y="106"/>
                  <a:pt x="170" y="110"/>
                  <a:pt x="174" y="113"/>
                </a:cubicBezTo>
                <a:cubicBezTo>
                  <a:pt x="178" y="115"/>
                  <a:pt x="182" y="116"/>
                  <a:pt x="186" y="116"/>
                </a:cubicBezTo>
                <a:cubicBezTo>
                  <a:pt x="193" y="116"/>
                  <a:pt x="199" y="114"/>
                  <a:pt x="203" y="108"/>
                </a:cubicBezTo>
                <a:cubicBezTo>
                  <a:pt x="208" y="103"/>
                  <a:pt x="210" y="96"/>
                  <a:pt x="210" y="87"/>
                </a:cubicBezTo>
                <a:cubicBezTo>
                  <a:pt x="210" y="78"/>
                  <a:pt x="208" y="71"/>
                  <a:pt x="203" y="66"/>
                </a:cubicBezTo>
                <a:cubicBezTo>
                  <a:pt x="199" y="61"/>
                  <a:pt x="193" y="59"/>
                  <a:pt x="186" y="59"/>
                </a:cubicBezTo>
                <a:cubicBezTo>
                  <a:pt x="179" y="59"/>
                  <a:pt x="173" y="61"/>
                  <a:pt x="168" y="66"/>
                </a:cubicBezTo>
                <a:cubicBezTo>
                  <a:pt x="163" y="71"/>
                  <a:pt x="161" y="78"/>
                  <a:pt x="161" y="86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4" name="Freeform 72"/>
          <p:cNvSpPr>
            <a:spLocks noEditPoints="1"/>
          </p:cNvSpPr>
          <p:nvPr/>
        </p:nvSpPr>
        <p:spPr bwMode="auto">
          <a:xfrm>
            <a:off x="1127400" y="4087107"/>
            <a:ext cx="136979" cy="91319"/>
          </a:xfrm>
          <a:custGeom>
            <a:avLst/>
            <a:gdLst>
              <a:gd name="T0" fmla="*/ 0 w 226"/>
              <a:gd name="T1" fmla="*/ 64 h 151"/>
              <a:gd name="T2" fmla="*/ 4 w 226"/>
              <a:gd name="T3" fmla="*/ 28 h 151"/>
              <a:gd name="T4" fmla="*/ 18 w 226"/>
              <a:gd name="T5" fmla="*/ 7 h 151"/>
              <a:gd name="T6" fmla="*/ 41 w 226"/>
              <a:gd name="T7" fmla="*/ 0 h 151"/>
              <a:gd name="T8" fmla="*/ 58 w 226"/>
              <a:gd name="T9" fmla="*/ 4 h 151"/>
              <a:gd name="T10" fmla="*/ 71 w 226"/>
              <a:gd name="T11" fmla="*/ 16 h 151"/>
              <a:gd name="T12" fmla="*/ 79 w 226"/>
              <a:gd name="T13" fmla="*/ 34 h 151"/>
              <a:gd name="T14" fmla="*/ 82 w 226"/>
              <a:gd name="T15" fmla="*/ 64 h 151"/>
              <a:gd name="T16" fmla="*/ 77 w 226"/>
              <a:gd name="T17" fmla="*/ 100 h 151"/>
              <a:gd name="T18" fmla="*/ 64 w 226"/>
              <a:gd name="T19" fmla="*/ 121 h 151"/>
              <a:gd name="T20" fmla="*/ 41 w 226"/>
              <a:gd name="T21" fmla="*/ 128 h 151"/>
              <a:gd name="T22" fmla="*/ 12 w 226"/>
              <a:gd name="T23" fmla="*/ 115 h 151"/>
              <a:gd name="T24" fmla="*/ 0 w 226"/>
              <a:gd name="T25" fmla="*/ 64 h 151"/>
              <a:gd name="T26" fmla="*/ 16 w 226"/>
              <a:gd name="T27" fmla="*/ 64 h 151"/>
              <a:gd name="T28" fmla="*/ 23 w 226"/>
              <a:gd name="T29" fmla="*/ 105 h 151"/>
              <a:gd name="T30" fmla="*/ 41 w 226"/>
              <a:gd name="T31" fmla="*/ 116 h 151"/>
              <a:gd name="T32" fmla="*/ 59 w 226"/>
              <a:gd name="T33" fmla="*/ 105 h 151"/>
              <a:gd name="T34" fmla="*/ 66 w 226"/>
              <a:gd name="T35" fmla="*/ 64 h 151"/>
              <a:gd name="T36" fmla="*/ 59 w 226"/>
              <a:gd name="T37" fmla="*/ 23 h 151"/>
              <a:gd name="T38" fmla="*/ 41 w 226"/>
              <a:gd name="T39" fmla="*/ 12 h 151"/>
              <a:gd name="T40" fmla="*/ 24 w 226"/>
              <a:gd name="T41" fmla="*/ 21 h 151"/>
              <a:gd name="T42" fmla="*/ 16 w 226"/>
              <a:gd name="T43" fmla="*/ 64 h 151"/>
              <a:gd name="T44" fmla="*/ 104 w 226"/>
              <a:gd name="T45" fmla="*/ 126 h 151"/>
              <a:gd name="T46" fmla="*/ 104 w 226"/>
              <a:gd name="T47" fmla="*/ 109 h 151"/>
              <a:gd name="T48" fmla="*/ 122 w 226"/>
              <a:gd name="T49" fmla="*/ 109 h 151"/>
              <a:gd name="T50" fmla="*/ 122 w 226"/>
              <a:gd name="T51" fmla="*/ 126 h 151"/>
              <a:gd name="T52" fmla="*/ 118 w 226"/>
              <a:gd name="T53" fmla="*/ 142 h 151"/>
              <a:gd name="T54" fmla="*/ 107 w 226"/>
              <a:gd name="T55" fmla="*/ 151 h 151"/>
              <a:gd name="T56" fmla="*/ 103 w 226"/>
              <a:gd name="T57" fmla="*/ 144 h 151"/>
              <a:gd name="T58" fmla="*/ 110 w 226"/>
              <a:gd name="T59" fmla="*/ 138 h 151"/>
              <a:gd name="T60" fmla="*/ 113 w 226"/>
              <a:gd name="T61" fmla="*/ 126 h 151"/>
              <a:gd name="T62" fmla="*/ 104 w 226"/>
              <a:gd name="T63" fmla="*/ 126 h 151"/>
              <a:gd name="T64" fmla="*/ 193 w 226"/>
              <a:gd name="T65" fmla="*/ 126 h 151"/>
              <a:gd name="T66" fmla="*/ 193 w 226"/>
              <a:gd name="T67" fmla="*/ 96 h 151"/>
              <a:gd name="T68" fmla="*/ 139 w 226"/>
              <a:gd name="T69" fmla="*/ 96 h 151"/>
              <a:gd name="T70" fmla="*/ 139 w 226"/>
              <a:gd name="T71" fmla="*/ 82 h 151"/>
              <a:gd name="T72" fmla="*/ 196 w 226"/>
              <a:gd name="T73" fmla="*/ 0 h 151"/>
              <a:gd name="T74" fmla="*/ 209 w 226"/>
              <a:gd name="T75" fmla="*/ 0 h 151"/>
              <a:gd name="T76" fmla="*/ 209 w 226"/>
              <a:gd name="T77" fmla="*/ 82 h 151"/>
              <a:gd name="T78" fmla="*/ 226 w 226"/>
              <a:gd name="T79" fmla="*/ 82 h 151"/>
              <a:gd name="T80" fmla="*/ 226 w 226"/>
              <a:gd name="T81" fmla="*/ 96 h 151"/>
              <a:gd name="T82" fmla="*/ 209 w 226"/>
              <a:gd name="T83" fmla="*/ 96 h 151"/>
              <a:gd name="T84" fmla="*/ 209 w 226"/>
              <a:gd name="T85" fmla="*/ 126 h 151"/>
              <a:gd name="T86" fmla="*/ 193 w 226"/>
              <a:gd name="T87" fmla="*/ 126 h 151"/>
              <a:gd name="T88" fmla="*/ 193 w 226"/>
              <a:gd name="T89" fmla="*/ 82 h 151"/>
              <a:gd name="T90" fmla="*/ 193 w 226"/>
              <a:gd name="T91" fmla="*/ 25 h 151"/>
              <a:gd name="T92" fmla="*/ 154 w 226"/>
              <a:gd name="T93" fmla="*/ 82 h 151"/>
              <a:gd name="T94" fmla="*/ 193 w 226"/>
              <a:gd name="T95" fmla="*/ 82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226" h="151">
                <a:moveTo>
                  <a:pt x="0" y="64"/>
                </a:moveTo>
                <a:cubicBezTo>
                  <a:pt x="0" y="49"/>
                  <a:pt x="1" y="37"/>
                  <a:pt x="4" y="28"/>
                </a:cubicBezTo>
                <a:cubicBezTo>
                  <a:pt x="7" y="19"/>
                  <a:pt x="12" y="12"/>
                  <a:pt x="18" y="7"/>
                </a:cubicBezTo>
                <a:cubicBezTo>
                  <a:pt x="24" y="2"/>
                  <a:pt x="32" y="0"/>
                  <a:pt x="41" y="0"/>
                </a:cubicBezTo>
                <a:cubicBezTo>
                  <a:pt x="48" y="0"/>
                  <a:pt x="53" y="1"/>
                  <a:pt x="58" y="4"/>
                </a:cubicBezTo>
                <a:cubicBezTo>
                  <a:pt x="64" y="7"/>
                  <a:pt x="68" y="10"/>
                  <a:pt x="71" y="16"/>
                </a:cubicBezTo>
                <a:cubicBezTo>
                  <a:pt x="74" y="21"/>
                  <a:pt x="77" y="27"/>
                  <a:pt x="79" y="34"/>
                </a:cubicBezTo>
                <a:cubicBezTo>
                  <a:pt x="81" y="42"/>
                  <a:pt x="82" y="52"/>
                  <a:pt x="82" y="64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6"/>
                  <a:pt x="64" y="121"/>
                </a:cubicBezTo>
                <a:cubicBezTo>
                  <a:pt x="58" y="126"/>
                  <a:pt x="50" y="128"/>
                  <a:pt x="41" y="128"/>
                </a:cubicBezTo>
                <a:cubicBezTo>
                  <a:pt x="29" y="128"/>
                  <a:pt x="19" y="124"/>
                  <a:pt x="12" y="115"/>
                </a:cubicBezTo>
                <a:cubicBezTo>
                  <a:pt x="4" y="105"/>
                  <a:pt x="0" y="88"/>
                  <a:pt x="0" y="64"/>
                </a:cubicBezTo>
                <a:close/>
                <a:moveTo>
                  <a:pt x="16" y="64"/>
                </a:moveTo>
                <a:cubicBezTo>
                  <a:pt x="16" y="85"/>
                  <a:pt x="18" y="99"/>
                  <a:pt x="23" y="105"/>
                </a:cubicBezTo>
                <a:cubicBezTo>
                  <a:pt x="28" y="112"/>
                  <a:pt x="34" y="116"/>
                  <a:pt x="41" y="116"/>
                </a:cubicBezTo>
                <a:cubicBezTo>
                  <a:pt x="48" y="116"/>
                  <a:pt x="54" y="112"/>
                  <a:pt x="59" y="105"/>
                </a:cubicBezTo>
                <a:cubicBezTo>
                  <a:pt x="63" y="98"/>
                  <a:pt x="66" y="85"/>
                  <a:pt x="66" y="64"/>
                </a:cubicBezTo>
                <a:cubicBezTo>
                  <a:pt x="66" y="43"/>
                  <a:pt x="63" y="29"/>
                  <a:pt x="59" y="23"/>
                </a:cubicBezTo>
                <a:cubicBezTo>
                  <a:pt x="54" y="16"/>
                  <a:pt x="48" y="12"/>
                  <a:pt x="41" y="12"/>
                </a:cubicBezTo>
                <a:cubicBezTo>
                  <a:pt x="33" y="12"/>
                  <a:pt x="28" y="15"/>
                  <a:pt x="24" y="21"/>
                </a:cubicBezTo>
                <a:cubicBezTo>
                  <a:pt x="18" y="29"/>
                  <a:pt x="16" y="43"/>
                  <a:pt x="16" y="64"/>
                </a:cubicBezTo>
                <a:close/>
                <a:moveTo>
                  <a:pt x="104" y="126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6"/>
                </a:lnTo>
                <a:cubicBezTo>
                  <a:pt x="122" y="133"/>
                  <a:pt x="120" y="138"/>
                  <a:pt x="118" y="142"/>
                </a:cubicBezTo>
                <a:cubicBezTo>
                  <a:pt x="116" y="146"/>
                  <a:pt x="112" y="149"/>
                  <a:pt x="107" y="151"/>
                </a:cubicBezTo>
                <a:lnTo>
                  <a:pt x="103" y="144"/>
                </a:lnTo>
                <a:cubicBezTo>
                  <a:pt x="106" y="143"/>
                  <a:pt x="109" y="141"/>
                  <a:pt x="110" y="138"/>
                </a:cubicBezTo>
                <a:cubicBezTo>
                  <a:pt x="112" y="135"/>
                  <a:pt x="113" y="131"/>
                  <a:pt x="113" y="126"/>
                </a:cubicBezTo>
                <a:lnTo>
                  <a:pt x="104" y="126"/>
                </a:lnTo>
                <a:close/>
                <a:moveTo>
                  <a:pt x="193" y="126"/>
                </a:moveTo>
                <a:lnTo>
                  <a:pt x="193" y="96"/>
                </a:lnTo>
                <a:lnTo>
                  <a:pt x="139" y="96"/>
                </a:lnTo>
                <a:lnTo>
                  <a:pt x="139" y="82"/>
                </a:lnTo>
                <a:lnTo>
                  <a:pt x="196" y="0"/>
                </a:lnTo>
                <a:lnTo>
                  <a:pt x="209" y="0"/>
                </a:lnTo>
                <a:lnTo>
                  <a:pt x="209" y="82"/>
                </a:lnTo>
                <a:lnTo>
                  <a:pt x="226" y="82"/>
                </a:lnTo>
                <a:lnTo>
                  <a:pt x="226" y="96"/>
                </a:lnTo>
                <a:lnTo>
                  <a:pt x="209" y="96"/>
                </a:lnTo>
                <a:lnTo>
                  <a:pt x="209" y="126"/>
                </a:lnTo>
                <a:lnTo>
                  <a:pt x="193" y="126"/>
                </a:lnTo>
                <a:close/>
                <a:moveTo>
                  <a:pt x="193" y="82"/>
                </a:moveTo>
                <a:lnTo>
                  <a:pt x="193" y="25"/>
                </a:lnTo>
                <a:lnTo>
                  <a:pt x="154" y="82"/>
                </a:lnTo>
                <a:lnTo>
                  <a:pt x="193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5" name="Freeform 73"/>
          <p:cNvSpPr>
            <a:spLocks noEditPoints="1"/>
          </p:cNvSpPr>
          <p:nvPr/>
        </p:nvSpPr>
        <p:spPr bwMode="auto">
          <a:xfrm>
            <a:off x="1127400" y="4797686"/>
            <a:ext cx="136979" cy="91319"/>
          </a:xfrm>
          <a:custGeom>
            <a:avLst/>
            <a:gdLst>
              <a:gd name="T0" fmla="*/ 0 w 225"/>
              <a:gd name="T1" fmla="*/ 64 h 151"/>
              <a:gd name="T2" fmla="*/ 4 w 225"/>
              <a:gd name="T3" fmla="*/ 28 h 151"/>
              <a:gd name="T4" fmla="*/ 18 w 225"/>
              <a:gd name="T5" fmla="*/ 7 h 151"/>
              <a:gd name="T6" fmla="*/ 41 w 225"/>
              <a:gd name="T7" fmla="*/ 0 h 151"/>
              <a:gd name="T8" fmla="*/ 58 w 225"/>
              <a:gd name="T9" fmla="*/ 4 h 151"/>
              <a:gd name="T10" fmla="*/ 71 w 225"/>
              <a:gd name="T11" fmla="*/ 16 h 151"/>
              <a:gd name="T12" fmla="*/ 79 w 225"/>
              <a:gd name="T13" fmla="*/ 34 h 151"/>
              <a:gd name="T14" fmla="*/ 82 w 225"/>
              <a:gd name="T15" fmla="*/ 64 h 151"/>
              <a:gd name="T16" fmla="*/ 77 w 225"/>
              <a:gd name="T17" fmla="*/ 100 h 151"/>
              <a:gd name="T18" fmla="*/ 64 w 225"/>
              <a:gd name="T19" fmla="*/ 121 h 151"/>
              <a:gd name="T20" fmla="*/ 41 w 225"/>
              <a:gd name="T21" fmla="*/ 129 h 151"/>
              <a:gd name="T22" fmla="*/ 12 w 225"/>
              <a:gd name="T23" fmla="*/ 115 h 151"/>
              <a:gd name="T24" fmla="*/ 0 w 225"/>
              <a:gd name="T25" fmla="*/ 64 h 151"/>
              <a:gd name="T26" fmla="*/ 16 w 225"/>
              <a:gd name="T27" fmla="*/ 64 h 151"/>
              <a:gd name="T28" fmla="*/ 23 w 225"/>
              <a:gd name="T29" fmla="*/ 106 h 151"/>
              <a:gd name="T30" fmla="*/ 41 w 225"/>
              <a:gd name="T31" fmla="*/ 116 h 151"/>
              <a:gd name="T32" fmla="*/ 59 w 225"/>
              <a:gd name="T33" fmla="*/ 105 h 151"/>
              <a:gd name="T34" fmla="*/ 66 w 225"/>
              <a:gd name="T35" fmla="*/ 64 h 151"/>
              <a:gd name="T36" fmla="*/ 59 w 225"/>
              <a:gd name="T37" fmla="*/ 23 h 151"/>
              <a:gd name="T38" fmla="*/ 41 w 225"/>
              <a:gd name="T39" fmla="*/ 13 h 151"/>
              <a:gd name="T40" fmla="*/ 24 w 225"/>
              <a:gd name="T41" fmla="*/ 22 h 151"/>
              <a:gd name="T42" fmla="*/ 16 w 225"/>
              <a:gd name="T43" fmla="*/ 64 h 151"/>
              <a:gd name="T44" fmla="*/ 104 w 225"/>
              <a:gd name="T45" fmla="*/ 126 h 151"/>
              <a:gd name="T46" fmla="*/ 104 w 225"/>
              <a:gd name="T47" fmla="*/ 109 h 151"/>
              <a:gd name="T48" fmla="*/ 122 w 225"/>
              <a:gd name="T49" fmla="*/ 109 h 151"/>
              <a:gd name="T50" fmla="*/ 122 w 225"/>
              <a:gd name="T51" fmla="*/ 126 h 151"/>
              <a:gd name="T52" fmla="*/ 118 w 225"/>
              <a:gd name="T53" fmla="*/ 142 h 151"/>
              <a:gd name="T54" fmla="*/ 107 w 225"/>
              <a:gd name="T55" fmla="*/ 151 h 151"/>
              <a:gd name="T56" fmla="*/ 103 w 225"/>
              <a:gd name="T57" fmla="*/ 145 h 151"/>
              <a:gd name="T58" fmla="*/ 110 w 225"/>
              <a:gd name="T59" fmla="*/ 138 h 151"/>
              <a:gd name="T60" fmla="*/ 113 w 225"/>
              <a:gd name="T61" fmla="*/ 126 h 151"/>
              <a:gd name="T62" fmla="*/ 104 w 225"/>
              <a:gd name="T63" fmla="*/ 126 h 151"/>
              <a:gd name="T64" fmla="*/ 225 w 225"/>
              <a:gd name="T65" fmla="*/ 112 h 151"/>
              <a:gd name="T66" fmla="*/ 225 w 225"/>
              <a:gd name="T67" fmla="*/ 126 h 151"/>
              <a:gd name="T68" fmla="*/ 142 w 225"/>
              <a:gd name="T69" fmla="*/ 126 h 151"/>
              <a:gd name="T70" fmla="*/ 144 w 225"/>
              <a:gd name="T71" fmla="*/ 116 h 151"/>
              <a:gd name="T72" fmla="*/ 154 w 225"/>
              <a:gd name="T73" fmla="*/ 99 h 151"/>
              <a:gd name="T74" fmla="*/ 174 w 225"/>
              <a:gd name="T75" fmla="*/ 80 h 151"/>
              <a:gd name="T76" fmla="*/ 202 w 225"/>
              <a:gd name="T77" fmla="*/ 53 h 151"/>
              <a:gd name="T78" fmla="*/ 209 w 225"/>
              <a:gd name="T79" fmla="*/ 35 h 151"/>
              <a:gd name="T80" fmla="*/ 202 w 225"/>
              <a:gd name="T81" fmla="*/ 19 h 151"/>
              <a:gd name="T82" fmla="*/ 185 w 225"/>
              <a:gd name="T83" fmla="*/ 13 h 151"/>
              <a:gd name="T84" fmla="*/ 167 w 225"/>
              <a:gd name="T85" fmla="*/ 19 h 151"/>
              <a:gd name="T86" fmla="*/ 161 w 225"/>
              <a:gd name="T87" fmla="*/ 38 h 151"/>
              <a:gd name="T88" fmla="*/ 145 w 225"/>
              <a:gd name="T89" fmla="*/ 36 h 151"/>
              <a:gd name="T90" fmla="*/ 157 w 225"/>
              <a:gd name="T91" fmla="*/ 9 h 151"/>
              <a:gd name="T92" fmla="*/ 186 w 225"/>
              <a:gd name="T93" fmla="*/ 0 h 151"/>
              <a:gd name="T94" fmla="*/ 214 w 225"/>
              <a:gd name="T95" fmla="*/ 10 h 151"/>
              <a:gd name="T96" fmla="*/ 225 w 225"/>
              <a:gd name="T97" fmla="*/ 35 h 151"/>
              <a:gd name="T98" fmla="*/ 222 w 225"/>
              <a:gd name="T99" fmla="*/ 50 h 151"/>
              <a:gd name="T100" fmla="*/ 211 w 225"/>
              <a:gd name="T101" fmla="*/ 65 h 151"/>
              <a:gd name="T102" fmla="*/ 188 w 225"/>
              <a:gd name="T103" fmla="*/ 87 h 151"/>
              <a:gd name="T104" fmla="*/ 170 w 225"/>
              <a:gd name="T105" fmla="*/ 103 h 151"/>
              <a:gd name="T106" fmla="*/ 163 w 225"/>
              <a:gd name="T107" fmla="*/ 112 h 151"/>
              <a:gd name="T108" fmla="*/ 225 w 225"/>
              <a:gd name="T109" fmla="*/ 112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225" h="151">
                <a:moveTo>
                  <a:pt x="0" y="64"/>
                </a:moveTo>
                <a:cubicBezTo>
                  <a:pt x="0" y="49"/>
                  <a:pt x="1" y="37"/>
                  <a:pt x="4" y="28"/>
                </a:cubicBezTo>
                <a:cubicBezTo>
                  <a:pt x="7" y="19"/>
                  <a:pt x="12" y="12"/>
                  <a:pt x="18" y="7"/>
                </a:cubicBezTo>
                <a:cubicBezTo>
                  <a:pt x="24" y="2"/>
                  <a:pt x="32" y="0"/>
                  <a:pt x="41" y="0"/>
                </a:cubicBezTo>
                <a:cubicBezTo>
                  <a:pt x="48" y="0"/>
                  <a:pt x="53" y="1"/>
                  <a:pt x="58" y="4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7"/>
                  <a:pt x="79" y="34"/>
                </a:cubicBezTo>
                <a:cubicBezTo>
                  <a:pt x="81" y="42"/>
                  <a:pt x="82" y="52"/>
                  <a:pt x="82" y="64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6"/>
                  <a:pt x="64" y="121"/>
                </a:cubicBezTo>
                <a:cubicBezTo>
                  <a:pt x="58" y="126"/>
                  <a:pt x="50" y="129"/>
                  <a:pt x="41" y="129"/>
                </a:cubicBezTo>
                <a:cubicBezTo>
                  <a:pt x="29" y="129"/>
                  <a:pt x="19" y="124"/>
                  <a:pt x="12" y="115"/>
                </a:cubicBezTo>
                <a:cubicBezTo>
                  <a:pt x="4" y="105"/>
                  <a:pt x="0" y="88"/>
                  <a:pt x="0" y="64"/>
                </a:cubicBezTo>
                <a:close/>
                <a:moveTo>
                  <a:pt x="16" y="64"/>
                </a:moveTo>
                <a:cubicBezTo>
                  <a:pt x="16" y="85"/>
                  <a:pt x="18" y="99"/>
                  <a:pt x="23" y="106"/>
                </a:cubicBezTo>
                <a:cubicBezTo>
                  <a:pt x="28" y="112"/>
                  <a:pt x="34" y="116"/>
                  <a:pt x="41" y="116"/>
                </a:cubicBezTo>
                <a:cubicBezTo>
                  <a:pt x="48" y="116"/>
                  <a:pt x="54" y="112"/>
                  <a:pt x="59" y="105"/>
                </a:cubicBezTo>
                <a:cubicBezTo>
                  <a:pt x="63" y="99"/>
                  <a:pt x="66" y="85"/>
                  <a:pt x="66" y="64"/>
                </a:cubicBezTo>
                <a:cubicBezTo>
                  <a:pt x="66" y="43"/>
                  <a:pt x="63" y="30"/>
                  <a:pt x="59" y="23"/>
                </a:cubicBezTo>
                <a:cubicBezTo>
                  <a:pt x="54" y="16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29"/>
                  <a:pt x="16" y="43"/>
                  <a:pt x="16" y="64"/>
                </a:cubicBezTo>
                <a:close/>
                <a:moveTo>
                  <a:pt x="104" y="126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6"/>
                </a:lnTo>
                <a:cubicBezTo>
                  <a:pt x="122" y="133"/>
                  <a:pt x="120" y="138"/>
                  <a:pt x="118" y="142"/>
                </a:cubicBezTo>
                <a:cubicBezTo>
                  <a:pt x="116" y="146"/>
                  <a:pt x="112" y="149"/>
                  <a:pt x="107" y="151"/>
                </a:cubicBezTo>
                <a:lnTo>
                  <a:pt x="103" y="145"/>
                </a:lnTo>
                <a:cubicBezTo>
                  <a:pt x="106" y="143"/>
                  <a:pt x="109" y="141"/>
                  <a:pt x="110" y="138"/>
                </a:cubicBezTo>
                <a:cubicBezTo>
                  <a:pt x="112" y="136"/>
                  <a:pt x="113" y="132"/>
                  <a:pt x="113" y="126"/>
                </a:cubicBezTo>
                <a:lnTo>
                  <a:pt x="104" y="126"/>
                </a:lnTo>
                <a:close/>
                <a:moveTo>
                  <a:pt x="225" y="112"/>
                </a:moveTo>
                <a:lnTo>
                  <a:pt x="225" y="126"/>
                </a:lnTo>
                <a:lnTo>
                  <a:pt x="142" y="126"/>
                </a:lnTo>
                <a:cubicBezTo>
                  <a:pt x="142" y="123"/>
                  <a:pt x="142" y="119"/>
                  <a:pt x="144" y="116"/>
                </a:cubicBezTo>
                <a:cubicBezTo>
                  <a:pt x="146" y="110"/>
                  <a:pt x="149" y="104"/>
                  <a:pt x="154" y="99"/>
                </a:cubicBezTo>
                <a:cubicBezTo>
                  <a:pt x="158" y="93"/>
                  <a:pt x="165" y="87"/>
                  <a:pt x="174" y="80"/>
                </a:cubicBezTo>
                <a:cubicBezTo>
                  <a:pt x="188" y="69"/>
                  <a:pt x="197" y="60"/>
                  <a:pt x="202" y="53"/>
                </a:cubicBezTo>
                <a:cubicBezTo>
                  <a:pt x="206" y="47"/>
                  <a:pt x="209" y="40"/>
                  <a:pt x="209" y="35"/>
                </a:cubicBezTo>
                <a:cubicBezTo>
                  <a:pt x="209" y="28"/>
                  <a:pt x="207" y="23"/>
                  <a:pt x="202" y="19"/>
                </a:cubicBezTo>
                <a:cubicBezTo>
                  <a:pt x="198" y="15"/>
                  <a:pt x="192" y="13"/>
                  <a:pt x="185" y="13"/>
                </a:cubicBezTo>
                <a:cubicBezTo>
                  <a:pt x="178" y="13"/>
                  <a:pt x="172" y="15"/>
                  <a:pt x="167" y="19"/>
                </a:cubicBezTo>
                <a:cubicBezTo>
                  <a:pt x="163" y="24"/>
                  <a:pt x="161" y="30"/>
                  <a:pt x="161" y="38"/>
                </a:cubicBezTo>
                <a:lnTo>
                  <a:pt x="145" y="36"/>
                </a:lnTo>
                <a:cubicBezTo>
                  <a:pt x="146" y="25"/>
                  <a:pt x="150" y="15"/>
                  <a:pt x="157" y="9"/>
                </a:cubicBezTo>
                <a:cubicBezTo>
                  <a:pt x="164" y="3"/>
                  <a:pt x="174" y="0"/>
                  <a:pt x="186" y="0"/>
                </a:cubicBezTo>
                <a:cubicBezTo>
                  <a:pt x="198" y="0"/>
                  <a:pt x="207" y="3"/>
                  <a:pt x="214" y="10"/>
                </a:cubicBezTo>
                <a:cubicBezTo>
                  <a:pt x="221" y="17"/>
                  <a:pt x="225" y="25"/>
                  <a:pt x="225" y="35"/>
                </a:cubicBezTo>
                <a:cubicBezTo>
                  <a:pt x="225" y="40"/>
                  <a:pt x="224" y="45"/>
                  <a:pt x="222" y="50"/>
                </a:cubicBezTo>
                <a:cubicBezTo>
                  <a:pt x="220" y="55"/>
                  <a:pt x="216" y="60"/>
                  <a:pt x="211" y="65"/>
                </a:cubicBezTo>
                <a:cubicBezTo>
                  <a:pt x="207" y="70"/>
                  <a:pt x="199" y="78"/>
                  <a:pt x="188" y="87"/>
                </a:cubicBezTo>
                <a:cubicBezTo>
                  <a:pt x="178" y="95"/>
                  <a:pt x="172" y="100"/>
                  <a:pt x="170" y="103"/>
                </a:cubicBezTo>
                <a:cubicBezTo>
                  <a:pt x="167" y="106"/>
                  <a:pt x="165" y="109"/>
                  <a:pt x="163" y="112"/>
                </a:cubicBezTo>
                <a:lnTo>
                  <a:pt x="225" y="11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6" name="Freeform 74"/>
          <p:cNvSpPr>
            <a:spLocks noEditPoints="1"/>
          </p:cNvSpPr>
          <p:nvPr/>
        </p:nvSpPr>
        <p:spPr bwMode="auto">
          <a:xfrm>
            <a:off x="1127400" y="5508266"/>
            <a:ext cx="136979" cy="94173"/>
          </a:xfrm>
          <a:custGeom>
            <a:avLst/>
            <a:gdLst>
              <a:gd name="T0" fmla="*/ 0 w 226"/>
              <a:gd name="T1" fmla="*/ 64 h 152"/>
              <a:gd name="T2" fmla="*/ 4 w 226"/>
              <a:gd name="T3" fmla="*/ 28 h 152"/>
              <a:gd name="T4" fmla="*/ 18 w 226"/>
              <a:gd name="T5" fmla="*/ 7 h 152"/>
              <a:gd name="T6" fmla="*/ 41 w 226"/>
              <a:gd name="T7" fmla="*/ 0 h 152"/>
              <a:gd name="T8" fmla="*/ 58 w 226"/>
              <a:gd name="T9" fmla="*/ 4 h 152"/>
              <a:gd name="T10" fmla="*/ 71 w 226"/>
              <a:gd name="T11" fmla="*/ 16 h 152"/>
              <a:gd name="T12" fmla="*/ 79 w 226"/>
              <a:gd name="T13" fmla="*/ 35 h 152"/>
              <a:gd name="T14" fmla="*/ 82 w 226"/>
              <a:gd name="T15" fmla="*/ 64 h 152"/>
              <a:gd name="T16" fmla="*/ 77 w 226"/>
              <a:gd name="T17" fmla="*/ 100 h 152"/>
              <a:gd name="T18" fmla="*/ 64 w 226"/>
              <a:gd name="T19" fmla="*/ 121 h 152"/>
              <a:gd name="T20" fmla="*/ 41 w 226"/>
              <a:gd name="T21" fmla="*/ 129 h 152"/>
              <a:gd name="T22" fmla="*/ 12 w 226"/>
              <a:gd name="T23" fmla="*/ 116 h 152"/>
              <a:gd name="T24" fmla="*/ 0 w 226"/>
              <a:gd name="T25" fmla="*/ 64 h 152"/>
              <a:gd name="T26" fmla="*/ 16 w 226"/>
              <a:gd name="T27" fmla="*/ 64 h 152"/>
              <a:gd name="T28" fmla="*/ 23 w 226"/>
              <a:gd name="T29" fmla="*/ 106 h 152"/>
              <a:gd name="T30" fmla="*/ 41 w 226"/>
              <a:gd name="T31" fmla="*/ 116 h 152"/>
              <a:gd name="T32" fmla="*/ 59 w 226"/>
              <a:gd name="T33" fmla="*/ 106 h 152"/>
              <a:gd name="T34" fmla="*/ 66 w 226"/>
              <a:gd name="T35" fmla="*/ 64 h 152"/>
              <a:gd name="T36" fmla="*/ 59 w 226"/>
              <a:gd name="T37" fmla="*/ 23 h 152"/>
              <a:gd name="T38" fmla="*/ 41 w 226"/>
              <a:gd name="T39" fmla="*/ 13 h 152"/>
              <a:gd name="T40" fmla="*/ 24 w 226"/>
              <a:gd name="T41" fmla="*/ 22 h 152"/>
              <a:gd name="T42" fmla="*/ 16 w 226"/>
              <a:gd name="T43" fmla="*/ 64 h 152"/>
              <a:gd name="T44" fmla="*/ 104 w 226"/>
              <a:gd name="T45" fmla="*/ 127 h 152"/>
              <a:gd name="T46" fmla="*/ 104 w 226"/>
              <a:gd name="T47" fmla="*/ 109 h 152"/>
              <a:gd name="T48" fmla="*/ 122 w 226"/>
              <a:gd name="T49" fmla="*/ 109 h 152"/>
              <a:gd name="T50" fmla="*/ 122 w 226"/>
              <a:gd name="T51" fmla="*/ 127 h 152"/>
              <a:gd name="T52" fmla="*/ 118 w 226"/>
              <a:gd name="T53" fmla="*/ 142 h 152"/>
              <a:gd name="T54" fmla="*/ 107 w 226"/>
              <a:gd name="T55" fmla="*/ 152 h 152"/>
              <a:gd name="T56" fmla="*/ 103 w 226"/>
              <a:gd name="T57" fmla="*/ 145 h 152"/>
              <a:gd name="T58" fmla="*/ 110 w 226"/>
              <a:gd name="T59" fmla="*/ 139 h 152"/>
              <a:gd name="T60" fmla="*/ 113 w 226"/>
              <a:gd name="T61" fmla="*/ 127 h 152"/>
              <a:gd name="T62" fmla="*/ 104 w 226"/>
              <a:gd name="T63" fmla="*/ 127 h 152"/>
              <a:gd name="T64" fmla="*/ 144 w 226"/>
              <a:gd name="T65" fmla="*/ 64 h 152"/>
              <a:gd name="T66" fmla="*/ 148 w 226"/>
              <a:gd name="T67" fmla="*/ 28 h 152"/>
              <a:gd name="T68" fmla="*/ 162 w 226"/>
              <a:gd name="T69" fmla="*/ 7 h 152"/>
              <a:gd name="T70" fmla="*/ 185 w 226"/>
              <a:gd name="T71" fmla="*/ 0 h 152"/>
              <a:gd name="T72" fmla="*/ 202 w 226"/>
              <a:gd name="T73" fmla="*/ 4 h 152"/>
              <a:gd name="T74" fmla="*/ 215 w 226"/>
              <a:gd name="T75" fmla="*/ 16 h 152"/>
              <a:gd name="T76" fmla="*/ 223 w 226"/>
              <a:gd name="T77" fmla="*/ 35 h 152"/>
              <a:gd name="T78" fmla="*/ 226 w 226"/>
              <a:gd name="T79" fmla="*/ 64 h 152"/>
              <a:gd name="T80" fmla="*/ 221 w 226"/>
              <a:gd name="T81" fmla="*/ 100 h 152"/>
              <a:gd name="T82" fmla="*/ 208 w 226"/>
              <a:gd name="T83" fmla="*/ 121 h 152"/>
              <a:gd name="T84" fmla="*/ 185 w 226"/>
              <a:gd name="T85" fmla="*/ 129 h 152"/>
              <a:gd name="T86" fmla="*/ 156 w 226"/>
              <a:gd name="T87" fmla="*/ 116 h 152"/>
              <a:gd name="T88" fmla="*/ 144 w 226"/>
              <a:gd name="T89" fmla="*/ 64 h 152"/>
              <a:gd name="T90" fmla="*/ 160 w 226"/>
              <a:gd name="T91" fmla="*/ 64 h 152"/>
              <a:gd name="T92" fmla="*/ 167 w 226"/>
              <a:gd name="T93" fmla="*/ 106 h 152"/>
              <a:gd name="T94" fmla="*/ 185 w 226"/>
              <a:gd name="T95" fmla="*/ 116 h 152"/>
              <a:gd name="T96" fmla="*/ 203 w 226"/>
              <a:gd name="T97" fmla="*/ 106 h 152"/>
              <a:gd name="T98" fmla="*/ 210 w 226"/>
              <a:gd name="T99" fmla="*/ 64 h 152"/>
              <a:gd name="T100" fmla="*/ 203 w 226"/>
              <a:gd name="T101" fmla="*/ 23 h 152"/>
              <a:gd name="T102" fmla="*/ 185 w 226"/>
              <a:gd name="T103" fmla="*/ 13 h 152"/>
              <a:gd name="T104" fmla="*/ 168 w 226"/>
              <a:gd name="T105" fmla="*/ 22 h 152"/>
              <a:gd name="T106" fmla="*/ 160 w 226"/>
              <a:gd name="T107" fmla="*/ 64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226" h="152">
                <a:moveTo>
                  <a:pt x="0" y="64"/>
                </a:moveTo>
                <a:cubicBezTo>
                  <a:pt x="0" y="49"/>
                  <a:pt x="1" y="37"/>
                  <a:pt x="4" y="28"/>
                </a:cubicBezTo>
                <a:cubicBezTo>
                  <a:pt x="7" y="19"/>
                  <a:pt x="12" y="12"/>
                  <a:pt x="18" y="7"/>
                </a:cubicBezTo>
                <a:cubicBezTo>
                  <a:pt x="24" y="2"/>
                  <a:pt x="32" y="0"/>
                  <a:pt x="41" y="0"/>
                </a:cubicBezTo>
                <a:cubicBezTo>
                  <a:pt x="48" y="0"/>
                  <a:pt x="53" y="1"/>
                  <a:pt x="58" y="4"/>
                </a:cubicBezTo>
                <a:cubicBezTo>
                  <a:pt x="64" y="7"/>
                  <a:pt x="68" y="11"/>
                  <a:pt x="71" y="16"/>
                </a:cubicBezTo>
                <a:cubicBezTo>
                  <a:pt x="74" y="21"/>
                  <a:pt x="77" y="27"/>
                  <a:pt x="79" y="35"/>
                </a:cubicBezTo>
                <a:cubicBezTo>
                  <a:pt x="81" y="42"/>
                  <a:pt x="82" y="52"/>
                  <a:pt x="82" y="64"/>
                </a:cubicBezTo>
                <a:cubicBezTo>
                  <a:pt x="82" y="79"/>
                  <a:pt x="80" y="91"/>
                  <a:pt x="77" y="100"/>
                </a:cubicBezTo>
                <a:cubicBezTo>
                  <a:pt x="74" y="109"/>
                  <a:pt x="70" y="116"/>
                  <a:pt x="64" y="121"/>
                </a:cubicBezTo>
                <a:cubicBezTo>
                  <a:pt x="58" y="126"/>
                  <a:pt x="50" y="129"/>
                  <a:pt x="41" y="129"/>
                </a:cubicBezTo>
                <a:cubicBezTo>
                  <a:pt x="29" y="129"/>
                  <a:pt x="19" y="124"/>
                  <a:pt x="12" y="116"/>
                </a:cubicBezTo>
                <a:cubicBezTo>
                  <a:pt x="4" y="105"/>
                  <a:pt x="0" y="88"/>
                  <a:pt x="0" y="64"/>
                </a:cubicBezTo>
                <a:close/>
                <a:moveTo>
                  <a:pt x="16" y="64"/>
                </a:moveTo>
                <a:cubicBezTo>
                  <a:pt x="16" y="85"/>
                  <a:pt x="18" y="99"/>
                  <a:pt x="23" y="106"/>
                </a:cubicBezTo>
                <a:cubicBezTo>
                  <a:pt x="28" y="113"/>
                  <a:pt x="34" y="116"/>
                  <a:pt x="41" y="116"/>
                </a:cubicBezTo>
                <a:cubicBezTo>
                  <a:pt x="48" y="116"/>
                  <a:pt x="54" y="113"/>
                  <a:pt x="59" y="106"/>
                </a:cubicBezTo>
                <a:cubicBezTo>
                  <a:pt x="63" y="99"/>
                  <a:pt x="66" y="85"/>
                  <a:pt x="66" y="64"/>
                </a:cubicBezTo>
                <a:cubicBezTo>
                  <a:pt x="66" y="44"/>
                  <a:pt x="63" y="30"/>
                  <a:pt x="59" y="23"/>
                </a:cubicBezTo>
                <a:cubicBezTo>
                  <a:pt x="54" y="16"/>
                  <a:pt x="48" y="13"/>
                  <a:pt x="41" y="13"/>
                </a:cubicBezTo>
                <a:cubicBezTo>
                  <a:pt x="33" y="13"/>
                  <a:pt x="28" y="16"/>
                  <a:pt x="24" y="22"/>
                </a:cubicBezTo>
                <a:cubicBezTo>
                  <a:pt x="18" y="29"/>
                  <a:pt x="16" y="44"/>
                  <a:pt x="16" y="64"/>
                </a:cubicBezTo>
                <a:close/>
                <a:moveTo>
                  <a:pt x="104" y="127"/>
                </a:moveTo>
                <a:lnTo>
                  <a:pt x="104" y="109"/>
                </a:lnTo>
                <a:lnTo>
                  <a:pt x="122" y="109"/>
                </a:lnTo>
                <a:lnTo>
                  <a:pt x="122" y="127"/>
                </a:lnTo>
                <a:cubicBezTo>
                  <a:pt x="122" y="133"/>
                  <a:pt x="120" y="138"/>
                  <a:pt x="118" y="142"/>
                </a:cubicBezTo>
                <a:cubicBezTo>
                  <a:pt x="116" y="146"/>
                  <a:pt x="112" y="149"/>
                  <a:pt x="107" y="152"/>
                </a:cubicBezTo>
                <a:lnTo>
                  <a:pt x="103" y="145"/>
                </a:lnTo>
                <a:cubicBezTo>
                  <a:pt x="106" y="143"/>
                  <a:pt x="109" y="141"/>
                  <a:pt x="110" y="139"/>
                </a:cubicBezTo>
                <a:cubicBezTo>
                  <a:pt x="112" y="136"/>
                  <a:pt x="113" y="132"/>
                  <a:pt x="113" y="127"/>
                </a:cubicBezTo>
                <a:lnTo>
                  <a:pt x="104" y="127"/>
                </a:lnTo>
                <a:close/>
                <a:moveTo>
                  <a:pt x="144" y="64"/>
                </a:moveTo>
                <a:cubicBezTo>
                  <a:pt x="144" y="49"/>
                  <a:pt x="145" y="37"/>
                  <a:pt x="148" y="28"/>
                </a:cubicBezTo>
                <a:cubicBezTo>
                  <a:pt x="151" y="19"/>
                  <a:pt x="156" y="12"/>
                  <a:pt x="162" y="7"/>
                </a:cubicBezTo>
                <a:cubicBezTo>
                  <a:pt x="168" y="2"/>
                  <a:pt x="176" y="0"/>
                  <a:pt x="185" y="0"/>
                </a:cubicBezTo>
                <a:cubicBezTo>
                  <a:pt x="192" y="0"/>
                  <a:pt x="197" y="1"/>
                  <a:pt x="202" y="4"/>
                </a:cubicBezTo>
                <a:cubicBezTo>
                  <a:pt x="208" y="7"/>
                  <a:pt x="212" y="11"/>
                  <a:pt x="215" y="16"/>
                </a:cubicBezTo>
                <a:cubicBezTo>
                  <a:pt x="218" y="21"/>
                  <a:pt x="221" y="27"/>
                  <a:pt x="223" y="35"/>
                </a:cubicBezTo>
                <a:cubicBezTo>
                  <a:pt x="225" y="42"/>
                  <a:pt x="226" y="52"/>
                  <a:pt x="226" y="64"/>
                </a:cubicBezTo>
                <a:cubicBezTo>
                  <a:pt x="226" y="79"/>
                  <a:pt x="224" y="91"/>
                  <a:pt x="221" y="100"/>
                </a:cubicBezTo>
                <a:cubicBezTo>
                  <a:pt x="218" y="109"/>
                  <a:pt x="214" y="116"/>
                  <a:pt x="208" y="121"/>
                </a:cubicBezTo>
                <a:cubicBezTo>
                  <a:pt x="202" y="126"/>
                  <a:pt x="194" y="129"/>
                  <a:pt x="185" y="129"/>
                </a:cubicBezTo>
                <a:cubicBezTo>
                  <a:pt x="173" y="129"/>
                  <a:pt x="163" y="124"/>
                  <a:pt x="156" y="116"/>
                </a:cubicBezTo>
                <a:cubicBezTo>
                  <a:pt x="148" y="105"/>
                  <a:pt x="144" y="88"/>
                  <a:pt x="144" y="64"/>
                </a:cubicBezTo>
                <a:close/>
                <a:moveTo>
                  <a:pt x="160" y="64"/>
                </a:moveTo>
                <a:cubicBezTo>
                  <a:pt x="160" y="85"/>
                  <a:pt x="162" y="99"/>
                  <a:pt x="167" y="106"/>
                </a:cubicBezTo>
                <a:cubicBezTo>
                  <a:pt x="172" y="113"/>
                  <a:pt x="178" y="116"/>
                  <a:pt x="185" y="116"/>
                </a:cubicBezTo>
                <a:cubicBezTo>
                  <a:pt x="192" y="116"/>
                  <a:pt x="198" y="113"/>
                  <a:pt x="203" y="106"/>
                </a:cubicBezTo>
                <a:cubicBezTo>
                  <a:pt x="207" y="99"/>
                  <a:pt x="210" y="85"/>
                  <a:pt x="210" y="64"/>
                </a:cubicBezTo>
                <a:cubicBezTo>
                  <a:pt x="210" y="44"/>
                  <a:pt x="207" y="30"/>
                  <a:pt x="203" y="23"/>
                </a:cubicBezTo>
                <a:cubicBezTo>
                  <a:pt x="198" y="16"/>
                  <a:pt x="192" y="13"/>
                  <a:pt x="185" y="13"/>
                </a:cubicBezTo>
                <a:cubicBezTo>
                  <a:pt x="177" y="13"/>
                  <a:pt x="172" y="16"/>
                  <a:pt x="168" y="22"/>
                </a:cubicBezTo>
                <a:cubicBezTo>
                  <a:pt x="162" y="29"/>
                  <a:pt x="160" y="44"/>
                  <a:pt x="160" y="64"/>
                </a:cubicBez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7" name="Freeform 75"/>
          <p:cNvSpPr>
            <a:spLocks/>
          </p:cNvSpPr>
          <p:nvPr/>
        </p:nvSpPr>
        <p:spPr bwMode="auto">
          <a:xfrm>
            <a:off x="1372454" y="1982434"/>
            <a:ext cx="3424478" cy="3558603"/>
          </a:xfrm>
          <a:custGeom>
            <a:avLst/>
            <a:gdLst>
              <a:gd name="T0" fmla="*/ 0 w 1200"/>
              <a:gd name="T1" fmla="*/ 0 h 1247"/>
              <a:gd name="T2" fmla="*/ 24 w 1200"/>
              <a:gd name="T3" fmla="*/ 12 h 1247"/>
              <a:gd name="T4" fmla="*/ 62 w 1200"/>
              <a:gd name="T5" fmla="*/ 25 h 1247"/>
              <a:gd name="T6" fmla="*/ 76 w 1200"/>
              <a:gd name="T7" fmla="*/ 37 h 1247"/>
              <a:gd name="T8" fmla="*/ 95 w 1200"/>
              <a:gd name="T9" fmla="*/ 49 h 1247"/>
              <a:gd name="T10" fmla="*/ 114 w 1200"/>
              <a:gd name="T11" fmla="*/ 62 h 1247"/>
              <a:gd name="T12" fmla="*/ 118 w 1200"/>
              <a:gd name="T13" fmla="*/ 75 h 1247"/>
              <a:gd name="T14" fmla="*/ 125 w 1200"/>
              <a:gd name="T15" fmla="*/ 88 h 1247"/>
              <a:gd name="T16" fmla="*/ 133 w 1200"/>
              <a:gd name="T17" fmla="*/ 100 h 1247"/>
              <a:gd name="T18" fmla="*/ 137 w 1200"/>
              <a:gd name="T19" fmla="*/ 113 h 1247"/>
              <a:gd name="T20" fmla="*/ 156 w 1200"/>
              <a:gd name="T21" fmla="*/ 126 h 1247"/>
              <a:gd name="T22" fmla="*/ 156 w 1200"/>
              <a:gd name="T23" fmla="*/ 139 h 1247"/>
              <a:gd name="T24" fmla="*/ 160 w 1200"/>
              <a:gd name="T25" fmla="*/ 152 h 1247"/>
              <a:gd name="T26" fmla="*/ 181 w 1200"/>
              <a:gd name="T27" fmla="*/ 166 h 1247"/>
              <a:gd name="T28" fmla="*/ 182 w 1200"/>
              <a:gd name="T29" fmla="*/ 179 h 1247"/>
              <a:gd name="T30" fmla="*/ 188 w 1200"/>
              <a:gd name="T31" fmla="*/ 192 h 1247"/>
              <a:gd name="T32" fmla="*/ 213 w 1200"/>
              <a:gd name="T33" fmla="*/ 206 h 1247"/>
              <a:gd name="T34" fmla="*/ 218 w 1200"/>
              <a:gd name="T35" fmla="*/ 220 h 1247"/>
              <a:gd name="T36" fmla="*/ 230 w 1200"/>
              <a:gd name="T37" fmla="*/ 248 h 1247"/>
              <a:gd name="T38" fmla="*/ 233 w 1200"/>
              <a:gd name="T39" fmla="*/ 262 h 1247"/>
              <a:gd name="T40" fmla="*/ 242 w 1200"/>
              <a:gd name="T41" fmla="*/ 277 h 1247"/>
              <a:gd name="T42" fmla="*/ 245 w 1200"/>
              <a:gd name="T43" fmla="*/ 292 h 1247"/>
              <a:gd name="T44" fmla="*/ 268 w 1200"/>
              <a:gd name="T45" fmla="*/ 306 h 1247"/>
              <a:gd name="T46" fmla="*/ 278 w 1200"/>
              <a:gd name="T47" fmla="*/ 322 h 1247"/>
              <a:gd name="T48" fmla="*/ 307 w 1200"/>
              <a:gd name="T49" fmla="*/ 337 h 1247"/>
              <a:gd name="T50" fmla="*/ 333 w 1200"/>
              <a:gd name="T51" fmla="*/ 353 h 1247"/>
              <a:gd name="T52" fmla="*/ 349 w 1200"/>
              <a:gd name="T53" fmla="*/ 370 h 1247"/>
              <a:gd name="T54" fmla="*/ 360 w 1200"/>
              <a:gd name="T55" fmla="*/ 386 h 1247"/>
              <a:gd name="T56" fmla="*/ 402 w 1200"/>
              <a:gd name="T57" fmla="*/ 404 h 1247"/>
              <a:gd name="T58" fmla="*/ 412 w 1200"/>
              <a:gd name="T59" fmla="*/ 422 h 1247"/>
              <a:gd name="T60" fmla="*/ 432 w 1200"/>
              <a:gd name="T61" fmla="*/ 440 h 1247"/>
              <a:gd name="T62" fmla="*/ 458 w 1200"/>
              <a:gd name="T63" fmla="*/ 459 h 1247"/>
              <a:gd name="T64" fmla="*/ 491 w 1200"/>
              <a:gd name="T65" fmla="*/ 477 h 1247"/>
              <a:gd name="T66" fmla="*/ 527 w 1200"/>
              <a:gd name="T67" fmla="*/ 497 h 1247"/>
              <a:gd name="T68" fmla="*/ 530 w 1200"/>
              <a:gd name="T69" fmla="*/ 516 h 1247"/>
              <a:gd name="T70" fmla="*/ 536 w 1200"/>
              <a:gd name="T71" fmla="*/ 535 h 1247"/>
              <a:gd name="T72" fmla="*/ 543 w 1200"/>
              <a:gd name="T73" fmla="*/ 555 h 1247"/>
              <a:gd name="T74" fmla="*/ 566 w 1200"/>
              <a:gd name="T75" fmla="*/ 596 h 1247"/>
              <a:gd name="T76" fmla="*/ 574 w 1200"/>
              <a:gd name="T77" fmla="*/ 616 h 1247"/>
              <a:gd name="T78" fmla="*/ 649 w 1200"/>
              <a:gd name="T79" fmla="*/ 646 h 1247"/>
              <a:gd name="T80" fmla="*/ 735 w 1200"/>
              <a:gd name="T81" fmla="*/ 678 h 1247"/>
              <a:gd name="T82" fmla="*/ 776 w 1200"/>
              <a:gd name="T83" fmla="*/ 709 h 1247"/>
              <a:gd name="T84" fmla="*/ 810 w 1200"/>
              <a:gd name="T85" fmla="*/ 741 h 1247"/>
              <a:gd name="T86" fmla="*/ 818 w 1200"/>
              <a:gd name="T87" fmla="*/ 772 h 1247"/>
              <a:gd name="T88" fmla="*/ 872 w 1200"/>
              <a:gd name="T89" fmla="*/ 809 h 1247"/>
              <a:gd name="T90" fmla="*/ 877 w 1200"/>
              <a:gd name="T91" fmla="*/ 845 h 1247"/>
              <a:gd name="T92" fmla="*/ 879 w 1200"/>
              <a:gd name="T93" fmla="*/ 882 h 1247"/>
              <a:gd name="T94" fmla="*/ 1086 w 1200"/>
              <a:gd name="T95" fmla="*/ 1004 h 1247"/>
              <a:gd name="T96" fmla="*/ 1200 w 1200"/>
              <a:gd name="T97" fmla="*/ 1247 h 12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</a:cxnLst>
            <a:rect l="0" t="0" r="r" b="b"/>
            <a:pathLst>
              <a:path w="1200" h="1247">
                <a:moveTo>
                  <a:pt x="0" y="0"/>
                </a:moveTo>
                <a:lnTo>
                  <a:pt x="24" y="12"/>
                </a:lnTo>
                <a:lnTo>
                  <a:pt x="62" y="25"/>
                </a:lnTo>
                <a:lnTo>
                  <a:pt x="76" y="37"/>
                </a:lnTo>
                <a:lnTo>
                  <a:pt x="95" y="49"/>
                </a:lnTo>
                <a:lnTo>
                  <a:pt x="114" y="62"/>
                </a:lnTo>
                <a:lnTo>
                  <a:pt x="118" y="75"/>
                </a:lnTo>
                <a:lnTo>
                  <a:pt x="125" y="88"/>
                </a:lnTo>
                <a:lnTo>
                  <a:pt x="133" y="100"/>
                </a:lnTo>
                <a:lnTo>
                  <a:pt x="137" y="113"/>
                </a:lnTo>
                <a:lnTo>
                  <a:pt x="156" y="126"/>
                </a:lnTo>
                <a:lnTo>
                  <a:pt x="156" y="139"/>
                </a:lnTo>
                <a:lnTo>
                  <a:pt x="160" y="152"/>
                </a:lnTo>
                <a:lnTo>
                  <a:pt x="181" y="166"/>
                </a:lnTo>
                <a:lnTo>
                  <a:pt x="182" y="179"/>
                </a:lnTo>
                <a:lnTo>
                  <a:pt x="188" y="192"/>
                </a:lnTo>
                <a:lnTo>
                  <a:pt x="213" y="206"/>
                </a:lnTo>
                <a:lnTo>
                  <a:pt x="218" y="220"/>
                </a:lnTo>
                <a:lnTo>
                  <a:pt x="230" y="248"/>
                </a:lnTo>
                <a:lnTo>
                  <a:pt x="233" y="262"/>
                </a:lnTo>
                <a:lnTo>
                  <a:pt x="242" y="277"/>
                </a:lnTo>
                <a:lnTo>
                  <a:pt x="245" y="292"/>
                </a:lnTo>
                <a:lnTo>
                  <a:pt x="268" y="306"/>
                </a:lnTo>
                <a:lnTo>
                  <a:pt x="278" y="322"/>
                </a:lnTo>
                <a:lnTo>
                  <a:pt x="307" y="337"/>
                </a:lnTo>
                <a:lnTo>
                  <a:pt x="333" y="353"/>
                </a:lnTo>
                <a:lnTo>
                  <a:pt x="349" y="370"/>
                </a:lnTo>
                <a:lnTo>
                  <a:pt x="360" y="386"/>
                </a:lnTo>
                <a:lnTo>
                  <a:pt x="402" y="404"/>
                </a:lnTo>
                <a:lnTo>
                  <a:pt x="412" y="422"/>
                </a:lnTo>
                <a:lnTo>
                  <a:pt x="432" y="440"/>
                </a:lnTo>
                <a:lnTo>
                  <a:pt x="458" y="459"/>
                </a:lnTo>
                <a:lnTo>
                  <a:pt x="491" y="477"/>
                </a:lnTo>
                <a:lnTo>
                  <a:pt x="527" y="497"/>
                </a:lnTo>
                <a:lnTo>
                  <a:pt x="530" y="516"/>
                </a:lnTo>
                <a:lnTo>
                  <a:pt x="536" y="535"/>
                </a:lnTo>
                <a:lnTo>
                  <a:pt x="543" y="555"/>
                </a:lnTo>
                <a:lnTo>
                  <a:pt x="566" y="596"/>
                </a:lnTo>
                <a:lnTo>
                  <a:pt x="574" y="616"/>
                </a:lnTo>
                <a:lnTo>
                  <a:pt x="649" y="646"/>
                </a:lnTo>
                <a:lnTo>
                  <a:pt x="735" y="678"/>
                </a:lnTo>
                <a:lnTo>
                  <a:pt x="776" y="709"/>
                </a:lnTo>
                <a:lnTo>
                  <a:pt x="810" y="741"/>
                </a:lnTo>
                <a:lnTo>
                  <a:pt x="818" y="772"/>
                </a:lnTo>
                <a:lnTo>
                  <a:pt x="872" y="809"/>
                </a:lnTo>
                <a:lnTo>
                  <a:pt x="877" y="845"/>
                </a:lnTo>
                <a:lnTo>
                  <a:pt x="879" y="882"/>
                </a:lnTo>
                <a:lnTo>
                  <a:pt x="1086" y="1004"/>
                </a:lnTo>
                <a:lnTo>
                  <a:pt x="1200" y="1247"/>
                </a:lnTo>
              </a:path>
            </a:pathLst>
          </a:cu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88" name="Rettangolo 87"/>
          <p:cNvSpPr/>
          <p:nvPr/>
        </p:nvSpPr>
        <p:spPr>
          <a:xfrm>
            <a:off x="1356619" y="1852654"/>
            <a:ext cx="3795463" cy="36883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9" name="Rettangolo 88"/>
          <p:cNvSpPr/>
          <p:nvPr/>
        </p:nvSpPr>
        <p:spPr>
          <a:xfrm>
            <a:off x="6148862" y="1852654"/>
            <a:ext cx="3795463" cy="36883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91" name="Connettore diritto 90"/>
          <p:cNvCxnSpPr/>
          <p:nvPr/>
        </p:nvCxnSpPr>
        <p:spPr>
          <a:xfrm>
            <a:off x="3307284" y="2050923"/>
            <a:ext cx="3644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ttore diritto 91"/>
          <p:cNvCxnSpPr/>
          <p:nvPr/>
        </p:nvCxnSpPr>
        <p:spPr>
          <a:xfrm>
            <a:off x="3310831" y="2203323"/>
            <a:ext cx="364493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CasellaDiTesto 92"/>
          <p:cNvSpPr txBox="1"/>
          <p:nvPr/>
        </p:nvSpPr>
        <p:spPr>
          <a:xfrm>
            <a:off x="3702802" y="1904053"/>
            <a:ext cx="10207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Without OH</a:t>
            </a:r>
            <a:endParaRPr lang="en-GB" sz="1000" dirty="0"/>
          </a:p>
        </p:txBody>
      </p:sp>
      <p:sp>
        <p:nvSpPr>
          <p:cNvPr id="94" name="CasellaDiTesto 93"/>
          <p:cNvSpPr txBox="1"/>
          <p:nvPr/>
        </p:nvSpPr>
        <p:spPr>
          <a:xfrm>
            <a:off x="3706841" y="2081984"/>
            <a:ext cx="10207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With OH</a:t>
            </a:r>
            <a:endParaRPr lang="it-IT" sz="1000" dirty="0"/>
          </a:p>
        </p:txBody>
      </p:sp>
      <p:cxnSp>
        <p:nvCxnSpPr>
          <p:cNvPr id="95" name="Connettore diritto 94"/>
          <p:cNvCxnSpPr/>
          <p:nvPr/>
        </p:nvCxnSpPr>
        <p:spPr>
          <a:xfrm>
            <a:off x="8346181" y="2106474"/>
            <a:ext cx="3644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ttore diritto 95"/>
          <p:cNvCxnSpPr/>
          <p:nvPr/>
        </p:nvCxnSpPr>
        <p:spPr>
          <a:xfrm>
            <a:off x="8349728" y="2258874"/>
            <a:ext cx="364493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CasellaDiTesto 96"/>
          <p:cNvSpPr txBox="1"/>
          <p:nvPr/>
        </p:nvSpPr>
        <p:spPr>
          <a:xfrm>
            <a:off x="8741699" y="1959604"/>
            <a:ext cx="10207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Without OH</a:t>
            </a:r>
            <a:endParaRPr lang="en-GB" sz="1000" dirty="0"/>
          </a:p>
        </p:txBody>
      </p:sp>
      <p:sp>
        <p:nvSpPr>
          <p:cNvPr id="98" name="CasellaDiTesto 97"/>
          <p:cNvSpPr txBox="1"/>
          <p:nvPr/>
        </p:nvSpPr>
        <p:spPr>
          <a:xfrm>
            <a:off x="8745738" y="2137535"/>
            <a:ext cx="10207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With OH</a:t>
            </a:r>
            <a:endParaRPr lang="it-IT" sz="1000" dirty="0"/>
          </a:p>
        </p:txBody>
      </p:sp>
      <p:sp>
        <p:nvSpPr>
          <p:cNvPr id="2" name="Rettangolo 1"/>
          <p:cNvSpPr/>
          <p:nvPr/>
        </p:nvSpPr>
        <p:spPr>
          <a:xfrm>
            <a:off x="2996227" y="2821210"/>
            <a:ext cx="200352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Log </a:t>
            </a:r>
            <a:r>
              <a:rPr lang="en-US" sz="14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Rank: 2.063, P=0.15</a:t>
            </a:r>
            <a:endParaRPr lang="it-IT" sz="1400" dirty="0"/>
          </a:p>
        </p:txBody>
      </p:sp>
      <p:sp>
        <p:nvSpPr>
          <p:cNvPr id="70" name="Rettangolo 69"/>
          <p:cNvSpPr/>
          <p:nvPr/>
        </p:nvSpPr>
        <p:spPr>
          <a:xfrm>
            <a:off x="1867055" y="1434142"/>
            <a:ext cx="288045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All-cause death</a:t>
            </a:r>
            <a:endParaRPr lang="it-IT" sz="1600" b="1" dirty="0"/>
          </a:p>
        </p:txBody>
      </p:sp>
      <p:sp>
        <p:nvSpPr>
          <p:cNvPr id="79" name="Rettangolo 78"/>
          <p:cNvSpPr/>
          <p:nvPr/>
        </p:nvSpPr>
        <p:spPr>
          <a:xfrm>
            <a:off x="6662763" y="1469189"/>
            <a:ext cx="288045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CV death</a:t>
            </a:r>
            <a:endParaRPr lang="it-IT" sz="1600" b="1" dirty="0"/>
          </a:p>
        </p:txBody>
      </p:sp>
      <p:sp>
        <p:nvSpPr>
          <p:cNvPr id="80" name="Rettangolo 79"/>
          <p:cNvSpPr/>
          <p:nvPr/>
        </p:nvSpPr>
        <p:spPr>
          <a:xfrm>
            <a:off x="1893644" y="5851636"/>
            <a:ext cx="28804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Time (days)</a:t>
            </a:r>
            <a:endParaRPr lang="it-IT" sz="1200" b="1" dirty="0"/>
          </a:p>
        </p:txBody>
      </p:sp>
      <p:sp>
        <p:nvSpPr>
          <p:cNvPr id="81" name="Rettangolo 80"/>
          <p:cNvSpPr/>
          <p:nvPr/>
        </p:nvSpPr>
        <p:spPr>
          <a:xfrm rot="16200000">
            <a:off x="-505365" y="3560603"/>
            <a:ext cx="28804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Cumulative survival</a:t>
            </a:r>
            <a:endParaRPr lang="it-IT" sz="1200" b="1" dirty="0"/>
          </a:p>
        </p:txBody>
      </p:sp>
      <p:sp>
        <p:nvSpPr>
          <p:cNvPr id="82" name="Rettangolo 81"/>
          <p:cNvSpPr/>
          <p:nvPr/>
        </p:nvSpPr>
        <p:spPr>
          <a:xfrm>
            <a:off x="6683473" y="5801440"/>
            <a:ext cx="28804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Time (days)</a:t>
            </a:r>
            <a:endParaRPr lang="it-IT" sz="1200" b="1" dirty="0"/>
          </a:p>
        </p:txBody>
      </p:sp>
      <p:sp>
        <p:nvSpPr>
          <p:cNvPr id="83" name="Rettangolo 82"/>
          <p:cNvSpPr/>
          <p:nvPr/>
        </p:nvSpPr>
        <p:spPr>
          <a:xfrm rot="16200000">
            <a:off x="4284464" y="3510407"/>
            <a:ext cx="28804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Cumulative survival</a:t>
            </a:r>
            <a:endParaRPr lang="it-IT" sz="1200" b="1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1073364" y="492981"/>
            <a:ext cx="84698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l figure 1: </a:t>
            </a:r>
            <a:r>
              <a:rPr lang="en-GB" dirty="0" smtClean="0"/>
              <a:t>Kaplan-Meier curves showing no association between OH and all-cause (left panel) and CV death (right panel) </a:t>
            </a:r>
          </a:p>
        </p:txBody>
      </p:sp>
      <p:sp>
        <p:nvSpPr>
          <p:cNvPr id="84" name="Rettangolo 83"/>
          <p:cNvSpPr/>
          <p:nvPr/>
        </p:nvSpPr>
        <p:spPr>
          <a:xfrm>
            <a:off x="7789083" y="4019618"/>
            <a:ext cx="199086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Log </a:t>
            </a:r>
            <a:r>
              <a:rPr lang="en-US" sz="140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Rank: </a:t>
            </a:r>
            <a:r>
              <a:rPr lang="en-US" sz="14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2.070, P= </a:t>
            </a:r>
            <a:r>
              <a:rPr lang="en-US" sz="1400" dirty="0" smtClean="0">
                <a:solidFill>
                  <a:srgbClr val="000000"/>
                </a:solidFill>
                <a:ea typeface="SimSun" panose="02010600030101010101" pitchFamily="2" charset="-122"/>
                <a:cs typeface="Times New Roman" panose="02020603050405020304" pitchFamily="18" charset="0"/>
              </a:rPr>
              <a:t>0.15</a:t>
            </a:r>
            <a:endParaRPr lang="it-IT" sz="1400" dirty="0"/>
          </a:p>
        </p:txBody>
      </p:sp>
      <p:sp>
        <p:nvSpPr>
          <p:cNvPr id="4" name="Figura a mano libera 3"/>
          <p:cNvSpPr/>
          <p:nvPr/>
        </p:nvSpPr>
        <p:spPr>
          <a:xfrm>
            <a:off x="1327868" y="1995777"/>
            <a:ext cx="2941982" cy="3458818"/>
          </a:xfrm>
          <a:custGeom>
            <a:avLst/>
            <a:gdLst>
              <a:gd name="connsiteX0" fmla="*/ 0 w 2941982"/>
              <a:gd name="connsiteY0" fmla="*/ 0 h 3458818"/>
              <a:gd name="connsiteX1" fmla="*/ 103367 w 2941982"/>
              <a:gd name="connsiteY1" fmla="*/ 15903 h 3458818"/>
              <a:gd name="connsiteX2" fmla="*/ 230588 w 2941982"/>
              <a:gd name="connsiteY2" fmla="*/ 79513 h 3458818"/>
              <a:gd name="connsiteX3" fmla="*/ 341906 w 2941982"/>
              <a:gd name="connsiteY3" fmla="*/ 127221 h 3458818"/>
              <a:gd name="connsiteX4" fmla="*/ 445273 w 2941982"/>
              <a:gd name="connsiteY4" fmla="*/ 214686 h 3458818"/>
              <a:gd name="connsiteX5" fmla="*/ 477078 w 2941982"/>
              <a:gd name="connsiteY5" fmla="*/ 326004 h 3458818"/>
              <a:gd name="connsiteX6" fmla="*/ 540689 w 2941982"/>
              <a:gd name="connsiteY6" fmla="*/ 485030 h 3458818"/>
              <a:gd name="connsiteX7" fmla="*/ 564542 w 2941982"/>
              <a:gd name="connsiteY7" fmla="*/ 636105 h 3458818"/>
              <a:gd name="connsiteX8" fmla="*/ 604299 w 2941982"/>
              <a:gd name="connsiteY8" fmla="*/ 826936 h 3458818"/>
              <a:gd name="connsiteX9" fmla="*/ 659958 w 2941982"/>
              <a:gd name="connsiteY9" fmla="*/ 1017767 h 3458818"/>
              <a:gd name="connsiteX10" fmla="*/ 699715 w 2941982"/>
              <a:gd name="connsiteY10" fmla="*/ 1168842 h 3458818"/>
              <a:gd name="connsiteX11" fmla="*/ 739471 w 2941982"/>
              <a:gd name="connsiteY11" fmla="*/ 1240404 h 3458818"/>
              <a:gd name="connsiteX12" fmla="*/ 779228 w 2941982"/>
              <a:gd name="connsiteY12" fmla="*/ 1296063 h 3458818"/>
              <a:gd name="connsiteX13" fmla="*/ 850789 w 2941982"/>
              <a:gd name="connsiteY13" fmla="*/ 1375576 h 3458818"/>
              <a:gd name="connsiteX14" fmla="*/ 1049572 w 2941982"/>
              <a:gd name="connsiteY14" fmla="*/ 1463040 h 3458818"/>
              <a:gd name="connsiteX15" fmla="*/ 1200647 w 2941982"/>
              <a:gd name="connsiteY15" fmla="*/ 1526651 h 3458818"/>
              <a:gd name="connsiteX16" fmla="*/ 1415332 w 2941982"/>
              <a:gd name="connsiteY16" fmla="*/ 1614115 h 3458818"/>
              <a:gd name="connsiteX17" fmla="*/ 1534602 w 2941982"/>
              <a:gd name="connsiteY17" fmla="*/ 1630018 h 3458818"/>
              <a:gd name="connsiteX18" fmla="*/ 1566407 w 2941982"/>
              <a:gd name="connsiteY18" fmla="*/ 1860606 h 3458818"/>
              <a:gd name="connsiteX19" fmla="*/ 1598212 w 2941982"/>
              <a:gd name="connsiteY19" fmla="*/ 1932167 h 3458818"/>
              <a:gd name="connsiteX20" fmla="*/ 1653871 w 2941982"/>
              <a:gd name="connsiteY20" fmla="*/ 2019632 h 3458818"/>
              <a:gd name="connsiteX21" fmla="*/ 1717482 w 2941982"/>
              <a:gd name="connsiteY21" fmla="*/ 2186609 h 3458818"/>
              <a:gd name="connsiteX22" fmla="*/ 1884459 w 2941982"/>
              <a:gd name="connsiteY22" fmla="*/ 2329733 h 3458818"/>
              <a:gd name="connsiteX23" fmla="*/ 2075290 w 2941982"/>
              <a:gd name="connsiteY23" fmla="*/ 2512613 h 3458818"/>
              <a:gd name="connsiteX24" fmla="*/ 2464904 w 2941982"/>
              <a:gd name="connsiteY24" fmla="*/ 2846567 h 3458818"/>
              <a:gd name="connsiteX25" fmla="*/ 2798859 w 2941982"/>
              <a:gd name="connsiteY25" fmla="*/ 3093058 h 3458818"/>
              <a:gd name="connsiteX26" fmla="*/ 2854518 w 2941982"/>
              <a:gd name="connsiteY26" fmla="*/ 3244133 h 3458818"/>
              <a:gd name="connsiteX27" fmla="*/ 2941982 w 2941982"/>
              <a:gd name="connsiteY27" fmla="*/ 3458818 h 3458818"/>
              <a:gd name="connsiteX28" fmla="*/ 2941982 w 2941982"/>
              <a:gd name="connsiteY28" fmla="*/ 3442915 h 34588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2941982" h="3458818">
                <a:moveTo>
                  <a:pt x="0" y="0"/>
                </a:moveTo>
                <a:lnTo>
                  <a:pt x="103367" y="15903"/>
                </a:lnTo>
                <a:lnTo>
                  <a:pt x="230588" y="79513"/>
                </a:lnTo>
                <a:lnTo>
                  <a:pt x="341906" y="127221"/>
                </a:lnTo>
                <a:lnTo>
                  <a:pt x="445273" y="214686"/>
                </a:lnTo>
                <a:lnTo>
                  <a:pt x="477078" y="326004"/>
                </a:lnTo>
                <a:lnTo>
                  <a:pt x="540689" y="485030"/>
                </a:lnTo>
                <a:lnTo>
                  <a:pt x="564542" y="636105"/>
                </a:lnTo>
                <a:lnTo>
                  <a:pt x="604299" y="826936"/>
                </a:lnTo>
                <a:lnTo>
                  <a:pt x="659958" y="1017767"/>
                </a:lnTo>
                <a:lnTo>
                  <a:pt x="699715" y="1168842"/>
                </a:lnTo>
                <a:lnTo>
                  <a:pt x="739471" y="1240404"/>
                </a:lnTo>
                <a:lnTo>
                  <a:pt x="779228" y="1296063"/>
                </a:lnTo>
                <a:lnTo>
                  <a:pt x="850789" y="1375576"/>
                </a:lnTo>
                <a:lnTo>
                  <a:pt x="1049572" y="1463040"/>
                </a:lnTo>
                <a:lnTo>
                  <a:pt x="1200647" y="1526651"/>
                </a:lnTo>
                <a:lnTo>
                  <a:pt x="1415332" y="1614115"/>
                </a:lnTo>
                <a:lnTo>
                  <a:pt x="1534602" y="1630018"/>
                </a:lnTo>
                <a:lnTo>
                  <a:pt x="1566407" y="1860606"/>
                </a:lnTo>
                <a:lnTo>
                  <a:pt x="1598212" y="1932167"/>
                </a:lnTo>
                <a:lnTo>
                  <a:pt x="1653871" y="2019632"/>
                </a:lnTo>
                <a:lnTo>
                  <a:pt x="1717482" y="2186609"/>
                </a:lnTo>
                <a:lnTo>
                  <a:pt x="1884459" y="2329733"/>
                </a:lnTo>
                <a:lnTo>
                  <a:pt x="2075290" y="2512613"/>
                </a:lnTo>
                <a:lnTo>
                  <a:pt x="2464904" y="2846567"/>
                </a:lnTo>
                <a:lnTo>
                  <a:pt x="2798859" y="3093058"/>
                </a:lnTo>
                <a:lnTo>
                  <a:pt x="2854518" y="3244133"/>
                </a:lnTo>
                <a:lnTo>
                  <a:pt x="2941982" y="3458818"/>
                </a:lnTo>
                <a:lnTo>
                  <a:pt x="2941982" y="3442915"/>
                </a:lnTo>
              </a:path>
            </a:pathLst>
          </a:cu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72650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audia Torino</dc:creator>
  <cp:lastModifiedBy>Claudia Torino</cp:lastModifiedBy>
  <cp:revision>11</cp:revision>
  <dcterms:created xsi:type="dcterms:W3CDTF">2021-05-28T16:43:55Z</dcterms:created>
  <dcterms:modified xsi:type="dcterms:W3CDTF">2021-06-09T11:09:23Z</dcterms:modified>
</cp:coreProperties>
</file>